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0"/>
  </p:notesMasterIdLst>
  <p:sldIdLst>
    <p:sldId id="282" r:id="rId2"/>
    <p:sldId id="256" r:id="rId3"/>
    <p:sldId id="260" r:id="rId4"/>
    <p:sldId id="267" r:id="rId5"/>
    <p:sldId id="280" r:id="rId6"/>
    <p:sldId id="276" r:id="rId7"/>
    <p:sldId id="268" r:id="rId8"/>
    <p:sldId id="281" r:id="rId9"/>
  </p:sldIdLst>
  <p:sldSz cx="9601200" cy="128016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6291"/>
  </p:normalViewPr>
  <p:slideViewPr>
    <p:cSldViewPr snapToGrid="0" snapToObjects="1">
      <p:cViewPr>
        <p:scale>
          <a:sx n="185" d="100"/>
          <a:sy n="185" d="100"/>
        </p:scale>
        <p:origin x="24" y="144"/>
      </p:cViewPr>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D1409E2-BEBD-0748-AA7F-11A96029B2A3}" type="datetimeFigureOut">
              <a:rPr kumimoji="1" lang="ja-JP" altLang="en-US" smtClean="0"/>
              <a:t>2023/7/16</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A2FE673-B333-994A-8EC7-B240E469D244}" type="slidenum">
              <a:rPr kumimoji="1" lang="ja-JP" altLang="en-US" smtClean="0"/>
              <a:t>‹#›</a:t>
            </a:fld>
            <a:endParaRPr kumimoji="1" lang="ja-JP" altLang="en-US"/>
          </a:p>
        </p:txBody>
      </p:sp>
    </p:spTree>
    <p:extLst>
      <p:ext uri="{BB962C8B-B14F-4D97-AF65-F5344CB8AC3E}">
        <p14:creationId xmlns:p14="http://schemas.microsoft.com/office/powerpoint/2010/main" val="241418234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ja-JP" altLang="en-US"/>
              <a:t>マスター タイトルの書式設定</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42C59F0-2DC4-AA42-9879-95511B4BEC11}" type="datetime1">
              <a:rPr kumimoji="1" lang="ja-JP" altLang="en-US" smtClean="0"/>
              <a:t>2023/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7387135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6042AE2-6371-C345-957F-D6A08087D6A9}" type="datetime1">
              <a:rPr kumimoji="1" lang="ja-JP" altLang="en-US" smtClean="0"/>
              <a:t>2023/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26434199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4286224-1E28-144C-9579-ECB37845C23C}" type="datetime1">
              <a:rPr kumimoji="1" lang="ja-JP" altLang="en-US" smtClean="0"/>
              <a:t>2023/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40448434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1E84F3D-990C-D04D-AF2A-958222FFE400}" type="datetime1">
              <a:rPr kumimoji="1" lang="ja-JP" altLang="en-US" smtClean="0"/>
              <a:t>2023/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7316160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EEAB527F-88BB-2C4F-9CD5-202DA488C28F}" type="datetime1">
              <a:rPr kumimoji="1" lang="ja-JP" altLang="en-US" smtClean="0"/>
              <a:t>2023/7/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23922611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83720A6-9D81-AF44-8BDC-E37D1E0D6E71}" type="datetime1">
              <a:rPr kumimoji="1" lang="ja-JP" altLang="en-US" smtClean="0"/>
              <a:t>2023/7/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2620872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ja-JP" altLang="en-US"/>
              <a:t>マスター テキストの書式設定</a:t>
            </a:r>
          </a:p>
        </p:txBody>
      </p:sp>
      <p:sp>
        <p:nvSpPr>
          <p:cNvPr id="4" name="Content Placeholder 3"/>
          <p:cNvSpPr>
            <a:spLocks noGrp="1"/>
          </p:cNvSpPr>
          <p:nvPr>
            <p:ph sz="half" idx="2"/>
          </p:nvPr>
        </p:nvSpPr>
        <p:spPr>
          <a:xfrm>
            <a:off x="661334" y="4676140"/>
            <a:ext cx="4061757" cy="68778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ja-JP" altLang="en-US"/>
              <a:t>マスター テキストの書式設定</a:t>
            </a:r>
          </a:p>
        </p:txBody>
      </p:sp>
      <p:sp>
        <p:nvSpPr>
          <p:cNvPr id="6" name="Content Placeholder 5"/>
          <p:cNvSpPr>
            <a:spLocks noGrp="1"/>
          </p:cNvSpPr>
          <p:nvPr>
            <p:ph sz="quarter" idx="4"/>
          </p:nvPr>
        </p:nvSpPr>
        <p:spPr>
          <a:xfrm>
            <a:off x="4860608" y="4676140"/>
            <a:ext cx="4081761" cy="68778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42E19B8B-D94F-914F-A0E2-C019FAF3D692}" type="datetime1">
              <a:rPr kumimoji="1" lang="ja-JP" altLang="en-US" smtClean="0"/>
              <a:t>2023/7/1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29838965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46F3BE4-CEF4-9E4B-9374-A38761A605D5}" type="datetime1">
              <a:rPr kumimoji="1" lang="ja-JP" altLang="en-US" smtClean="0"/>
              <a:t>2023/7/1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9604185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E377B6-C873-8E45-BED0-73D6E36CBD7E}" type="datetime1">
              <a:rPr kumimoji="1" lang="ja-JP" altLang="en-US" smtClean="0"/>
              <a:t>2023/7/1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21746003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ja-JP" altLang="en-US"/>
              <a:t>マスター タイトルの書式設定</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5BF8661-4EF6-B64A-9A53-3D677A0CEDBA}" type="datetime1">
              <a:rPr kumimoji="1" lang="ja-JP" altLang="en-US" smtClean="0"/>
              <a:t>2023/7/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7290561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7FBB366-5D0F-6B47-8E81-69E7C2EA8A1E}" type="datetime1">
              <a:rPr kumimoji="1" lang="ja-JP" altLang="en-US" smtClean="0"/>
              <a:t>2023/7/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40822610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36268CF3-575E-8644-B62C-39202F6A5025}" type="datetime1">
              <a:rPr kumimoji="1" lang="ja-JP" altLang="en-US" smtClean="0"/>
              <a:t>2023/7/16</a:t>
            </a:fld>
            <a:endParaRPr kumimoji="1" lang="ja-JP" altLang="en-US"/>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FE361FE6-19F7-A94F-A1B6-44A806D68AC9}" type="slidenum">
              <a:rPr kumimoji="1" lang="ja-JP" altLang="en-US" smtClean="0"/>
              <a:t>‹#›</a:t>
            </a:fld>
            <a:endParaRPr kumimoji="1" lang="ja-JP" altLang="en-US"/>
          </a:p>
        </p:txBody>
      </p:sp>
    </p:spTree>
    <p:extLst>
      <p:ext uri="{BB962C8B-B14F-4D97-AF65-F5344CB8AC3E}">
        <p14:creationId xmlns:p14="http://schemas.microsoft.com/office/powerpoint/2010/main" val="17932183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960120" rtl="0" eaLnBrk="1" latinLnBrk="0" hangingPunct="1">
        <a:lnSpc>
          <a:spcPct val="90000"/>
        </a:lnSpc>
        <a:spcBef>
          <a:spcPct val="0"/>
        </a:spcBef>
        <a:buNone/>
        <a:defRPr kumimoji="1"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kumimoji="1"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kumimoji="1"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kumimoji="1"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9pPr>
    </p:bodyStyle>
    <p:otherStyle>
      <a:defPPr>
        <a:defRPr lang="en-US"/>
      </a:defPPr>
      <a:lvl1pPr marL="0" algn="l" defTabSz="960120" rtl="0" eaLnBrk="1" latinLnBrk="0" hangingPunct="1">
        <a:defRPr kumimoji="1" sz="1890" kern="1200">
          <a:solidFill>
            <a:schemeClr val="tx1"/>
          </a:solidFill>
          <a:latin typeface="+mn-lt"/>
          <a:ea typeface="+mn-ea"/>
          <a:cs typeface="+mn-cs"/>
        </a:defRPr>
      </a:lvl1pPr>
      <a:lvl2pPr marL="480060" algn="l" defTabSz="960120" rtl="0" eaLnBrk="1" latinLnBrk="0" hangingPunct="1">
        <a:defRPr kumimoji="1" sz="1890" kern="1200">
          <a:solidFill>
            <a:schemeClr val="tx1"/>
          </a:solidFill>
          <a:latin typeface="+mn-lt"/>
          <a:ea typeface="+mn-ea"/>
          <a:cs typeface="+mn-cs"/>
        </a:defRPr>
      </a:lvl2pPr>
      <a:lvl3pPr marL="960120" algn="l" defTabSz="960120" rtl="0" eaLnBrk="1" latinLnBrk="0" hangingPunct="1">
        <a:defRPr kumimoji="1" sz="1890" kern="1200">
          <a:solidFill>
            <a:schemeClr val="tx1"/>
          </a:solidFill>
          <a:latin typeface="+mn-lt"/>
          <a:ea typeface="+mn-ea"/>
          <a:cs typeface="+mn-cs"/>
        </a:defRPr>
      </a:lvl3pPr>
      <a:lvl4pPr marL="1440180" algn="l" defTabSz="960120" rtl="0" eaLnBrk="1" latinLnBrk="0" hangingPunct="1">
        <a:defRPr kumimoji="1" sz="1890" kern="1200">
          <a:solidFill>
            <a:schemeClr val="tx1"/>
          </a:solidFill>
          <a:latin typeface="+mn-lt"/>
          <a:ea typeface="+mn-ea"/>
          <a:cs typeface="+mn-cs"/>
        </a:defRPr>
      </a:lvl4pPr>
      <a:lvl5pPr marL="1920240" algn="l" defTabSz="960120" rtl="0" eaLnBrk="1" latinLnBrk="0" hangingPunct="1">
        <a:defRPr kumimoji="1" sz="1890" kern="1200">
          <a:solidFill>
            <a:schemeClr val="tx1"/>
          </a:solidFill>
          <a:latin typeface="+mn-lt"/>
          <a:ea typeface="+mn-ea"/>
          <a:cs typeface="+mn-cs"/>
        </a:defRPr>
      </a:lvl5pPr>
      <a:lvl6pPr marL="2400300" algn="l" defTabSz="960120" rtl="0" eaLnBrk="1" latinLnBrk="0" hangingPunct="1">
        <a:defRPr kumimoji="1" sz="1890" kern="1200">
          <a:solidFill>
            <a:schemeClr val="tx1"/>
          </a:solidFill>
          <a:latin typeface="+mn-lt"/>
          <a:ea typeface="+mn-ea"/>
          <a:cs typeface="+mn-cs"/>
        </a:defRPr>
      </a:lvl6pPr>
      <a:lvl7pPr marL="2880360" algn="l" defTabSz="960120" rtl="0" eaLnBrk="1" latinLnBrk="0" hangingPunct="1">
        <a:defRPr kumimoji="1" sz="1890" kern="1200">
          <a:solidFill>
            <a:schemeClr val="tx1"/>
          </a:solidFill>
          <a:latin typeface="+mn-lt"/>
          <a:ea typeface="+mn-ea"/>
          <a:cs typeface="+mn-cs"/>
        </a:defRPr>
      </a:lvl7pPr>
      <a:lvl8pPr marL="3360420" algn="l" defTabSz="960120" rtl="0" eaLnBrk="1" latinLnBrk="0" hangingPunct="1">
        <a:defRPr kumimoji="1" sz="1890" kern="1200">
          <a:solidFill>
            <a:schemeClr val="tx1"/>
          </a:solidFill>
          <a:latin typeface="+mn-lt"/>
          <a:ea typeface="+mn-ea"/>
          <a:cs typeface="+mn-cs"/>
        </a:defRPr>
      </a:lvl8pPr>
      <a:lvl9pPr marL="3840480" algn="l" defTabSz="960120" rtl="0" eaLnBrk="1" latinLnBrk="0" hangingPunct="1">
        <a:defRPr kumimoji="1"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7.jpg"/><Relationship Id="rId13" Type="http://schemas.openxmlformats.org/officeDocument/2006/relationships/image" Target="../media/image12.jpg"/><Relationship Id="rId3" Type="http://schemas.openxmlformats.org/officeDocument/2006/relationships/image" Target="../media/image2.jpg"/><Relationship Id="rId7" Type="http://schemas.openxmlformats.org/officeDocument/2006/relationships/image" Target="../media/image6.jpg"/><Relationship Id="rId12" Type="http://schemas.openxmlformats.org/officeDocument/2006/relationships/image" Target="../media/image11.jpg"/><Relationship Id="rId2" Type="http://schemas.openxmlformats.org/officeDocument/2006/relationships/image" Target="../media/image1.jpg"/><Relationship Id="rId1" Type="http://schemas.openxmlformats.org/officeDocument/2006/relationships/slideLayout" Target="../slideLayouts/slideLayout7.xml"/><Relationship Id="rId6" Type="http://schemas.openxmlformats.org/officeDocument/2006/relationships/image" Target="../media/image5.jpg"/><Relationship Id="rId11" Type="http://schemas.openxmlformats.org/officeDocument/2006/relationships/image" Target="../media/image10.jpg"/><Relationship Id="rId5" Type="http://schemas.openxmlformats.org/officeDocument/2006/relationships/image" Target="../media/image4.jpg"/><Relationship Id="rId10" Type="http://schemas.openxmlformats.org/officeDocument/2006/relationships/image" Target="../media/image9.jpg"/><Relationship Id="rId4" Type="http://schemas.openxmlformats.org/officeDocument/2006/relationships/image" Target="../media/image3.jpg"/><Relationship Id="rId9" Type="http://schemas.openxmlformats.org/officeDocument/2006/relationships/image" Target="../media/image8.jpg"/><Relationship Id="rId14" Type="http://schemas.openxmlformats.org/officeDocument/2006/relationships/image" Target="../media/image13.png"/></Relationships>
</file>

<file path=ppt/slides/_rels/slide6.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image" Target="../media/image14.tiff"/><Relationship Id="rId1" Type="http://schemas.openxmlformats.org/officeDocument/2006/relationships/slideLayout" Target="../slideLayouts/slideLayout7.xml"/><Relationship Id="rId6" Type="http://schemas.openxmlformats.org/officeDocument/2006/relationships/image" Target="../media/image18.tiff"/><Relationship Id="rId5" Type="http://schemas.openxmlformats.org/officeDocument/2006/relationships/image" Target="../media/image17.tiff"/><Relationship Id="rId4" Type="http://schemas.openxmlformats.org/officeDocument/2006/relationships/image" Target="../media/image16.tiff"/></Relationships>
</file>

<file path=ppt/slides/_rels/slide7.xml.rels><?xml version="1.0" encoding="UTF-8" standalone="yes"?>
<Relationships xmlns="http://schemas.openxmlformats.org/package/2006/relationships"><Relationship Id="rId8" Type="http://schemas.openxmlformats.org/officeDocument/2006/relationships/image" Target="../media/image25.jpg"/><Relationship Id="rId3" Type="http://schemas.openxmlformats.org/officeDocument/2006/relationships/image" Target="../media/image20.jpg"/><Relationship Id="rId7" Type="http://schemas.openxmlformats.org/officeDocument/2006/relationships/image" Target="../media/image24.jpg"/><Relationship Id="rId2" Type="http://schemas.openxmlformats.org/officeDocument/2006/relationships/image" Target="../media/image19.jpg"/><Relationship Id="rId1" Type="http://schemas.openxmlformats.org/officeDocument/2006/relationships/slideLayout" Target="../slideLayouts/slideLayout7.xml"/><Relationship Id="rId6" Type="http://schemas.openxmlformats.org/officeDocument/2006/relationships/image" Target="../media/image23.jpg"/><Relationship Id="rId5" Type="http://schemas.openxmlformats.org/officeDocument/2006/relationships/image" Target="../media/image22.jpg"/><Relationship Id="rId4" Type="http://schemas.openxmlformats.org/officeDocument/2006/relationships/image" Target="../media/image21.jpg"/><Relationship Id="rId9" Type="http://schemas.openxmlformats.org/officeDocument/2006/relationships/image" Target="../media/image26.jpg"/></Relationships>
</file>

<file path=ppt/slides/_rels/slide8.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package" Target="../embeddings/Microsoft_Word___.docx"/><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EEDD3480-748A-1C26-F651-A1EB27527013}"/>
              </a:ext>
            </a:extLst>
          </p:cNvPr>
          <p:cNvSpPr>
            <a:spLocks noGrp="1"/>
          </p:cNvSpPr>
          <p:nvPr>
            <p:ph type="sldNum" sz="quarter" idx="12"/>
          </p:nvPr>
        </p:nvSpPr>
        <p:spPr/>
        <p:txBody>
          <a:bodyPr/>
          <a:lstStyle/>
          <a:p>
            <a:fld id="{FE361FE6-19F7-A94F-A1B6-44A806D68AC9}" type="slidenum">
              <a:rPr kumimoji="1" lang="ja-JP" altLang="en-US" smtClean="0"/>
              <a:t>1</a:t>
            </a:fld>
            <a:endParaRPr kumimoji="1" lang="ja-JP" altLang="en-US"/>
          </a:p>
        </p:txBody>
      </p:sp>
      <p:sp>
        <p:nvSpPr>
          <p:cNvPr id="4" name="円/楕円 3">
            <a:extLst>
              <a:ext uri="{FF2B5EF4-FFF2-40B4-BE49-F238E27FC236}">
                <a16:creationId xmlns:a16="http://schemas.microsoft.com/office/drawing/2014/main" id="{54AEF9BD-5251-458B-4CE3-362F4BE33E5D}"/>
              </a:ext>
            </a:extLst>
          </p:cNvPr>
          <p:cNvSpPr/>
          <p:nvPr/>
        </p:nvSpPr>
        <p:spPr>
          <a:xfrm>
            <a:off x="477576" y="4098755"/>
            <a:ext cx="1640910" cy="1640910"/>
          </a:xfrm>
          <a:prstGeom prst="ellipse">
            <a:avLst/>
          </a:prstGeom>
          <a:solidFill>
            <a:schemeClr val="bg1">
              <a:lumMod val="85000"/>
            </a:schemeClr>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5" name="テキスト ボックス 4">
            <a:extLst>
              <a:ext uri="{FF2B5EF4-FFF2-40B4-BE49-F238E27FC236}">
                <a16:creationId xmlns:a16="http://schemas.microsoft.com/office/drawing/2014/main" id="{8DAC6BD4-8282-1EBC-ED01-1BBE8D742BED}"/>
              </a:ext>
            </a:extLst>
          </p:cNvPr>
          <p:cNvSpPr txBox="1"/>
          <p:nvPr/>
        </p:nvSpPr>
        <p:spPr>
          <a:xfrm>
            <a:off x="860258" y="5818442"/>
            <a:ext cx="1007007" cy="369332"/>
          </a:xfrm>
          <a:prstGeom prst="rect">
            <a:avLst/>
          </a:prstGeom>
          <a:noFill/>
        </p:spPr>
        <p:txBody>
          <a:bodyPr wrap="none" rtlCol="0">
            <a:spAutoFit/>
          </a:bodyPr>
          <a:lstStyle/>
          <a:p>
            <a:pPr algn="ctr"/>
            <a:r>
              <a:rPr kumimoji="1" lang="en-US" altLang="ja-JP" b="1" dirty="0">
                <a:latin typeface="Meiryo" panose="020B0604030504040204" pitchFamily="34" charset="-128"/>
                <a:ea typeface="Meiryo" panose="020B0604030504040204" pitchFamily="34" charset="-128"/>
              </a:rPr>
              <a:t>PBMCs</a:t>
            </a:r>
          </a:p>
        </p:txBody>
      </p:sp>
      <p:sp>
        <p:nvSpPr>
          <p:cNvPr id="6" name="爆発 1 5">
            <a:extLst>
              <a:ext uri="{FF2B5EF4-FFF2-40B4-BE49-F238E27FC236}">
                <a16:creationId xmlns:a16="http://schemas.microsoft.com/office/drawing/2014/main" id="{C66683EF-BC1B-0214-F94D-4147C3BA5231}"/>
              </a:ext>
            </a:extLst>
          </p:cNvPr>
          <p:cNvSpPr/>
          <p:nvPr/>
        </p:nvSpPr>
        <p:spPr>
          <a:xfrm>
            <a:off x="2952752" y="3726418"/>
            <a:ext cx="2085430" cy="2381429"/>
          </a:xfrm>
          <a:prstGeom prst="irregularSeal1">
            <a:avLst/>
          </a:prstGeom>
          <a:solidFill>
            <a:srgbClr val="00FA00"/>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7" name="円/楕円 6">
            <a:extLst>
              <a:ext uri="{FF2B5EF4-FFF2-40B4-BE49-F238E27FC236}">
                <a16:creationId xmlns:a16="http://schemas.microsoft.com/office/drawing/2014/main" id="{5D0F6767-020F-16FE-2F07-5CF4AA5244F8}"/>
              </a:ext>
            </a:extLst>
          </p:cNvPr>
          <p:cNvSpPr/>
          <p:nvPr/>
        </p:nvSpPr>
        <p:spPr>
          <a:xfrm>
            <a:off x="3154778" y="4091667"/>
            <a:ext cx="1640910" cy="1640910"/>
          </a:xfrm>
          <a:prstGeom prst="ellipse">
            <a:avLst/>
          </a:prstGeom>
          <a:solidFill>
            <a:srgbClr val="00FA00"/>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nvGrpSpPr>
          <p:cNvPr id="8" name="グループ化 7">
            <a:extLst>
              <a:ext uri="{FF2B5EF4-FFF2-40B4-BE49-F238E27FC236}">
                <a16:creationId xmlns:a16="http://schemas.microsoft.com/office/drawing/2014/main" id="{75B87405-843F-AD0D-66EE-8CD100ABA74D}"/>
              </a:ext>
            </a:extLst>
          </p:cNvPr>
          <p:cNvGrpSpPr/>
          <p:nvPr/>
        </p:nvGrpSpPr>
        <p:grpSpPr>
          <a:xfrm>
            <a:off x="3900258" y="3478432"/>
            <a:ext cx="506815" cy="1007014"/>
            <a:chOff x="3407637" y="2364654"/>
            <a:chExt cx="506815" cy="1007014"/>
          </a:xfrm>
        </p:grpSpPr>
        <p:cxnSp>
          <p:nvCxnSpPr>
            <p:cNvPr id="9" name="直線コネクタ 8">
              <a:extLst>
                <a:ext uri="{FF2B5EF4-FFF2-40B4-BE49-F238E27FC236}">
                  <a16:creationId xmlns:a16="http://schemas.microsoft.com/office/drawing/2014/main" id="{A0B7A310-1237-24EE-CC0D-24FFAD185544}"/>
                </a:ext>
              </a:extLst>
            </p:cNvPr>
            <p:cNvCxnSpPr>
              <a:cxnSpLocks/>
            </p:cNvCxnSpPr>
            <p:nvPr/>
          </p:nvCxnSpPr>
          <p:spPr>
            <a:xfrm flipV="1">
              <a:off x="3488209" y="2857500"/>
              <a:ext cx="1" cy="225425"/>
            </a:xfrm>
            <a:prstGeom prst="line">
              <a:avLst/>
            </a:prstGeom>
            <a:ln w="19050"/>
          </p:spPr>
          <p:style>
            <a:lnRef idx="1">
              <a:schemeClr val="dk1"/>
            </a:lnRef>
            <a:fillRef idx="0">
              <a:schemeClr val="dk1"/>
            </a:fillRef>
            <a:effectRef idx="0">
              <a:schemeClr val="dk1"/>
            </a:effectRef>
            <a:fontRef idx="minor">
              <a:schemeClr val="tx1"/>
            </a:fontRef>
          </p:style>
        </p:cxnSp>
        <p:sp>
          <p:nvSpPr>
            <p:cNvPr id="10" name="フリーフォーム 9">
              <a:extLst>
                <a:ext uri="{FF2B5EF4-FFF2-40B4-BE49-F238E27FC236}">
                  <a16:creationId xmlns:a16="http://schemas.microsoft.com/office/drawing/2014/main" id="{7468CA5F-50DB-D56B-A4E0-9855FAC95DE5}"/>
                </a:ext>
              </a:extLst>
            </p:cNvPr>
            <p:cNvSpPr/>
            <p:nvPr/>
          </p:nvSpPr>
          <p:spPr>
            <a:xfrm>
              <a:off x="3481466" y="2364654"/>
              <a:ext cx="322288" cy="495934"/>
            </a:xfrm>
            <a:custGeom>
              <a:avLst/>
              <a:gdLst>
                <a:gd name="connsiteX0" fmla="*/ 0 w 322288"/>
                <a:gd name="connsiteY0" fmla="*/ 161189 h 495934"/>
                <a:gd name="connsiteX1" fmla="*/ 112426 w 322288"/>
                <a:gd name="connsiteY1" fmla="*/ 15035 h 495934"/>
                <a:gd name="connsiteX2" fmla="*/ 168639 w 322288"/>
                <a:gd name="connsiteY2" fmla="*/ 483477 h 495934"/>
                <a:gd name="connsiteX3" fmla="*/ 322288 w 322288"/>
                <a:gd name="connsiteY3" fmla="*/ 314838 h 495934"/>
              </a:gdLst>
              <a:ahLst/>
              <a:cxnLst>
                <a:cxn ang="0">
                  <a:pos x="connsiteX0" y="connsiteY0"/>
                </a:cxn>
                <a:cxn ang="0">
                  <a:pos x="connsiteX1" y="connsiteY1"/>
                </a:cxn>
                <a:cxn ang="0">
                  <a:pos x="connsiteX2" y="connsiteY2"/>
                </a:cxn>
                <a:cxn ang="0">
                  <a:pos x="connsiteX3" y="connsiteY3"/>
                </a:cxn>
              </a:cxnLst>
              <a:rect l="l" t="t" r="r" b="b"/>
              <a:pathLst>
                <a:path w="322288" h="495934">
                  <a:moveTo>
                    <a:pt x="0" y="161189"/>
                  </a:moveTo>
                  <a:cubicBezTo>
                    <a:pt x="42160" y="61254"/>
                    <a:pt x="84320" y="-38680"/>
                    <a:pt x="112426" y="15035"/>
                  </a:cubicBezTo>
                  <a:cubicBezTo>
                    <a:pt x="140533" y="68750"/>
                    <a:pt x="133662" y="433510"/>
                    <a:pt x="168639" y="483477"/>
                  </a:cubicBezTo>
                  <a:cubicBezTo>
                    <a:pt x="203616" y="533444"/>
                    <a:pt x="262952" y="424141"/>
                    <a:pt x="322288" y="314838"/>
                  </a:cubicBezTo>
                </a:path>
              </a:pathLst>
            </a:custGeom>
            <a:ln w="1905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11" name="角丸四角形 10">
              <a:extLst>
                <a:ext uri="{FF2B5EF4-FFF2-40B4-BE49-F238E27FC236}">
                  <a16:creationId xmlns:a16="http://schemas.microsoft.com/office/drawing/2014/main" id="{931D64F5-F6E5-A13B-131E-80D111A7C0E1}"/>
                </a:ext>
              </a:extLst>
            </p:cNvPr>
            <p:cNvSpPr/>
            <p:nvPr/>
          </p:nvSpPr>
          <p:spPr>
            <a:xfrm>
              <a:off x="3412067" y="2480733"/>
              <a:ext cx="152284" cy="448733"/>
            </a:xfrm>
            <a:prstGeom prst="roundRect">
              <a:avLst/>
            </a:prstGeom>
            <a:solidFill>
              <a:schemeClr val="accent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2" name="角丸四角形 11">
              <a:extLst>
                <a:ext uri="{FF2B5EF4-FFF2-40B4-BE49-F238E27FC236}">
                  <a16:creationId xmlns:a16="http://schemas.microsoft.com/office/drawing/2014/main" id="{768FF004-9061-5695-5364-09A6797C0A1F}"/>
                </a:ext>
              </a:extLst>
            </p:cNvPr>
            <p:cNvSpPr/>
            <p:nvPr/>
          </p:nvSpPr>
          <p:spPr>
            <a:xfrm rot="2004588">
              <a:off x="3762168" y="2501987"/>
              <a:ext cx="152284" cy="250192"/>
            </a:xfrm>
            <a:prstGeom prst="roundRect">
              <a:avLst/>
            </a:prstGeom>
            <a:solidFill>
              <a:schemeClr val="accent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3" name="円/楕円 12">
              <a:extLst>
                <a:ext uri="{FF2B5EF4-FFF2-40B4-BE49-F238E27FC236}">
                  <a16:creationId xmlns:a16="http://schemas.microsoft.com/office/drawing/2014/main" id="{CBF6827A-863D-9CC1-6A47-3DAFADB35F33}"/>
                </a:ext>
              </a:extLst>
            </p:cNvPr>
            <p:cNvSpPr/>
            <p:nvPr/>
          </p:nvSpPr>
          <p:spPr>
            <a:xfrm>
              <a:off x="3407637" y="3016466"/>
              <a:ext cx="161144" cy="161144"/>
            </a:xfrm>
            <a:prstGeom prst="ellipse">
              <a:avLst/>
            </a:prstGeom>
            <a:solidFill>
              <a:schemeClr val="accent3"/>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4" name="角丸四角形 13">
              <a:extLst>
                <a:ext uri="{FF2B5EF4-FFF2-40B4-BE49-F238E27FC236}">
                  <a16:creationId xmlns:a16="http://schemas.microsoft.com/office/drawing/2014/main" id="{C5858237-483F-2E15-BC56-216D7AA71EDE}"/>
                </a:ext>
              </a:extLst>
            </p:cNvPr>
            <p:cNvSpPr/>
            <p:nvPr/>
          </p:nvSpPr>
          <p:spPr>
            <a:xfrm>
              <a:off x="3407637" y="3177732"/>
              <a:ext cx="161144" cy="193936"/>
            </a:xfrm>
            <a:prstGeom prst="roundRect">
              <a:avLst/>
            </a:prstGeom>
            <a:solidFill>
              <a:schemeClr val="accent2"/>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sp>
        <p:nvSpPr>
          <p:cNvPr id="15" name="円/楕円 14">
            <a:extLst>
              <a:ext uri="{FF2B5EF4-FFF2-40B4-BE49-F238E27FC236}">
                <a16:creationId xmlns:a16="http://schemas.microsoft.com/office/drawing/2014/main" id="{824A3A87-AFD9-7022-7FAC-4FFCF8D484B2}"/>
              </a:ext>
            </a:extLst>
          </p:cNvPr>
          <p:cNvSpPr/>
          <p:nvPr/>
        </p:nvSpPr>
        <p:spPr>
          <a:xfrm rot="1256553">
            <a:off x="6684845" y="3078741"/>
            <a:ext cx="747514" cy="594360"/>
          </a:xfrm>
          <a:prstGeom prst="ellipse">
            <a:avLst/>
          </a:prstGeom>
          <a:solidFill>
            <a:schemeClr val="accent5"/>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6" name="爆発 1 15">
            <a:extLst>
              <a:ext uri="{FF2B5EF4-FFF2-40B4-BE49-F238E27FC236}">
                <a16:creationId xmlns:a16="http://schemas.microsoft.com/office/drawing/2014/main" id="{F8730958-EE2C-03D9-6E25-6A67C8F9BD4F}"/>
              </a:ext>
            </a:extLst>
          </p:cNvPr>
          <p:cNvSpPr/>
          <p:nvPr/>
        </p:nvSpPr>
        <p:spPr>
          <a:xfrm>
            <a:off x="5850333" y="3729555"/>
            <a:ext cx="2085430" cy="2381429"/>
          </a:xfrm>
          <a:prstGeom prst="irregularSeal1">
            <a:avLst/>
          </a:prstGeom>
          <a:solidFill>
            <a:srgbClr val="00FA00"/>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17" name="円/楕円 16">
            <a:extLst>
              <a:ext uri="{FF2B5EF4-FFF2-40B4-BE49-F238E27FC236}">
                <a16:creationId xmlns:a16="http://schemas.microsoft.com/office/drawing/2014/main" id="{552F2B6B-AD2D-D5D9-7B46-633709FE5EA3}"/>
              </a:ext>
            </a:extLst>
          </p:cNvPr>
          <p:cNvSpPr/>
          <p:nvPr/>
        </p:nvSpPr>
        <p:spPr>
          <a:xfrm>
            <a:off x="6052359" y="4094804"/>
            <a:ext cx="1640910" cy="1640910"/>
          </a:xfrm>
          <a:prstGeom prst="ellipse">
            <a:avLst/>
          </a:prstGeom>
          <a:solidFill>
            <a:srgbClr val="00FA00"/>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nvGrpSpPr>
          <p:cNvPr id="18" name="グループ化 17">
            <a:extLst>
              <a:ext uri="{FF2B5EF4-FFF2-40B4-BE49-F238E27FC236}">
                <a16:creationId xmlns:a16="http://schemas.microsoft.com/office/drawing/2014/main" id="{292B02CE-A6CE-A495-8426-A6A2FE38439B}"/>
              </a:ext>
            </a:extLst>
          </p:cNvPr>
          <p:cNvGrpSpPr/>
          <p:nvPr/>
        </p:nvGrpSpPr>
        <p:grpSpPr>
          <a:xfrm>
            <a:off x="6797839" y="3481569"/>
            <a:ext cx="506815" cy="1007014"/>
            <a:chOff x="3407637" y="2364654"/>
            <a:chExt cx="506815" cy="1007014"/>
          </a:xfrm>
        </p:grpSpPr>
        <p:cxnSp>
          <p:nvCxnSpPr>
            <p:cNvPr id="19" name="直線コネクタ 18">
              <a:extLst>
                <a:ext uri="{FF2B5EF4-FFF2-40B4-BE49-F238E27FC236}">
                  <a16:creationId xmlns:a16="http://schemas.microsoft.com/office/drawing/2014/main" id="{6A2C653C-2DA9-577D-5357-16920005B141}"/>
                </a:ext>
              </a:extLst>
            </p:cNvPr>
            <p:cNvCxnSpPr>
              <a:cxnSpLocks/>
            </p:cNvCxnSpPr>
            <p:nvPr/>
          </p:nvCxnSpPr>
          <p:spPr>
            <a:xfrm flipV="1">
              <a:off x="3488209" y="2857500"/>
              <a:ext cx="1" cy="225425"/>
            </a:xfrm>
            <a:prstGeom prst="line">
              <a:avLst/>
            </a:prstGeom>
            <a:ln w="19050"/>
          </p:spPr>
          <p:style>
            <a:lnRef idx="1">
              <a:schemeClr val="dk1"/>
            </a:lnRef>
            <a:fillRef idx="0">
              <a:schemeClr val="dk1"/>
            </a:fillRef>
            <a:effectRef idx="0">
              <a:schemeClr val="dk1"/>
            </a:effectRef>
            <a:fontRef idx="minor">
              <a:schemeClr val="tx1"/>
            </a:fontRef>
          </p:style>
        </p:cxnSp>
        <p:sp>
          <p:nvSpPr>
            <p:cNvPr id="20" name="フリーフォーム 19">
              <a:extLst>
                <a:ext uri="{FF2B5EF4-FFF2-40B4-BE49-F238E27FC236}">
                  <a16:creationId xmlns:a16="http://schemas.microsoft.com/office/drawing/2014/main" id="{5915AD87-B210-F1D4-27AA-C92BE25F5E10}"/>
                </a:ext>
              </a:extLst>
            </p:cNvPr>
            <p:cNvSpPr/>
            <p:nvPr/>
          </p:nvSpPr>
          <p:spPr>
            <a:xfrm>
              <a:off x="3481466" y="2364654"/>
              <a:ext cx="322288" cy="495934"/>
            </a:xfrm>
            <a:custGeom>
              <a:avLst/>
              <a:gdLst>
                <a:gd name="connsiteX0" fmla="*/ 0 w 322288"/>
                <a:gd name="connsiteY0" fmla="*/ 161189 h 495934"/>
                <a:gd name="connsiteX1" fmla="*/ 112426 w 322288"/>
                <a:gd name="connsiteY1" fmla="*/ 15035 h 495934"/>
                <a:gd name="connsiteX2" fmla="*/ 168639 w 322288"/>
                <a:gd name="connsiteY2" fmla="*/ 483477 h 495934"/>
                <a:gd name="connsiteX3" fmla="*/ 322288 w 322288"/>
                <a:gd name="connsiteY3" fmla="*/ 314838 h 495934"/>
              </a:gdLst>
              <a:ahLst/>
              <a:cxnLst>
                <a:cxn ang="0">
                  <a:pos x="connsiteX0" y="connsiteY0"/>
                </a:cxn>
                <a:cxn ang="0">
                  <a:pos x="connsiteX1" y="connsiteY1"/>
                </a:cxn>
                <a:cxn ang="0">
                  <a:pos x="connsiteX2" y="connsiteY2"/>
                </a:cxn>
                <a:cxn ang="0">
                  <a:pos x="connsiteX3" y="connsiteY3"/>
                </a:cxn>
              </a:cxnLst>
              <a:rect l="l" t="t" r="r" b="b"/>
              <a:pathLst>
                <a:path w="322288" h="495934">
                  <a:moveTo>
                    <a:pt x="0" y="161189"/>
                  </a:moveTo>
                  <a:cubicBezTo>
                    <a:pt x="42160" y="61254"/>
                    <a:pt x="84320" y="-38680"/>
                    <a:pt x="112426" y="15035"/>
                  </a:cubicBezTo>
                  <a:cubicBezTo>
                    <a:pt x="140533" y="68750"/>
                    <a:pt x="133662" y="433510"/>
                    <a:pt x="168639" y="483477"/>
                  </a:cubicBezTo>
                  <a:cubicBezTo>
                    <a:pt x="203616" y="533444"/>
                    <a:pt x="262952" y="424141"/>
                    <a:pt x="322288" y="314838"/>
                  </a:cubicBezTo>
                </a:path>
              </a:pathLst>
            </a:custGeom>
            <a:ln w="1905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21" name="角丸四角形 20">
              <a:extLst>
                <a:ext uri="{FF2B5EF4-FFF2-40B4-BE49-F238E27FC236}">
                  <a16:creationId xmlns:a16="http://schemas.microsoft.com/office/drawing/2014/main" id="{2D382F1F-E107-BE08-3C8A-9834CAB52950}"/>
                </a:ext>
              </a:extLst>
            </p:cNvPr>
            <p:cNvSpPr/>
            <p:nvPr/>
          </p:nvSpPr>
          <p:spPr>
            <a:xfrm>
              <a:off x="3412067" y="2480733"/>
              <a:ext cx="152284" cy="448733"/>
            </a:xfrm>
            <a:prstGeom prst="roundRect">
              <a:avLst/>
            </a:prstGeom>
            <a:solidFill>
              <a:schemeClr val="accent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2" name="角丸四角形 21">
              <a:extLst>
                <a:ext uri="{FF2B5EF4-FFF2-40B4-BE49-F238E27FC236}">
                  <a16:creationId xmlns:a16="http://schemas.microsoft.com/office/drawing/2014/main" id="{2B695C50-D9F8-C843-C533-AC825FA51877}"/>
                </a:ext>
              </a:extLst>
            </p:cNvPr>
            <p:cNvSpPr/>
            <p:nvPr/>
          </p:nvSpPr>
          <p:spPr>
            <a:xfrm rot="2004588">
              <a:off x="3762168" y="2501987"/>
              <a:ext cx="152284" cy="250192"/>
            </a:xfrm>
            <a:prstGeom prst="roundRect">
              <a:avLst/>
            </a:prstGeom>
            <a:solidFill>
              <a:schemeClr val="accent1"/>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3" name="円/楕円 22">
              <a:extLst>
                <a:ext uri="{FF2B5EF4-FFF2-40B4-BE49-F238E27FC236}">
                  <a16:creationId xmlns:a16="http://schemas.microsoft.com/office/drawing/2014/main" id="{4C4085D4-F3C6-9522-77E4-040A724E2762}"/>
                </a:ext>
              </a:extLst>
            </p:cNvPr>
            <p:cNvSpPr/>
            <p:nvPr/>
          </p:nvSpPr>
          <p:spPr>
            <a:xfrm>
              <a:off x="3407637" y="3016466"/>
              <a:ext cx="161144" cy="161144"/>
            </a:xfrm>
            <a:prstGeom prst="ellipse">
              <a:avLst/>
            </a:prstGeom>
            <a:solidFill>
              <a:schemeClr val="accent3"/>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24" name="角丸四角形 23">
              <a:extLst>
                <a:ext uri="{FF2B5EF4-FFF2-40B4-BE49-F238E27FC236}">
                  <a16:creationId xmlns:a16="http://schemas.microsoft.com/office/drawing/2014/main" id="{651C99D0-6748-5547-7664-91CA5E6B01E5}"/>
                </a:ext>
              </a:extLst>
            </p:cNvPr>
            <p:cNvSpPr/>
            <p:nvPr/>
          </p:nvSpPr>
          <p:spPr>
            <a:xfrm>
              <a:off x="3407637" y="3177732"/>
              <a:ext cx="161144" cy="193936"/>
            </a:xfrm>
            <a:prstGeom prst="roundRect">
              <a:avLst/>
            </a:prstGeom>
            <a:solidFill>
              <a:schemeClr val="accent2"/>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grpSp>
      <p:grpSp>
        <p:nvGrpSpPr>
          <p:cNvPr id="25" name="グループ化 24">
            <a:extLst>
              <a:ext uri="{FF2B5EF4-FFF2-40B4-BE49-F238E27FC236}">
                <a16:creationId xmlns:a16="http://schemas.microsoft.com/office/drawing/2014/main" id="{5E3C1E14-8DFA-BA15-2E3A-7902AC04034A}"/>
              </a:ext>
            </a:extLst>
          </p:cNvPr>
          <p:cNvGrpSpPr/>
          <p:nvPr/>
        </p:nvGrpSpPr>
        <p:grpSpPr>
          <a:xfrm rot="7268607" flipV="1">
            <a:off x="7762296" y="3479538"/>
            <a:ext cx="168821" cy="590174"/>
            <a:chOff x="3906982" y="632098"/>
            <a:chExt cx="274912" cy="961052"/>
          </a:xfrm>
        </p:grpSpPr>
        <p:cxnSp>
          <p:nvCxnSpPr>
            <p:cNvPr id="26" name="直線コネクタ 25">
              <a:extLst>
                <a:ext uri="{FF2B5EF4-FFF2-40B4-BE49-F238E27FC236}">
                  <a16:creationId xmlns:a16="http://schemas.microsoft.com/office/drawing/2014/main" id="{3A6CAB2F-7CEE-E9D4-B80A-ACE9C09E15A5}"/>
                </a:ext>
              </a:extLst>
            </p:cNvPr>
            <p:cNvCxnSpPr>
              <a:cxnSpLocks/>
            </p:cNvCxnSpPr>
            <p:nvPr/>
          </p:nvCxnSpPr>
          <p:spPr>
            <a:xfrm>
              <a:off x="3906982" y="632098"/>
              <a:ext cx="133596" cy="393149"/>
            </a:xfrm>
            <a:prstGeom prst="line">
              <a:avLst/>
            </a:prstGeom>
            <a:ln w="38100">
              <a:solidFill>
                <a:schemeClr val="tx1"/>
              </a:solidFill>
            </a:ln>
          </p:spPr>
          <p:style>
            <a:lnRef idx="1">
              <a:schemeClr val="dk1"/>
            </a:lnRef>
            <a:fillRef idx="0">
              <a:schemeClr val="dk1"/>
            </a:fillRef>
            <a:effectRef idx="0">
              <a:schemeClr val="dk1"/>
            </a:effectRef>
            <a:fontRef idx="minor">
              <a:schemeClr val="tx1"/>
            </a:fontRef>
          </p:style>
        </p:cxnSp>
        <p:cxnSp>
          <p:nvCxnSpPr>
            <p:cNvPr id="27" name="直線コネクタ 26">
              <a:extLst>
                <a:ext uri="{FF2B5EF4-FFF2-40B4-BE49-F238E27FC236}">
                  <a16:creationId xmlns:a16="http://schemas.microsoft.com/office/drawing/2014/main" id="{9C0929CC-A598-40FC-C881-91DA7651069B}"/>
                </a:ext>
              </a:extLst>
            </p:cNvPr>
            <p:cNvCxnSpPr/>
            <p:nvPr/>
          </p:nvCxnSpPr>
          <p:spPr>
            <a:xfrm>
              <a:off x="4044438" y="1007368"/>
              <a:ext cx="0" cy="585782"/>
            </a:xfrm>
            <a:prstGeom prst="line">
              <a:avLst/>
            </a:prstGeom>
            <a:ln w="38100"/>
          </p:spPr>
          <p:style>
            <a:lnRef idx="1">
              <a:schemeClr val="dk1"/>
            </a:lnRef>
            <a:fillRef idx="0">
              <a:schemeClr val="dk1"/>
            </a:fillRef>
            <a:effectRef idx="0">
              <a:schemeClr val="dk1"/>
            </a:effectRef>
            <a:fontRef idx="minor">
              <a:schemeClr val="tx1"/>
            </a:fontRef>
          </p:style>
        </p:cxnSp>
        <p:cxnSp>
          <p:nvCxnSpPr>
            <p:cNvPr id="28" name="直線コネクタ 27">
              <a:extLst>
                <a:ext uri="{FF2B5EF4-FFF2-40B4-BE49-F238E27FC236}">
                  <a16:creationId xmlns:a16="http://schemas.microsoft.com/office/drawing/2014/main" id="{BEFF636C-A170-8F4B-5CBC-DE7066C73825}"/>
                </a:ext>
              </a:extLst>
            </p:cNvPr>
            <p:cNvCxnSpPr>
              <a:cxnSpLocks/>
            </p:cNvCxnSpPr>
            <p:nvPr/>
          </p:nvCxnSpPr>
          <p:spPr>
            <a:xfrm flipH="1">
              <a:off x="4048298" y="632098"/>
              <a:ext cx="133596" cy="393149"/>
            </a:xfrm>
            <a:prstGeom prst="line">
              <a:avLst/>
            </a:prstGeom>
            <a:ln w="38100">
              <a:solidFill>
                <a:schemeClr val="tx1"/>
              </a:solidFill>
            </a:ln>
          </p:spPr>
          <p:style>
            <a:lnRef idx="1">
              <a:schemeClr val="dk1"/>
            </a:lnRef>
            <a:fillRef idx="0">
              <a:schemeClr val="dk1"/>
            </a:fillRef>
            <a:effectRef idx="0">
              <a:schemeClr val="dk1"/>
            </a:effectRef>
            <a:fontRef idx="minor">
              <a:schemeClr val="tx1"/>
            </a:fontRef>
          </p:style>
        </p:cxnSp>
      </p:grpSp>
      <p:sp>
        <p:nvSpPr>
          <p:cNvPr id="29" name="爆発 1 28">
            <a:extLst>
              <a:ext uri="{FF2B5EF4-FFF2-40B4-BE49-F238E27FC236}">
                <a16:creationId xmlns:a16="http://schemas.microsoft.com/office/drawing/2014/main" id="{7C8ED087-C2EE-B7BA-A834-F62C1E359E17}"/>
              </a:ext>
            </a:extLst>
          </p:cNvPr>
          <p:cNvSpPr/>
          <p:nvPr/>
        </p:nvSpPr>
        <p:spPr>
          <a:xfrm>
            <a:off x="7834459" y="3460871"/>
            <a:ext cx="1072283" cy="1224479"/>
          </a:xfrm>
          <a:prstGeom prst="irregularSeal1">
            <a:avLst/>
          </a:prstGeom>
          <a:solidFill>
            <a:srgbClr val="FF2F92"/>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30" name="テキスト ボックス 29">
            <a:extLst>
              <a:ext uri="{FF2B5EF4-FFF2-40B4-BE49-F238E27FC236}">
                <a16:creationId xmlns:a16="http://schemas.microsoft.com/office/drawing/2014/main" id="{E26918DF-5A3D-AA20-95E7-E4676B50B541}"/>
              </a:ext>
            </a:extLst>
          </p:cNvPr>
          <p:cNvSpPr txBox="1"/>
          <p:nvPr/>
        </p:nvSpPr>
        <p:spPr>
          <a:xfrm>
            <a:off x="5724488" y="2643703"/>
            <a:ext cx="1792863" cy="646331"/>
          </a:xfrm>
          <a:prstGeom prst="rect">
            <a:avLst/>
          </a:prstGeom>
          <a:noFill/>
        </p:spPr>
        <p:txBody>
          <a:bodyPr wrap="none" rtlCol="0">
            <a:spAutoFit/>
          </a:bodyPr>
          <a:lstStyle/>
          <a:p>
            <a:r>
              <a:rPr lang="en-US" altLang="ja-JP" b="1" dirty="0">
                <a:latin typeface="Meiryo" panose="020B0604030504040204" pitchFamily="34" charset="-128"/>
                <a:ea typeface="Meiryo" panose="020B0604030504040204" pitchFamily="34" charset="-128"/>
              </a:rPr>
              <a:t>Recombinant</a:t>
            </a:r>
          </a:p>
          <a:p>
            <a:r>
              <a:rPr kumimoji="1" lang="en-US" altLang="ja-JP" b="1" dirty="0">
                <a:latin typeface="Meiryo" panose="020B0604030504040204" pitchFamily="34" charset="-128"/>
                <a:ea typeface="Meiryo" panose="020B0604030504040204" pitchFamily="34" charset="-128"/>
              </a:rPr>
              <a:t>CD26</a:t>
            </a:r>
          </a:p>
        </p:txBody>
      </p:sp>
      <p:sp>
        <p:nvSpPr>
          <p:cNvPr id="31" name="テキスト ボックス 30">
            <a:extLst>
              <a:ext uri="{FF2B5EF4-FFF2-40B4-BE49-F238E27FC236}">
                <a16:creationId xmlns:a16="http://schemas.microsoft.com/office/drawing/2014/main" id="{BCC20762-C6F0-7EB1-0C8A-63CD9CEE4C56}"/>
              </a:ext>
            </a:extLst>
          </p:cNvPr>
          <p:cNvSpPr txBox="1"/>
          <p:nvPr/>
        </p:nvSpPr>
        <p:spPr>
          <a:xfrm>
            <a:off x="8144647" y="4625363"/>
            <a:ext cx="1456553" cy="369332"/>
          </a:xfrm>
          <a:prstGeom prst="rect">
            <a:avLst/>
          </a:prstGeom>
          <a:noFill/>
        </p:spPr>
        <p:txBody>
          <a:bodyPr wrap="none" rtlCol="0">
            <a:spAutoFit/>
          </a:bodyPr>
          <a:lstStyle/>
          <a:p>
            <a:r>
              <a:rPr lang="en-US" altLang="ja-JP" b="1" dirty="0">
                <a:latin typeface="Meiryo" panose="020B0604030504040204" pitchFamily="34" charset="-128"/>
                <a:ea typeface="Meiryo" panose="020B0604030504040204" pitchFamily="34" charset="-128"/>
              </a:rPr>
              <a:t>Anti-Fc Ab</a:t>
            </a:r>
            <a:endParaRPr kumimoji="1" lang="ja-JP" altLang="en-US" b="1">
              <a:latin typeface="Meiryo" panose="020B0604030504040204" pitchFamily="34" charset="-128"/>
              <a:ea typeface="Meiryo" panose="020B0604030504040204" pitchFamily="34" charset="-128"/>
            </a:endParaRPr>
          </a:p>
        </p:txBody>
      </p:sp>
      <p:sp>
        <p:nvSpPr>
          <p:cNvPr id="32" name="テキスト ボックス 31">
            <a:extLst>
              <a:ext uri="{FF2B5EF4-FFF2-40B4-BE49-F238E27FC236}">
                <a16:creationId xmlns:a16="http://schemas.microsoft.com/office/drawing/2014/main" id="{343387DF-D37B-04BF-7704-4E4EFE9860BE}"/>
              </a:ext>
            </a:extLst>
          </p:cNvPr>
          <p:cNvSpPr txBox="1"/>
          <p:nvPr/>
        </p:nvSpPr>
        <p:spPr>
          <a:xfrm>
            <a:off x="2098302" y="3606337"/>
            <a:ext cx="1721946" cy="369332"/>
          </a:xfrm>
          <a:prstGeom prst="rect">
            <a:avLst/>
          </a:prstGeom>
          <a:noFill/>
        </p:spPr>
        <p:txBody>
          <a:bodyPr wrap="none" rtlCol="0">
            <a:spAutoFit/>
          </a:bodyPr>
          <a:lstStyle/>
          <a:p>
            <a:r>
              <a:rPr kumimoji="1" lang="en-US" altLang="ja-JP" b="1" dirty="0">
                <a:latin typeface="Meiryo" panose="020B0604030504040204" pitchFamily="34" charset="-128"/>
                <a:ea typeface="Meiryo" panose="020B0604030504040204" pitchFamily="34" charset="-128"/>
              </a:rPr>
              <a:t>CD26 </a:t>
            </a:r>
            <a:r>
              <a:rPr lang="en-US" altLang="ja-JP" b="1" dirty="0">
                <a:latin typeface="Meiryo" panose="020B0604030504040204" pitchFamily="34" charset="-128"/>
                <a:ea typeface="Meiryo" panose="020B0604030504040204" pitchFamily="34" charset="-128"/>
              </a:rPr>
              <a:t>2G/3G</a:t>
            </a:r>
            <a:endParaRPr kumimoji="1" lang="ja-JP" altLang="en-US" b="1">
              <a:latin typeface="Meiryo" panose="020B0604030504040204" pitchFamily="34" charset="-128"/>
              <a:ea typeface="Meiryo" panose="020B0604030504040204" pitchFamily="34" charset="-128"/>
            </a:endParaRPr>
          </a:p>
        </p:txBody>
      </p:sp>
      <p:sp>
        <p:nvSpPr>
          <p:cNvPr id="33" name="テキスト ボックス 32">
            <a:extLst>
              <a:ext uri="{FF2B5EF4-FFF2-40B4-BE49-F238E27FC236}">
                <a16:creationId xmlns:a16="http://schemas.microsoft.com/office/drawing/2014/main" id="{94D8B6B5-22C7-F941-F36B-4248A1499212}"/>
              </a:ext>
            </a:extLst>
          </p:cNvPr>
          <p:cNvSpPr txBox="1"/>
          <p:nvPr/>
        </p:nvSpPr>
        <p:spPr>
          <a:xfrm>
            <a:off x="8101747" y="3872045"/>
            <a:ext cx="494046" cy="369332"/>
          </a:xfrm>
          <a:prstGeom prst="rect">
            <a:avLst/>
          </a:prstGeom>
          <a:noFill/>
        </p:spPr>
        <p:txBody>
          <a:bodyPr wrap="none" rtlCol="0">
            <a:spAutoFit/>
          </a:bodyPr>
          <a:lstStyle/>
          <a:p>
            <a:r>
              <a:rPr kumimoji="1" lang="en-US" altLang="ja-JP" b="1" dirty="0">
                <a:latin typeface="Meiryo" panose="020B0604030504040204" pitchFamily="34" charset="-128"/>
                <a:ea typeface="Meiryo" panose="020B0604030504040204" pitchFamily="34" charset="-128"/>
              </a:rPr>
              <a:t>PE</a:t>
            </a:r>
            <a:endParaRPr kumimoji="1" lang="ja-JP" altLang="en-US" b="1">
              <a:latin typeface="Meiryo" panose="020B0604030504040204" pitchFamily="34" charset="-128"/>
              <a:ea typeface="Meiryo" panose="020B0604030504040204" pitchFamily="34" charset="-128"/>
            </a:endParaRPr>
          </a:p>
        </p:txBody>
      </p:sp>
      <p:sp>
        <p:nvSpPr>
          <p:cNvPr id="34" name="テキスト ボックス 33">
            <a:extLst>
              <a:ext uri="{FF2B5EF4-FFF2-40B4-BE49-F238E27FC236}">
                <a16:creationId xmlns:a16="http://schemas.microsoft.com/office/drawing/2014/main" id="{C24B4467-9997-9445-F4CC-CE55E2D6757E}"/>
              </a:ext>
            </a:extLst>
          </p:cNvPr>
          <p:cNvSpPr txBox="1"/>
          <p:nvPr/>
        </p:nvSpPr>
        <p:spPr>
          <a:xfrm>
            <a:off x="3661810" y="5025945"/>
            <a:ext cx="665567" cy="369332"/>
          </a:xfrm>
          <a:prstGeom prst="rect">
            <a:avLst/>
          </a:prstGeom>
          <a:noFill/>
        </p:spPr>
        <p:txBody>
          <a:bodyPr wrap="none" rtlCol="0">
            <a:spAutoFit/>
          </a:bodyPr>
          <a:lstStyle/>
          <a:p>
            <a:r>
              <a:rPr kumimoji="1" lang="en-US" altLang="ja-JP" b="1" dirty="0">
                <a:latin typeface="Meiryo" panose="020B0604030504040204" pitchFamily="34" charset="-128"/>
                <a:ea typeface="Meiryo" panose="020B0604030504040204" pitchFamily="34" charset="-128"/>
              </a:rPr>
              <a:t>GFP</a:t>
            </a:r>
            <a:endParaRPr kumimoji="1" lang="ja-JP" altLang="en-US" b="1">
              <a:latin typeface="Meiryo" panose="020B0604030504040204" pitchFamily="34" charset="-128"/>
              <a:ea typeface="Meiryo" panose="020B0604030504040204" pitchFamily="34" charset="-128"/>
            </a:endParaRPr>
          </a:p>
        </p:txBody>
      </p:sp>
      <p:sp>
        <p:nvSpPr>
          <p:cNvPr id="35" name="右矢印 34">
            <a:extLst>
              <a:ext uri="{FF2B5EF4-FFF2-40B4-BE49-F238E27FC236}">
                <a16:creationId xmlns:a16="http://schemas.microsoft.com/office/drawing/2014/main" id="{86B70CE9-9879-7A41-09D3-51AE7FD7E5F2}"/>
              </a:ext>
            </a:extLst>
          </p:cNvPr>
          <p:cNvSpPr/>
          <p:nvPr/>
        </p:nvSpPr>
        <p:spPr>
          <a:xfrm>
            <a:off x="2318902" y="4731967"/>
            <a:ext cx="518225" cy="263047"/>
          </a:xfrm>
          <a:prstGeom prst="rightArrow">
            <a:avLst/>
          </a:prstGeom>
          <a:no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36" name="右矢印 35">
            <a:extLst>
              <a:ext uri="{FF2B5EF4-FFF2-40B4-BE49-F238E27FC236}">
                <a16:creationId xmlns:a16="http://schemas.microsoft.com/office/drawing/2014/main" id="{0BAE4F1F-9ED1-A121-79FC-25E7C3EBCD57}"/>
              </a:ext>
            </a:extLst>
          </p:cNvPr>
          <p:cNvSpPr/>
          <p:nvPr/>
        </p:nvSpPr>
        <p:spPr>
          <a:xfrm>
            <a:off x="5166202" y="4731967"/>
            <a:ext cx="518225" cy="263047"/>
          </a:xfrm>
          <a:prstGeom prst="rightArrow">
            <a:avLst/>
          </a:prstGeom>
          <a:no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37" name="爆発 1 36">
            <a:extLst>
              <a:ext uri="{FF2B5EF4-FFF2-40B4-BE49-F238E27FC236}">
                <a16:creationId xmlns:a16="http://schemas.microsoft.com/office/drawing/2014/main" id="{51F9C661-91C6-2E9C-7E51-98F9F74EF82B}"/>
              </a:ext>
            </a:extLst>
          </p:cNvPr>
          <p:cNvSpPr/>
          <p:nvPr/>
        </p:nvSpPr>
        <p:spPr>
          <a:xfrm>
            <a:off x="2689155" y="6705018"/>
            <a:ext cx="1398948" cy="1597510"/>
          </a:xfrm>
          <a:prstGeom prst="irregularSeal1">
            <a:avLst/>
          </a:prstGeom>
          <a:solidFill>
            <a:srgbClr val="00FA00"/>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38" name="円/楕円 37">
            <a:extLst>
              <a:ext uri="{FF2B5EF4-FFF2-40B4-BE49-F238E27FC236}">
                <a16:creationId xmlns:a16="http://schemas.microsoft.com/office/drawing/2014/main" id="{E427442B-9C37-853C-BC78-EBC9BF8F8D32}"/>
              </a:ext>
            </a:extLst>
          </p:cNvPr>
          <p:cNvSpPr/>
          <p:nvPr/>
        </p:nvSpPr>
        <p:spPr>
          <a:xfrm>
            <a:off x="2824678" y="6950034"/>
            <a:ext cx="1100755" cy="1100755"/>
          </a:xfrm>
          <a:prstGeom prst="ellipse">
            <a:avLst/>
          </a:prstGeom>
          <a:solidFill>
            <a:srgbClr val="00FA00"/>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cxnSp>
        <p:nvCxnSpPr>
          <p:cNvPr id="39" name="直線コネクタ 38">
            <a:extLst>
              <a:ext uri="{FF2B5EF4-FFF2-40B4-BE49-F238E27FC236}">
                <a16:creationId xmlns:a16="http://schemas.microsoft.com/office/drawing/2014/main" id="{8ACBEC42-2DAC-15E7-12DB-E179404FAC0B}"/>
              </a:ext>
            </a:extLst>
          </p:cNvPr>
          <p:cNvCxnSpPr>
            <a:cxnSpLocks/>
          </p:cNvCxnSpPr>
          <p:nvPr/>
        </p:nvCxnSpPr>
        <p:spPr>
          <a:xfrm flipV="1">
            <a:off x="3378810" y="6869275"/>
            <a:ext cx="1" cy="151220"/>
          </a:xfrm>
          <a:prstGeom prst="line">
            <a:avLst/>
          </a:prstGeom>
          <a:ln w="19050"/>
        </p:spPr>
        <p:style>
          <a:lnRef idx="1">
            <a:schemeClr val="dk1"/>
          </a:lnRef>
          <a:fillRef idx="0">
            <a:schemeClr val="dk1"/>
          </a:fillRef>
          <a:effectRef idx="0">
            <a:schemeClr val="dk1"/>
          </a:effectRef>
          <a:fontRef idx="minor">
            <a:schemeClr val="tx1"/>
          </a:fontRef>
        </p:style>
      </p:cxnSp>
      <p:sp>
        <p:nvSpPr>
          <p:cNvPr id="40" name="円/楕円 39">
            <a:extLst>
              <a:ext uri="{FF2B5EF4-FFF2-40B4-BE49-F238E27FC236}">
                <a16:creationId xmlns:a16="http://schemas.microsoft.com/office/drawing/2014/main" id="{2AA9314F-EE00-1763-0366-443A060896DE}"/>
              </a:ext>
            </a:extLst>
          </p:cNvPr>
          <p:cNvSpPr/>
          <p:nvPr/>
        </p:nvSpPr>
        <p:spPr>
          <a:xfrm>
            <a:off x="3324761" y="6975912"/>
            <a:ext cx="108099" cy="108099"/>
          </a:xfrm>
          <a:prstGeom prst="ellipse">
            <a:avLst/>
          </a:prstGeom>
          <a:solidFill>
            <a:schemeClr val="accent3"/>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41" name="角丸四角形 40">
            <a:extLst>
              <a:ext uri="{FF2B5EF4-FFF2-40B4-BE49-F238E27FC236}">
                <a16:creationId xmlns:a16="http://schemas.microsoft.com/office/drawing/2014/main" id="{194A4690-740F-454E-2929-2D316059A5DB}"/>
              </a:ext>
            </a:extLst>
          </p:cNvPr>
          <p:cNvSpPr/>
          <p:nvPr/>
        </p:nvSpPr>
        <p:spPr>
          <a:xfrm>
            <a:off x="3324761" y="7084093"/>
            <a:ext cx="108099" cy="130096"/>
          </a:xfrm>
          <a:prstGeom prst="roundRect">
            <a:avLst/>
          </a:prstGeom>
          <a:solidFill>
            <a:schemeClr val="accent2"/>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42" name="円/楕円 41">
            <a:extLst>
              <a:ext uri="{FF2B5EF4-FFF2-40B4-BE49-F238E27FC236}">
                <a16:creationId xmlns:a16="http://schemas.microsoft.com/office/drawing/2014/main" id="{ED603EB9-5A98-E681-2438-1CE3081C0BFD}"/>
              </a:ext>
            </a:extLst>
          </p:cNvPr>
          <p:cNvSpPr/>
          <p:nvPr/>
        </p:nvSpPr>
        <p:spPr>
          <a:xfrm rot="5400000">
            <a:off x="3164362" y="6480653"/>
            <a:ext cx="439567" cy="349507"/>
          </a:xfrm>
          <a:prstGeom prst="ellipse">
            <a:avLst/>
          </a:prstGeom>
          <a:solidFill>
            <a:schemeClr val="accent1">
              <a:lumMod val="60000"/>
              <a:lumOff val="40000"/>
            </a:schemeClr>
          </a:solidFill>
          <a:ln>
            <a:no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43" name="テキスト ボックス 42">
            <a:extLst>
              <a:ext uri="{FF2B5EF4-FFF2-40B4-BE49-F238E27FC236}">
                <a16:creationId xmlns:a16="http://schemas.microsoft.com/office/drawing/2014/main" id="{3E5A3FB7-BF5A-565B-58BB-B3C8DC7AB654}"/>
              </a:ext>
            </a:extLst>
          </p:cNvPr>
          <p:cNvSpPr txBox="1"/>
          <p:nvPr/>
        </p:nvSpPr>
        <p:spPr>
          <a:xfrm>
            <a:off x="1926138" y="6620747"/>
            <a:ext cx="1260281" cy="307777"/>
          </a:xfrm>
          <a:prstGeom prst="rect">
            <a:avLst/>
          </a:prstGeom>
          <a:noFill/>
        </p:spPr>
        <p:txBody>
          <a:bodyPr wrap="none" rtlCol="0">
            <a:spAutoFit/>
          </a:bodyPr>
          <a:lstStyle/>
          <a:p>
            <a:r>
              <a:rPr kumimoji="1" lang="en-US" altLang="ja-JP" sz="1400" b="1" dirty="0">
                <a:latin typeface="Meiryo" panose="020B0604030504040204" pitchFamily="34" charset="-128"/>
                <a:ea typeface="Meiryo" panose="020B0604030504040204" pitchFamily="34" charset="-128"/>
              </a:rPr>
              <a:t>CD8 </a:t>
            </a:r>
            <a:r>
              <a:rPr lang="en-US" altLang="ja-JP" sz="1400" b="1" dirty="0">
                <a:latin typeface="Meiryo" panose="020B0604030504040204" pitchFamily="34" charset="-128"/>
                <a:ea typeface="Meiryo" panose="020B0604030504040204" pitchFamily="34" charset="-128"/>
              </a:rPr>
              <a:t>2G/3G</a:t>
            </a:r>
            <a:endParaRPr kumimoji="1" lang="ja-JP" altLang="en-US" sz="1400" b="1">
              <a:latin typeface="Meiryo" panose="020B0604030504040204" pitchFamily="34" charset="-128"/>
              <a:ea typeface="Meiryo" panose="020B0604030504040204" pitchFamily="34" charset="-128"/>
            </a:endParaRPr>
          </a:p>
        </p:txBody>
      </p:sp>
      <p:sp>
        <p:nvSpPr>
          <p:cNvPr id="44" name="テキスト ボックス 43">
            <a:extLst>
              <a:ext uri="{FF2B5EF4-FFF2-40B4-BE49-F238E27FC236}">
                <a16:creationId xmlns:a16="http://schemas.microsoft.com/office/drawing/2014/main" id="{00F88788-85C7-FDF8-47A0-974B41A79D67}"/>
              </a:ext>
            </a:extLst>
          </p:cNvPr>
          <p:cNvSpPr txBox="1"/>
          <p:nvPr/>
        </p:nvSpPr>
        <p:spPr>
          <a:xfrm>
            <a:off x="3164805" y="7576766"/>
            <a:ext cx="558166" cy="307777"/>
          </a:xfrm>
          <a:prstGeom prst="rect">
            <a:avLst/>
          </a:prstGeom>
          <a:noFill/>
        </p:spPr>
        <p:txBody>
          <a:bodyPr wrap="none" rtlCol="0">
            <a:spAutoFit/>
          </a:bodyPr>
          <a:lstStyle/>
          <a:p>
            <a:r>
              <a:rPr kumimoji="1" lang="en-US" altLang="ja-JP" sz="1400" b="1" dirty="0">
                <a:latin typeface="Meiryo" panose="020B0604030504040204" pitchFamily="34" charset="-128"/>
                <a:ea typeface="Meiryo" panose="020B0604030504040204" pitchFamily="34" charset="-128"/>
              </a:rPr>
              <a:t>GFP</a:t>
            </a:r>
            <a:endParaRPr kumimoji="1" lang="ja-JP" altLang="en-US" sz="1400" b="1">
              <a:latin typeface="Meiryo" panose="020B0604030504040204" pitchFamily="34" charset="-128"/>
              <a:ea typeface="Meiryo" panose="020B0604030504040204" pitchFamily="34" charset="-128"/>
            </a:endParaRPr>
          </a:p>
        </p:txBody>
      </p:sp>
      <p:sp>
        <p:nvSpPr>
          <p:cNvPr id="45" name="右矢印 44">
            <a:extLst>
              <a:ext uri="{FF2B5EF4-FFF2-40B4-BE49-F238E27FC236}">
                <a16:creationId xmlns:a16="http://schemas.microsoft.com/office/drawing/2014/main" id="{A8436666-8D82-2C10-7D29-05BB61C3181C}"/>
              </a:ext>
            </a:extLst>
          </p:cNvPr>
          <p:cNvSpPr/>
          <p:nvPr/>
        </p:nvSpPr>
        <p:spPr>
          <a:xfrm rot="2768904">
            <a:off x="2014460" y="6252083"/>
            <a:ext cx="347636" cy="176457"/>
          </a:xfrm>
          <a:prstGeom prst="rightArrow">
            <a:avLst/>
          </a:prstGeom>
          <a:no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a:p>
        </p:txBody>
      </p:sp>
      <p:sp>
        <p:nvSpPr>
          <p:cNvPr id="46" name="三角形 45">
            <a:extLst>
              <a:ext uri="{FF2B5EF4-FFF2-40B4-BE49-F238E27FC236}">
                <a16:creationId xmlns:a16="http://schemas.microsoft.com/office/drawing/2014/main" id="{49A129FB-F4D8-0D49-3033-E514B6F51DED}"/>
              </a:ext>
            </a:extLst>
          </p:cNvPr>
          <p:cNvSpPr/>
          <p:nvPr/>
        </p:nvSpPr>
        <p:spPr>
          <a:xfrm rot="7061588">
            <a:off x="7440827" y="3443763"/>
            <a:ext cx="155402" cy="297830"/>
          </a:xfrm>
          <a:prstGeom prst="triangle">
            <a:avLst/>
          </a:prstGeom>
          <a:solidFill>
            <a:srgbClr val="8064A2">
              <a:lumMod val="60000"/>
              <a:lumOff val="40000"/>
            </a:srgbClr>
          </a:solidFill>
          <a:ln w="25400" cap="flat" cmpd="sng" algn="ctr">
            <a:noFill/>
            <a:prstDash val="solid"/>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latin typeface="Calibri"/>
              <a:ea typeface="ＭＳ Ｐゴシック" panose="020B0600070205080204" pitchFamily="34" charset="-128"/>
              <a:cs typeface="+mn-cs"/>
            </a:endParaRPr>
          </a:p>
        </p:txBody>
      </p:sp>
      <p:sp>
        <p:nvSpPr>
          <p:cNvPr id="47" name="テキスト ボックス 46">
            <a:extLst>
              <a:ext uri="{FF2B5EF4-FFF2-40B4-BE49-F238E27FC236}">
                <a16:creationId xmlns:a16="http://schemas.microsoft.com/office/drawing/2014/main" id="{F99FF946-7F3B-F09E-22BB-C712B2858558}"/>
              </a:ext>
            </a:extLst>
          </p:cNvPr>
          <p:cNvSpPr txBox="1"/>
          <p:nvPr/>
        </p:nvSpPr>
        <p:spPr>
          <a:xfrm>
            <a:off x="7375136" y="3120366"/>
            <a:ext cx="1183529" cy="369332"/>
          </a:xfrm>
          <a:prstGeom prst="rect">
            <a:avLst/>
          </a:prstGeom>
          <a:noFill/>
        </p:spPr>
        <p:txBody>
          <a:bodyPr wrap="none" rtlCol="0">
            <a:spAutoFit/>
          </a:bodyPr>
          <a:lstStyle/>
          <a:p>
            <a:pPr defTabSz="457200"/>
            <a:r>
              <a:rPr lang="en-US" altLang="ja-JP" b="1" dirty="0">
                <a:latin typeface="Meiryo" panose="020B0604030504040204" pitchFamily="34" charset="-128"/>
                <a:ea typeface="Meiryo" panose="020B0604030504040204" pitchFamily="34" charset="-128"/>
              </a:rPr>
              <a:t>Tag (Fc)</a:t>
            </a:r>
            <a:endParaRPr lang="ja-JP" altLang="en-US" b="1">
              <a:latin typeface="Meiryo" panose="020B0604030504040204" pitchFamily="34" charset="-128"/>
              <a:ea typeface="Meiryo" panose="020B0604030504040204" pitchFamily="34" charset="-128"/>
            </a:endParaRPr>
          </a:p>
        </p:txBody>
      </p:sp>
      <p:sp>
        <p:nvSpPr>
          <p:cNvPr id="48" name="テキスト ボックス 47">
            <a:extLst>
              <a:ext uri="{FF2B5EF4-FFF2-40B4-BE49-F238E27FC236}">
                <a16:creationId xmlns:a16="http://schemas.microsoft.com/office/drawing/2014/main" id="{BE21E35F-D854-1CB8-EDE6-ADAE72C75DAF}"/>
              </a:ext>
            </a:extLst>
          </p:cNvPr>
          <p:cNvSpPr txBox="1"/>
          <p:nvPr/>
        </p:nvSpPr>
        <p:spPr>
          <a:xfrm>
            <a:off x="3299397" y="3070301"/>
            <a:ext cx="1582484" cy="369332"/>
          </a:xfrm>
          <a:prstGeom prst="rect">
            <a:avLst/>
          </a:prstGeom>
          <a:noFill/>
        </p:spPr>
        <p:txBody>
          <a:bodyPr wrap="none" rtlCol="0">
            <a:spAutoFit/>
          </a:bodyPr>
          <a:lstStyle/>
          <a:p>
            <a:r>
              <a:rPr kumimoji="1" lang="en-US" altLang="ja-JP" b="1" dirty="0">
                <a:latin typeface="Meiryo" panose="020B0604030504040204" pitchFamily="34" charset="-128"/>
                <a:ea typeface="Meiryo" panose="020B0604030504040204" pitchFamily="34" charset="-128"/>
              </a:rPr>
              <a:t>YS110 </a:t>
            </a:r>
            <a:r>
              <a:rPr kumimoji="1" lang="en-US" altLang="ja-JP" b="1" dirty="0" err="1">
                <a:latin typeface="Meiryo" panose="020B0604030504040204" pitchFamily="34" charset="-128"/>
                <a:ea typeface="Meiryo" panose="020B0604030504040204" pitchFamily="34" charset="-128"/>
              </a:rPr>
              <a:t>scFv</a:t>
            </a:r>
            <a:endParaRPr kumimoji="1" lang="ja-JP" altLang="en-US" b="1">
              <a:latin typeface="Meiryo" panose="020B0604030504040204" pitchFamily="34" charset="-128"/>
              <a:ea typeface="Meiryo" panose="020B0604030504040204" pitchFamily="34" charset="-128"/>
            </a:endParaRPr>
          </a:p>
        </p:txBody>
      </p:sp>
      <p:sp>
        <p:nvSpPr>
          <p:cNvPr id="49" name="テキスト ボックス 48">
            <a:extLst>
              <a:ext uri="{FF2B5EF4-FFF2-40B4-BE49-F238E27FC236}">
                <a16:creationId xmlns:a16="http://schemas.microsoft.com/office/drawing/2014/main" id="{1E0923DB-4532-114B-4730-4D835235266A}"/>
              </a:ext>
            </a:extLst>
          </p:cNvPr>
          <p:cNvSpPr txBox="1"/>
          <p:nvPr/>
        </p:nvSpPr>
        <p:spPr>
          <a:xfrm>
            <a:off x="2855372" y="6181828"/>
            <a:ext cx="57099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Meiryo" panose="020B0604030504040204" pitchFamily="34" charset="-128"/>
                <a:ea typeface="Meiryo" panose="020B0604030504040204" pitchFamily="34" charset="-128"/>
                <a:cs typeface="+mn-cs"/>
              </a:rPr>
              <a:t>CD8</a:t>
            </a:r>
            <a:endParaRPr kumimoji="1" lang="ja-JP" altLang="en-US" sz="1400" b="1" i="0" u="none" strike="noStrike" kern="1200" cap="none" spc="0" normalizeH="0" baseline="0" noProof="0">
              <a:ln>
                <a:noFill/>
              </a:ln>
              <a:solidFill>
                <a:prstClr val="black"/>
              </a:solidFill>
              <a:effectLst/>
              <a:uLnTx/>
              <a:uFillTx/>
              <a:latin typeface="Meiryo" panose="020B0604030504040204" pitchFamily="34" charset="-128"/>
              <a:ea typeface="Meiryo" panose="020B0604030504040204" pitchFamily="34" charset="-128"/>
              <a:cs typeface="+mn-cs"/>
            </a:endParaRPr>
          </a:p>
        </p:txBody>
      </p:sp>
      <p:grpSp>
        <p:nvGrpSpPr>
          <p:cNvPr id="50" name="グループ化 49">
            <a:extLst>
              <a:ext uri="{FF2B5EF4-FFF2-40B4-BE49-F238E27FC236}">
                <a16:creationId xmlns:a16="http://schemas.microsoft.com/office/drawing/2014/main" id="{9A4D597A-DEC1-6F47-6AC4-07DF0A55A294}"/>
              </a:ext>
            </a:extLst>
          </p:cNvPr>
          <p:cNvGrpSpPr/>
          <p:nvPr/>
        </p:nvGrpSpPr>
        <p:grpSpPr>
          <a:xfrm rot="16200000">
            <a:off x="3728707" y="6424030"/>
            <a:ext cx="112158" cy="392089"/>
            <a:chOff x="3906982" y="632098"/>
            <a:chExt cx="274912" cy="961052"/>
          </a:xfrm>
        </p:grpSpPr>
        <p:cxnSp>
          <p:nvCxnSpPr>
            <p:cNvPr id="51" name="直線コネクタ 50">
              <a:extLst>
                <a:ext uri="{FF2B5EF4-FFF2-40B4-BE49-F238E27FC236}">
                  <a16:creationId xmlns:a16="http://schemas.microsoft.com/office/drawing/2014/main" id="{C427AC46-5DFE-56A3-1810-90808C8380D1}"/>
                </a:ext>
              </a:extLst>
            </p:cNvPr>
            <p:cNvCxnSpPr>
              <a:cxnSpLocks/>
            </p:cNvCxnSpPr>
            <p:nvPr/>
          </p:nvCxnSpPr>
          <p:spPr>
            <a:xfrm>
              <a:off x="3906982" y="632098"/>
              <a:ext cx="133596" cy="393149"/>
            </a:xfrm>
            <a:prstGeom prst="line">
              <a:avLst/>
            </a:prstGeom>
            <a:ln w="38100">
              <a:solidFill>
                <a:schemeClr val="tx1"/>
              </a:solidFill>
            </a:ln>
          </p:spPr>
          <p:style>
            <a:lnRef idx="1">
              <a:schemeClr val="dk1"/>
            </a:lnRef>
            <a:fillRef idx="0">
              <a:schemeClr val="dk1"/>
            </a:fillRef>
            <a:effectRef idx="0">
              <a:schemeClr val="dk1"/>
            </a:effectRef>
            <a:fontRef idx="minor">
              <a:schemeClr val="tx1"/>
            </a:fontRef>
          </p:style>
        </p:cxnSp>
        <p:cxnSp>
          <p:nvCxnSpPr>
            <p:cNvPr id="52" name="直線コネクタ 51">
              <a:extLst>
                <a:ext uri="{FF2B5EF4-FFF2-40B4-BE49-F238E27FC236}">
                  <a16:creationId xmlns:a16="http://schemas.microsoft.com/office/drawing/2014/main" id="{F33E12B8-A221-4F9E-DA80-2BE2259A8331}"/>
                </a:ext>
              </a:extLst>
            </p:cNvPr>
            <p:cNvCxnSpPr/>
            <p:nvPr/>
          </p:nvCxnSpPr>
          <p:spPr>
            <a:xfrm>
              <a:off x="4044438" y="1007368"/>
              <a:ext cx="0" cy="585782"/>
            </a:xfrm>
            <a:prstGeom prst="line">
              <a:avLst/>
            </a:prstGeom>
            <a:ln w="38100"/>
          </p:spPr>
          <p:style>
            <a:lnRef idx="1">
              <a:schemeClr val="dk1"/>
            </a:lnRef>
            <a:fillRef idx="0">
              <a:schemeClr val="dk1"/>
            </a:fillRef>
            <a:effectRef idx="0">
              <a:schemeClr val="dk1"/>
            </a:effectRef>
            <a:fontRef idx="minor">
              <a:schemeClr val="tx1"/>
            </a:fontRef>
          </p:style>
        </p:cxnSp>
        <p:cxnSp>
          <p:nvCxnSpPr>
            <p:cNvPr id="53" name="直線コネクタ 52">
              <a:extLst>
                <a:ext uri="{FF2B5EF4-FFF2-40B4-BE49-F238E27FC236}">
                  <a16:creationId xmlns:a16="http://schemas.microsoft.com/office/drawing/2014/main" id="{EFE4AD70-DA9B-84AE-9828-03D15E5BACAC}"/>
                </a:ext>
              </a:extLst>
            </p:cNvPr>
            <p:cNvCxnSpPr>
              <a:cxnSpLocks/>
            </p:cNvCxnSpPr>
            <p:nvPr/>
          </p:nvCxnSpPr>
          <p:spPr>
            <a:xfrm flipH="1">
              <a:off x="4048298" y="632098"/>
              <a:ext cx="133596" cy="393149"/>
            </a:xfrm>
            <a:prstGeom prst="line">
              <a:avLst/>
            </a:prstGeom>
            <a:ln w="38100">
              <a:solidFill>
                <a:schemeClr val="tx1"/>
              </a:solidFill>
            </a:ln>
          </p:spPr>
          <p:style>
            <a:lnRef idx="1">
              <a:schemeClr val="dk1"/>
            </a:lnRef>
            <a:fillRef idx="0">
              <a:schemeClr val="dk1"/>
            </a:fillRef>
            <a:effectRef idx="0">
              <a:schemeClr val="dk1"/>
            </a:effectRef>
            <a:fontRef idx="minor">
              <a:schemeClr val="tx1"/>
            </a:fontRef>
          </p:style>
        </p:cxnSp>
      </p:grpSp>
      <p:sp>
        <p:nvSpPr>
          <p:cNvPr id="54" name="爆発 1 53">
            <a:extLst>
              <a:ext uri="{FF2B5EF4-FFF2-40B4-BE49-F238E27FC236}">
                <a16:creationId xmlns:a16="http://schemas.microsoft.com/office/drawing/2014/main" id="{CFDC95EF-C13E-A674-05AC-814899662BE8}"/>
              </a:ext>
            </a:extLst>
          </p:cNvPr>
          <p:cNvSpPr/>
          <p:nvPr/>
        </p:nvSpPr>
        <p:spPr>
          <a:xfrm>
            <a:off x="3839808" y="6224189"/>
            <a:ext cx="712383" cy="813497"/>
          </a:xfrm>
          <a:prstGeom prst="irregularSeal1">
            <a:avLst/>
          </a:prstGeom>
          <a:solidFill>
            <a:srgbClr val="FF2F92"/>
          </a:solidFill>
          <a:ln>
            <a:no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55" name="テキスト ボックス 54">
            <a:extLst>
              <a:ext uri="{FF2B5EF4-FFF2-40B4-BE49-F238E27FC236}">
                <a16:creationId xmlns:a16="http://schemas.microsoft.com/office/drawing/2014/main" id="{774E5F2D-2F5B-E6F2-4251-4FC6E2A9750F}"/>
              </a:ext>
            </a:extLst>
          </p:cNvPr>
          <p:cNvSpPr txBox="1"/>
          <p:nvPr/>
        </p:nvSpPr>
        <p:spPr>
          <a:xfrm>
            <a:off x="4206692" y="6952917"/>
            <a:ext cx="147773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400" b="1" dirty="0">
                <a:solidFill>
                  <a:prstClr val="black"/>
                </a:solidFill>
                <a:latin typeface="Meiryo" panose="020B0604030504040204" pitchFamily="34" charset="-128"/>
                <a:ea typeface="Meiryo" panose="020B0604030504040204" pitchFamily="34" charset="-128"/>
              </a:rPr>
              <a:t>Anti-</a:t>
            </a:r>
            <a:r>
              <a:rPr kumimoji="1" lang="en-US" altLang="ja-JP" sz="1400" b="1" i="0" u="none" strike="noStrike" kern="1200" cap="none" spc="0" normalizeH="0" baseline="0" noProof="0" dirty="0">
                <a:ln>
                  <a:noFill/>
                </a:ln>
                <a:solidFill>
                  <a:prstClr val="black"/>
                </a:solidFill>
                <a:effectLst/>
                <a:uLnTx/>
                <a:uFillTx/>
                <a:latin typeface="Meiryo" panose="020B0604030504040204" pitchFamily="34" charset="-128"/>
                <a:ea typeface="Meiryo" panose="020B0604030504040204" pitchFamily="34" charset="-128"/>
                <a:cs typeface="+mn-cs"/>
              </a:rPr>
              <a:t>CD8 Ab</a:t>
            </a:r>
            <a:endParaRPr kumimoji="1" lang="ja-JP" altLang="en-US" sz="1400" b="1" i="0" u="none" strike="noStrike" kern="1200" cap="none" spc="0" normalizeH="0" baseline="0" noProof="0">
              <a:ln>
                <a:noFill/>
              </a:ln>
              <a:solidFill>
                <a:prstClr val="black"/>
              </a:solidFill>
              <a:effectLst/>
              <a:uLnTx/>
              <a:uFillTx/>
              <a:latin typeface="Meiryo" panose="020B0604030504040204" pitchFamily="34" charset="-128"/>
              <a:ea typeface="Meiryo" panose="020B0604030504040204" pitchFamily="34" charset="-128"/>
              <a:cs typeface="+mn-cs"/>
            </a:endParaRPr>
          </a:p>
        </p:txBody>
      </p:sp>
      <p:sp>
        <p:nvSpPr>
          <p:cNvPr id="56" name="テキスト ボックス 55">
            <a:extLst>
              <a:ext uri="{FF2B5EF4-FFF2-40B4-BE49-F238E27FC236}">
                <a16:creationId xmlns:a16="http://schemas.microsoft.com/office/drawing/2014/main" id="{4A1A2943-E251-9102-3E87-1438E28317AE}"/>
              </a:ext>
            </a:extLst>
          </p:cNvPr>
          <p:cNvSpPr txBox="1"/>
          <p:nvPr/>
        </p:nvSpPr>
        <p:spPr>
          <a:xfrm>
            <a:off x="3976579" y="6486395"/>
            <a:ext cx="425116"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Meiryo" panose="020B0604030504040204" pitchFamily="34" charset="-128"/>
                <a:ea typeface="Meiryo" panose="020B0604030504040204" pitchFamily="34" charset="-128"/>
                <a:cs typeface="+mn-cs"/>
              </a:rPr>
              <a:t>PE</a:t>
            </a:r>
            <a:endParaRPr kumimoji="1" lang="ja-JP" altLang="en-US" sz="1400" b="1" i="0" u="none" strike="noStrike" kern="1200" cap="none" spc="0" normalizeH="0" baseline="0" noProof="0">
              <a:ln>
                <a:noFill/>
              </a:ln>
              <a:solidFill>
                <a:prstClr val="black"/>
              </a:solidFill>
              <a:effectLst/>
              <a:uLnTx/>
              <a:uFillTx/>
              <a:latin typeface="Meiryo" panose="020B0604030504040204" pitchFamily="34" charset="-128"/>
              <a:ea typeface="Meiryo" panose="020B0604030504040204" pitchFamily="34" charset="-128"/>
              <a:cs typeface="+mn-cs"/>
            </a:endParaRPr>
          </a:p>
        </p:txBody>
      </p:sp>
      <p:sp>
        <p:nvSpPr>
          <p:cNvPr id="57" name="テキスト ボックス 56">
            <a:extLst>
              <a:ext uri="{FF2B5EF4-FFF2-40B4-BE49-F238E27FC236}">
                <a16:creationId xmlns:a16="http://schemas.microsoft.com/office/drawing/2014/main" id="{62BB8C04-B198-E260-EDDE-0037D2F240FD}"/>
              </a:ext>
            </a:extLst>
          </p:cNvPr>
          <p:cNvSpPr txBox="1"/>
          <p:nvPr/>
        </p:nvSpPr>
        <p:spPr>
          <a:xfrm>
            <a:off x="588183" y="8471705"/>
            <a:ext cx="7094096" cy="276999"/>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Arial" panose="020B0604020202020204" pitchFamily="34" charset="0"/>
              </a:rPr>
              <a:t>Figure S1: </a:t>
            </a:r>
            <a:r>
              <a:rPr lang="en-US" altLang="ja-JP" sz="1200" b="1" dirty="0">
                <a:solidFill>
                  <a:srgbClr val="000000"/>
                </a:solidFill>
                <a:latin typeface="Arial" panose="020B0604020202020204" pitchFamily="34" charset="0"/>
                <a:ea typeface="ＭＳ 明朝" panose="02020609040205080304" pitchFamily="49" charset="-128"/>
                <a:cs typeface="Arial" panose="020B0604020202020204" pitchFamily="34" charset="0"/>
              </a:rPr>
              <a:t>S</a:t>
            </a:r>
            <a:r>
              <a:rPr lang="en-US" altLang="ja-JP" sz="1200" b="1" dirty="0">
                <a:solidFill>
                  <a:srgbClr val="000000"/>
                </a:solidFill>
                <a:effectLst/>
                <a:latin typeface="Arial" panose="020B0604020202020204" pitchFamily="34" charset="0"/>
                <a:ea typeface="ＭＳ 明朝" panose="02020609040205080304" pitchFamily="49" charset="-128"/>
                <a:cs typeface="Arial" panose="020B0604020202020204" pitchFamily="34" charset="0"/>
              </a:rPr>
              <a:t>chematic diagram describing the</a:t>
            </a:r>
            <a:r>
              <a:rPr lang="en-US" altLang="ja-JP" sz="1200" b="1" dirty="0">
                <a:solidFill>
                  <a:srgbClr val="000000"/>
                </a:solidFill>
                <a:latin typeface="Arial" panose="020B0604020202020204" pitchFamily="34" charset="0"/>
                <a:ea typeface="ＭＳ 明朝" panose="02020609040205080304" pitchFamily="49" charset="-128"/>
                <a:cs typeface="Arial" panose="020B0604020202020204" pitchFamily="34" charset="0"/>
              </a:rPr>
              <a:t> method </a:t>
            </a:r>
            <a:r>
              <a:rPr lang="en-US" altLang="ja-JP" sz="1200" b="1" dirty="0">
                <a:solidFill>
                  <a:srgbClr val="000000"/>
                </a:solidFill>
                <a:effectLst/>
                <a:latin typeface="Arial" panose="020B0604020202020204" pitchFamily="34" charset="0"/>
                <a:ea typeface="ＭＳ 明朝" panose="02020609040205080304" pitchFamily="49" charset="-128"/>
                <a:cs typeface="Arial" panose="020B0604020202020204" pitchFamily="34" charset="0"/>
              </a:rPr>
              <a:t>to detect expression of YS110 </a:t>
            </a:r>
            <a:r>
              <a:rPr lang="en-US" altLang="ja-JP" sz="1200" b="1" dirty="0" err="1">
                <a:solidFill>
                  <a:srgbClr val="000000"/>
                </a:solidFill>
                <a:effectLst/>
                <a:latin typeface="Arial" panose="020B0604020202020204" pitchFamily="34" charset="0"/>
                <a:ea typeface="ＭＳ 明朝" panose="02020609040205080304" pitchFamily="49" charset="-128"/>
                <a:cs typeface="Arial" panose="020B0604020202020204" pitchFamily="34" charset="0"/>
              </a:rPr>
              <a:t>scFv</a:t>
            </a:r>
            <a:r>
              <a:rPr lang="en-US" altLang="ja-JP" sz="1200" b="1" dirty="0">
                <a:solidFill>
                  <a:srgbClr val="000000"/>
                </a:solidFill>
                <a:latin typeface="Arial" panose="020B0604020202020204" pitchFamily="34" charset="0"/>
                <a:ea typeface="ＭＳ 明朝" panose="02020609040205080304" pitchFamily="49" charset="-128"/>
                <a:cs typeface="Arial" panose="020B0604020202020204" pitchFamily="34" charset="0"/>
              </a:rPr>
              <a:t>.</a:t>
            </a:r>
            <a:r>
              <a:rPr lang="en-US" altLang="ja-JP" sz="1200" dirty="0">
                <a:solidFill>
                  <a:srgbClr val="000000"/>
                </a:solidFill>
                <a:effectLst/>
                <a:latin typeface="Arial" panose="020B0604020202020204" pitchFamily="34" charset="0"/>
                <a:ea typeface="ＭＳ 明朝" panose="02020609040205080304" pitchFamily="49" charset="-128"/>
                <a:cs typeface="Arial" panose="020B0604020202020204" pitchFamily="34" charset="0"/>
              </a:rPr>
              <a:t> </a:t>
            </a:r>
            <a:endParaRPr lang="ja-JP" altLang="ja-JP" sz="1200">
              <a:effectLst/>
              <a:latin typeface="Arial" panose="020B0604020202020204" pitchFamily="34" charset="0"/>
              <a:ea typeface="ＭＳ Ｐゴシック" panose="020B0600070205080204" pitchFamily="34" charset="-128"/>
              <a:cs typeface="Arial" panose="020B0604020202020204" pitchFamily="34" charset="0"/>
            </a:endParaRPr>
          </a:p>
        </p:txBody>
      </p:sp>
    </p:spTree>
    <p:extLst>
      <p:ext uri="{BB962C8B-B14F-4D97-AF65-F5344CB8AC3E}">
        <p14:creationId xmlns:p14="http://schemas.microsoft.com/office/powerpoint/2010/main" val="2394948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 name="TextBox 48">
            <a:extLst>
              <a:ext uri="{FF2B5EF4-FFF2-40B4-BE49-F238E27FC236}">
                <a16:creationId xmlns:a16="http://schemas.microsoft.com/office/drawing/2014/main" id="{45989AB7-1CF9-F84F-A8AF-3A6187AE3CE1}"/>
              </a:ext>
            </a:extLst>
          </p:cNvPr>
          <p:cNvSpPr txBox="1"/>
          <p:nvPr/>
        </p:nvSpPr>
        <p:spPr>
          <a:xfrm>
            <a:off x="4334902" y="128490"/>
            <a:ext cx="1131390" cy="523220"/>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Effector:</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8 3G</a:t>
            </a:r>
          </a:p>
        </p:txBody>
      </p:sp>
      <p:sp>
        <p:nvSpPr>
          <p:cNvPr id="61" name="TextBox 53">
            <a:extLst>
              <a:ext uri="{FF2B5EF4-FFF2-40B4-BE49-F238E27FC236}">
                <a16:creationId xmlns:a16="http://schemas.microsoft.com/office/drawing/2014/main" id="{F2177D57-2FDE-7D47-B409-D12FE8D77C4D}"/>
              </a:ext>
            </a:extLst>
          </p:cNvPr>
          <p:cNvSpPr txBox="1"/>
          <p:nvPr/>
        </p:nvSpPr>
        <p:spPr>
          <a:xfrm>
            <a:off x="7701929" y="128491"/>
            <a:ext cx="1019998" cy="523220"/>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Effector:</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26 3G</a:t>
            </a:r>
          </a:p>
        </p:txBody>
      </p:sp>
      <p:sp>
        <p:nvSpPr>
          <p:cNvPr id="62" name="TextBox 15">
            <a:extLst>
              <a:ext uri="{FF2B5EF4-FFF2-40B4-BE49-F238E27FC236}">
                <a16:creationId xmlns:a16="http://schemas.microsoft.com/office/drawing/2014/main" id="{DC36B3E8-1957-5548-926A-1A26F9567D6D}"/>
              </a:ext>
            </a:extLst>
          </p:cNvPr>
          <p:cNvSpPr txBox="1"/>
          <p:nvPr/>
        </p:nvSpPr>
        <p:spPr>
          <a:xfrm>
            <a:off x="2705422" y="128490"/>
            <a:ext cx="1075554" cy="523220"/>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Effector:</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8 2G</a:t>
            </a:r>
          </a:p>
        </p:txBody>
      </p:sp>
      <p:sp>
        <p:nvSpPr>
          <p:cNvPr id="63" name="TextBox 48">
            <a:extLst>
              <a:ext uri="{FF2B5EF4-FFF2-40B4-BE49-F238E27FC236}">
                <a16:creationId xmlns:a16="http://schemas.microsoft.com/office/drawing/2014/main" id="{54142947-4119-514B-90F4-2168BAF21431}"/>
              </a:ext>
            </a:extLst>
          </p:cNvPr>
          <p:cNvSpPr txBox="1"/>
          <p:nvPr/>
        </p:nvSpPr>
        <p:spPr>
          <a:xfrm>
            <a:off x="6039750" y="128491"/>
            <a:ext cx="1028476" cy="523220"/>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Effector:</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26 2G</a:t>
            </a:r>
          </a:p>
        </p:txBody>
      </p:sp>
      <p:cxnSp>
        <p:nvCxnSpPr>
          <p:cNvPr id="64" name="直線矢印コネクタ 63">
            <a:extLst>
              <a:ext uri="{FF2B5EF4-FFF2-40B4-BE49-F238E27FC236}">
                <a16:creationId xmlns:a16="http://schemas.microsoft.com/office/drawing/2014/main" id="{B923E782-CD85-5441-94BE-B56A983EA348}"/>
              </a:ext>
            </a:extLst>
          </p:cNvPr>
          <p:cNvCxnSpPr/>
          <p:nvPr/>
        </p:nvCxnSpPr>
        <p:spPr>
          <a:xfrm>
            <a:off x="2614640" y="3843139"/>
            <a:ext cx="812151" cy="0"/>
          </a:xfrm>
          <a:prstGeom prst="straightConnector1">
            <a:avLst/>
          </a:prstGeom>
          <a:ln w="38100">
            <a:solidFill>
              <a:schemeClr val="tx1"/>
            </a:solidFill>
            <a:tailEnd type="triangle"/>
          </a:ln>
        </p:spPr>
        <p:style>
          <a:lnRef idx="1">
            <a:schemeClr val="dk1"/>
          </a:lnRef>
          <a:fillRef idx="0">
            <a:schemeClr val="dk1"/>
          </a:fillRef>
          <a:effectRef idx="0">
            <a:schemeClr val="dk1"/>
          </a:effectRef>
          <a:fontRef idx="minor">
            <a:schemeClr val="tx1"/>
          </a:fontRef>
        </p:style>
      </p:cxnSp>
      <p:sp>
        <p:nvSpPr>
          <p:cNvPr id="65" name="テキスト ボックス 64">
            <a:extLst>
              <a:ext uri="{FF2B5EF4-FFF2-40B4-BE49-F238E27FC236}">
                <a16:creationId xmlns:a16="http://schemas.microsoft.com/office/drawing/2014/main" id="{E902C43E-E97E-DB46-9B8D-9A914F83E1E4}"/>
              </a:ext>
            </a:extLst>
          </p:cNvPr>
          <p:cNvSpPr txBox="1"/>
          <p:nvPr/>
        </p:nvSpPr>
        <p:spPr>
          <a:xfrm>
            <a:off x="2673292" y="3928176"/>
            <a:ext cx="643125" cy="307777"/>
          </a:xfrm>
          <a:prstGeom prst="rect">
            <a:avLst/>
          </a:prstGeom>
          <a:noFill/>
        </p:spPr>
        <p:txBody>
          <a:bodyPr wrap="none" rtlCol="0">
            <a:spAutoFit/>
          </a:bodyPr>
          <a:lstStyle/>
          <a:p>
            <a:pPr marL="0" marR="0" lvl="0" indent="0" algn="l" defTabSz="914361"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69</a:t>
            </a:r>
            <a:endParaRPr kumimoji="0" lang="ja-JP" altLang="en-US" sz="1400" b="1" i="0" u="none" strike="noStrike" kern="1200" cap="none" spc="0" normalizeH="0" baseline="0" noProof="0">
              <a:ln>
                <a:noFill/>
              </a:ln>
              <a:solidFill>
                <a:prstClr val="black"/>
              </a:solidFill>
              <a:effectLst/>
              <a:uLnTx/>
              <a:uFillTx/>
              <a:latin typeface="Helvetica" pitchFamily="2" charset="0"/>
              <a:ea typeface="Meiryo" panose="020B0604030504040204" pitchFamily="34" charset="-128"/>
              <a:cs typeface="+mn-cs"/>
            </a:endParaRPr>
          </a:p>
        </p:txBody>
      </p:sp>
      <p:sp>
        <p:nvSpPr>
          <p:cNvPr id="67" name="TextBox 15">
            <a:extLst>
              <a:ext uri="{FF2B5EF4-FFF2-40B4-BE49-F238E27FC236}">
                <a16:creationId xmlns:a16="http://schemas.microsoft.com/office/drawing/2014/main" id="{D7526017-2F8E-0A4E-92EC-6504AC3E22E4}"/>
              </a:ext>
            </a:extLst>
          </p:cNvPr>
          <p:cNvSpPr txBox="1"/>
          <p:nvPr/>
        </p:nvSpPr>
        <p:spPr>
          <a:xfrm>
            <a:off x="898490" y="36855"/>
            <a:ext cx="536325" cy="369332"/>
          </a:xfrm>
          <a:prstGeom prst="rect">
            <a:avLst/>
          </a:prstGeom>
          <a:noFill/>
        </p:spPr>
        <p:txBody>
          <a:bodyPr wrap="square" rtlCol="0">
            <a:spAutoFit/>
          </a:bodyPr>
          <a:lstStyle/>
          <a:p>
            <a:pPr marL="0" marR="0" lvl="0" indent="0" algn="l" defTabSz="914361" rtl="0" eaLnBrk="1" fontAlgn="auto" latinLnBrk="0" hangingPunct="1">
              <a:lnSpc>
                <a:spcPct val="100000"/>
              </a:lnSpc>
              <a:spcBef>
                <a:spcPts val="0"/>
              </a:spcBef>
              <a:spcAft>
                <a:spcPts val="0"/>
              </a:spcAft>
              <a:buClrTx/>
              <a:buSzTx/>
              <a:buFontTx/>
              <a:buNone/>
              <a:tabLst/>
              <a:defRPr/>
            </a:pPr>
            <a:r>
              <a:rPr kumimoji="0" lang="en-US" altLang="ja-JP" sz="18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a:t>
            </a:r>
          </a:p>
        </p:txBody>
      </p:sp>
      <p:grpSp>
        <p:nvGrpSpPr>
          <p:cNvPr id="80" name="グループ化 79">
            <a:extLst>
              <a:ext uri="{FF2B5EF4-FFF2-40B4-BE49-F238E27FC236}">
                <a16:creationId xmlns:a16="http://schemas.microsoft.com/office/drawing/2014/main" id="{EE73B8D1-BE6A-CD40-A873-BE11ABCB7320}"/>
              </a:ext>
            </a:extLst>
          </p:cNvPr>
          <p:cNvGrpSpPr/>
          <p:nvPr/>
        </p:nvGrpSpPr>
        <p:grpSpPr>
          <a:xfrm>
            <a:off x="906929" y="650746"/>
            <a:ext cx="1724459" cy="1166108"/>
            <a:chOff x="756777" y="2181440"/>
            <a:chExt cx="1724459" cy="966997"/>
          </a:xfrm>
        </p:grpSpPr>
        <p:cxnSp>
          <p:nvCxnSpPr>
            <p:cNvPr id="81" name="直線矢印コネクタ 80">
              <a:extLst>
                <a:ext uri="{FF2B5EF4-FFF2-40B4-BE49-F238E27FC236}">
                  <a16:creationId xmlns:a16="http://schemas.microsoft.com/office/drawing/2014/main" id="{7BE42460-4116-1944-8D99-B0CB15B45834}"/>
                </a:ext>
              </a:extLst>
            </p:cNvPr>
            <p:cNvCxnSpPr>
              <a:cxnSpLocks/>
            </p:cNvCxnSpPr>
            <p:nvPr/>
          </p:nvCxnSpPr>
          <p:spPr>
            <a:xfrm>
              <a:off x="883888" y="2784458"/>
              <a:ext cx="432000" cy="0"/>
            </a:xfrm>
            <a:prstGeom prst="straightConnector1">
              <a:avLst/>
            </a:prstGeom>
            <a:ln w="12700">
              <a:solidFill>
                <a:schemeClr val="tx1"/>
              </a:solidFill>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82" name="直線矢印コネクタ 81">
              <a:extLst>
                <a:ext uri="{FF2B5EF4-FFF2-40B4-BE49-F238E27FC236}">
                  <a16:creationId xmlns:a16="http://schemas.microsoft.com/office/drawing/2014/main" id="{06B84FB8-51FF-4145-83C1-504D6FD07FF3}"/>
                </a:ext>
              </a:extLst>
            </p:cNvPr>
            <p:cNvCxnSpPr/>
            <p:nvPr/>
          </p:nvCxnSpPr>
          <p:spPr>
            <a:xfrm>
              <a:off x="883888" y="3047100"/>
              <a:ext cx="432000" cy="0"/>
            </a:xfrm>
            <a:prstGeom prst="straightConnector1">
              <a:avLst/>
            </a:prstGeom>
            <a:ln w="12700">
              <a:solidFill>
                <a:schemeClr val="tx1"/>
              </a:solidFill>
              <a:prstDash val="sysDash"/>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83" name="TextBox 15">
              <a:extLst>
                <a:ext uri="{FF2B5EF4-FFF2-40B4-BE49-F238E27FC236}">
                  <a16:creationId xmlns:a16="http://schemas.microsoft.com/office/drawing/2014/main" id="{FE97CB11-1C67-E24B-9834-BA5D4B624BE0}"/>
                </a:ext>
              </a:extLst>
            </p:cNvPr>
            <p:cNvSpPr txBox="1"/>
            <p:nvPr/>
          </p:nvSpPr>
          <p:spPr>
            <a:xfrm>
              <a:off x="1201622" y="2630570"/>
              <a:ext cx="548482" cy="255225"/>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t>
              </a:r>
              <a:endPar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84" name="TextBox 15">
              <a:extLst>
                <a:ext uri="{FF2B5EF4-FFF2-40B4-BE49-F238E27FC236}">
                  <a16:creationId xmlns:a16="http://schemas.microsoft.com/office/drawing/2014/main" id="{C266011F-8373-224E-BAF9-D8A3ED41489A}"/>
                </a:ext>
              </a:extLst>
            </p:cNvPr>
            <p:cNvSpPr txBox="1"/>
            <p:nvPr/>
          </p:nvSpPr>
          <p:spPr>
            <a:xfrm>
              <a:off x="1201622" y="2893212"/>
              <a:ext cx="548482" cy="255225"/>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t>
              </a:r>
              <a:endPar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85" name="TextBox 15">
              <a:extLst>
                <a:ext uri="{FF2B5EF4-FFF2-40B4-BE49-F238E27FC236}">
                  <a16:creationId xmlns:a16="http://schemas.microsoft.com/office/drawing/2014/main" id="{DB298483-42CC-B645-B0AF-5A8331355B3F}"/>
                </a:ext>
              </a:extLst>
            </p:cNvPr>
            <p:cNvSpPr txBox="1"/>
            <p:nvPr/>
          </p:nvSpPr>
          <p:spPr>
            <a:xfrm>
              <a:off x="756777" y="2181440"/>
              <a:ext cx="1724459" cy="43388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Positive control:</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P/I</a:t>
              </a:r>
            </a:p>
          </p:txBody>
        </p:sp>
      </p:grpSp>
      <p:grpSp>
        <p:nvGrpSpPr>
          <p:cNvPr id="86" name="グループ化 85">
            <a:extLst>
              <a:ext uri="{FF2B5EF4-FFF2-40B4-BE49-F238E27FC236}">
                <a16:creationId xmlns:a16="http://schemas.microsoft.com/office/drawing/2014/main" id="{47B54E28-23EF-4543-8579-7DA279E1C066}"/>
              </a:ext>
            </a:extLst>
          </p:cNvPr>
          <p:cNvGrpSpPr/>
          <p:nvPr/>
        </p:nvGrpSpPr>
        <p:grpSpPr>
          <a:xfrm>
            <a:off x="906929" y="2258508"/>
            <a:ext cx="1421879" cy="1166108"/>
            <a:chOff x="756777" y="2181440"/>
            <a:chExt cx="1421879" cy="966997"/>
          </a:xfrm>
        </p:grpSpPr>
        <p:cxnSp>
          <p:nvCxnSpPr>
            <p:cNvPr id="87" name="直線矢印コネクタ 86">
              <a:extLst>
                <a:ext uri="{FF2B5EF4-FFF2-40B4-BE49-F238E27FC236}">
                  <a16:creationId xmlns:a16="http://schemas.microsoft.com/office/drawing/2014/main" id="{7087CEE8-45C4-B245-B853-4689A2AAF77B}"/>
                </a:ext>
              </a:extLst>
            </p:cNvPr>
            <p:cNvCxnSpPr>
              <a:cxnSpLocks/>
            </p:cNvCxnSpPr>
            <p:nvPr/>
          </p:nvCxnSpPr>
          <p:spPr>
            <a:xfrm>
              <a:off x="883888" y="2784458"/>
              <a:ext cx="432000" cy="0"/>
            </a:xfrm>
            <a:prstGeom prst="straightConnector1">
              <a:avLst/>
            </a:prstGeom>
            <a:ln w="12700">
              <a:solidFill>
                <a:schemeClr val="tx1"/>
              </a:solidFill>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88" name="直線矢印コネクタ 87">
              <a:extLst>
                <a:ext uri="{FF2B5EF4-FFF2-40B4-BE49-F238E27FC236}">
                  <a16:creationId xmlns:a16="http://schemas.microsoft.com/office/drawing/2014/main" id="{59F240DE-601C-4E47-B5CB-87A3A5FA3638}"/>
                </a:ext>
              </a:extLst>
            </p:cNvPr>
            <p:cNvCxnSpPr/>
            <p:nvPr/>
          </p:nvCxnSpPr>
          <p:spPr>
            <a:xfrm>
              <a:off x="883888" y="3047100"/>
              <a:ext cx="432000" cy="0"/>
            </a:xfrm>
            <a:prstGeom prst="straightConnector1">
              <a:avLst/>
            </a:prstGeom>
            <a:ln w="12700">
              <a:solidFill>
                <a:schemeClr val="tx1"/>
              </a:solidFill>
              <a:prstDash val="sysDash"/>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89" name="TextBox 15">
              <a:extLst>
                <a:ext uri="{FF2B5EF4-FFF2-40B4-BE49-F238E27FC236}">
                  <a16:creationId xmlns:a16="http://schemas.microsoft.com/office/drawing/2014/main" id="{E77E69C5-3A8E-184F-85C6-F88CD5227B69}"/>
                </a:ext>
              </a:extLst>
            </p:cNvPr>
            <p:cNvSpPr txBox="1"/>
            <p:nvPr/>
          </p:nvSpPr>
          <p:spPr>
            <a:xfrm>
              <a:off x="1201622" y="2630570"/>
              <a:ext cx="548482" cy="255225"/>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t>
              </a:r>
              <a:endPar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90" name="TextBox 15">
              <a:extLst>
                <a:ext uri="{FF2B5EF4-FFF2-40B4-BE49-F238E27FC236}">
                  <a16:creationId xmlns:a16="http://schemas.microsoft.com/office/drawing/2014/main" id="{55E1CF4F-0B9B-7242-89EC-EFCF71B60BB1}"/>
                </a:ext>
              </a:extLst>
            </p:cNvPr>
            <p:cNvSpPr txBox="1"/>
            <p:nvPr/>
          </p:nvSpPr>
          <p:spPr>
            <a:xfrm>
              <a:off x="1201622" y="2893212"/>
              <a:ext cx="548482" cy="255225"/>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t>
              </a:r>
              <a:endPar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91" name="TextBox 15">
              <a:extLst>
                <a:ext uri="{FF2B5EF4-FFF2-40B4-BE49-F238E27FC236}">
                  <a16:creationId xmlns:a16="http://schemas.microsoft.com/office/drawing/2014/main" id="{BD04269A-D024-0F4C-BAE1-492E905E4D3F}"/>
                </a:ext>
              </a:extLst>
            </p:cNvPr>
            <p:cNvSpPr txBox="1"/>
            <p:nvPr/>
          </p:nvSpPr>
          <p:spPr>
            <a:xfrm>
              <a:off x="756777" y="2181440"/>
              <a:ext cx="1421879" cy="43388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Target:</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26-Jurkat</a:t>
              </a:r>
            </a:p>
          </p:txBody>
        </p:sp>
      </p:grpSp>
      <p:sp>
        <p:nvSpPr>
          <p:cNvPr id="92" name="フリーフォーム 91">
            <a:extLst>
              <a:ext uri="{FF2B5EF4-FFF2-40B4-BE49-F238E27FC236}">
                <a16:creationId xmlns:a16="http://schemas.microsoft.com/office/drawing/2014/main" id="{4DD7E92A-4942-D845-8E40-4D3C4FD1D7B6}"/>
              </a:ext>
            </a:extLst>
          </p:cNvPr>
          <p:cNvSpPr/>
          <p:nvPr/>
        </p:nvSpPr>
        <p:spPr>
          <a:xfrm>
            <a:off x="2610349" y="1417450"/>
            <a:ext cx="1266825" cy="495300"/>
          </a:xfrm>
          <a:custGeom>
            <a:avLst/>
            <a:gdLst>
              <a:gd name="connsiteX0" fmla="*/ 0 w 1266825"/>
              <a:gd name="connsiteY0" fmla="*/ 495300 h 495300"/>
              <a:gd name="connsiteX1" fmla="*/ 53975 w 1266825"/>
              <a:gd name="connsiteY1" fmla="*/ 101600 h 495300"/>
              <a:gd name="connsiteX2" fmla="*/ 69850 w 1266825"/>
              <a:gd name="connsiteY2" fmla="*/ 136525 h 495300"/>
              <a:gd name="connsiteX3" fmla="*/ 95250 w 1266825"/>
              <a:gd name="connsiteY3" fmla="*/ 0 h 495300"/>
              <a:gd name="connsiteX4" fmla="*/ 120650 w 1266825"/>
              <a:gd name="connsiteY4" fmla="*/ 57150 h 495300"/>
              <a:gd name="connsiteX5" fmla="*/ 161925 w 1266825"/>
              <a:gd name="connsiteY5" fmla="*/ 41275 h 495300"/>
              <a:gd name="connsiteX6" fmla="*/ 215900 w 1266825"/>
              <a:gd name="connsiteY6" fmla="*/ 342900 h 495300"/>
              <a:gd name="connsiteX7" fmla="*/ 257175 w 1266825"/>
              <a:gd name="connsiteY7" fmla="*/ 374650 h 495300"/>
              <a:gd name="connsiteX8" fmla="*/ 282575 w 1266825"/>
              <a:gd name="connsiteY8" fmla="*/ 431800 h 495300"/>
              <a:gd name="connsiteX9" fmla="*/ 339725 w 1266825"/>
              <a:gd name="connsiteY9" fmla="*/ 463550 h 495300"/>
              <a:gd name="connsiteX10" fmla="*/ 384175 w 1266825"/>
              <a:gd name="connsiteY10" fmla="*/ 447675 h 495300"/>
              <a:gd name="connsiteX11" fmla="*/ 457200 w 1266825"/>
              <a:gd name="connsiteY11" fmla="*/ 460375 h 495300"/>
              <a:gd name="connsiteX12" fmla="*/ 508000 w 1266825"/>
              <a:gd name="connsiteY12" fmla="*/ 441325 h 495300"/>
              <a:gd name="connsiteX13" fmla="*/ 527050 w 1266825"/>
              <a:gd name="connsiteY13" fmla="*/ 454025 h 495300"/>
              <a:gd name="connsiteX14" fmla="*/ 609600 w 1266825"/>
              <a:gd name="connsiteY14" fmla="*/ 457200 h 495300"/>
              <a:gd name="connsiteX15" fmla="*/ 647700 w 1266825"/>
              <a:gd name="connsiteY15" fmla="*/ 428625 h 495300"/>
              <a:gd name="connsiteX16" fmla="*/ 682625 w 1266825"/>
              <a:gd name="connsiteY16" fmla="*/ 441325 h 495300"/>
              <a:gd name="connsiteX17" fmla="*/ 739775 w 1266825"/>
              <a:gd name="connsiteY17" fmla="*/ 419100 h 495300"/>
              <a:gd name="connsiteX18" fmla="*/ 771525 w 1266825"/>
              <a:gd name="connsiteY18" fmla="*/ 412750 h 495300"/>
              <a:gd name="connsiteX19" fmla="*/ 796925 w 1266825"/>
              <a:gd name="connsiteY19" fmla="*/ 422275 h 495300"/>
              <a:gd name="connsiteX20" fmla="*/ 841375 w 1266825"/>
              <a:gd name="connsiteY20" fmla="*/ 463550 h 495300"/>
              <a:gd name="connsiteX21" fmla="*/ 876300 w 1266825"/>
              <a:gd name="connsiteY21" fmla="*/ 485775 h 495300"/>
              <a:gd name="connsiteX22" fmla="*/ 933450 w 1266825"/>
              <a:gd name="connsiteY22" fmla="*/ 492125 h 495300"/>
              <a:gd name="connsiteX23" fmla="*/ 1266825 w 1266825"/>
              <a:gd name="connsiteY23" fmla="*/ 492125 h 495300"/>
              <a:gd name="connsiteX24" fmla="*/ 1266825 w 1266825"/>
              <a:gd name="connsiteY24" fmla="*/ 492125 h 4953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Lst>
            <a:rect l="l" t="t" r="r" b="b"/>
            <a:pathLst>
              <a:path w="1266825" h="495300">
                <a:moveTo>
                  <a:pt x="0" y="495300"/>
                </a:moveTo>
                <a:lnTo>
                  <a:pt x="53975" y="101600"/>
                </a:lnTo>
                <a:lnTo>
                  <a:pt x="69850" y="136525"/>
                </a:lnTo>
                <a:lnTo>
                  <a:pt x="95250" y="0"/>
                </a:lnTo>
                <a:lnTo>
                  <a:pt x="120650" y="57150"/>
                </a:lnTo>
                <a:lnTo>
                  <a:pt x="161925" y="41275"/>
                </a:lnTo>
                <a:lnTo>
                  <a:pt x="215900" y="342900"/>
                </a:lnTo>
                <a:lnTo>
                  <a:pt x="257175" y="374650"/>
                </a:lnTo>
                <a:lnTo>
                  <a:pt x="282575" y="431800"/>
                </a:lnTo>
                <a:lnTo>
                  <a:pt x="339725" y="463550"/>
                </a:lnTo>
                <a:lnTo>
                  <a:pt x="384175" y="447675"/>
                </a:lnTo>
                <a:lnTo>
                  <a:pt x="457200" y="460375"/>
                </a:lnTo>
                <a:lnTo>
                  <a:pt x="508000" y="441325"/>
                </a:lnTo>
                <a:lnTo>
                  <a:pt x="527050" y="454025"/>
                </a:lnTo>
                <a:lnTo>
                  <a:pt x="609600" y="457200"/>
                </a:lnTo>
                <a:lnTo>
                  <a:pt x="647700" y="428625"/>
                </a:lnTo>
                <a:lnTo>
                  <a:pt x="682625" y="441325"/>
                </a:lnTo>
                <a:lnTo>
                  <a:pt x="739775" y="419100"/>
                </a:lnTo>
                <a:lnTo>
                  <a:pt x="771525" y="412750"/>
                </a:lnTo>
                <a:lnTo>
                  <a:pt x="796925" y="422275"/>
                </a:lnTo>
                <a:lnTo>
                  <a:pt x="841375" y="463550"/>
                </a:lnTo>
                <a:lnTo>
                  <a:pt x="876300" y="485775"/>
                </a:lnTo>
                <a:lnTo>
                  <a:pt x="933450" y="492125"/>
                </a:lnTo>
                <a:lnTo>
                  <a:pt x="1266825" y="492125"/>
                </a:lnTo>
                <a:lnTo>
                  <a:pt x="1266825" y="49212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3" name="フリーフォーム 92">
            <a:extLst>
              <a:ext uri="{FF2B5EF4-FFF2-40B4-BE49-F238E27FC236}">
                <a16:creationId xmlns:a16="http://schemas.microsoft.com/office/drawing/2014/main" id="{B9F70CBC-BD91-0F4E-9DDC-B5C5843E0691}"/>
              </a:ext>
            </a:extLst>
          </p:cNvPr>
          <p:cNvSpPr/>
          <p:nvPr/>
        </p:nvSpPr>
        <p:spPr>
          <a:xfrm>
            <a:off x="2610349" y="985650"/>
            <a:ext cx="1263650" cy="927100"/>
          </a:xfrm>
          <a:custGeom>
            <a:avLst/>
            <a:gdLst>
              <a:gd name="connsiteX0" fmla="*/ 0 w 1263650"/>
              <a:gd name="connsiteY0" fmla="*/ 923925 h 927100"/>
              <a:gd name="connsiteX1" fmla="*/ 622300 w 1263650"/>
              <a:gd name="connsiteY1" fmla="*/ 927100 h 927100"/>
              <a:gd name="connsiteX2" fmla="*/ 654050 w 1263650"/>
              <a:gd name="connsiteY2" fmla="*/ 920750 h 927100"/>
              <a:gd name="connsiteX3" fmla="*/ 701675 w 1263650"/>
              <a:gd name="connsiteY3" fmla="*/ 917575 h 927100"/>
              <a:gd name="connsiteX4" fmla="*/ 742950 w 1263650"/>
              <a:gd name="connsiteY4" fmla="*/ 911225 h 927100"/>
              <a:gd name="connsiteX5" fmla="*/ 781050 w 1263650"/>
              <a:gd name="connsiteY5" fmla="*/ 898525 h 927100"/>
              <a:gd name="connsiteX6" fmla="*/ 800100 w 1263650"/>
              <a:gd name="connsiteY6" fmla="*/ 892175 h 927100"/>
              <a:gd name="connsiteX7" fmla="*/ 835025 w 1263650"/>
              <a:gd name="connsiteY7" fmla="*/ 850900 h 927100"/>
              <a:gd name="connsiteX8" fmla="*/ 860425 w 1263650"/>
              <a:gd name="connsiteY8" fmla="*/ 784225 h 927100"/>
              <a:gd name="connsiteX9" fmla="*/ 876300 w 1263650"/>
              <a:gd name="connsiteY9" fmla="*/ 711200 h 927100"/>
              <a:gd name="connsiteX10" fmla="*/ 901700 w 1263650"/>
              <a:gd name="connsiteY10" fmla="*/ 638175 h 927100"/>
              <a:gd name="connsiteX11" fmla="*/ 908050 w 1263650"/>
              <a:gd name="connsiteY11" fmla="*/ 593725 h 927100"/>
              <a:gd name="connsiteX12" fmla="*/ 923925 w 1263650"/>
              <a:gd name="connsiteY12" fmla="*/ 571500 h 927100"/>
              <a:gd name="connsiteX13" fmla="*/ 939800 w 1263650"/>
              <a:gd name="connsiteY13" fmla="*/ 403225 h 927100"/>
              <a:gd name="connsiteX14" fmla="*/ 942975 w 1263650"/>
              <a:gd name="connsiteY14" fmla="*/ 269875 h 927100"/>
              <a:gd name="connsiteX15" fmla="*/ 955675 w 1263650"/>
              <a:gd name="connsiteY15" fmla="*/ 219075 h 927100"/>
              <a:gd name="connsiteX16" fmla="*/ 958850 w 1263650"/>
              <a:gd name="connsiteY16" fmla="*/ 187325 h 927100"/>
              <a:gd name="connsiteX17" fmla="*/ 971550 w 1263650"/>
              <a:gd name="connsiteY17" fmla="*/ 219075 h 927100"/>
              <a:gd name="connsiteX18" fmla="*/ 993775 w 1263650"/>
              <a:gd name="connsiteY18" fmla="*/ 104775 h 927100"/>
              <a:gd name="connsiteX19" fmla="*/ 993775 w 1263650"/>
              <a:gd name="connsiteY19" fmla="*/ 73025 h 927100"/>
              <a:gd name="connsiteX20" fmla="*/ 1025525 w 1263650"/>
              <a:gd name="connsiteY20" fmla="*/ 50800 h 927100"/>
              <a:gd name="connsiteX21" fmla="*/ 1025525 w 1263650"/>
              <a:gd name="connsiteY21" fmla="*/ 28575 h 927100"/>
              <a:gd name="connsiteX22" fmla="*/ 1041400 w 1263650"/>
              <a:gd name="connsiteY22" fmla="*/ 0 h 927100"/>
              <a:gd name="connsiteX23" fmla="*/ 1057275 w 1263650"/>
              <a:gd name="connsiteY23" fmla="*/ 95250 h 927100"/>
              <a:gd name="connsiteX24" fmla="*/ 1063625 w 1263650"/>
              <a:gd name="connsiteY24" fmla="*/ 184150 h 927100"/>
              <a:gd name="connsiteX25" fmla="*/ 1073150 w 1263650"/>
              <a:gd name="connsiteY25" fmla="*/ 234950 h 927100"/>
              <a:gd name="connsiteX26" fmla="*/ 1098550 w 1263650"/>
              <a:gd name="connsiteY26" fmla="*/ 250825 h 927100"/>
              <a:gd name="connsiteX27" fmla="*/ 1120775 w 1263650"/>
              <a:gd name="connsiteY27" fmla="*/ 361950 h 927100"/>
              <a:gd name="connsiteX28" fmla="*/ 1127125 w 1263650"/>
              <a:gd name="connsiteY28" fmla="*/ 476250 h 927100"/>
              <a:gd name="connsiteX29" fmla="*/ 1143000 w 1263650"/>
              <a:gd name="connsiteY29" fmla="*/ 561975 h 927100"/>
              <a:gd name="connsiteX30" fmla="*/ 1149350 w 1263650"/>
              <a:gd name="connsiteY30" fmla="*/ 647700 h 927100"/>
              <a:gd name="connsiteX31" fmla="*/ 1155700 w 1263650"/>
              <a:gd name="connsiteY31" fmla="*/ 727075 h 927100"/>
              <a:gd name="connsiteX32" fmla="*/ 1171575 w 1263650"/>
              <a:gd name="connsiteY32" fmla="*/ 790575 h 927100"/>
              <a:gd name="connsiteX33" fmla="*/ 1196975 w 1263650"/>
              <a:gd name="connsiteY33" fmla="*/ 854075 h 927100"/>
              <a:gd name="connsiteX34" fmla="*/ 1231900 w 1263650"/>
              <a:gd name="connsiteY34" fmla="*/ 895350 h 927100"/>
              <a:gd name="connsiteX35" fmla="*/ 1263650 w 1263650"/>
              <a:gd name="connsiteY35" fmla="*/ 923925 h 927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263650" h="927100">
                <a:moveTo>
                  <a:pt x="0" y="923925"/>
                </a:moveTo>
                <a:lnTo>
                  <a:pt x="622300" y="927100"/>
                </a:lnTo>
                <a:lnTo>
                  <a:pt x="654050" y="920750"/>
                </a:lnTo>
                <a:lnTo>
                  <a:pt x="701675" y="917575"/>
                </a:lnTo>
                <a:lnTo>
                  <a:pt x="742950" y="911225"/>
                </a:lnTo>
                <a:lnTo>
                  <a:pt x="781050" y="898525"/>
                </a:lnTo>
                <a:lnTo>
                  <a:pt x="800100" y="892175"/>
                </a:lnTo>
                <a:lnTo>
                  <a:pt x="835025" y="850900"/>
                </a:lnTo>
                <a:lnTo>
                  <a:pt x="860425" y="784225"/>
                </a:lnTo>
                <a:lnTo>
                  <a:pt x="876300" y="711200"/>
                </a:lnTo>
                <a:lnTo>
                  <a:pt x="901700" y="638175"/>
                </a:lnTo>
                <a:lnTo>
                  <a:pt x="908050" y="593725"/>
                </a:lnTo>
                <a:lnTo>
                  <a:pt x="923925" y="571500"/>
                </a:lnTo>
                <a:lnTo>
                  <a:pt x="939800" y="403225"/>
                </a:lnTo>
                <a:cubicBezTo>
                  <a:pt x="940858" y="358775"/>
                  <a:pt x="941917" y="314325"/>
                  <a:pt x="942975" y="269875"/>
                </a:cubicBezTo>
                <a:lnTo>
                  <a:pt x="955675" y="219075"/>
                </a:lnTo>
                <a:lnTo>
                  <a:pt x="958850" y="187325"/>
                </a:lnTo>
                <a:lnTo>
                  <a:pt x="971550" y="219075"/>
                </a:lnTo>
                <a:lnTo>
                  <a:pt x="993775" y="104775"/>
                </a:lnTo>
                <a:lnTo>
                  <a:pt x="993775" y="73025"/>
                </a:lnTo>
                <a:lnTo>
                  <a:pt x="1025525" y="50800"/>
                </a:lnTo>
                <a:lnTo>
                  <a:pt x="1025525" y="28575"/>
                </a:lnTo>
                <a:lnTo>
                  <a:pt x="1041400" y="0"/>
                </a:lnTo>
                <a:lnTo>
                  <a:pt x="1057275" y="95250"/>
                </a:lnTo>
                <a:lnTo>
                  <a:pt x="1063625" y="184150"/>
                </a:lnTo>
                <a:lnTo>
                  <a:pt x="1073150" y="234950"/>
                </a:lnTo>
                <a:lnTo>
                  <a:pt x="1098550" y="250825"/>
                </a:lnTo>
                <a:lnTo>
                  <a:pt x="1120775" y="361950"/>
                </a:lnTo>
                <a:lnTo>
                  <a:pt x="1127125" y="476250"/>
                </a:lnTo>
                <a:lnTo>
                  <a:pt x="1143000" y="561975"/>
                </a:lnTo>
                <a:lnTo>
                  <a:pt x="1149350" y="647700"/>
                </a:lnTo>
                <a:lnTo>
                  <a:pt x="1155700" y="727075"/>
                </a:lnTo>
                <a:lnTo>
                  <a:pt x="1171575" y="790575"/>
                </a:lnTo>
                <a:lnTo>
                  <a:pt x="1196975" y="854075"/>
                </a:lnTo>
                <a:lnTo>
                  <a:pt x="1231900" y="895350"/>
                </a:lnTo>
                <a:lnTo>
                  <a:pt x="1263650" y="92392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4" name="フリーフォーム 93">
            <a:extLst>
              <a:ext uri="{FF2B5EF4-FFF2-40B4-BE49-F238E27FC236}">
                <a16:creationId xmlns:a16="http://schemas.microsoft.com/office/drawing/2014/main" id="{60F0CF43-7350-F145-9943-FDB817C78626}"/>
              </a:ext>
            </a:extLst>
          </p:cNvPr>
          <p:cNvSpPr/>
          <p:nvPr/>
        </p:nvSpPr>
        <p:spPr>
          <a:xfrm>
            <a:off x="4274049" y="1172975"/>
            <a:ext cx="1270000" cy="746125"/>
          </a:xfrm>
          <a:custGeom>
            <a:avLst/>
            <a:gdLst>
              <a:gd name="connsiteX0" fmla="*/ 3175 w 1270000"/>
              <a:gd name="connsiteY0" fmla="*/ 746125 h 746125"/>
              <a:gd name="connsiteX1" fmla="*/ 0 w 1270000"/>
              <a:gd name="connsiteY1" fmla="*/ 647700 h 746125"/>
              <a:gd name="connsiteX2" fmla="*/ 15875 w 1270000"/>
              <a:gd name="connsiteY2" fmla="*/ 549275 h 746125"/>
              <a:gd name="connsiteX3" fmla="*/ 31750 w 1270000"/>
              <a:gd name="connsiteY3" fmla="*/ 447675 h 746125"/>
              <a:gd name="connsiteX4" fmla="*/ 47625 w 1270000"/>
              <a:gd name="connsiteY4" fmla="*/ 368300 h 746125"/>
              <a:gd name="connsiteX5" fmla="*/ 57150 w 1270000"/>
              <a:gd name="connsiteY5" fmla="*/ 288925 h 746125"/>
              <a:gd name="connsiteX6" fmla="*/ 82550 w 1270000"/>
              <a:gd name="connsiteY6" fmla="*/ 222250 h 746125"/>
              <a:gd name="connsiteX7" fmla="*/ 101600 w 1270000"/>
              <a:gd name="connsiteY7" fmla="*/ 155575 h 746125"/>
              <a:gd name="connsiteX8" fmla="*/ 127000 w 1270000"/>
              <a:gd name="connsiteY8" fmla="*/ 238125 h 746125"/>
              <a:gd name="connsiteX9" fmla="*/ 149225 w 1270000"/>
              <a:gd name="connsiteY9" fmla="*/ 212725 h 746125"/>
              <a:gd name="connsiteX10" fmla="*/ 155575 w 1270000"/>
              <a:gd name="connsiteY10" fmla="*/ 66675 h 746125"/>
              <a:gd name="connsiteX11" fmla="*/ 168275 w 1270000"/>
              <a:gd name="connsiteY11" fmla="*/ 0 h 746125"/>
              <a:gd name="connsiteX12" fmla="*/ 184150 w 1270000"/>
              <a:gd name="connsiteY12" fmla="*/ 60325 h 746125"/>
              <a:gd name="connsiteX13" fmla="*/ 196850 w 1270000"/>
              <a:gd name="connsiteY13" fmla="*/ 219075 h 746125"/>
              <a:gd name="connsiteX14" fmla="*/ 215900 w 1270000"/>
              <a:gd name="connsiteY14" fmla="*/ 415925 h 746125"/>
              <a:gd name="connsiteX15" fmla="*/ 234950 w 1270000"/>
              <a:gd name="connsiteY15" fmla="*/ 539750 h 746125"/>
              <a:gd name="connsiteX16" fmla="*/ 266700 w 1270000"/>
              <a:gd name="connsiteY16" fmla="*/ 647700 h 746125"/>
              <a:gd name="connsiteX17" fmla="*/ 298450 w 1270000"/>
              <a:gd name="connsiteY17" fmla="*/ 688975 h 746125"/>
              <a:gd name="connsiteX18" fmla="*/ 336550 w 1270000"/>
              <a:gd name="connsiteY18" fmla="*/ 714375 h 746125"/>
              <a:gd name="connsiteX19" fmla="*/ 371475 w 1270000"/>
              <a:gd name="connsiteY19" fmla="*/ 714375 h 746125"/>
              <a:gd name="connsiteX20" fmla="*/ 406400 w 1270000"/>
              <a:gd name="connsiteY20" fmla="*/ 698500 h 746125"/>
              <a:gd name="connsiteX21" fmla="*/ 438150 w 1270000"/>
              <a:gd name="connsiteY21" fmla="*/ 720725 h 746125"/>
              <a:gd name="connsiteX22" fmla="*/ 460375 w 1270000"/>
              <a:gd name="connsiteY22" fmla="*/ 720725 h 746125"/>
              <a:gd name="connsiteX23" fmla="*/ 501650 w 1270000"/>
              <a:gd name="connsiteY23" fmla="*/ 688975 h 746125"/>
              <a:gd name="connsiteX24" fmla="*/ 527050 w 1270000"/>
              <a:gd name="connsiteY24" fmla="*/ 663575 h 746125"/>
              <a:gd name="connsiteX25" fmla="*/ 549275 w 1270000"/>
              <a:gd name="connsiteY25" fmla="*/ 657225 h 746125"/>
              <a:gd name="connsiteX26" fmla="*/ 600075 w 1270000"/>
              <a:gd name="connsiteY26" fmla="*/ 669925 h 746125"/>
              <a:gd name="connsiteX27" fmla="*/ 628650 w 1270000"/>
              <a:gd name="connsiteY27" fmla="*/ 669925 h 746125"/>
              <a:gd name="connsiteX28" fmla="*/ 663575 w 1270000"/>
              <a:gd name="connsiteY28" fmla="*/ 638175 h 746125"/>
              <a:gd name="connsiteX29" fmla="*/ 698500 w 1270000"/>
              <a:gd name="connsiteY29" fmla="*/ 609600 h 746125"/>
              <a:gd name="connsiteX30" fmla="*/ 720725 w 1270000"/>
              <a:gd name="connsiteY30" fmla="*/ 596900 h 746125"/>
              <a:gd name="connsiteX31" fmla="*/ 739775 w 1270000"/>
              <a:gd name="connsiteY31" fmla="*/ 603250 h 746125"/>
              <a:gd name="connsiteX32" fmla="*/ 768350 w 1270000"/>
              <a:gd name="connsiteY32" fmla="*/ 647700 h 746125"/>
              <a:gd name="connsiteX33" fmla="*/ 806450 w 1270000"/>
              <a:gd name="connsiteY33" fmla="*/ 682625 h 746125"/>
              <a:gd name="connsiteX34" fmla="*/ 857250 w 1270000"/>
              <a:gd name="connsiteY34" fmla="*/ 717550 h 746125"/>
              <a:gd name="connsiteX35" fmla="*/ 911225 w 1270000"/>
              <a:gd name="connsiteY35" fmla="*/ 736600 h 746125"/>
              <a:gd name="connsiteX36" fmla="*/ 1270000 w 1270000"/>
              <a:gd name="connsiteY36" fmla="*/ 736600 h 746125"/>
              <a:gd name="connsiteX37" fmla="*/ 1270000 w 1270000"/>
              <a:gd name="connsiteY37" fmla="*/ 742950 h 7461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270000" h="746125">
                <a:moveTo>
                  <a:pt x="3175" y="746125"/>
                </a:moveTo>
                <a:lnTo>
                  <a:pt x="0" y="647700"/>
                </a:lnTo>
                <a:lnTo>
                  <a:pt x="15875" y="549275"/>
                </a:lnTo>
                <a:lnTo>
                  <a:pt x="31750" y="447675"/>
                </a:lnTo>
                <a:lnTo>
                  <a:pt x="47625" y="368300"/>
                </a:lnTo>
                <a:lnTo>
                  <a:pt x="57150" y="288925"/>
                </a:lnTo>
                <a:lnTo>
                  <a:pt x="82550" y="222250"/>
                </a:lnTo>
                <a:lnTo>
                  <a:pt x="101600" y="155575"/>
                </a:lnTo>
                <a:lnTo>
                  <a:pt x="127000" y="238125"/>
                </a:lnTo>
                <a:lnTo>
                  <a:pt x="149225" y="212725"/>
                </a:lnTo>
                <a:lnTo>
                  <a:pt x="155575" y="66675"/>
                </a:lnTo>
                <a:lnTo>
                  <a:pt x="168275" y="0"/>
                </a:lnTo>
                <a:lnTo>
                  <a:pt x="184150" y="60325"/>
                </a:lnTo>
                <a:lnTo>
                  <a:pt x="196850" y="219075"/>
                </a:lnTo>
                <a:lnTo>
                  <a:pt x="215900" y="415925"/>
                </a:lnTo>
                <a:lnTo>
                  <a:pt x="234950" y="539750"/>
                </a:lnTo>
                <a:lnTo>
                  <a:pt x="266700" y="647700"/>
                </a:lnTo>
                <a:lnTo>
                  <a:pt x="298450" y="688975"/>
                </a:lnTo>
                <a:lnTo>
                  <a:pt x="336550" y="714375"/>
                </a:lnTo>
                <a:lnTo>
                  <a:pt x="371475" y="714375"/>
                </a:lnTo>
                <a:lnTo>
                  <a:pt x="406400" y="698500"/>
                </a:lnTo>
                <a:lnTo>
                  <a:pt x="438150" y="720725"/>
                </a:lnTo>
                <a:lnTo>
                  <a:pt x="460375" y="720725"/>
                </a:lnTo>
                <a:lnTo>
                  <a:pt x="501650" y="688975"/>
                </a:lnTo>
                <a:lnTo>
                  <a:pt x="527050" y="663575"/>
                </a:lnTo>
                <a:lnTo>
                  <a:pt x="549275" y="657225"/>
                </a:lnTo>
                <a:lnTo>
                  <a:pt x="600075" y="669925"/>
                </a:lnTo>
                <a:lnTo>
                  <a:pt x="628650" y="669925"/>
                </a:lnTo>
                <a:lnTo>
                  <a:pt x="663575" y="638175"/>
                </a:lnTo>
                <a:lnTo>
                  <a:pt x="698500" y="609600"/>
                </a:lnTo>
                <a:lnTo>
                  <a:pt x="720725" y="596900"/>
                </a:lnTo>
                <a:lnTo>
                  <a:pt x="739775" y="603250"/>
                </a:lnTo>
                <a:lnTo>
                  <a:pt x="768350" y="647700"/>
                </a:lnTo>
                <a:lnTo>
                  <a:pt x="806450" y="682625"/>
                </a:lnTo>
                <a:lnTo>
                  <a:pt x="857250" y="717550"/>
                </a:lnTo>
                <a:lnTo>
                  <a:pt x="911225" y="736600"/>
                </a:lnTo>
                <a:lnTo>
                  <a:pt x="1270000" y="736600"/>
                </a:lnTo>
                <a:lnTo>
                  <a:pt x="1270000" y="74295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5" name="フリーフォーム 94">
            <a:extLst>
              <a:ext uri="{FF2B5EF4-FFF2-40B4-BE49-F238E27FC236}">
                <a16:creationId xmlns:a16="http://schemas.microsoft.com/office/drawing/2014/main" id="{B26B2C3C-B951-9C47-95A3-808617F84DC7}"/>
              </a:ext>
            </a:extLst>
          </p:cNvPr>
          <p:cNvSpPr/>
          <p:nvPr/>
        </p:nvSpPr>
        <p:spPr>
          <a:xfrm>
            <a:off x="4274049" y="1042800"/>
            <a:ext cx="1263650" cy="869950"/>
          </a:xfrm>
          <a:custGeom>
            <a:avLst/>
            <a:gdLst>
              <a:gd name="connsiteX0" fmla="*/ 0 w 1263650"/>
              <a:gd name="connsiteY0" fmla="*/ 869950 h 869950"/>
              <a:gd name="connsiteX1" fmla="*/ 323850 w 1263650"/>
              <a:gd name="connsiteY1" fmla="*/ 866775 h 869950"/>
              <a:gd name="connsiteX2" fmla="*/ 349250 w 1263650"/>
              <a:gd name="connsiteY2" fmla="*/ 850900 h 869950"/>
              <a:gd name="connsiteX3" fmla="*/ 393700 w 1263650"/>
              <a:gd name="connsiteY3" fmla="*/ 847725 h 869950"/>
              <a:gd name="connsiteX4" fmla="*/ 434975 w 1263650"/>
              <a:gd name="connsiteY4" fmla="*/ 854075 h 869950"/>
              <a:gd name="connsiteX5" fmla="*/ 479425 w 1263650"/>
              <a:gd name="connsiteY5" fmla="*/ 854075 h 869950"/>
              <a:gd name="connsiteX6" fmla="*/ 536575 w 1263650"/>
              <a:gd name="connsiteY6" fmla="*/ 847725 h 869950"/>
              <a:gd name="connsiteX7" fmla="*/ 590550 w 1263650"/>
              <a:gd name="connsiteY7" fmla="*/ 857250 h 869950"/>
              <a:gd name="connsiteX8" fmla="*/ 663575 w 1263650"/>
              <a:gd name="connsiteY8" fmla="*/ 847725 h 869950"/>
              <a:gd name="connsiteX9" fmla="*/ 739775 w 1263650"/>
              <a:gd name="connsiteY9" fmla="*/ 831850 h 869950"/>
              <a:gd name="connsiteX10" fmla="*/ 790575 w 1263650"/>
              <a:gd name="connsiteY10" fmla="*/ 809625 h 869950"/>
              <a:gd name="connsiteX11" fmla="*/ 844550 w 1263650"/>
              <a:gd name="connsiteY11" fmla="*/ 784225 h 869950"/>
              <a:gd name="connsiteX12" fmla="*/ 873125 w 1263650"/>
              <a:gd name="connsiteY12" fmla="*/ 717550 h 869950"/>
              <a:gd name="connsiteX13" fmla="*/ 895350 w 1263650"/>
              <a:gd name="connsiteY13" fmla="*/ 644525 h 869950"/>
              <a:gd name="connsiteX14" fmla="*/ 911225 w 1263650"/>
              <a:gd name="connsiteY14" fmla="*/ 590550 h 869950"/>
              <a:gd name="connsiteX15" fmla="*/ 923925 w 1263650"/>
              <a:gd name="connsiteY15" fmla="*/ 539750 h 869950"/>
              <a:gd name="connsiteX16" fmla="*/ 955675 w 1263650"/>
              <a:gd name="connsiteY16" fmla="*/ 492125 h 869950"/>
              <a:gd name="connsiteX17" fmla="*/ 968375 w 1263650"/>
              <a:gd name="connsiteY17" fmla="*/ 454025 h 869950"/>
              <a:gd name="connsiteX18" fmla="*/ 977900 w 1263650"/>
              <a:gd name="connsiteY18" fmla="*/ 400050 h 869950"/>
              <a:gd name="connsiteX19" fmla="*/ 984250 w 1263650"/>
              <a:gd name="connsiteY19" fmla="*/ 342900 h 869950"/>
              <a:gd name="connsiteX20" fmla="*/ 984250 w 1263650"/>
              <a:gd name="connsiteY20" fmla="*/ 257175 h 869950"/>
              <a:gd name="connsiteX21" fmla="*/ 996950 w 1263650"/>
              <a:gd name="connsiteY21" fmla="*/ 146050 h 869950"/>
              <a:gd name="connsiteX22" fmla="*/ 1003300 w 1263650"/>
              <a:gd name="connsiteY22" fmla="*/ 57150 h 869950"/>
              <a:gd name="connsiteX23" fmla="*/ 1025525 w 1263650"/>
              <a:gd name="connsiteY23" fmla="*/ 76200 h 869950"/>
              <a:gd name="connsiteX24" fmla="*/ 1041400 w 1263650"/>
              <a:gd name="connsiteY24" fmla="*/ 0 h 869950"/>
              <a:gd name="connsiteX25" fmla="*/ 1060450 w 1263650"/>
              <a:gd name="connsiteY25" fmla="*/ 117475 h 869950"/>
              <a:gd name="connsiteX26" fmla="*/ 1066800 w 1263650"/>
              <a:gd name="connsiteY26" fmla="*/ 228600 h 869950"/>
              <a:gd name="connsiteX27" fmla="*/ 1076325 w 1263650"/>
              <a:gd name="connsiteY27" fmla="*/ 301625 h 869950"/>
              <a:gd name="connsiteX28" fmla="*/ 1095375 w 1263650"/>
              <a:gd name="connsiteY28" fmla="*/ 368300 h 869950"/>
              <a:gd name="connsiteX29" fmla="*/ 1117600 w 1263650"/>
              <a:gd name="connsiteY29" fmla="*/ 415925 h 869950"/>
              <a:gd name="connsiteX30" fmla="*/ 1123950 w 1263650"/>
              <a:gd name="connsiteY30" fmla="*/ 523875 h 869950"/>
              <a:gd name="connsiteX31" fmla="*/ 1139825 w 1263650"/>
              <a:gd name="connsiteY31" fmla="*/ 596900 h 869950"/>
              <a:gd name="connsiteX32" fmla="*/ 1162050 w 1263650"/>
              <a:gd name="connsiteY32" fmla="*/ 647700 h 869950"/>
              <a:gd name="connsiteX33" fmla="*/ 1174750 w 1263650"/>
              <a:gd name="connsiteY33" fmla="*/ 730250 h 869950"/>
              <a:gd name="connsiteX34" fmla="*/ 1187450 w 1263650"/>
              <a:gd name="connsiteY34" fmla="*/ 781050 h 869950"/>
              <a:gd name="connsiteX35" fmla="*/ 1209675 w 1263650"/>
              <a:gd name="connsiteY35" fmla="*/ 822325 h 869950"/>
              <a:gd name="connsiteX36" fmla="*/ 1250950 w 1263650"/>
              <a:gd name="connsiteY36" fmla="*/ 838200 h 869950"/>
              <a:gd name="connsiteX37" fmla="*/ 1263650 w 1263650"/>
              <a:gd name="connsiteY37" fmla="*/ 866775 h 869950"/>
              <a:gd name="connsiteX38" fmla="*/ 1263650 w 1263650"/>
              <a:gd name="connsiteY38" fmla="*/ 866775 h 8699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Lst>
            <a:rect l="l" t="t" r="r" b="b"/>
            <a:pathLst>
              <a:path w="1263650" h="869950">
                <a:moveTo>
                  <a:pt x="0" y="869950"/>
                </a:moveTo>
                <a:lnTo>
                  <a:pt x="323850" y="866775"/>
                </a:lnTo>
                <a:lnTo>
                  <a:pt x="349250" y="850900"/>
                </a:lnTo>
                <a:lnTo>
                  <a:pt x="393700" y="847725"/>
                </a:lnTo>
                <a:lnTo>
                  <a:pt x="434975" y="854075"/>
                </a:lnTo>
                <a:lnTo>
                  <a:pt x="479425" y="854075"/>
                </a:lnTo>
                <a:lnTo>
                  <a:pt x="536575" y="847725"/>
                </a:lnTo>
                <a:lnTo>
                  <a:pt x="590550" y="857250"/>
                </a:lnTo>
                <a:lnTo>
                  <a:pt x="663575" y="847725"/>
                </a:lnTo>
                <a:lnTo>
                  <a:pt x="739775" y="831850"/>
                </a:lnTo>
                <a:lnTo>
                  <a:pt x="790575" y="809625"/>
                </a:lnTo>
                <a:lnTo>
                  <a:pt x="844550" y="784225"/>
                </a:lnTo>
                <a:lnTo>
                  <a:pt x="873125" y="717550"/>
                </a:lnTo>
                <a:lnTo>
                  <a:pt x="895350" y="644525"/>
                </a:lnTo>
                <a:lnTo>
                  <a:pt x="911225" y="590550"/>
                </a:lnTo>
                <a:lnTo>
                  <a:pt x="923925" y="539750"/>
                </a:lnTo>
                <a:lnTo>
                  <a:pt x="955675" y="492125"/>
                </a:lnTo>
                <a:lnTo>
                  <a:pt x="968375" y="454025"/>
                </a:lnTo>
                <a:lnTo>
                  <a:pt x="977900" y="400050"/>
                </a:lnTo>
                <a:lnTo>
                  <a:pt x="984250" y="342900"/>
                </a:lnTo>
                <a:lnTo>
                  <a:pt x="984250" y="257175"/>
                </a:lnTo>
                <a:lnTo>
                  <a:pt x="996950" y="146050"/>
                </a:lnTo>
                <a:lnTo>
                  <a:pt x="1003300" y="57150"/>
                </a:lnTo>
                <a:lnTo>
                  <a:pt x="1025525" y="76200"/>
                </a:lnTo>
                <a:lnTo>
                  <a:pt x="1041400" y="0"/>
                </a:lnTo>
                <a:lnTo>
                  <a:pt x="1060450" y="117475"/>
                </a:lnTo>
                <a:lnTo>
                  <a:pt x="1066800" y="228600"/>
                </a:lnTo>
                <a:lnTo>
                  <a:pt x="1076325" y="301625"/>
                </a:lnTo>
                <a:lnTo>
                  <a:pt x="1095375" y="368300"/>
                </a:lnTo>
                <a:lnTo>
                  <a:pt x="1117600" y="415925"/>
                </a:lnTo>
                <a:lnTo>
                  <a:pt x="1123950" y="523875"/>
                </a:lnTo>
                <a:lnTo>
                  <a:pt x="1139825" y="596900"/>
                </a:lnTo>
                <a:lnTo>
                  <a:pt x="1162050" y="647700"/>
                </a:lnTo>
                <a:lnTo>
                  <a:pt x="1174750" y="730250"/>
                </a:lnTo>
                <a:lnTo>
                  <a:pt x="1187450" y="781050"/>
                </a:lnTo>
                <a:lnTo>
                  <a:pt x="1209675" y="822325"/>
                </a:lnTo>
                <a:lnTo>
                  <a:pt x="1250950" y="838200"/>
                </a:lnTo>
                <a:lnTo>
                  <a:pt x="1263650" y="866775"/>
                </a:lnTo>
                <a:lnTo>
                  <a:pt x="1263650" y="86677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6" name="正方形/長方形 95">
            <a:extLst>
              <a:ext uri="{FF2B5EF4-FFF2-40B4-BE49-F238E27FC236}">
                <a16:creationId xmlns:a16="http://schemas.microsoft.com/office/drawing/2014/main" id="{9D4C3278-AFA0-4E46-9FA0-7201FFDE8223}"/>
              </a:ext>
            </a:extLst>
          </p:cNvPr>
          <p:cNvSpPr/>
          <p:nvPr/>
        </p:nvSpPr>
        <p:spPr>
          <a:xfrm>
            <a:off x="2606777" y="649795"/>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7" name="正方形/長方形 96">
            <a:extLst>
              <a:ext uri="{FF2B5EF4-FFF2-40B4-BE49-F238E27FC236}">
                <a16:creationId xmlns:a16="http://schemas.microsoft.com/office/drawing/2014/main" id="{A0CF5D0E-0B27-514A-B443-93EAFFD2C151}"/>
              </a:ext>
            </a:extLst>
          </p:cNvPr>
          <p:cNvSpPr/>
          <p:nvPr/>
        </p:nvSpPr>
        <p:spPr>
          <a:xfrm>
            <a:off x="4272463" y="649796"/>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8" name="フリーフォーム 97">
            <a:extLst>
              <a:ext uri="{FF2B5EF4-FFF2-40B4-BE49-F238E27FC236}">
                <a16:creationId xmlns:a16="http://schemas.microsoft.com/office/drawing/2014/main" id="{B7569D11-6039-9F4C-BC44-E3470E4C0115}"/>
              </a:ext>
            </a:extLst>
          </p:cNvPr>
          <p:cNvSpPr/>
          <p:nvPr/>
        </p:nvSpPr>
        <p:spPr>
          <a:xfrm>
            <a:off x="5928224" y="1023750"/>
            <a:ext cx="1263650" cy="889000"/>
          </a:xfrm>
          <a:custGeom>
            <a:avLst/>
            <a:gdLst>
              <a:gd name="connsiteX0" fmla="*/ 0 w 1263650"/>
              <a:gd name="connsiteY0" fmla="*/ 885825 h 889000"/>
              <a:gd name="connsiteX1" fmla="*/ 12700 w 1263650"/>
              <a:gd name="connsiteY1" fmla="*/ 774700 h 889000"/>
              <a:gd name="connsiteX2" fmla="*/ 28575 w 1263650"/>
              <a:gd name="connsiteY2" fmla="*/ 609600 h 889000"/>
              <a:gd name="connsiteX3" fmla="*/ 34925 w 1263650"/>
              <a:gd name="connsiteY3" fmla="*/ 492125 h 889000"/>
              <a:gd name="connsiteX4" fmla="*/ 41275 w 1263650"/>
              <a:gd name="connsiteY4" fmla="*/ 377825 h 889000"/>
              <a:gd name="connsiteX5" fmla="*/ 47625 w 1263650"/>
              <a:gd name="connsiteY5" fmla="*/ 298450 h 889000"/>
              <a:gd name="connsiteX6" fmla="*/ 73025 w 1263650"/>
              <a:gd name="connsiteY6" fmla="*/ 238125 h 889000"/>
              <a:gd name="connsiteX7" fmla="*/ 85725 w 1263650"/>
              <a:gd name="connsiteY7" fmla="*/ 219075 h 889000"/>
              <a:gd name="connsiteX8" fmla="*/ 92075 w 1263650"/>
              <a:gd name="connsiteY8" fmla="*/ 174625 h 889000"/>
              <a:gd name="connsiteX9" fmla="*/ 98425 w 1263650"/>
              <a:gd name="connsiteY9" fmla="*/ 155575 h 889000"/>
              <a:gd name="connsiteX10" fmla="*/ 117475 w 1263650"/>
              <a:gd name="connsiteY10" fmla="*/ 127000 h 889000"/>
              <a:gd name="connsiteX11" fmla="*/ 136525 w 1263650"/>
              <a:gd name="connsiteY11" fmla="*/ 0 h 889000"/>
              <a:gd name="connsiteX12" fmla="*/ 146050 w 1263650"/>
              <a:gd name="connsiteY12" fmla="*/ 82550 h 889000"/>
              <a:gd name="connsiteX13" fmla="*/ 158750 w 1263650"/>
              <a:gd name="connsiteY13" fmla="*/ 69850 h 889000"/>
              <a:gd name="connsiteX14" fmla="*/ 180975 w 1263650"/>
              <a:gd name="connsiteY14" fmla="*/ 165100 h 889000"/>
              <a:gd name="connsiteX15" fmla="*/ 200025 w 1263650"/>
              <a:gd name="connsiteY15" fmla="*/ 288925 h 889000"/>
              <a:gd name="connsiteX16" fmla="*/ 222250 w 1263650"/>
              <a:gd name="connsiteY16" fmla="*/ 381000 h 889000"/>
              <a:gd name="connsiteX17" fmla="*/ 238125 w 1263650"/>
              <a:gd name="connsiteY17" fmla="*/ 530225 h 889000"/>
              <a:gd name="connsiteX18" fmla="*/ 263525 w 1263650"/>
              <a:gd name="connsiteY18" fmla="*/ 679450 h 889000"/>
              <a:gd name="connsiteX19" fmla="*/ 298450 w 1263650"/>
              <a:gd name="connsiteY19" fmla="*/ 765175 h 889000"/>
              <a:gd name="connsiteX20" fmla="*/ 339725 w 1263650"/>
              <a:gd name="connsiteY20" fmla="*/ 793750 h 889000"/>
              <a:gd name="connsiteX21" fmla="*/ 371475 w 1263650"/>
              <a:gd name="connsiteY21" fmla="*/ 800100 h 889000"/>
              <a:gd name="connsiteX22" fmla="*/ 400050 w 1263650"/>
              <a:gd name="connsiteY22" fmla="*/ 819150 h 889000"/>
              <a:gd name="connsiteX23" fmla="*/ 425450 w 1263650"/>
              <a:gd name="connsiteY23" fmla="*/ 803275 h 889000"/>
              <a:gd name="connsiteX24" fmla="*/ 447675 w 1263650"/>
              <a:gd name="connsiteY24" fmla="*/ 812800 h 889000"/>
              <a:gd name="connsiteX25" fmla="*/ 469900 w 1263650"/>
              <a:gd name="connsiteY25" fmla="*/ 825500 h 889000"/>
              <a:gd name="connsiteX26" fmla="*/ 498475 w 1263650"/>
              <a:gd name="connsiteY26" fmla="*/ 825500 h 889000"/>
              <a:gd name="connsiteX27" fmla="*/ 520700 w 1263650"/>
              <a:gd name="connsiteY27" fmla="*/ 803275 h 889000"/>
              <a:gd name="connsiteX28" fmla="*/ 549275 w 1263650"/>
              <a:gd name="connsiteY28" fmla="*/ 806450 h 889000"/>
              <a:gd name="connsiteX29" fmla="*/ 600075 w 1263650"/>
              <a:gd name="connsiteY29" fmla="*/ 806450 h 889000"/>
              <a:gd name="connsiteX30" fmla="*/ 647700 w 1263650"/>
              <a:gd name="connsiteY30" fmla="*/ 762000 h 889000"/>
              <a:gd name="connsiteX31" fmla="*/ 685800 w 1263650"/>
              <a:gd name="connsiteY31" fmla="*/ 755650 h 889000"/>
              <a:gd name="connsiteX32" fmla="*/ 701675 w 1263650"/>
              <a:gd name="connsiteY32" fmla="*/ 777875 h 889000"/>
              <a:gd name="connsiteX33" fmla="*/ 733425 w 1263650"/>
              <a:gd name="connsiteY33" fmla="*/ 777875 h 889000"/>
              <a:gd name="connsiteX34" fmla="*/ 765175 w 1263650"/>
              <a:gd name="connsiteY34" fmla="*/ 768350 h 889000"/>
              <a:gd name="connsiteX35" fmla="*/ 790575 w 1263650"/>
              <a:gd name="connsiteY35" fmla="*/ 768350 h 889000"/>
              <a:gd name="connsiteX36" fmla="*/ 809625 w 1263650"/>
              <a:gd name="connsiteY36" fmla="*/ 774700 h 889000"/>
              <a:gd name="connsiteX37" fmla="*/ 825500 w 1263650"/>
              <a:gd name="connsiteY37" fmla="*/ 803275 h 889000"/>
              <a:gd name="connsiteX38" fmla="*/ 841375 w 1263650"/>
              <a:gd name="connsiteY38" fmla="*/ 835025 h 889000"/>
              <a:gd name="connsiteX39" fmla="*/ 866775 w 1263650"/>
              <a:gd name="connsiteY39" fmla="*/ 847725 h 889000"/>
              <a:gd name="connsiteX40" fmla="*/ 901700 w 1263650"/>
              <a:gd name="connsiteY40" fmla="*/ 847725 h 889000"/>
              <a:gd name="connsiteX41" fmla="*/ 930275 w 1263650"/>
              <a:gd name="connsiteY41" fmla="*/ 863600 h 889000"/>
              <a:gd name="connsiteX42" fmla="*/ 946150 w 1263650"/>
              <a:gd name="connsiteY42" fmla="*/ 876300 h 889000"/>
              <a:gd name="connsiteX43" fmla="*/ 987425 w 1263650"/>
              <a:gd name="connsiteY43" fmla="*/ 876300 h 889000"/>
              <a:gd name="connsiteX44" fmla="*/ 1000125 w 1263650"/>
              <a:gd name="connsiteY44" fmla="*/ 885825 h 889000"/>
              <a:gd name="connsiteX45" fmla="*/ 1263650 w 1263650"/>
              <a:gd name="connsiteY45" fmla="*/ 885825 h 889000"/>
              <a:gd name="connsiteX46" fmla="*/ 1263650 w 1263650"/>
              <a:gd name="connsiteY46" fmla="*/ 889000 h 889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1263650" h="889000">
                <a:moveTo>
                  <a:pt x="0" y="885825"/>
                </a:moveTo>
                <a:lnTo>
                  <a:pt x="12700" y="774700"/>
                </a:lnTo>
                <a:lnTo>
                  <a:pt x="28575" y="609600"/>
                </a:lnTo>
                <a:lnTo>
                  <a:pt x="34925" y="492125"/>
                </a:lnTo>
                <a:lnTo>
                  <a:pt x="41275" y="377825"/>
                </a:lnTo>
                <a:lnTo>
                  <a:pt x="47625" y="298450"/>
                </a:lnTo>
                <a:lnTo>
                  <a:pt x="73025" y="238125"/>
                </a:lnTo>
                <a:lnTo>
                  <a:pt x="85725" y="219075"/>
                </a:lnTo>
                <a:lnTo>
                  <a:pt x="92075" y="174625"/>
                </a:lnTo>
                <a:lnTo>
                  <a:pt x="98425" y="155575"/>
                </a:lnTo>
                <a:lnTo>
                  <a:pt x="117475" y="127000"/>
                </a:lnTo>
                <a:lnTo>
                  <a:pt x="136525" y="0"/>
                </a:lnTo>
                <a:lnTo>
                  <a:pt x="146050" y="82550"/>
                </a:lnTo>
                <a:lnTo>
                  <a:pt x="158750" y="69850"/>
                </a:lnTo>
                <a:lnTo>
                  <a:pt x="180975" y="165100"/>
                </a:lnTo>
                <a:lnTo>
                  <a:pt x="200025" y="288925"/>
                </a:lnTo>
                <a:lnTo>
                  <a:pt x="222250" y="381000"/>
                </a:lnTo>
                <a:lnTo>
                  <a:pt x="238125" y="530225"/>
                </a:lnTo>
                <a:lnTo>
                  <a:pt x="263525" y="679450"/>
                </a:lnTo>
                <a:lnTo>
                  <a:pt x="298450" y="765175"/>
                </a:lnTo>
                <a:lnTo>
                  <a:pt x="339725" y="793750"/>
                </a:lnTo>
                <a:lnTo>
                  <a:pt x="371475" y="800100"/>
                </a:lnTo>
                <a:lnTo>
                  <a:pt x="400050" y="819150"/>
                </a:lnTo>
                <a:lnTo>
                  <a:pt x="425450" y="803275"/>
                </a:lnTo>
                <a:lnTo>
                  <a:pt x="447675" y="812800"/>
                </a:lnTo>
                <a:lnTo>
                  <a:pt x="469900" y="825500"/>
                </a:lnTo>
                <a:lnTo>
                  <a:pt x="498475" y="825500"/>
                </a:lnTo>
                <a:lnTo>
                  <a:pt x="520700" y="803275"/>
                </a:lnTo>
                <a:lnTo>
                  <a:pt x="549275" y="806450"/>
                </a:lnTo>
                <a:lnTo>
                  <a:pt x="600075" y="806450"/>
                </a:lnTo>
                <a:lnTo>
                  <a:pt x="647700" y="762000"/>
                </a:lnTo>
                <a:lnTo>
                  <a:pt x="685800" y="755650"/>
                </a:lnTo>
                <a:lnTo>
                  <a:pt x="701675" y="777875"/>
                </a:lnTo>
                <a:lnTo>
                  <a:pt x="733425" y="777875"/>
                </a:lnTo>
                <a:lnTo>
                  <a:pt x="765175" y="768350"/>
                </a:lnTo>
                <a:lnTo>
                  <a:pt x="790575" y="768350"/>
                </a:lnTo>
                <a:lnTo>
                  <a:pt x="809625" y="774700"/>
                </a:lnTo>
                <a:lnTo>
                  <a:pt x="825500" y="803275"/>
                </a:lnTo>
                <a:lnTo>
                  <a:pt x="841375" y="835025"/>
                </a:lnTo>
                <a:lnTo>
                  <a:pt x="866775" y="847725"/>
                </a:lnTo>
                <a:lnTo>
                  <a:pt x="901700" y="847725"/>
                </a:lnTo>
                <a:lnTo>
                  <a:pt x="930275" y="863600"/>
                </a:lnTo>
                <a:lnTo>
                  <a:pt x="946150" y="876300"/>
                </a:lnTo>
                <a:lnTo>
                  <a:pt x="987425" y="876300"/>
                </a:lnTo>
                <a:lnTo>
                  <a:pt x="1000125" y="885825"/>
                </a:lnTo>
                <a:lnTo>
                  <a:pt x="1263650" y="885825"/>
                </a:lnTo>
                <a:lnTo>
                  <a:pt x="1263650" y="88900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99" name="フリーフォーム 98">
            <a:extLst>
              <a:ext uri="{FF2B5EF4-FFF2-40B4-BE49-F238E27FC236}">
                <a16:creationId xmlns:a16="http://schemas.microsoft.com/office/drawing/2014/main" id="{A1E13D67-F52C-6A41-94D1-C4CCF30F0576}"/>
              </a:ext>
            </a:extLst>
          </p:cNvPr>
          <p:cNvSpPr/>
          <p:nvPr/>
        </p:nvSpPr>
        <p:spPr>
          <a:xfrm>
            <a:off x="5928224" y="1004700"/>
            <a:ext cx="1263650" cy="911225"/>
          </a:xfrm>
          <a:custGeom>
            <a:avLst/>
            <a:gdLst>
              <a:gd name="connsiteX0" fmla="*/ 0 w 1263650"/>
              <a:gd name="connsiteY0" fmla="*/ 904875 h 911225"/>
              <a:gd name="connsiteX1" fmla="*/ 542925 w 1263650"/>
              <a:gd name="connsiteY1" fmla="*/ 904875 h 911225"/>
              <a:gd name="connsiteX2" fmla="*/ 584200 w 1263650"/>
              <a:gd name="connsiteY2" fmla="*/ 889000 h 911225"/>
              <a:gd name="connsiteX3" fmla="*/ 644525 w 1263650"/>
              <a:gd name="connsiteY3" fmla="*/ 898525 h 911225"/>
              <a:gd name="connsiteX4" fmla="*/ 701675 w 1263650"/>
              <a:gd name="connsiteY4" fmla="*/ 876300 h 911225"/>
              <a:gd name="connsiteX5" fmla="*/ 727075 w 1263650"/>
              <a:gd name="connsiteY5" fmla="*/ 841375 h 911225"/>
              <a:gd name="connsiteX6" fmla="*/ 742950 w 1263650"/>
              <a:gd name="connsiteY6" fmla="*/ 819150 h 911225"/>
              <a:gd name="connsiteX7" fmla="*/ 806450 w 1263650"/>
              <a:gd name="connsiteY7" fmla="*/ 819150 h 911225"/>
              <a:gd name="connsiteX8" fmla="*/ 835025 w 1263650"/>
              <a:gd name="connsiteY8" fmla="*/ 787400 h 911225"/>
              <a:gd name="connsiteX9" fmla="*/ 860425 w 1263650"/>
              <a:gd name="connsiteY9" fmla="*/ 736600 h 911225"/>
              <a:gd name="connsiteX10" fmla="*/ 889000 w 1263650"/>
              <a:gd name="connsiteY10" fmla="*/ 654050 h 911225"/>
              <a:gd name="connsiteX11" fmla="*/ 914400 w 1263650"/>
              <a:gd name="connsiteY11" fmla="*/ 530225 h 911225"/>
              <a:gd name="connsiteX12" fmla="*/ 920750 w 1263650"/>
              <a:gd name="connsiteY12" fmla="*/ 469900 h 911225"/>
              <a:gd name="connsiteX13" fmla="*/ 955675 w 1263650"/>
              <a:gd name="connsiteY13" fmla="*/ 390525 h 911225"/>
              <a:gd name="connsiteX14" fmla="*/ 971550 w 1263650"/>
              <a:gd name="connsiteY14" fmla="*/ 276225 h 911225"/>
              <a:gd name="connsiteX15" fmla="*/ 981075 w 1263650"/>
              <a:gd name="connsiteY15" fmla="*/ 123825 h 911225"/>
              <a:gd name="connsiteX16" fmla="*/ 987425 w 1263650"/>
              <a:gd name="connsiteY16" fmla="*/ 57150 h 911225"/>
              <a:gd name="connsiteX17" fmla="*/ 987425 w 1263650"/>
              <a:gd name="connsiteY17" fmla="*/ 28575 h 911225"/>
              <a:gd name="connsiteX18" fmla="*/ 1006475 w 1263650"/>
              <a:gd name="connsiteY18" fmla="*/ 0 h 911225"/>
              <a:gd name="connsiteX19" fmla="*/ 1031875 w 1263650"/>
              <a:gd name="connsiteY19" fmla="*/ 95250 h 911225"/>
              <a:gd name="connsiteX20" fmla="*/ 1050925 w 1263650"/>
              <a:gd name="connsiteY20" fmla="*/ 22225 h 911225"/>
              <a:gd name="connsiteX21" fmla="*/ 1063625 w 1263650"/>
              <a:gd name="connsiteY21" fmla="*/ 180975 h 911225"/>
              <a:gd name="connsiteX22" fmla="*/ 1079500 w 1263650"/>
              <a:gd name="connsiteY22" fmla="*/ 330200 h 911225"/>
              <a:gd name="connsiteX23" fmla="*/ 1098550 w 1263650"/>
              <a:gd name="connsiteY23" fmla="*/ 511175 h 911225"/>
              <a:gd name="connsiteX24" fmla="*/ 1120775 w 1263650"/>
              <a:gd name="connsiteY24" fmla="*/ 692150 h 911225"/>
              <a:gd name="connsiteX25" fmla="*/ 1133475 w 1263650"/>
              <a:gd name="connsiteY25" fmla="*/ 803275 h 911225"/>
              <a:gd name="connsiteX26" fmla="*/ 1165225 w 1263650"/>
              <a:gd name="connsiteY26" fmla="*/ 873125 h 911225"/>
              <a:gd name="connsiteX27" fmla="*/ 1206500 w 1263650"/>
              <a:gd name="connsiteY27" fmla="*/ 892175 h 911225"/>
              <a:gd name="connsiteX28" fmla="*/ 1263650 w 1263650"/>
              <a:gd name="connsiteY28" fmla="*/ 911225 h 911225"/>
              <a:gd name="connsiteX29" fmla="*/ 1263650 w 1263650"/>
              <a:gd name="connsiteY29" fmla="*/ 911225 h 9112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Lst>
            <a:rect l="l" t="t" r="r" b="b"/>
            <a:pathLst>
              <a:path w="1263650" h="911225">
                <a:moveTo>
                  <a:pt x="0" y="904875"/>
                </a:moveTo>
                <a:lnTo>
                  <a:pt x="542925" y="904875"/>
                </a:lnTo>
                <a:lnTo>
                  <a:pt x="584200" y="889000"/>
                </a:lnTo>
                <a:lnTo>
                  <a:pt x="644525" y="898525"/>
                </a:lnTo>
                <a:lnTo>
                  <a:pt x="701675" y="876300"/>
                </a:lnTo>
                <a:lnTo>
                  <a:pt x="727075" y="841375"/>
                </a:lnTo>
                <a:lnTo>
                  <a:pt x="742950" y="819150"/>
                </a:lnTo>
                <a:lnTo>
                  <a:pt x="806450" y="819150"/>
                </a:lnTo>
                <a:lnTo>
                  <a:pt x="835025" y="787400"/>
                </a:lnTo>
                <a:lnTo>
                  <a:pt x="860425" y="736600"/>
                </a:lnTo>
                <a:lnTo>
                  <a:pt x="889000" y="654050"/>
                </a:lnTo>
                <a:lnTo>
                  <a:pt x="914400" y="530225"/>
                </a:lnTo>
                <a:lnTo>
                  <a:pt x="920750" y="469900"/>
                </a:lnTo>
                <a:lnTo>
                  <a:pt x="955675" y="390525"/>
                </a:lnTo>
                <a:lnTo>
                  <a:pt x="971550" y="276225"/>
                </a:lnTo>
                <a:lnTo>
                  <a:pt x="981075" y="123825"/>
                </a:lnTo>
                <a:lnTo>
                  <a:pt x="987425" y="57150"/>
                </a:lnTo>
                <a:lnTo>
                  <a:pt x="987425" y="28575"/>
                </a:lnTo>
                <a:lnTo>
                  <a:pt x="1006475" y="0"/>
                </a:lnTo>
                <a:lnTo>
                  <a:pt x="1031875" y="95250"/>
                </a:lnTo>
                <a:lnTo>
                  <a:pt x="1050925" y="22225"/>
                </a:lnTo>
                <a:lnTo>
                  <a:pt x="1063625" y="180975"/>
                </a:lnTo>
                <a:lnTo>
                  <a:pt x="1079500" y="330200"/>
                </a:lnTo>
                <a:lnTo>
                  <a:pt x="1098550" y="511175"/>
                </a:lnTo>
                <a:lnTo>
                  <a:pt x="1120775" y="692150"/>
                </a:lnTo>
                <a:lnTo>
                  <a:pt x="1133475" y="803275"/>
                </a:lnTo>
                <a:lnTo>
                  <a:pt x="1165225" y="873125"/>
                </a:lnTo>
                <a:lnTo>
                  <a:pt x="1206500" y="892175"/>
                </a:lnTo>
                <a:lnTo>
                  <a:pt x="1263650" y="911225"/>
                </a:lnTo>
                <a:lnTo>
                  <a:pt x="1263650" y="91122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0" name="正方形/長方形 99">
            <a:extLst>
              <a:ext uri="{FF2B5EF4-FFF2-40B4-BE49-F238E27FC236}">
                <a16:creationId xmlns:a16="http://schemas.microsoft.com/office/drawing/2014/main" id="{44AC0CCA-C46E-7345-832C-1B6812E5492A}"/>
              </a:ext>
            </a:extLst>
          </p:cNvPr>
          <p:cNvSpPr/>
          <p:nvPr/>
        </p:nvSpPr>
        <p:spPr>
          <a:xfrm>
            <a:off x="5922845" y="652030"/>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1" name="フリーフォーム 100">
            <a:extLst>
              <a:ext uri="{FF2B5EF4-FFF2-40B4-BE49-F238E27FC236}">
                <a16:creationId xmlns:a16="http://schemas.microsoft.com/office/drawing/2014/main" id="{C01BAE93-BDA4-054F-A2A0-A447AFF506B9}"/>
              </a:ext>
            </a:extLst>
          </p:cNvPr>
          <p:cNvSpPr/>
          <p:nvPr/>
        </p:nvSpPr>
        <p:spPr>
          <a:xfrm>
            <a:off x="7585574" y="1153926"/>
            <a:ext cx="1263650" cy="752475"/>
          </a:xfrm>
          <a:custGeom>
            <a:avLst/>
            <a:gdLst>
              <a:gd name="connsiteX0" fmla="*/ 0 w 1263650"/>
              <a:gd name="connsiteY0" fmla="*/ 752475 h 752475"/>
              <a:gd name="connsiteX1" fmla="*/ 3175 w 1263650"/>
              <a:gd name="connsiteY1" fmla="*/ 666750 h 752475"/>
              <a:gd name="connsiteX2" fmla="*/ 12700 w 1263650"/>
              <a:gd name="connsiteY2" fmla="*/ 581025 h 752475"/>
              <a:gd name="connsiteX3" fmla="*/ 22225 w 1263650"/>
              <a:gd name="connsiteY3" fmla="*/ 466725 h 752475"/>
              <a:gd name="connsiteX4" fmla="*/ 28575 w 1263650"/>
              <a:gd name="connsiteY4" fmla="*/ 346075 h 752475"/>
              <a:gd name="connsiteX5" fmla="*/ 34925 w 1263650"/>
              <a:gd name="connsiteY5" fmla="*/ 257175 h 752475"/>
              <a:gd name="connsiteX6" fmla="*/ 41275 w 1263650"/>
              <a:gd name="connsiteY6" fmla="*/ 203200 h 752475"/>
              <a:gd name="connsiteX7" fmla="*/ 53975 w 1263650"/>
              <a:gd name="connsiteY7" fmla="*/ 158750 h 752475"/>
              <a:gd name="connsiteX8" fmla="*/ 82550 w 1263650"/>
              <a:gd name="connsiteY8" fmla="*/ 215900 h 752475"/>
              <a:gd name="connsiteX9" fmla="*/ 92075 w 1263650"/>
              <a:gd name="connsiteY9" fmla="*/ 95250 h 752475"/>
              <a:gd name="connsiteX10" fmla="*/ 104775 w 1263650"/>
              <a:gd name="connsiteY10" fmla="*/ 111125 h 752475"/>
              <a:gd name="connsiteX11" fmla="*/ 127000 w 1263650"/>
              <a:gd name="connsiteY11" fmla="*/ 98425 h 752475"/>
              <a:gd name="connsiteX12" fmla="*/ 142875 w 1263650"/>
              <a:gd name="connsiteY12" fmla="*/ 120650 h 752475"/>
              <a:gd name="connsiteX13" fmla="*/ 165100 w 1263650"/>
              <a:gd name="connsiteY13" fmla="*/ 0 h 752475"/>
              <a:gd name="connsiteX14" fmla="*/ 177800 w 1263650"/>
              <a:gd name="connsiteY14" fmla="*/ 139700 h 752475"/>
              <a:gd name="connsiteX15" fmla="*/ 177800 w 1263650"/>
              <a:gd name="connsiteY15" fmla="*/ 254000 h 752475"/>
              <a:gd name="connsiteX16" fmla="*/ 206375 w 1263650"/>
              <a:gd name="connsiteY16" fmla="*/ 355600 h 752475"/>
              <a:gd name="connsiteX17" fmla="*/ 228600 w 1263650"/>
              <a:gd name="connsiteY17" fmla="*/ 469900 h 752475"/>
              <a:gd name="connsiteX18" fmla="*/ 266700 w 1263650"/>
              <a:gd name="connsiteY18" fmla="*/ 596900 h 752475"/>
              <a:gd name="connsiteX19" fmla="*/ 301625 w 1263650"/>
              <a:gd name="connsiteY19" fmla="*/ 666750 h 752475"/>
              <a:gd name="connsiteX20" fmla="*/ 317500 w 1263650"/>
              <a:gd name="connsiteY20" fmla="*/ 704850 h 752475"/>
              <a:gd name="connsiteX21" fmla="*/ 396875 w 1263650"/>
              <a:gd name="connsiteY21" fmla="*/ 720725 h 752475"/>
              <a:gd name="connsiteX22" fmla="*/ 488950 w 1263650"/>
              <a:gd name="connsiteY22" fmla="*/ 685800 h 752475"/>
              <a:gd name="connsiteX23" fmla="*/ 527050 w 1263650"/>
              <a:gd name="connsiteY23" fmla="*/ 688975 h 752475"/>
              <a:gd name="connsiteX24" fmla="*/ 571500 w 1263650"/>
              <a:gd name="connsiteY24" fmla="*/ 679450 h 752475"/>
              <a:gd name="connsiteX25" fmla="*/ 590550 w 1263650"/>
              <a:gd name="connsiteY25" fmla="*/ 666750 h 752475"/>
              <a:gd name="connsiteX26" fmla="*/ 590550 w 1263650"/>
              <a:gd name="connsiteY26" fmla="*/ 666750 h 752475"/>
              <a:gd name="connsiteX27" fmla="*/ 641350 w 1263650"/>
              <a:gd name="connsiteY27" fmla="*/ 650875 h 752475"/>
              <a:gd name="connsiteX28" fmla="*/ 673100 w 1263650"/>
              <a:gd name="connsiteY28" fmla="*/ 682625 h 752475"/>
              <a:gd name="connsiteX29" fmla="*/ 720725 w 1263650"/>
              <a:gd name="connsiteY29" fmla="*/ 654050 h 752475"/>
              <a:gd name="connsiteX30" fmla="*/ 755650 w 1263650"/>
              <a:gd name="connsiteY30" fmla="*/ 673100 h 752475"/>
              <a:gd name="connsiteX31" fmla="*/ 787400 w 1263650"/>
              <a:gd name="connsiteY31" fmla="*/ 660400 h 752475"/>
              <a:gd name="connsiteX32" fmla="*/ 825500 w 1263650"/>
              <a:gd name="connsiteY32" fmla="*/ 688975 h 752475"/>
              <a:gd name="connsiteX33" fmla="*/ 863600 w 1263650"/>
              <a:gd name="connsiteY33" fmla="*/ 717550 h 752475"/>
              <a:gd name="connsiteX34" fmla="*/ 898525 w 1263650"/>
              <a:gd name="connsiteY34" fmla="*/ 723900 h 752475"/>
              <a:gd name="connsiteX35" fmla="*/ 927100 w 1263650"/>
              <a:gd name="connsiteY35" fmla="*/ 733425 h 752475"/>
              <a:gd name="connsiteX36" fmla="*/ 990600 w 1263650"/>
              <a:gd name="connsiteY36" fmla="*/ 752475 h 752475"/>
              <a:gd name="connsiteX37" fmla="*/ 1263650 w 1263650"/>
              <a:gd name="connsiteY37" fmla="*/ 752475 h 7524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263650" h="752475">
                <a:moveTo>
                  <a:pt x="0" y="752475"/>
                </a:moveTo>
                <a:lnTo>
                  <a:pt x="3175" y="666750"/>
                </a:lnTo>
                <a:lnTo>
                  <a:pt x="12700" y="581025"/>
                </a:lnTo>
                <a:lnTo>
                  <a:pt x="22225" y="466725"/>
                </a:lnTo>
                <a:lnTo>
                  <a:pt x="28575" y="346075"/>
                </a:lnTo>
                <a:lnTo>
                  <a:pt x="34925" y="257175"/>
                </a:lnTo>
                <a:lnTo>
                  <a:pt x="41275" y="203200"/>
                </a:lnTo>
                <a:lnTo>
                  <a:pt x="53975" y="158750"/>
                </a:lnTo>
                <a:lnTo>
                  <a:pt x="82550" y="215900"/>
                </a:lnTo>
                <a:lnTo>
                  <a:pt x="92075" y="95250"/>
                </a:lnTo>
                <a:lnTo>
                  <a:pt x="104775" y="111125"/>
                </a:lnTo>
                <a:lnTo>
                  <a:pt x="127000" y="98425"/>
                </a:lnTo>
                <a:lnTo>
                  <a:pt x="142875" y="120650"/>
                </a:lnTo>
                <a:lnTo>
                  <a:pt x="165100" y="0"/>
                </a:lnTo>
                <a:lnTo>
                  <a:pt x="177800" y="139700"/>
                </a:lnTo>
                <a:lnTo>
                  <a:pt x="177800" y="254000"/>
                </a:lnTo>
                <a:lnTo>
                  <a:pt x="206375" y="355600"/>
                </a:lnTo>
                <a:lnTo>
                  <a:pt x="228600" y="469900"/>
                </a:lnTo>
                <a:lnTo>
                  <a:pt x="266700" y="596900"/>
                </a:lnTo>
                <a:lnTo>
                  <a:pt x="301625" y="666750"/>
                </a:lnTo>
                <a:lnTo>
                  <a:pt x="317500" y="704850"/>
                </a:lnTo>
                <a:lnTo>
                  <a:pt x="396875" y="720725"/>
                </a:lnTo>
                <a:lnTo>
                  <a:pt x="488950" y="685800"/>
                </a:lnTo>
                <a:lnTo>
                  <a:pt x="527050" y="688975"/>
                </a:lnTo>
                <a:lnTo>
                  <a:pt x="571500" y="679450"/>
                </a:lnTo>
                <a:lnTo>
                  <a:pt x="590550" y="666750"/>
                </a:lnTo>
                <a:lnTo>
                  <a:pt x="590550" y="666750"/>
                </a:lnTo>
                <a:lnTo>
                  <a:pt x="641350" y="650875"/>
                </a:lnTo>
                <a:lnTo>
                  <a:pt x="673100" y="682625"/>
                </a:lnTo>
                <a:lnTo>
                  <a:pt x="720725" y="654050"/>
                </a:lnTo>
                <a:lnTo>
                  <a:pt x="755650" y="673100"/>
                </a:lnTo>
                <a:lnTo>
                  <a:pt x="787400" y="660400"/>
                </a:lnTo>
                <a:lnTo>
                  <a:pt x="825500" y="688975"/>
                </a:lnTo>
                <a:lnTo>
                  <a:pt x="863600" y="717550"/>
                </a:lnTo>
                <a:lnTo>
                  <a:pt x="898525" y="723900"/>
                </a:lnTo>
                <a:lnTo>
                  <a:pt x="927100" y="733425"/>
                </a:lnTo>
                <a:lnTo>
                  <a:pt x="990600" y="752475"/>
                </a:lnTo>
                <a:lnTo>
                  <a:pt x="1263650" y="75247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2" name="フリーフォーム 101">
            <a:extLst>
              <a:ext uri="{FF2B5EF4-FFF2-40B4-BE49-F238E27FC236}">
                <a16:creationId xmlns:a16="http://schemas.microsoft.com/office/drawing/2014/main" id="{66F83093-5843-F44C-B70C-0283A5CC150B}"/>
              </a:ext>
            </a:extLst>
          </p:cNvPr>
          <p:cNvSpPr/>
          <p:nvPr/>
        </p:nvSpPr>
        <p:spPr>
          <a:xfrm>
            <a:off x="7579225" y="798326"/>
            <a:ext cx="1266825" cy="1108075"/>
          </a:xfrm>
          <a:custGeom>
            <a:avLst/>
            <a:gdLst>
              <a:gd name="connsiteX0" fmla="*/ 0 w 1266825"/>
              <a:gd name="connsiteY0" fmla="*/ 1108075 h 1108075"/>
              <a:gd name="connsiteX1" fmla="*/ 587375 w 1266825"/>
              <a:gd name="connsiteY1" fmla="*/ 1108075 h 1108075"/>
              <a:gd name="connsiteX2" fmla="*/ 603250 w 1266825"/>
              <a:gd name="connsiteY2" fmla="*/ 1098550 h 1108075"/>
              <a:gd name="connsiteX3" fmla="*/ 654050 w 1266825"/>
              <a:gd name="connsiteY3" fmla="*/ 1098550 h 1108075"/>
              <a:gd name="connsiteX4" fmla="*/ 688975 w 1266825"/>
              <a:gd name="connsiteY4" fmla="*/ 1101725 h 1108075"/>
              <a:gd name="connsiteX5" fmla="*/ 720725 w 1266825"/>
              <a:gd name="connsiteY5" fmla="*/ 1082675 h 1108075"/>
              <a:gd name="connsiteX6" fmla="*/ 771525 w 1266825"/>
              <a:gd name="connsiteY6" fmla="*/ 1098550 h 1108075"/>
              <a:gd name="connsiteX7" fmla="*/ 819150 w 1266825"/>
              <a:gd name="connsiteY7" fmla="*/ 1063625 h 1108075"/>
              <a:gd name="connsiteX8" fmla="*/ 857250 w 1266825"/>
              <a:gd name="connsiteY8" fmla="*/ 996950 h 1108075"/>
              <a:gd name="connsiteX9" fmla="*/ 895350 w 1266825"/>
              <a:gd name="connsiteY9" fmla="*/ 876300 h 1108075"/>
              <a:gd name="connsiteX10" fmla="*/ 923925 w 1266825"/>
              <a:gd name="connsiteY10" fmla="*/ 768350 h 1108075"/>
              <a:gd name="connsiteX11" fmla="*/ 952500 w 1266825"/>
              <a:gd name="connsiteY11" fmla="*/ 723900 h 1108075"/>
              <a:gd name="connsiteX12" fmla="*/ 974725 w 1266825"/>
              <a:gd name="connsiteY12" fmla="*/ 466725 h 1108075"/>
              <a:gd name="connsiteX13" fmla="*/ 993775 w 1266825"/>
              <a:gd name="connsiteY13" fmla="*/ 285750 h 1108075"/>
              <a:gd name="connsiteX14" fmla="*/ 996950 w 1266825"/>
              <a:gd name="connsiteY14" fmla="*/ 117475 h 1108075"/>
              <a:gd name="connsiteX15" fmla="*/ 1009650 w 1266825"/>
              <a:gd name="connsiteY15" fmla="*/ 0 h 1108075"/>
              <a:gd name="connsiteX16" fmla="*/ 1028700 w 1266825"/>
              <a:gd name="connsiteY16" fmla="*/ 149225 h 1108075"/>
              <a:gd name="connsiteX17" fmla="*/ 1063625 w 1266825"/>
              <a:gd name="connsiteY17" fmla="*/ 38100 h 1108075"/>
              <a:gd name="connsiteX18" fmla="*/ 1082675 w 1266825"/>
              <a:gd name="connsiteY18" fmla="*/ 142875 h 1108075"/>
              <a:gd name="connsiteX19" fmla="*/ 1095375 w 1266825"/>
              <a:gd name="connsiteY19" fmla="*/ 301625 h 1108075"/>
              <a:gd name="connsiteX20" fmla="*/ 1098550 w 1266825"/>
              <a:gd name="connsiteY20" fmla="*/ 396875 h 1108075"/>
              <a:gd name="connsiteX21" fmla="*/ 1120775 w 1266825"/>
              <a:gd name="connsiteY21" fmla="*/ 454025 h 1108075"/>
              <a:gd name="connsiteX22" fmla="*/ 1130300 w 1266825"/>
              <a:gd name="connsiteY22" fmla="*/ 577850 h 1108075"/>
              <a:gd name="connsiteX23" fmla="*/ 1146175 w 1266825"/>
              <a:gd name="connsiteY23" fmla="*/ 758825 h 1108075"/>
              <a:gd name="connsiteX24" fmla="*/ 1158875 w 1266825"/>
              <a:gd name="connsiteY24" fmla="*/ 885825 h 1108075"/>
              <a:gd name="connsiteX25" fmla="*/ 1184275 w 1266825"/>
              <a:gd name="connsiteY25" fmla="*/ 981075 h 1108075"/>
              <a:gd name="connsiteX26" fmla="*/ 1206500 w 1266825"/>
              <a:gd name="connsiteY26" fmla="*/ 1047750 h 1108075"/>
              <a:gd name="connsiteX27" fmla="*/ 1250950 w 1266825"/>
              <a:gd name="connsiteY27" fmla="*/ 1101725 h 1108075"/>
              <a:gd name="connsiteX28" fmla="*/ 1266825 w 1266825"/>
              <a:gd name="connsiteY28" fmla="*/ 1108075 h 11080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1266825" h="1108075">
                <a:moveTo>
                  <a:pt x="0" y="1108075"/>
                </a:moveTo>
                <a:lnTo>
                  <a:pt x="587375" y="1108075"/>
                </a:lnTo>
                <a:lnTo>
                  <a:pt x="603250" y="1098550"/>
                </a:lnTo>
                <a:lnTo>
                  <a:pt x="654050" y="1098550"/>
                </a:lnTo>
                <a:lnTo>
                  <a:pt x="688975" y="1101725"/>
                </a:lnTo>
                <a:lnTo>
                  <a:pt x="720725" y="1082675"/>
                </a:lnTo>
                <a:lnTo>
                  <a:pt x="771525" y="1098550"/>
                </a:lnTo>
                <a:lnTo>
                  <a:pt x="819150" y="1063625"/>
                </a:lnTo>
                <a:lnTo>
                  <a:pt x="857250" y="996950"/>
                </a:lnTo>
                <a:lnTo>
                  <a:pt x="895350" y="876300"/>
                </a:lnTo>
                <a:lnTo>
                  <a:pt x="923925" y="768350"/>
                </a:lnTo>
                <a:lnTo>
                  <a:pt x="952500" y="723900"/>
                </a:lnTo>
                <a:lnTo>
                  <a:pt x="974725" y="466725"/>
                </a:lnTo>
                <a:lnTo>
                  <a:pt x="993775" y="285750"/>
                </a:lnTo>
                <a:cubicBezTo>
                  <a:pt x="994833" y="229658"/>
                  <a:pt x="995892" y="173567"/>
                  <a:pt x="996950" y="117475"/>
                </a:cubicBezTo>
                <a:lnTo>
                  <a:pt x="1009650" y="0"/>
                </a:lnTo>
                <a:lnTo>
                  <a:pt x="1028700" y="149225"/>
                </a:lnTo>
                <a:lnTo>
                  <a:pt x="1063625" y="38100"/>
                </a:lnTo>
                <a:lnTo>
                  <a:pt x="1082675" y="142875"/>
                </a:lnTo>
                <a:lnTo>
                  <a:pt x="1095375" y="301625"/>
                </a:lnTo>
                <a:lnTo>
                  <a:pt x="1098550" y="396875"/>
                </a:lnTo>
                <a:lnTo>
                  <a:pt x="1120775" y="454025"/>
                </a:lnTo>
                <a:lnTo>
                  <a:pt x="1130300" y="577850"/>
                </a:lnTo>
                <a:lnTo>
                  <a:pt x="1146175" y="758825"/>
                </a:lnTo>
                <a:lnTo>
                  <a:pt x="1158875" y="885825"/>
                </a:lnTo>
                <a:lnTo>
                  <a:pt x="1184275" y="981075"/>
                </a:lnTo>
                <a:lnTo>
                  <a:pt x="1206500" y="1047750"/>
                </a:lnTo>
                <a:lnTo>
                  <a:pt x="1250950" y="1101725"/>
                </a:lnTo>
                <a:lnTo>
                  <a:pt x="1266825" y="110807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3" name="正方形/長方形 102">
            <a:extLst>
              <a:ext uri="{FF2B5EF4-FFF2-40B4-BE49-F238E27FC236}">
                <a16:creationId xmlns:a16="http://schemas.microsoft.com/office/drawing/2014/main" id="{2FED9A50-D758-254A-BC91-2524FAA7641A}"/>
              </a:ext>
            </a:extLst>
          </p:cNvPr>
          <p:cNvSpPr/>
          <p:nvPr/>
        </p:nvSpPr>
        <p:spPr>
          <a:xfrm>
            <a:off x="7573317" y="643712"/>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4" name="フリーフォーム 103">
            <a:extLst>
              <a:ext uri="{FF2B5EF4-FFF2-40B4-BE49-F238E27FC236}">
                <a16:creationId xmlns:a16="http://schemas.microsoft.com/office/drawing/2014/main" id="{A77985F9-703E-464F-8682-C954A71BDA5C}"/>
              </a:ext>
            </a:extLst>
          </p:cNvPr>
          <p:cNvSpPr/>
          <p:nvPr/>
        </p:nvSpPr>
        <p:spPr>
          <a:xfrm>
            <a:off x="2613524" y="3024000"/>
            <a:ext cx="1260475" cy="495300"/>
          </a:xfrm>
          <a:custGeom>
            <a:avLst/>
            <a:gdLst>
              <a:gd name="connsiteX0" fmla="*/ 0 w 1260475"/>
              <a:gd name="connsiteY0" fmla="*/ 492125 h 495300"/>
              <a:gd name="connsiteX1" fmla="*/ 3175 w 1260475"/>
              <a:gd name="connsiteY1" fmla="*/ 428625 h 495300"/>
              <a:gd name="connsiteX2" fmla="*/ 15875 w 1260475"/>
              <a:gd name="connsiteY2" fmla="*/ 355600 h 495300"/>
              <a:gd name="connsiteX3" fmla="*/ 28575 w 1260475"/>
              <a:gd name="connsiteY3" fmla="*/ 247650 h 495300"/>
              <a:gd name="connsiteX4" fmla="*/ 41275 w 1260475"/>
              <a:gd name="connsiteY4" fmla="*/ 161925 h 495300"/>
              <a:gd name="connsiteX5" fmla="*/ 50800 w 1260475"/>
              <a:gd name="connsiteY5" fmla="*/ 101600 h 495300"/>
              <a:gd name="connsiteX6" fmla="*/ 76200 w 1260475"/>
              <a:gd name="connsiteY6" fmla="*/ 139700 h 495300"/>
              <a:gd name="connsiteX7" fmla="*/ 98425 w 1260475"/>
              <a:gd name="connsiteY7" fmla="*/ 0 h 495300"/>
              <a:gd name="connsiteX8" fmla="*/ 107950 w 1260475"/>
              <a:gd name="connsiteY8" fmla="*/ 47625 h 495300"/>
              <a:gd name="connsiteX9" fmla="*/ 120650 w 1260475"/>
              <a:gd name="connsiteY9" fmla="*/ 57150 h 495300"/>
              <a:gd name="connsiteX10" fmla="*/ 161925 w 1260475"/>
              <a:gd name="connsiteY10" fmla="*/ 41275 h 495300"/>
              <a:gd name="connsiteX11" fmla="*/ 174625 w 1260475"/>
              <a:gd name="connsiteY11" fmla="*/ 82550 h 495300"/>
              <a:gd name="connsiteX12" fmla="*/ 196850 w 1260475"/>
              <a:gd name="connsiteY12" fmla="*/ 225425 h 495300"/>
              <a:gd name="connsiteX13" fmla="*/ 206375 w 1260475"/>
              <a:gd name="connsiteY13" fmla="*/ 282575 h 495300"/>
              <a:gd name="connsiteX14" fmla="*/ 225425 w 1260475"/>
              <a:gd name="connsiteY14" fmla="*/ 342900 h 495300"/>
              <a:gd name="connsiteX15" fmla="*/ 250825 w 1260475"/>
              <a:gd name="connsiteY15" fmla="*/ 355600 h 495300"/>
              <a:gd name="connsiteX16" fmla="*/ 263525 w 1260475"/>
              <a:gd name="connsiteY16" fmla="*/ 387350 h 495300"/>
              <a:gd name="connsiteX17" fmla="*/ 282575 w 1260475"/>
              <a:gd name="connsiteY17" fmla="*/ 428625 h 495300"/>
              <a:gd name="connsiteX18" fmla="*/ 314325 w 1260475"/>
              <a:gd name="connsiteY18" fmla="*/ 444500 h 495300"/>
              <a:gd name="connsiteX19" fmla="*/ 346075 w 1260475"/>
              <a:gd name="connsiteY19" fmla="*/ 463550 h 495300"/>
              <a:gd name="connsiteX20" fmla="*/ 396875 w 1260475"/>
              <a:gd name="connsiteY20" fmla="*/ 444500 h 495300"/>
              <a:gd name="connsiteX21" fmla="*/ 434975 w 1260475"/>
              <a:gd name="connsiteY21" fmla="*/ 460375 h 495300"/>
              <a:gd name="connsiteX22" fmla="*/ 495300 w 1260475"/>
              <a:gd name="connsiteY22" fmla="*/ 450850 h 495300"/>
              <a:gd name="connsiteX23" fmla="*/ 530225 w 1260475"/>
              <a:gd name="connsiteY23" fmla="*/ 463550 h 495300"/>
              <a:gd name="connsiteX24" fmla="*/ 561975 w 1260475"/>
              <a:gd name="connsiteY24" fmla="*/ 457200 h 495300"/>
              <a:gd name="connsiteX25" fmla="*/ 622300 w 1260475"/>
              <a:gd name="connsiteY25" fmla="*/ 447675 h 495300"/>
              <a:gd name="connsiteX26" fmla="*/ 647700 w 1260475"/>
              <a:gd name="connsiteY26" fmla="*/ 428625 h 495300"/>
              <a:gd name="connsiteX27" fmla="*/ 673100 w 1260475"/>
              <a:gd name="connsiteY27" fmla="*/ 444500 h 495300"/>
              <a:gd name="connsiteX28" fmla="*/ 714375 w 1260475"/>
              <a:gd name="connsiteY28" fmla="*/ 434975 h 495300"/>
              <a:gd name="connsiteX29" fmla="*/ 739775 w 1260475"/>
              <a:gd name="connsiteY29" fmla="*/ 419100 h 495300"/>
              <a:gd name="connsiteX30" fmla="*/ 755650 w 1260475"/>
              <a:gd name="connsiteY30" fmla="*/ 419100 h 495300"/>
              <a:gd name="connsiteX31" fmla="*/ 774700 w 1260475"/>
              <a:gd name="connsiteY31" fmla="*/ 419100 h 495300"/>
              <a:gd name="connsiteX32" fmla="*/ 800100 w 1260475"/>
              <a:gd name="connsiteY32" fmla="*/ 434975 h 495300"/>
              <a:gd name="connsiteX33" fmla="*/ 838200 w 1260475"/>
              <a:gd name="connsiteY33" fmla="*/ 463550 h 495300"/>
              <a:gd name="connsiteX34" fmla="*/ 869950 w 1260475"/>
              <a:gd name="connsiteY34" fmla="*/ 476250 h 495300"/>
              <a:gd name="connsiteX35" fmla="*/ 914400 w 1260475"/>
              <a:gd name="connsiteY35" fmla="*/ 482600 h 495300"/>
              <a:gd name="connsiteX36" fmla="*/ 949325 w 1260475"/>
              <a:gd name="connsiteY36" fmla="*/ 485775 h 495300"/>
              <a:gd name="connsiteX37" fmla="*/ 958850 w 1260475"/>
              <a:gd name="connsiteY37" fmla="*/ 495300 h 495300"/>
              <a:gd name="connsiteX38" fmla="*/ 1260475 w 1260475"/>
              <a:gd name="connsiteY38" fmla="*/ 495300 h 495300"/>
              <a:gd name="connsiteX39" fmla="*/ 1260475 w 1260475"/>
              <a:gd name="connsiteY39" fmla="*/ 495300 h 4953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Lst>
            <a:rect l="l" t="t" r="r" b="b"/>
            <a:pathLst>
              <a:path w="1260475" h="495300">
                <a:moveTo>
                  <a:pt x="0" y="492125"/>
                </a:moveTo>
                <a:lnTo>
                  <a:pt x="3175" y="428625"/>
                </a:lnTo>
                <a:lnTo>
                  <a:pt x="15875" y="355600"/>
                </a:lnTo>
                <a:lnTo>
                  <a:pt x="28575" y="247650"/>
                </a:lnTo>
                <a:lnTo>
                  <a:pt x="41275" y="161925"/>
                </a:lnTo>
                <a:lnTo>
                  <a:pt x="50800" y="101600"/>
                </a:lnTo>
                <a:lnTo>
                  <a:pt x="76200" y="139700"/>
                </a:lnTo>
                <a:lnTo>
                  <a:pt x="98425" y="0"/>
                </a:lnTo>
                <a:lnTo>
                  <a:pt x="107950" y="47625"/>
                </a:lnTo>
                <a:lnTo>
                  <a:pt x="120650" y="57150"/>
                </a:lnTo>
                <a:lnTo>
                  <a:pt x="161925" y="41275"/>
                </a:lnTo>
                <a:lnTo>
                  <a:pt x="174625" y="82550"/>
                </a:lnTo>
                <a:lnTo>
                  <a:pt x="196850" y="225425"/>
                </a:lnTo>
                <a:lnTo>
                  <a:pt x="206375" y="282575"/>
                </a:lnTo>
                <a:lnTo>
                  <a:pt x="225425" y="342900"/>
                </a:lnTo>
                <a:lnTo>
                  <a:pt x="250825" y="355600"/>
                </a:lnTo>
                <a:lnTo>
                  <a:pt x="263525" y="387350"/>
                </a:lnTo>
                <a:lnTo>
                  <a:pt x="282575" y="428625"/>
                </a:lnTo>
                <a:lnTo>
                  <a:pt x="314325" y="444500"/>
                </a:lnTo>
                <a:lnTo>
                  <a:pt x="346075" y="463550"/>
                </a:lnTo>
                <a:lnTo>
                  <a:pt x="396875" y="444500"/>
                </a:lnTo>
                <a:lnTo>
                  <a:pt x="434975" y="460375"/>
                </a:lnTo>
                <a:lnTo>
                  <a:pt x="495300" y="450850"/>
                </a:lnTo>
                <a:lnTo>
                  <a:pt x="530225" y="463550"/>
                </a:lnTo>
                <a:lnTo>
                  <a:pt x="561975" y="457200"/>
                </a:lnTo>
                <a:lnTo>
                  <a:pt x="622300" y="447675"/>
                </a:lnTo>
                <a:lnTo>
                  <a:pt x="647700" y="428625"/>
                </a:lnTo>
                <a:lnTo>
                  <a:pt x="673100" y="444500"/>
                </a:lnTo>
                <a:lnTo>
                  <a:pt x="714375" y="434975"/>
                </a:lnTo>
                <a:lnTo>
                  <a:pt x="739775" y="419100"/>
                </a:lnTo>
                <a:lnTo>
                  <a:pt x="755650" y="419100"/>
                </a:lnTo>
                <a:lnTo>
                  <a:pt x="774700" y="419100"/>
                </a:lnTo>
                <a:lnTo>
                  <a:pt x="800100" y="434975"/>
                </a:lnTo>
                <a:lnTo>
                  <a:pt x="838200" y="463550"/>
                </a:lnTo>
                <a:lnTo>
                  <a:pt x="869950" y="476250"/>
                </a:lnTo>
                <a:lnTo>
                  <a:pt x="914400" y="482600"/>
                </a:lnTo>
                <a:lnTo>
                  <a:pt x="949325" y="485775"/>
                </a:lnTo>
                <a:lnTo>
                  <a:pt x="958850" y="495300"/>
                </a:lnTo>
                <a:lnTo>
                  <a:pt x="1260475" y="495300"/>
                </a:lnTo>
                <a:lnTo>
                  <a:pt x="1260475" y="49530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5" name="フリーフォーム 104">
            <a:extLst>
              <a:ext uri="{FF2B5EF4-FFF2-40B4-BE49-F238E27FC236}">
                <a16:creationId xmlns:a16="http://schemas.microsoft.com/office/drawing/2014/main" id="{7528BB61-062C-E642-8162-A4A35DC4DFF7}"/>
              </a:ext>
            </a:extLst>
          </p:cNvPr>
          <p:cNvSpPr/>
          <p:nvPr/>
        </p:nvSpPr>
        <p:spPr>
          <a:xfrm>
            <a:off x="2613524" y="2795400"/>
            <a:ext cx="1266825" cy="723900"/>
          </a:xfrm>
          <a:custGeom>
            <a:avLst/>
            <a:gdLst>
              <a:gd name="connsiteX0" fmla="*/ 0 w 1266825"/>
              <a:gd name="connsiteY0" fmla="*/ 717550 h 723900"/>
              <a:gd name="connsiteX1" fmla="*/ 41275 w 1266825"/>
              <a:gd name="connsiteY1" fmla="*/ 250825 h 723900"/>
              <a:gd name="connsiteX2" fmla="*/ 82550 w 1266825"/>
              <a:gd name="connsiteY2" fmla="*/ 222250 h 723900"/>
              <a:gd name="connsiteX3" fmla="*/ 88900 w 1266825"/>
              <a:gd name="connsiteY3" fmla="*/ 187325 h 723900"/>
              <a:gd name="connsiteX4" fmla="*/ 98425 w 1266825"/>
              <a:gd name="connsiteY4" fmla="*/ 133350 h 723900"/>
              <a:gd name="connsiteX5" fmla="*/ 114300 w 1266825"/>
              <a:gd name="connsiteY5" fmla="*/ 104775 h 723900"/>
              <a:gd name="connsiteX6" fmla="*/ 123825 w 1266825"/>
              <a:gd name="connsiteY6" fmla="*/ 127000 h 723900"/>
              <a:gd name="connsiteX7" fmla="*/ 149225 w 1266825"/>
              <a:gd name="connsiteY7" fmla="*/ 0 h 723900"/>
              <a:gd name="connsiteX8" fmla="*/ 168275 w 1266825"/>
              <a:gd name="connsiteY8" fmla="*/ 66675 h 723900"/>
              <a:gd name="connsiteX9" fmla="*/ 174625 w 1266825"/>
              <a:gd name="connsiteY9" fmla="*/ 165100 h 723900"/>
              <a:gd name="connsiteX10" fmla="*/ 193675 w 1266825"/>
              <a:gd name="connsiteY10" fmla="*/ 269875 h 723900"/>
              <a:gd name="connsiteX11" fmla="*/ 215900 w 1266825"/>
              <a:gd name="connsiteY11" fmla="*/ 260350 h 723900"/>
              <a:gd name="connsiteX12" fmla="*/ 238125 w 1266825"/>
              <a:gd name="connsiteY12" fmla="*/ 361950 h 723900"/>
              <a:gd name="connsiteX13" fmla="*/ 263525 w 1266825"/>
              <a:gd name="connsiteY13" fmla="*/ 469900 h 723900"/>
              <a:gd name="connsiteX14" fmla="*/ 276225 w 1266825"/>
              <a:gd name="connsiteY14" fmla="*/ 552450 h 723900"/>
              <a:gd name="connsiteX15" fmla="*/ 295275 w 1266825"/>
              <a:gd name="connsiteY15" fmla="*/ 603250 h 723900"/>
              <a:gd name="connsiteX16" fmla="*/ 320675 w 1266825"/>
              <a:gd name="connsiteY16" fmla="*/ 650875 h 723900"/>
              <a:gd name="connsiteX17" fmla="*/ 346075 w 1266825"/>
              <a:gd name="connsiteY17" fmla="*/ 676275 h 723900"/>
              <a:gd name="connsiteX18" fmla="*/ 393700 w 1266825"/>
              <a:gd name="connsiteY18" fmla="*/ 673100 h 723900"/>
              <a:gd name="connsiteX19" fmla="*/ 431800 w 1266825"/>
              <a:gd name="connsiteY19" fmla="*/ 692150 h 723900"/>
              <a:gd name="connsiteX20" fmla="*/ 485775 w 1266825"/>
              <a:gd name="connsiteY20" fmla="*/ 685800 h 723900"/>
              <a:gd name="connsiteX21" fmla="*/ 514350 w 1266825"/>
              <a:gd name="connsiteY21" fmla="*/ 688975 h 723900"/>
              <a:gd name="connsiteX22" fmla="*/ 552450 w 1266825"/>
              <a:gd name="connsiteY22" fmla="*/ 657225 h 723900"/>
              <a:gd name="connsiteX23" fmla="*/ 609600 w 1266825"/>
              <a:gd name="connsiteY23" fmla="*/ 657225 h 723900"/>
              <a:gd name="connsiteX24" fmla="*/ 644525 w 1266825"/>
              <a:gd name="connsiteY24" fmla="*/ 663575 h 723900"/>
              <a:gd name="connsiteX25" fmla="*/ 698500 w 1266825"/>
              <a:gd name="connsiteY25" fmla="*/ 593725 h 723900"/>
              <a:gd name="connsiteX26" fmla="*/ 733425 w 1266825"/>
              <a:gd name="connsiteY26" fmla="*/ 584200 h 723900"/>
              <a:gd name="connsiteX27" fmla="*/ 781050 w 1266825"/>
              <a:gd name="connsiteY27" fmla="*/ 514350 h 723900"/>
              <a:gd name="connsiteX28" fmla="*/ 841375 w 1266825"/>
              <a:gd name="connsiteY28" fmla="*/ 593725 h 723900"/>
              <a:gd name="connsiteX29" fmla="*/ 879475 w 1266825"/>
              <a:gd name="connsiteY29" fmla="*/ 647700 h 723900"/>
              <a:gd name="connsiteX30" fmla="*/ 933450 w 1266825"/>
              <a:gd name="connsiteY30" fmla="*/ 698500 h 723900"/>
              <a:gd name="connsiteX31" fmla="*/ 1038225 w 1266825"/>
              <a:gd name="connsiteY31" fmla="*/ 723900 h 723900"/>
              <a:gd name="connsiteX32" fmla="*/ 1266825 w 1266825"/>
              <a:gd name="connsiteY32" fmla="*/ 723900 h 7239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Lst>
            <a:rect l="l" t="t" r="r" b="b"/>
            <a:pathLst>
              <a:path w="1266825" h="723900">
                <a:moveTo>
                  <a:pt x="0" y="717550"/>
                </a:moveTo>
                <a:lnTo>
                  <a:pt x="41275" y="250825"/>
                </a:lnTo>
                <a:lnTo>
                  <a:pt x="82550" y="222250"/>
                </a:lnTo>
                <a:lnTo>
                  <a:pt x="88900" y="187325"/>
                </a:lnTo>
                <a:lnTo>
                  <a:pt x="98425" y="133350"/>
                </a:lnTo>
                <a:lnTo>
                  <a:pt x="114300" y="104775"/>
                </a:lnTo>
                <a:lnTo>
                  <a:pt x="123825" y="127000"/>
                </a:lnTo>
                <a:lnTo>
                  <a:pt x="149225" y="0"/>
                </a:lnTo>
                <a:lnTo>
                  <a:pt x="168275" y="66675"/>
                </a:lnTo>
                <a:lnTo>
                  <a:pt x="174625" y="165100"/>
                </a:lnTo>
                <a:lnTo>
                  <a:pt x="193675" y="269875"/>
                </a:lnTo>
                <a:lnTo>
                  <a:pt x="215900" y="260350"/>
                </a:lnTo>
                <a:lnTo>
                  <a:pt x="238125" y="361950"/>
                </a:lnTo>
                <a:lnTo>
                  <a:pt x="263525" y="469900"/>
                </a:lnTo>
                <a:lnTo>
                  <a:pt x="276225" y="552450"/>
                </a:lnTo>
                <a:lnTo>
                  <a:pt x="295275" y="603250"/>
                </a:lnTo>
                <a:lnTo>
                  <a:pt x="320675" y="650875"/>
                </a:lnTo>
                <a:lnTo>
                  <a:pt x="346075" y="676275"/>
                </a:lnTo>
                <a:lnTo>
                  <a:pt x="393700" y="673100"/>
                </a:lnTo>
                <a:lnTo>
                  <a:pt x="431800" y="692150"/>
                </a:lnTo>
                <a:lnTo>
                  <a:pt x="485775" y="685800"/>
                </a:lnTo>
                <a:lnTo>
                  <a:pt x="514350" y="688975"/>
                </a:lnTo>
                <a:lnTo>
                  <a:pt x="552450" y="657225"/>
                </a:lnTo>
                <a:lnTo>
                  <a:pt x="609600" y="657225"/>
                </a:lnTo>
                <a:lnTo>
                  <a:pt x="644525" y="663575"/>
                </a:lnTo>
                <a:lnTo>
                  <a:pt x="698500" y="593725"/>
                </a:lnTo>
                <a:lnTo>
                  <a:pt x="733425" y="584200"/>
                </a:lnTo>
                <a:lnTo>
                  <a:pt x="781050" y="514350"/>
                </a:lnTo>
                <a:lnTo>
                  <a:pt x="841375" y="593725"/>
                </a:lnTo>
                <a:lnTo>
                  <a:pt x="879475" y="647700"/>
                </a:lnTo>
                <a:lnTo>
                  <a:pt x="933450" y="698500"/>
                </a:lnTo>
                <a:lnTo>
                  <a:pt x="1038225" y="723900"/>
                </a:lnTo>
                <a:lnTo>
                  <a:pt x="1266825" y="72390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6" name="正方形/長方形 105">
            <a:extLst>
              <a:ext uri="{FF2B5EF4-FFF2-40B4-BE49-F238E27FC236}">
                <a16:creationId xmlns:a16="http://schemas.microsoft.com/office/drawing/2014/main" id="{DAF0BD0E-0B66-764C-9677-8C57ABF9D0C9}"/>
              </a:ext>
            </a:extLst>
          </p:cNvPr>
          <p:cNvSpPr/>
          <p:nvPr/>
        </p:nvSpPr>
        <p:spPr>
          <a:xfrm>
            <a:off x="2604521" y="2255638"/>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7" name="フリーフォーム 106">
            <a:extLst>
              <a:ext uri="{FF2B5EF4-FFF2-40B4-BE49-F238E27FC236}">
                <a16:creationId xmlns:a16="http://schemas.microsoft.com/office/drawing/2014/main" id="{B39DF5AC-0444-624F-8DC4-06F3EB000D89}"/>
              </a:ext>
            </a:extLst>
          </p:cNvPr>
          <p:cNvSpPr/>
          <p:nvPr/>
        </p:nvSpPr>
        <p:spPr>
          <a:xfrm>
            <a:off x="4274049" y="2775641"/>
            <a:ext cx="1266825" cy="739775"/>
          </a:xfrm>
          <a:custGeom>
            <a:avLst/>
            <a:gdLst>
              <a:gd name="connsiteX0" fmla="*/ 0 w 1266825"/>
              <a:gd name="connsiteY0" fmla="*/ 739775 h 739775"/>
              <a:gd name="connsiteX1" fmla="*/ 6350 w 1266825"/>
              <a:gd name="connsiteY1" fmla="*/ 647700 h 739775"/>
              <a:gd name="connsiteX2" fmla="*/ 22225 w 1266825"/>
              <a:gd name="connsiteY2" fmla="*/ 584200 h 739775"/>
              <a:gd name="connsiteX3" fmla="*/ 38100 w 1266825"/>
              <a:gd name="connsiteY3" fmla="*/ 434975 h 739775"/>
              <a:gd name="connsiteX4" fmla="*/ 47625 w 1266825"/>
              <a:gd name="connsiteY4" fmla="*/ 352425 h 739775"/>
              <a:gd name="connsiteX5" fmla="*/ 66675 w 1266825"/>
              <a:gd name="connsiteY5" fmla="*/ 269875 h 739775"/>
              <a:gd name="connsiteX6" fmla="*/ 82550 w 1266825"/>
              <a:gd name="connsiteY6" fmla="*/ 206375 h 739775"/>
              <a:gd name="connsiteX7" fmla="*/ 107950 w 1266825"/>
              <a:gd name="connsiteY7" fmla="*/ 155575 h 739775"/>
              <a:gd name="connsiteX8" fmla="*/ 133350 w 1266825"/>
              <a:gd name="connsiteY8" fmla="*/ 238125 h 739775"/>
              <a:gd name="connsiteX9" fmla="*/ 168275 w 1266825"/>
              <a:gd name="connsiteY9" fmla="*/ 0 h 739775"/>
              <a:gd name="connsiteX10" fmla="*/ 184150 w 1266825"/>
              <a:gd name="connsiteY10" fmla="*/ 63500 h 739775"/>
              <a:gd name="connsiteX11" fmla="*/ 193675 w 1266825"/>
              <a:gd name="connsiteY11" fmla="*/ 212725 h 739775"/>
              <a:gd name="connsiteX12" fmla="*/ 219075 w 1266825"/>
              <a:gd name="connsiteY12" fmla="*/ 438150 h 739775"/>
              <a:gd name="connsiteX13" fmla="*/ 241300 w 1266825"/>
              <a:gd name="connsiteY13" fmla="*/ 539750 h 739775"/>
              <a:gd name="connsiteX14" fmla="*/ 257175 w 1266825"/>
              <a:gd name="connsiteY14" fmla="*/ 631825 h 739775"/>
              <a:gd name="connsiteX15" fmla="*/ 304800 w 1266825"/>
              <a:gd name="connsiteY15" fmla="*/ 695325 h 739775"/>
              <a:gd name="connsiteX16" fmla="*/ 339725 w 1266825"/>
              <a:gd name="connsiteY16" fmla="*/ 717550 h 739775"/>
              <a:gd name="connsiteX17" fmla="*/ 393700 w 1266825"/>
              <a:gd name="connsiteY17" fmla="*/ 698500 h 739775"/>
              <a:gd name="connsiteX18" fmla="*/ 425450 w 1266825"/>
              <a:gd name="connsiteY18" fmla="*/ 720725 h 739775"/>
              <a:gd name="connsiteX19" fmla="*/ 473075 w 1266825"/>
              <a:gd name="connsiteY19" fmla="*/ 723900 h 739775"/>
              <a:gd name="connsiteX20" fmla="*/ 533400 w 1266825"/>
              <a:gd name="connsiteY20" fmla="*/ 666750 h 739775"/>
              <a:gd name="connsiteX21" fmla="*/ 555625 w 1266825"/>
              <a:gd name="connsiteY21" fmla="*/ 654050 h 739775"/>
              <a:gd name="connsiteX22" fmla="*/ 612775 w 1266825"/>
              <a:gd name="connsiteY22" fmla="*/ 673100 h 739775"/>
              <a:gd name="connsiteX23" fmla="*/ 650875 w 1266825"/>
              <a:gd name="connsiteY23" fmla="*/ 654050 h 739775"/>
              <a:gd name="connsiteX24" fmla="*/ 698500 w 1266825"/>
              <a:gd name="connsiteY24" fmla="*/ 615950 h 739775"/>
              <a:gd name="connsiteX25" fmla="*/ 730250 w 1266825"/>
              <a:gd name="connsiteY25" fmla="*/ 593725 h 739775"/>
              <a:gd name="connsiteX26" fmla="*/ 765175 w 1266825"/>
              <a:gd name="connsiteY26" fmla="*/ 647700 h 739775"/>
              <a:gd name="connsiteX27" fmla="*/ 812800 w 1266825"/>
              <a:gd name="connsiteY27" fmla="*/ 685800 h 739775"/>
              <a:gd name="connsiteX28" fmla="*/ 869950 w 1266825"/>
              <a:gd name="connsiteY28" fmla="*/ 720725 h 739775"/>
              <a:gd name="connsiteX29" fmla="*/ 917575 w 1266825"/>
              <a:gd name="connsiteY29" fmla="*/ 739775 h 739775"/>
              <a:gd name="connsiteX30" fmla="*/ 1266825 w 1266825"/>
              <a:gd name="connsiteY30" fmla="*/ 739775 h 739775"/>
              <a:gd name="connsiteX31" fmla="*/ 1266825 w 1266825"/>
              <a:gd name="connsiteY31" fmla="*/ 739775 h 7397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1266825" h="739775">
                <a:moveTo>
                  <a:pt x="0" y="739775"/>
                </a:moveTo>
                <a:lnTo>
                  <a:pt x="6350" y="647700"/>
                </a:lnTo>
                <a:lnTo>
                  <a:pt x="22225" y="584200"/>
                </a:lnTo>
                <a:lnTo>
                  <a:pt x="38100" y="434975"/>
                </a:lnTo>
                <a:lnTo>
                  <a:pt x="47625" y="352425"/>
                </a:lnTo>
                <a:lnTo>
                  <a:pt x="66675" y="269875"/>
                </a:lnTo>
                <a:lnTo>
                  <a:pt x="82550" y="206375"/>
                </a:lnTo>
                <a:lnTo>
                  <a:pt x="107950" y="155575"/>
                </a:lnTo>
                <a:lnTo>
                  <a:pt x="133350" y="238125"/>
                </a:lnTo>
                <a:lnTo>
                  <a:pt x="168275" y="0"/>
                </a:lnTo>
                <a:lnTo>
                  <a:pt x="184150" y="63500"/>
                </a:lnTo>
                <a:lnTo>
                  <a:pt x="193675" y="212725"/>
                </a:lnTo>
                <a:lnTo>
                  <a:pt x="219075" y="438150"/>
                </a:lnTo>
                <a:lnTo>
                  <a:pt x="241300" y="539750"/>
                </a:lnTo>
                <a:lnTo>
                  <a:pt x="257175" y="631825"/>
                </a:lnTo>
                <a:lnTo>
                  <a:pt x="304800" y="695325"/>
                </a:lnTo>
                <a:lnTo>
                  <a:pt x="339725" y="717550"/>
                </a:lnTo>
                <a:lnTo>
                  <a:pt x="393700" y="698500"/>
                </a:lnTo>
                <a:lnTo>
                  <a:pt x="425450" y="720725"/>
                </a:lnTo>
                <a:lnTo>
                  <a:pt x="473075" y="723900"/>
                </a:lnTo>
                <a:lnTo>
                  <a:pt x="533400" y="666750"/>
                </a:lnTo>
                <a:lnTo>
                  <a:pt x="555625" y="654050"/>
                </a:lnTo>
                <a:lnTo>
                  <a:pt x="612775" y="673100"/>
                </a:lnTo>
                <a:lnTo>
                  <a:pt x="650875" y="654050"/>
                </a:lnTo>
                <a:lnTo>
                  <a:pt x="698500" y="615950"/>
                </a:lnTo>
                <a:lnTo>
                  <a:pt x="730250" y="593725"/>
                </a:lnTo>
                <a:lnTo>
                  <a:pt x="765175" y="647700"/>
                </a:lnTo>
                <a:lnTo>
                  <a:pt x="812800" y="685800"/>
                </a:lnTo>
                <a:lnTo>
                  <a:pt x="869950" y="720725"/>
                </a:lnTo>
                <a:lnTo>
                  <a:pt x="917575" y="739775"/>
                </a:lnTo>
                <a:lnTo>
                  <a:pt x="1266825" y="739775"/>
                </a:lnTo>
                <a:lnTo>
                  <a:pt x="1266825" y="73977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8" name="フリーフォーム 107">
            <a:extLst>
              <a:ext uri="{FF2B5EF4-FFF2-40B4-BE49-F238E27FC236}">
                <a16:creationId xmlns:a16="http://schemas.microsoft.com/office/drawing/2014/main" id="{6EA19E77-2E8A-624E-BE6E-FDE12A2F012F}"/>
              </a:ext>
            </a:extLst>
          </p:cNvPr>
          <p:cNvSpPr/>
          <p:nvPr/>
        </p:nvSpPr>
        <p:spPr>
          <a:xfrm>
            <a:off x="4274049" y="2852551"/>
            <a:ext cx="1266825" cy="663575"/>
          </a:xfrm>
          <a:custGeom>
            <a:avLst/>
            <a:gdLst>
              <a:gd name="connsiteX0" fmla="*/ 0 w 1266825"/>
              <a:gd name="connsiteY0" fmla="*/ 660400 h 663575"/>
              <a:gd name="connsiteX1" fmla="*/ 9525 w 1266825"/>
              <a:gd name="connsiteY1" fmla="*/ 533400 h 663575"/>
              <a:gd name="connsiteX2" fmla="*/ 25400 w 1266825"/>
              <a:gd name="connsiteY2" fmla="*/ 438150 h 663575"/>
              <a:gd name="connsiteX3" fmla="*/ 31750 w 1266825"/>
              <a:gd name="connsiteY3" fmla="*/ 330200 h 663575"/>
              <a:gd name="connsiteX4" fmla="*/ 41275 w 1266825"/>
              <a:gd name="connsiteY4" fmla="*/ 244475 h 663575"/>
              <a:gd name="connsiteX5" fmla="*/ 53975 w 1266825"/>
              <a:gd name="connsiteY5" fmla="*/ 149225 h 663575"/>
              <a:gd name="connsiteX6" fmla="*/ 60325 w 1266825"/>
              <a:gd name="connsiteY6" fmla="*/ 146050 h 663575"/>
              <a:gd name="connsiteX7" fmla="*/ 76200 w 1266825"/>
              <a:gd name="connsiteY7" fmla="*/ 161925 h 663575"/>
              <a:gd name="connsiteX8" fmla="*/ 88900 w 1266825"/>
              <a:gd name="connsiteY8" fmla="*/ 136525 h 663575"/>
              <a:gd name="connsiteX9" fmla="*/ 104775 w 1266825"/>
              <a:gd name="connsiteY9" fmla="*/ 73025 h 663575"/>
              <a:gd name="connsiteX10" fmla="*/ 120650 w 1266825"/>
              <a:gd name="connsiteY10" fmla="*/ 104775 h 663575"/>
              <a:gd name="connsiteX11" fmla="*/ 139700 w 1266825"/>
              <a:gd name="connsiteY11" fmla="*/ 85725 h 663575"/>
              <a:gd name="connsiteX12" fmla="*/ 146050 w 1266825"/>
              <a:gd name="connsiteY12" fmla="*/ 34925 h 663575"/>
              <a:gd name="connsiteX13" fmla="*/ 155575 w 1266825"/>
              <a:gd name="connsiteY13" fmla="*/ 0 h 663575"/>
              <a:gd name="connsiteX14" fmla="*/ 171450 w 1266825"/>
              <a:gd name="connsiteY14" fmla="*/ 60325 h 663575"/>
              <a:gd name="connsiteX15" fmla="*/ 193675 w 1266825"/>
              <a:gd name="connsiteY15" fmla="*/ 95250 h 663575"/>
              <a:gd name="connsiteX16" fmla="*/ 196850 w 1266825"/>
              <a:gd name="connsiteY16" fmla="*/ 174625 h 663575"/>
              <a:gd name="connsiteX17" fmla="*/ 215900 w 1266825"/>
              <a:gd name="connsiteY17" fmla="*/ 301625 h 663575"/>
              <a:gd name="connsiteX18" fmla="*/ 244475 w 1266825"/>
              <a:gd name="connsiteY18" fmla="*/ 428625 h 663575"/>
              <a:gd name="connsiteX19" fmla="*/ 276225 w 1266825"/>
              <a:gd name="connsiteY19" fmla="*/ 504825 h 663575"/>
              <a:gd name="connsiteX20" fmla="*/ 295275 w 1266825"/>
              <a:gd name="connsiteY20" fmla="*/ 549275 h 663575"/>
              <a:gd name="connsiteX21" fmla="*/ 323850 w 1266825"/>
              <a:gd name="connsiteY21" fmla="*/ 581025 h 663575"/>
              <a:gd name="connsiteX22" fmla="*/ 358775 w 1266825"/>
              <a:gd name="connsiteY22" fmla="*/ 619125 h 663575"/>
              <a:gd name="connsiteX23" fmla="*/ 396875 w 1266825"/>
              <a:gd name="connsiteY23" fmla="*/ 619125 h 663575"/>
              <a:gd name="connsiteX24" fmla="*/ 422275 w 1266825"/>
              <a:gd name="connsiteY24" fmla="*/ 631825 h 663575"/>
              <a:gd name="connsiteX25" fmla="*/ 444500 w 1266825"/>
              <a:gd name="connsiteY25" fmla="*/ 635000 h 663575"/>
              <a:gd name="connsiteX26" fmla="*/ 495300 w 1266825"/>
              <a:gd name="connsiteY26" fmla="*/ 622300 h 663575"/>
              <a:gd name="connsiteX27" fmla="*/ 530225 w 1266825"/>
              <a:gd name="connsiteY27" fmla="*/ 609600 h 663575"/>
              <a:gd name="connsiteX28" fmla="*/ 546100 w 1266825"/>
              <a:gd name="connsiteY28" fmla="*/ 612775 h 663575"/>
              <a:gd name="connsiteX29" fmla="*/ 615950 w 1266825"/>
              <a:gd name="connsiteY29" fmla="*/ 568325 h 663575"/>
              <a:gd name="connsiteX30" fmla="*/ 644525 w 1266825"/>
              <a:gd name="connsiteY30" fmla="*/ 539750 h 663575"/>
              <a:gd name="connsiteX31" fmla="*/ 660400 w 1266825"/>
              <a:gd name="connsiteY31" fmla="*/ 527050 h 663575"/>
              <a:gd name="connsiteX32" fmla="*/ 673100 w 1266825"/>
              <a:gd name="connsiteY32" fmla="*/ 523875 h 663575"/>
              <a:gd name="connsiteX33" fmla="*/ 695325 w 1266825"/>
              <a:gd name="connsiteY33" fmla="*/ 492125 h 663575"/>
              <a:gd name="connsiteX34" fmla="*/ 717550 w 1266825"/>
              <a:gd name="connsiteY34" fmla="*/ 454025 h 663575"/>
              <a:gd name="connsiteX35" fmla="*/ 739775 w 1266825"/>
              <a:gd name="connsiteY35" fmla="*/ 460375 h 663575"/>
              <a:gd name="connsiteX36" fmla="*/ 768350 w 1266825"/>
              <a:gd name="connsiteY36" fmla="*/ 476250 h 663575"/>
              <a:gd name="connsiteX37" fmla="*/ 774700 w 1266825"/>
              <a:gd name="connsiteY37" fmla="*/ 498475 h 663575"/>
              <a:gd name="connsiteX38" fmla="*/ 800100 w 1266825"/>
              <a:gd name="connsiteY38" fmla="*/ 549275 h 663575"/>
              <a:gd name="connsiteX39" fmla="*/ 831850 w 1266825"/>
              <a:gd name="connsiteY39" fmla="*/ 584200 h 663575"/>
              <a:gd name="connsiteX40" fmla="*/ 847725 w 1266825"/>
              <a:gd name="connsiteY40" fmla="*/ 577850 h 663575"/>
              <a:gd name="connsiteX41" fmla="*/ 876300 w 1266825"/>
              <a:gd name="connsiteY41" fmla="*/ 606425 h 663575"/>
              <a:gd name="connsiteX42" fmla="*/ 901700 w 1266825"/>
              <a:gd name="connsiteY42" fmla="*/ 638175 h 663575"/>
              <a:gd name="connsiteX43" fmla="*/ 923925 w 1266825"/>
              <a:gd name="connsiteY43" fmla="*/ 654050 h 663575"/>
              <a:gd name="connsiteX44" fmla="*/ 981075 w 1266825"/>
              <a:gd name="connsiteY44" fmla="*/ 657225 h 663575"/>
              <a:gd name="connsiteX45" fmla="*/ 1009650 w 1266825"/>
              <a:gd name="connsiteY45" fmla="*/ 663575 h 663575"/>
              <a:gd name="connsiteX46" fmla="*/ 1266825 w 1266825"/>
              <a:gd name="connsiteY46" fmla="*/ 663575 h 6635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1266825" h="663575">
                <a:moveTo>
                  <a:pt x="0" y="660400"/>
                </a:moveTo>
                <a:lnTo>
                  <a:pt x="9525" y="533400"/>
                </a:lnTo>
                <a:lnTo>
                  <a:pt x="25400" y="438150"/>
                </a:lnTo>
                <a:lnTo>
                  <a:pt x="31750" y="330200"/>
                </a:lnTo>
                <a:lnTo>
                  <a:pt x="41275" y="244475"/>
                </a:lnTo>
                <a:lnTo>
                  <a:pt x="53975" y="149225"/>
                </a:lnTo>
                <a:lnTo>
                  <a:pt x="60325" y="146050"/>
                </a:lnTo>
                <a:lnTo>
                  <a:pt x="76200" y="161925"/>
                </a:lnTo>
                <a:lnTo>
                  <a:pt x="88900" y="136525"/>
                </a:lnTo>
                <a:lnTo>
                  <a:pt x="104775" y="73025"/>
                </a:lnTo>
                <a:lnTo>
                  <a:pt x="120650" y="104775"/>
                </a:lnTo>
                <a:lnTo>
                  <a:pt x="139700" y="85725"/>
                </a:lnTo>
                <a:lnTo>
                  <a:pt x="146050" y="34925"/>
                </a:lnTo>
                <a:lnTo>
                  <a:pt x="155575" y="0"/>
                </a:lnTo>
                <a:lnTo>
                  <a:pt x="171450" y="60325"/>
                </a:lnTo>
                <a:lnTo>
                  <a:pt x="193675" y="95250"/>
                </a:lnTo>
                <a:lnTo>
                  <a:pt x="196850" y="174625"/>
                </a:lnTo>
                <a:lnTo>
                  <a:pt x="215900" y="301625"/>
                </a:lnTo>
                <a:lnTo>
                  <a:pt x="244475" y="428625"/>
                </a:lnTo>
                <a:lnTo>
                  <a:pt x="276225" y="504825"/>
                </a:lnTo>
                <a:lnTo>
                  <a:pt x="295275" y="549275"/>
                </a:lnTo>
                <a:lnTo>
                  <a:pt x="323850" y="581025"/>
                </a:lnTo>
                <a:lnTo>
                  <a:pt x="358775" y="619125"/>
                </a:lnTo>
                <a:lnTo>
                  <a:pt x="396875" y="619125"/>
                </a:lnTo>
                <a:lnTo>
                  <a:pt x="422275" y="631825"/>
                </a:lnTo>
                <a:lnTo>
                  <a:pt x="444500" y="635000"/>
                </a:lnTo>
                <a:lnTo>
                  <a:pt x="495300" y="622300"/>
                </a:lnTo>
                <a:lnTo>
                  <a:pt x="530225" y="609600"/>
                </a:lnTo>
                <a:lnTo>
                  <a:pt x="546100" y="612775"/>
                </a:lnTo>
                <a:lnTo>
                  <a:pt x="615950" y="568325"/>
                </a:lnTo>
                <a:lnTo>
                  <a:pt x="644525" y="539750"/>
                </a:lnTo>
                <a:lnTo>
                  <a:pt x="660400" y="527050"/>
                </a:lnTo>
                <a:lnTo>
                  <a:pt x="673100" y="523875"/>
                </a:lnTo>
                <a:lnTo>
                  <a:pt x="695325" y="492125"/>
                </a:lnTo>
                <a:lnTo>
                  <a:pt x="717550" y="454025"/>
                </a:lnTo>
                <a:lnTo>
                  <a:pt x="739775" y="460375"/>
                </a:lnTo>
                <a:lnTo>
                  <a:pt x="768350" y="476250"/>
                </a:lnTo>
                <a:lnTo>
                  <a:pt x="774700" y="498475"/>
                </a:lnTo>
                <a:lnTo>
                  <a:pt x="800100" y="549275"/>
                </a:lnTo>
                <a:lnTo>
                  <a:pt x="831850" y="584200"/>
                </a:lnTo>
                <a:lnTo>
                  <a:pt x="847725" y="577850"/>
                </a:lnTo>
                <a:lnTo>
                  <a:pt x="876300" y="606425"/>
                </a:lnTo>
                <a:lnTo>
                  <a:pt x="901700" y="638175"/>
                </a:lnTo>
                <a:lnTo>
                  <a:pt x="923925" y="654050"/>
                </a:lnTo>
                <a:lnTo>
                  <a:pt x="981075" y="657225"/>
                </a:lnTo>
                <a:lnTo>
                  <a:pt x="1009650" y="663575"/>
                </a:lnTo>
                <a:lnTo>
                  <a:pt x="1266825" y="66357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09" name="正方形/長方形 108">
            <a:extLst>
              <a:ext uri="{FF2B5EF4-FFF2-40B4-BE49-F238E27FC236}">
                <a16:creationId xmlns:a16="http://schemas.microsoft.com/office/drawing/2014/main" id="{4E2A80A6-3878-AC4F-A9C1-5649B508838C}"/>
              </a:ext>
            </a:extLst>
          </p:cNvPr>
          <p:cNvSpPr/>
          <p:nvPr/>
        </p:nvSpPr>
        <p:spPr>
          <a:xfrm>
            <a:off x="4264642" y="2255639"/>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10" name="フリーフォーム 109">
            <a:extLst>
              <a:ext uri="{FF2B5EF4-FFF2-40B4-BE49-F238E27FC236}">
                <a16:creationId xmlns:a16="http://schemas.microsoft.com/office/drawing/2014/main" id="{15F9C9AB-D452-3545-AE03-F844F95CCDC0}"/>
              </a:ext>
            </a:extLst>
          </p:cNvPr>
          <p:cNvSpPr/>
          <p:nvPr/>
        </p:nvSpPr>
        <p:spPr>
          <a:xfrm>
            <a:off x="5925050" y="2630301"/>
            <a:ext cx="1260475" cy="882650"/>
          </a:xfrm>
          <a:custGeom>
            <a:avLst/>
            <a:gdLst>
              <a:gd name="connsiteX0" fmla="*/ 0 w 1260475"/>
              <a:gd name="connsiteY0" fmla="*/ 882650 h 882650"/>
              <a:gd name="connsiteX1" fmla="*/ 25400 w 1260475"/>
              <a:gd name="connsiteY1" fmla="*/ 631825 h 882650"/>
              <a:gd name="connsiteX2" fmla="*/ 41275 w 1260475"/>
              <a:gd name="connsiteY2" fmla="*/ 428625 h 882650"/>
              <a:gd name="connsiteX3" fmla="*/ 50800 w 1260475"/>
              <a:gd name="connsiteY3" fmla="*/ 304800 h 882650"/>
              <a:gd name="connsiteX4" fmla="*/ 63500 w 1260475"/>
              <a:gd name="connsiteY4" fmla="*/ 244475 h 882650"/>
              <a:gd name="connsiteX5" fmla="*/ 85725 w 1260475"/>
              <a:gd name="connsiteY5" fmla="*/ 219075 h 882650"/>
              <a:gd name="connsiteX6" fmla="*/ 98425 w 1260475"/>
              <a:gd name="connsiteY6" fmla="*/ 165100 h 882650"/>
              <a:gd name="connsiteX7" fmla="*/ 117475 w 1260475"/>
              <a:gd name="connsiteY7" fmla="*/ 146050 h 882650"/>
              <a:gd name="connsiteX8" fmla="*/ 142875 w 1260475"/>
              <a:gd name="connsiteY8" fmla="*/ 0 h 882650"/>
              <a:gd name="connsiteX9" fmla="*/ 155575 w 1260475"/>
              <a:gd name="connsiteY9" fmla="*/ 85725 h 882650"/>
              <a:gd name="connsiteX10" fmla="*/ 161925 w 1260475"/>
              <a:gd name="connsiteY10" fmla="*/ 76200 h 882650"/>
              <a:gd name="connsiteX11" fmla="*/ 187325 w 1260475"/>
              <a:gd name="connsiteY11" fmla="*/ 187325 h 882650"/>
              <a:gd name="connsiteX12" fmla="*/ 209550 w 1260475"/>
              <a:gd name="connsiteY12" fmla="*/ 323850 h 882650"/>
              <a:gd name="connsiteX13" fmla="*/ 228600 w 1260475"/>
              <a:gd name="connsiteY13" fmla="*/ 415925 h 882650"/>
              <a:gd name="connsiteX14" fmla="*/ 241300 w 1260475"/>
              <a:gd name="connsiteY14" fmla="*/ 517525 h 882650"/>
              <a:gd name="connsiteX15" fmla="*/ 257175 w 1260475"/>
              <a:gd name="connsiteY15" fmla="*/ 631825 h 882650"/>
              <a:gd name="connsiteX16" fmla="*/ 292100 w 1260475"/>
              <a:gd name="connsiteY16" fmla="*/ 749300 h 882650"/>
              <a:gd name="connsiteX17" fmla="*/ 317500 w 1260475"/>
              <a:gd name="connsiteY17" fmla="*/ 765175 h 882650"/>
              <a:gd name="connsiteX18" fmla="*/ 349250 w 1260475"/>
              <a:gd name="connsiteY18" fmla="*/ 796925 h 882650"/>
              <a:gd name="connsiteX19" fmla="*/ 371475 w 1260475"/>
              <a:gd name="connsiteY19" fmla="*/ 796925 h 882650"/>
              <a:gd name="connsiteX20" fmla="*/ 390525 w 1260475"/>
              <a:gd name="connsiteY20" fmla="*/ 809625 h 882650"/>
              <a:gd name="connsiteX21" fmla="*/ 434975 w 1260475"/>
              <a:gd name="connsiteY21" fmla="*/ 790575 h 882650"/>
              <a:gd name="connsiteX22" fmla="*/ 469900 w 1260475"/>
              <a:gd name="connsiteY22" fmla="*/ 822325 h 882650"/>
              <a:gd name="connsiteX23" fmla="*/ 533400 w 1260475"/>
              <a:gd name="connsiteY23" fmla="*/ 796925 h 882650"/>
              <a:gd name="connsiteX24" fmla="*/ 581025 w 1260475"/>
              <a:gd name="connsiteY24" fmla="*/ 806450 h 882650"/>
              <a:gd name="connsiteX25" fmla="*/ 685800 w 1260475"/>
              <a:gd name="connsiteY25" fmla="*/ 749300 h 882650"/>
              <a:gd name="connsiteX26" fmla="*/ 714375 w 1260475"/>
              <a:gd name="connsiteY26" fmla="*/ 774700 h 882650"/>
              <a:gd name="connsiteX27" fmla="*/ 752475 w 1260475"/>
              <a:gd name="connsiteY27" fmla="*/ 781050 h 882650"/>
              <a:gd name="connsiteX28" fmla="*/ 781050 w 1260475"/>
              <a:gd name="connsiteY28" fmla="*/ 762000 h 882650"/>
              <a:gd name="connsiteX29" fmla="*/ 822325 w 1260475"/>
              <a:gd name="connsiteY29" fmla="*/ 768350 h 882650"/>
              <a:gd name="connsiteX30" fmla="*/ 844550 w 1260475"/>
              <a:gd name="connsiteY30" fmla="*/ 809625 h 882650"/>
              <a:gd name="connsiteX31" fmla="*/ 889000 w 1260475"/>
              <a:gd name="connsiteY31" fmla="*/ 844550 h 882650"/>
              <a:gd name="connsiteX32" fmla="*/ 920750 w 1260475"/>
              <a:gd name="connsiteY32" fmla="*/ 844550 h 882650"/>
              <a:gd name="connsiteX33" fmla="*/ 952500 w 1260475"/>
              <a:gd name="connsiteY33" fmla="*/ 866775 h 882650"/>
              <a:gd name="connsiteX34" fmla="*/ 974725 w 1260475"/>
              <a:gd name="connsiteY34" fmla="*/ 873125 h 882650"/>
              <a:gd name="connsiteX35" fmla="*/ 1000125 w 1260475"/>
              <a:gd name="connsiteY35" fmla="*/ 869950 h 882650"/>
              <a:gd name="connsiteX36" fmla="*/ 1019175 w 1260475"/>
              <a:gd name="connsiteY36" fmla="*/ 882650 h 882650"/>
              <a:gd name="connsiteX37" fmla="*/ 1260475 w 1260475"/>
              <a:gd name="connsiteY37" fmla="*/ 882650 h 882650"/>
              <a:gd name="connsiteX38" fmla="*/ 1260475 w 1260475"/>
              <a:gd name="connsiteY38" fmla="*/ 879475 h 8826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Lst>
            <a:rect l="l" t="t" r="r" b="b"/>
            <a:pathLst>
              <a:path w="1260475" h="882650">
                <a:moveTo>
                  <a:pt x="0" y="882650"/>
                </a:moveTo>
                <a:lnTo>
                  <a:pt x="25400" y="631825"/>
                </a:lnTo>
                <a:lnTo>
                  <a:pt x="41275" y="428625"/>
                </a:lnTo>
                <a:lnTo>
                  <a:pt x="50800" y="304800"/>
                </a:lnTo>
                <a:lnTo>
                  <a:pt x="63500" y="244475"/>
                </a:lnTo>
                <a:lnTo>
                  <a:pt x="85725" y="219075"/>
                </a:lnTo>
                <a:lnTo>
                  <a:pt x="98425" y="165100"/>
                </a:lnTo>
                <a:lnTo>
                  <a:pt x="117475" y="146050"/>
                </a:lnTo>
                <a:lnTo>
                  <a:pt x="142875" y="0"/>
                </a:lnTo>
                <a:lnTo>
                  <a:pt x="155575" y="85725"/>
                </a:lnTo>
                <a:lnTo>
                  <a:pt x="161925" y="76200"/>
                </a:lnTo>
                <a:lnTo>
                  <a:pt x="187325" y="187325"/>
                </a:lnTo>
                <a:lnTo>
                  <a:pt x="209550" y="323850"/>
                </a:lnTo>
                <a:lnTo>
                  <a:pt x="228600" y="415925"/>
                </a:lnTo>
                <a:lnTo>
                  <a:pt x="241300" y="517525"/>
                </a:lnTo>
                <a:lnTo>
                  <a:pt x="257175" y="631825"/>
                </a:lnTo>
                <a:lnTo>
                  <a:pt x="292100" y="749300"/>
                </a:lnTo>
                <a:lnTo>
                  <a:pt x="317500" y="765175"/>
                </a:lnTo>
                <a:lnTo>
                  <a:pt x="349250" y="796925"/>
                </a:lnTo>
                <a:lnTo>
                  <a:pt x="371475" y="796925"/>
                </a:lnTo>
                <a:lnTo>
                  <a:pt x="390525" y="809625"/>
                </a:lnTo>
                <a:lnTo>
                  <a:pt x="434975" y="790575"/>
                </a:lnTo>
                <a:lnTo>
                  <a:pt x="469900" y="822325"/>
                </a:lnTo>
                <a:lnTo>
                  <a:pt x="533400" y="796925"/>
                </a:lnTo>
                <a:lnTo>
                  <a:pt x="581025" y="806450"/>
                </a:lnTo>
                <a:lnTo>
                  <a:pt x="685800" y="749300"/>
                </a:lnTo>
                <a:lnTo>
                  <a:pt x="714375" y="774700"/>
                </a:lnTo>
                <a:lnTo>
                  <a:pt x="752475" y="781050"/>
                </a:lnTo>
                <a:lnTo>
                  <a:pt x="781050" y="762000"/>
                </a:lnTo>
                <a:lnTo>
                  <a:pt x="822325" y="768350"/>
                </a:lnTo>
                <a:lnTo>
                  <a:pt x="844550" y="809625"/>
                </a:lnTo>
                <a:lnTo>
                  <a:pt x="889000" y="844550"/>
                </a:lnTo>
                <a:lnTo>
                  <a:pt x="920750" y="844550"/>
                </a:lnTo>
                <a:lnTo>
                  <a:pt x="952500" y="866775"/>
                </a:lnTo>
                <a:lnTo>
                  <a:pt x="974725" y="873125"/>
                </a:lnTo>
                <a:lnTo>
                  <a:pt x="1000125" y="869950"/>
                </a:lnTo>
                <a:lnTo>
                  <a:pt x="1019175" y="882650"/>
                </a:lnTo>
                <a:lnTo>
                  <a:pt x="1260475" y="882650"/>
                </a:lnTo>
                <a:lnTo>
                  <a:pt x="1260475" y="87947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11" name="フリーフォーム 110">
            <a:extLst>
              <a:ext uri="{FF2B5EF4-FFF2-40B4-BE49-F238E27FC236}">
                <a16:creationId xmlns:a16="http://schemas.microsoft.com/office/drawing/2014/main" id="{1420DFD3-873F-BF40-9704-D7497093B5C0}"/>
              </a:ext>
            </a:extLst>
          </p:cNvPr>
          <p:cNvSpPr/>
          <p:nvPr/>
        </p:nvSpPr>
        <p:spPr>
          <a:xfrm>
            <a:off x="5928225" y="2455676"/>
            <a:ext cx="1260475" cy="1060450"/>
          </a:xfrm>
          <a:custGeom>
            <a:avLst/>
            <a:gdLst>
              <a:gd name="connsiteX0" fmla="*/ 0 w 1260475"/>
              <a:gd name="connsiteY0" fmla="*/ 1060450 h 1060450"/>
              <a:gd name="connsiteX1" fmla="*/ 34925 w 1260475"/>
              <a:gd name="connsiteY1" fmla="*/ 923925 h 1060450"/>
              <a:gd name="connsiteX2" fmla="*/ 88900 w 1260475"/>
              <a:gd name="connsiteY2" fmla="*/ 831850 h 1060450"/>
              <a:gd name="connsiteX3" fmla="*/ 101600 w 1260475"/>
              <a:gd name="connsiteY3" fmla="*/ 739775 h 1060450"/>
              <a:gd name="connsiteX4" fmla="*/ 127000 w 1260475"/>
              <a:gd name="connsiteY4" fmla="*/ 692150 h 1060450"/>
              <a:gd name="connsiteX5" fmla="*/ 155575 w 1260475"/>
              <a:gd name="connsiteY5" fmla="*/ 635000 h 1060450"/>
              <a:gd name="connsiteX6" fmla="*/ 165100 w 1260475"/>
              <a:gd name="connsiteY6" fmla="*/ 552450 h 1060450"/>
              <a:gd name="connsiteX7" fmla="*/ 177800 w 1260475"/>
              <a:gd name="connsiteY7" fmla="*/ 517525 h 1060450"/>
              <a:gd name="connsiteX8" fmla="*/ 203200 w 1260475"/>
              <a:gd name="connsiteY8" fmla="*/ 584200 h 1060450"/>
              <a:gd name="connsiteX9" fmla="*/ 228600 w 1260475"/>
              <a:gd name="connsiteY9" fmla="*/ 473075 h 1060450"/>
              <a:gd name="connsiteX10" fmla="*/ 263525 w 1260475"/>
              <a:gd name="connsiteY10" fmla="*/ 514350 h 1060450"/>
              <a:gd name="connsiteX11" fmla="*/ 288925 w 1260475"/>
              <a:gd name="connsiteY11" fmla="*/ 581025 h 1060450"/>
              <a:gd name="connsiteX12" fmla="*/ 317500 w 1260475"/>
              <a:gd name="connsiteY12" fmla="*/ 692150 h 1060450"/>
              <a:gd name="connsiteX13" fmla="*/ 336550 w 1260475"/>
              <a:gd name="connsiteY13" fmla="*/ 695325 h 1060450"/>
              <a:gd name="connsiteX14" fmla="*/ 355600 w 1260475"/>
              <a:gd name="connsiteY14" fmla="*/ 739775 h 1060450"/>
              <a:gd name="connsiteX15" fmla="*/ 384175 w 1260475"/>
              <a:gd name="connsiteY15" fmla="*/ 803275 h 1060450"/>
              <a:gd name="connsiteX16" fmla="*/ 415925 w 1260475"/>
              <a:gd name="connsiteY16" fmla="*/ 749300 h 1060450"/>
              <a:gd name="connsiteX17" fmla="*/ 466725 w 1260475"/>
              <a:gd name="connsiteY17" fmla="*/ 844550 h 1060450"/>
              <a:gd name="connsiteX18" fmla="*/ 488950 w 1260475"/>
              <a:gd name="connsiteY18" fmla="*/ 822325 h 1060450"/>
              <a:gd name="connsiteX19" fmla="*/ 520700 w 1260475"/>
              <a:gd name="connsiteY19" fmla="*/ 768350 h 1060450"/>
              <a:gd name="connsiteX20" fmla="*/ 533400 w 1260475"/>
              <a:gd name="connsiteY20" fmla="*/ 746125 h 1060450"/>
              <a:gd name="connsiteX21" fmla="*/ 552450 w 1260475"/>
              <a:gd name="connsiteY21" fmla="*/ 746125 h 1060450"/>
              <a:gd name="connsiteX22" fmla="*/ 574675 w 1260475"/>
              <a:gd name="connsiteY22" fmla="*/ 704850 h 1060450"/>
              <a:gd name="connsiteX23" fmla="*/ 600075 w 1260475"/>
              <a:gd name="connsiteY23" fmla="*/ 660400 h 1060450"/>
              <a:gd name="connsiteX24" fmla="*/ 622300 w 1260475"/>
              <a:gd name="connsiteY24" fmla="*/ 682625 h 1060450"/>
              <a:gd name="connsiteX25" fmla="*/ 650875 w 1260475"/>
              <a:gd name="connsiteY25" fmla="*/ 603250 h 1060450"/>
              <a:gd name="connsiteX26" fmla="*/ 669925 w 1260475"/>
              <a:gd name="connsiteY26" fmla="*/ 444500 h 1060450"/>
              <a:gd name="connsiteX27" fmla="*/ 682625 w 1260475"/>
              <a:gd name="connsiteY27" fmla="*/ 450850 h 1060450"/>
              <a:gd name="connsiteX28" fmla="*/ 704850 w 1260475"/>
              <a:gd name="connsiteY28" fmla="*/ 425450 h 1060450"/>
              <a:gd name="connsiteX29" fmla="*/ 723900 w 1260475"/>
              <a:gd name="connsiteY29" fmla="*/ 412750 h 1060450"/>
              <a:gd name="connsiteX30" fmla="*/ 739775 w 1260475"/>
              <a:gd name="connsiteY30" fmla="*/ 355600 h 1060450"/>
              <a:gd name="connsiteX31" fmla="*/ 752475 w 1260475"/>
              <a:gd name="connsiteY31" fmla="*/ 193675 h 1060450"/>
              <a:gd name="connsiteX32" fmla="*/ 768350 w 1260475"/>
              <a:gd name="connsiteY32" fmla="*/ 206375 h 1060450"/>
              <a:gd name="connsiteX33" fmla="*/ 784225 w 1260475"/>
              <a:gd name="connsiteY33" fmla="*/ 149225 h 1060450"/>
              <a:gd name="connsiteX34" fmla="*/ 822325 w 1260475"/>
              <a:gd name="connsiteY34" fmla="*/ 63500 h 1060450"/>
              <a:gd name="connsiteX35" fmla="*/ 854075 w 1260475"/>
              <a:gd name="connsiteY35" fmla="*/ 136525 h 1060450"/>
              <a:gd name="connsiteX36" fmla="*/ 879475 w 1260475"/>
              <a:gd name="connsiteY36" fmla="*/ 0 h 1060450"/>
              <a:gd name="connsiteX37" fmla="*/ 895350 w 1260475"/>
              <a:gd name="connsiteY37" fmla="*/ 117475 h 1060450"/>
              <a:gd name="connsiteX38" fmla="*/ 917575 w 1260475"/>
              <a:gd name="connsiteY38" fmla="*/ 292100 h 1060450"/>
              <a:gd name="connsiteX39" fmla="*/ 936625 w 1260475"/>
              <a:gd name="connsiteY39" fmla="*/ 495300 h 1060450"/>
              <a:gd name="connsiteX40" fmla="*/ 949325 w 1260475"/>
              <a:gd name="connsiteY40" fmla="*/ 612775 h 1060450"/>
              <a:gd name="connsiteX41" fmla="*/ 971550 w 1260475"/>
              <a:gd name="connsiteY41" fmla="*/ 714375 h 1060450"/>
              <a:gd name="connsiteX42" fmla="*/ 987425 w 1260475"/>
              <a:gd name="connsiteY42" fmla="*/ 803275 h 1060450"/>
              <a:gd name="connsiteX43" fmla="*/ 1006475 w 1260475"/>
              <a:gd name="connsiteY43" fmla="*/ 879475 h 1060450"/>
              <a:gd name="connsiteX44" fmla="*/ 1019175 w 1260475"/>
              <a:gd name="connsiteY44" fmla="*/ 955675 h 1060450"/>
              <a:gd name="connsiteX45" fmla="*/ 1041400 w 1260475"/>
              <a:gd name="connsiteY45" fmla="*/ 1016000 h 1060450"/>
              <a:gd name="connsiteX46" fmla="*/ 1076325 w 1260475"/>
              <a:gd name="connsiteY46" fmla="*/ 1044575 h 1060450"/>
              <a:gd name="connsiteX47" fmla="*/ 1117600 w 1260475"/>
              <a:gd name="connsiteY47" fmla="*/ 1035050 h 1060450"/>
              <a:gd name="connsiteX48" fmla="*/ 1155700 w 1260475"/>
              <a:gd name="connsiteY48" fmla="*/ 1060450 h 1060450"/>
              <a:gd name="connsiteX49" fmla="*/ 1260475 w 1260475"/>
              <a:gd name="connsiteY49" fmla="*/ 1060450 h 10604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Lst>
            <a:rect l="l" t="t" r="r" b="b"/>
            <a:pathLst>
              <a:path w="1260475" h="1060450">
                <a:moveTo>
                  <a:pt x="0" y="1060450"/>
                </a:moveTo>
                <a:lnTo>
                  <a:pt x="34925" y="923925"/>
                </a:lnTo>
                <a:lnTo>
                  <a:pt x="88900" y="831850"/>
                </a:lnTo>
                <a:lnTo>
                  <a:pt x="101600" y="739775"/>
                </a:lnTo>
                <a:lnTo>
                  <a:pt x="127000" y="692150"/>
                </a:lnTo>
                <a:lnTo>
                  <a:pt x="155575" y="635000"/>
                </a:lnTo>
                <a:lnTo>
                  <a:pt x="165100" y="552450"/>
                </a:lnTo>
                <a:lnTo>
                  <a:pt x="177800" y="517525"/>
                </a:lnTo>
                <a:lnTo>
                  <a:pt x="203200" y="584200"/>
                </a:lnTo>
                <a:lnTo>
                  <a:pt x="228600" y="473075"/>
                </a:lnTo>
                <a:lnTo>
                  <a:pt x="263525" y="514350"/>
                </a:lnTo>
                <a:lnTo>
                  <a:pt x="288925" y="581025"/>
                </a:lnTo>
                <a:lnTo>
                  <a:pt x="317500" y="692150"/>
                </a:lnTo>
                <a:lnTo>
                  <a:pt x="336550" y="695325"/>
                </a:lnTo>
                <a:lnTo>
                  <a:pt x="355600" y="739775"/>
                </a:lnTo>
                <a:lnTo>
                  <a:pt x="384175" y="803275"/>
                </a:lnTo>
                <a:lnTo>
                  <a:pt x="415925" y="749300"/>
                </a:lnTo>
                <a:lnTo>
                  <a:pt x="466725" y="844550"/>
                </a:lnTo>
                <a:lnTo>
                  <a:pt x="488950" y="822325"/>
                </a:lnTo>
                <a:lnTo>
                  <a:pt x="520700" y="768350"/>
                </a:lnTo>
                <a:lnTo>
                  <a:pt x="533400" y="746125"/>
                </a:lnTo>
                <a:lnTo>
                  <a:pt x="552450" y="746125"/>
                </a:lnTo>
                <a:lnTo>
                  <a:pt x="574675" y="704850"/>
                </a:lnTo>
                <a:lnTo>
                  <a:pt x="600075" y="660400"/>
                </a:lnTo>
                <a:lnTo>
                  <a:pt x="622300" y="682625"/>
                </a:lnTo>
                <a:lnTo>
                  <a:pt x="650875" y="603250"/>
                </a:lnTo>
                <a:lnTo>
                  <a:pt x="669925" y="444500"/>
                </a:lnTo>
                <a:lnTo>
                  <a:pt x="682625" y="450850"/>
                </a:lnTo>
                <a:lnTo>
                  <a:pt x="704850" y="425450"/>
                </a:lnTo>
                <a:lnTo>
                  <a:pt x="723900" y="412750"/>
                </a:lnTo>
                <a:lnTo>
                  <a:pt x="739775" y="355600"/>
                </a:lnTo>
                <a:lnTo>
                  <a:pt x="752475" y="193675"/>
                </a:lnTo>
                <a:lnTo>
                  <a:pt x="768350" y="206375"/>
                </a:lnTo>
                <a:lnTo>
                  <a:pt x="784225" y="149225"/>
                </a:lnTo>
                <a:lnTo>
                  <a:pt x="822325" y="63500"/>
                </a:lnTo>
                <a:lnTo>
                  <a:pt x="854075" y="136525"/>
                </a:lnTo>
                <a:lnTo>
                  <a:pt x="879475" y="0"/>
                </a:lnTo>
                <a:lnTo>
                  <a:pt x="895350" y="117475"/>
                </a:lnTo>
                <a:lnTo>
                  <a:pt x="917575" y="292100"/>
                </a:lnTo>
                <a:lnTo>
                  <a:pt x="936625" y="495300"/>
                </a:lnTo>
                <a:lnTo>
                  <a:pt x="949325" y="612775"/>
                </a:lnTo>
                <a:lnTo>
                  <a:pt x="971550" y="714375"/>
                </a:lnTo>
                <a:lnTo>
                  <a:pt x="987425" y="803275"/>
                </a:lnTo>
                <a:lnTo>
                  <a:pt x="1006475" y="879475"/>
                </a:lnTo>
                <a:lnTo>
                  <a:pt x="1019175" y="955675"/>
                </a:lnTo>
                <a:lnTo>
                  <a:pt x="1041400" y="1016000"/>
                </a:lnTo>
                <a:lnTo>
                  <a:pt x="1076325" y="1044575"/>
                </a:lnTo>
                <a:lnTo>
                  <a:pt x="1117600" y="1035050"/>
                </a:lnTo>
                <a:lnTo>
                  <a:pt x="1155700" y="1060450"/>
                </a:lnTo>
                <a:lnTo>
                  <a:pt x="1260475" y="106045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12" name="正方形/長方形 111">
            <a:extLst>
              <a:ext uri="{FF2B5EF4-FFF2-40B4-BE49-F238E27FC236}">
                <a16:creationId xmlns:a16="http://schemas.microsoft.com/office/drawing/2014/main" id="{76945745-2DA4-6A48-B215-A6DC0A2E1E68}"/>
              </a:ext>
            </a:extLst>
          </p:cNvPr>
          <p:cNvSpPr/>
          <p:nvPr/>
        </p:nvSpPr>
        <p:spPr>
          <a:xfrm>
            <a:off x="5921662" y="2259523"/>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13" name="フリーフォーム 112">
            <a:extLst>
              <a:ext uri="{FF2B5EF4-FFF2-40B4-BE49-F238E27FC236}">
                <a16:creationId xmlns:a16="http://schemas.microsoft.com/office/drawing/2014/main" id="{C8EB48B1-FC03-F74D-8C98-18A4769F5713}"/>
              </a:ext>
            </a:extLst>
          </p:cNvPr>
          <p:cNvSpPr/>
          <p:nvPr/>
        </p:nvSpPr>
        <p:spPr>
          <a:xfrm>
            <a:off x="7582400" y="2757301"/>
            <a:ext cx="1260475" cy="765175"/>
          </a:xfrm>
          <a:custGeom>
            <a:avLst/>
            <a:gdLst>
              <a:gd name="connsiteX0" fmla="*/ 0 w 1260475"/>
              <a:gd name="connsiteY0" fmla="*/ 758825 h 765175"/>
              <a:gd name="connsiteX1" fmla="*/ 28575 w 1260475"/>
              <a:gd name="connsiteY1" fmla="*/ 400050 h 765175"/>
              <a:gd name="connsiteX2" fmla="*/ 44450 w 1260475"/>
              <a:gd name="connsiteY2" fmla="*/ 203200 h 765175"/>
              <a:gd name="connsiteX3" fmla="*/ 53975 w 1260475"/>
              <a:gd name="connsiteY3" fmla="*/ 161925 h 765175"/>
              <a:gd name="connsiteX4" fmla="*/ 76200 w 1260475"/>
              <a:gd name="connsiteY4" fmla="*/ 215900 h 765175"/>
              <a:gd name="connsiteX5" fmla="*/ 92075 w 1260475"/>
              <a:gd name="connsiteY5" fmla="*/ 92075 h 765175"/>
              <a:gd name="connsiteX6" fmla="*/ 104775 w 1260475"/>
              <a:gd name="connsiteY6" fmla="*/ 117475 h 765175"/>
              <a:gd name="connsiteX7" fmla="*/ 127000 w 1260475"/>
              <a:gd name="connsiteY7" fmla="*/ 92075 h 765175"/>
              <a:gd name="connsiteX8" fmla="*/ 133350 w 1260475"/>
              <a:gd name="connsiteY8" fmla="*/ 117475 h 765175"/>
              <a:gd name="connsiteX9" fmla="*/ 165100 w 1260475"/>
              <a:gd name="connsiteY9" fmla="*/ 0 h 765175"/>
              <a:gd name="connsiteX10" fmla="*/ 171450 w 1260475"/>
              <a:gd name="connsiteY10" fmla="*/ 123825 h 765175"/>
              <a:gd name="connsiteX11" fmla="*/ 180975 w 1260475"/>
              <a:gd name="connsiteY11" fmla="*/ 250825 h 765175"/>
              <a:gd name="connsiteX12" fmla="*/ 200025 w 1260475"/>
              <a:gd name="connsiteY12" fmla="*/ 377825 h 765175"/>
              <a:gd name="connsiteX13" fmla="*/ 222250 w 1260475"/>
              <a:gd name="connsiteY13" fmla="*/ 431800 h 765175"/>
              <a:gd name="connsiteX14" fmla="*/ 247650 w 1260475"/>
              <a:gd name="connsiteY14" fmla="*/ 546100 h 765175"/>
              <a:gd name="connsiteX15" fmla="*/ 276225 w 1260475"/>
              <a:gd name="connsiteY15" fmla="*/ 622300 h 765175"/>
              <a:gd name="connsiteX16" fmla="*/ 311150 w 1260475"/>
              <a:gd name="connsiteY16" fmla="*/ 708025 h 765175"/>
              <a:gd name="connsiteX17" fmla="*/ 403225 w 1260475"/>
              <a:gd name="connsiteY17" fmla="*/ 727075 h 765175"/>
              <a:gd name="connsiteX18" fmla="*/ 511175 w 1260475"/>
              <a:gd name="connsiteY18" fmla="*/ 685800 h 765175"/>
              <a:gd name="connsiteX19" fmla="*/ 542925 w 1260475"/>
              <a:gd name="connsiteY19" fmla="*/ 701675 h 765175"/>
              <a:gd name="connsiteX20" fmla="*/ 581025 w 1260475"/>
              <a:gd name="connsiteY20" fmla="*/ 682625 h 765175"/>
              <a:gd name="connsiteX21" fmla="*/ 628650 w 1260475"/>
              <a:gd name="connsiteY21" fmla="*/ 660400 h 765175"/>
              <a:gd name="connsiteX22" fmla="*/ 654050 w 1260475"/>
              <a:gd name="connsiteY22" fmla="*/ 660400 h 765175"/>
              <a:gd name="connsiteX23" fmla="*/ 676275 w 1260475"/>
              <a:gd name="connsiteY23" fmla="*/ 688975 h 765175"/>
              <a:gd name="connsiteX24" fmla="*/ 717550 w 1260475"/>
              <a:gd name="connsiteY24" fmla="*/ 654050 h 765175"/>
              <a:gd name="connsiteX25" fmla="*/ 755650 w 1260475"/>
              <a:gd name="connsiteY25" fmla="*/ 688975 h 765175"/>
              <a:gd name="connsiteX26" fmla="*/ 800100 w 1260475"/>
              <a:gd name="connsiteY26" fmla="*/ 663575 h 765175"/>
              <a:gd name="connsiteX27" fmla="*/ 866775 w 1260475"/>
              <a:gd name="connsiteY27" fmla="*/ 720725 h 765175"/>
              <a:gd name="connsiteX28" fmla="*/ 923925 w 1260475"/>
              <a:gd name="connsiteY28" fmla="*/ 727075 h 765175"/>
              <a:gd name="connsiteX29" fmla="*/ 955675 w 1260475"/>
              <a:gd name="connsiteY29" fmla="*/ 752475 h 765175"/>
              <a:gd name="connsiteX30" fmla="*/ 1012825 w 1260475"/>
              <a:gd name="connsiteY30" fmla="*/ 765175 h 765175"/>
              <a:gd name="connsiteX31" fmla="*/ 1260475 w 1260475"/>
              <a:gd name="connsiteY31" fmla="*/ 765175 h 7651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1260475" h="765175">
                <a:moveTo>
                  <a:pt x="0" y="758825"/>
                </a:moveTo>
                <a:lnTo>
                  <a:pt x="28575" y="400050"/>
                </a:lnTo>
                <a:lnTo>
                  <a:pt x="44450" y="203200"/>
                </a:lnTo>
                <a:lnTo>
                  <a:pt x="53975" y="161925"/>
                </a:lnTo>
                <a:lnTo>
                  <a:pt x="76200" y="215900"/>
                </a:lnTo>
                <a:lnTo>
                  <a:pt x="92075" y="92075"/>
                </a:lnTo>
                <a:lnTo>
                  <a:pt x="104775" y="117475"/>
                </a:lnTo>
                <a:lnTo>
                  <a:pt x="127000" y="92075"/>
                </a:lnTo>
                <a:lnTo>
                  <a:pt x="133350" y="117475"/>
                </a:lnTo>
                <a:lnTo>
                  <a:pt x="165100" y="0"/>
                </a:lnTo>
                <a:lnTo>
                  <a:pt x="171450" y="123825"/>
                </a:lnTo>
                <a:lnTo>
                  <a:pt x="180975" y="250825"/>
                </a:lnTo>
                <a:lnTo>
                  <a:pt x="200025" y="377825"/>
                </a:lnTo>
                <a:lnTo>
                  <a:pt x="222250" y="431800"/>
                </a:lnTo>
                <a:lnTo>
                  <a:pt x="247650" y="546100"/>
                </a:lnTo>
                <a:lnTo>
                  <a:pt x="276225" y="622300"/>
                </a:lnTo>
                <a:lnTo>
                  <a:pt x="311150" y="708025"/>
                </a:lnTo>
                <a:lnTo>
                  <a:pt x="403225" y="727075"/>
                </a:lnTo>
                <a:lnTo>
                  <a:pt x="511175" y="685800"/>
                </a:lnTo>
                <a:lnTo>
                  <a:pt x="542925" y="701675"/>
                </a:lnTo>
                <a:lnTo>
                  <a:pt x="581025" y="682625"/>
                </a:lnTo>
                <a:lnTo>
                  <a:pt x="628650" y="660400"/>
                </a:lnTo>
                <a:lnTo>
                  <a:pt x="654050" y="660400"/>
                </a:lnTo>
                <a:lnTo>
                  <a:pt x="676275" y="688975"/>
                </a:lnTo>
                <a:lnTo>
                  <a:pt x="717550" y="654050"/>
                </a:lnTo>
                <a:lnTo>
                  <a:pt x="755650" y="688975"/>
                </a:lnTo>
                <a:lnTo>
                  <a:pt x="800100" y="663575"/>
                </a:lnTo>
                <a:lnTo>
                  <a:pt x="866775" y="720725"/>
                </a:lnTo>
                <a:lnTo>
                  <a:pt x="923925" y="727075"/>
                </a:lnTo>
                <a:lnTo>
                  <a:pt x="955675" y="752475"/>
                </a:lnTo>
                <a:lnTo>
                  <a:pt x="1012825" y="765175"/>
                </a:lnTo>
                <a:lnTo>
                  <a:pt x="1260475" y="76517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14" name="フリーフォーム 113">
            <a:extLst>
              <a:ext uri="{FF2B5EF4-FFF2-40B4-BE49-F238E27FC236}">
                <a16:creationId xmlns:a16="http://schemas.microsoft.com/office/drawing/2014/main" id="{A612762F-E4CC-4945-88F1-2F56B50FA57F}"/>
              </a:ext>
            </a:extLst>
          </p:cNvPr>
          <p:cNvSpPr/>
          <p:nvPr/>
        </p:nvSpPr>
        <p:spPr>
          <a:xfrm>
            <a:off x="7582400" y="2630301"/>
            <a:ext cx="1266825" cy="892175"/>
          </a:xfrm>
          <a:custGeom>
            <a:avLst/>
            <a:gdLst>
              <a:gd name="connsiteX0" fmla="*/ 0 w 1266825"/>
              <a:gd name="connsiteY0" fmla="*/ 876300 h 892175"/>
              <a:gd name="connsiteX1" fmla="*/ 12700 w 1266825"/>
              <a:gd name="connsiteY1" fmla="*/ 815975 h 892175"/>
              <a:gd name="connsiteX2" fmla="*/ 34925 w 1266825"/>
              <a:gd name="connsiteY2" fmla="*/ 755650 h 892175"/>
              <a:gd name="connsiteX3" fmla="*/ 53975 w 1266825"/>
              <a:gd name="connsiteY3" fmla="*/ 755650 h 892175"/>
              <a:gd name="connsiteX4" fmla="*/ 79375 w 1266825"/>
              <a:gd name="connsiteY4" fmla="*/ 698500 h 892175"/>
              <a:gd name="connsiteX5" fmla="*/ 92075 w 1266825"/>
              <a:gd name="connsiteY5" fmla="*/ 666750 h 892175"/>
              <a:gd name="connsiteX6" fmla="*/ 120650 w 1266825"/>
              <a:gd name="connsiteY6" fmla="*/ 650875 h 892175"/>
              <a:gd name="connsiteX7" fmla="*/ 142875 w 1266825"/>
              <a:gd name="connsiteY7" fmla="*/ 612775 h 892175"/>
              <a:gd name="connsiteX8" fmla="*/ 161925 w 1266825"/>
              <a:gd name="connsiteY8" fmla="*/ 593725 h 892175"/>
              <a:gd name="connsiteX9" fmla="*/ 174625 w 1266825"/>
              <a:gd name="connsiteY9" fmla="*/ 590550 h 892175"/>
              <a:gd name="connsiteX10" fmla="*/ 222250 w 1266825"/>
              <a:gd name="connsiteY10" fmla="*/ 517525 h 892175"/>
              <a:gd name="connsiteX11" fmla="*/ 250825 w 1266825"/>
              <a:gd name="connsiteY11" fmla="*/ 561975 h 892175"/>
              <a:gd name="connsiteX12" fmla="*/ 266700 w 1266825"/>
              <a:gd name="connsiteY12" fmla="*/ 635000 h 892175"/>
              <a:gd name="connsiteX13" fmla="*/ 304800 w 1266825"/>
              <a:gd name="connsiteY13" fmla="*/ 679450 h 892175"/>
              <a:gd name="connsiteX14" fmla="*/ 333375 w 1266825"/>
              <a:gd name="connsiteY14" fmla="*/ 622300 h 892175"/>
              <a:gd name="connsiteX15" fmla="*/ 355600 w 1266825"/>
              <a:gd name="connsiteY15" fmla="*/ 673100 h 892175"/>
              <a:gd name="connsiteX16" fmla="*/ 393700 w 1266825"/>
              <a:gd name="connsiteY16" fmla="*/ 635000 h 892175"/>
              <a:gd name="connsiteX17" fmla="*/ 441325 w 1266825"/>
              <a:gd name="connsiteY17" fmla="*/ 711200 h 892175"/>
              <a:gd name="connsiteX18" fmla="*/ 469900 w 1266825"/>
              <a:gd name="connsiteY18" fmla="*/ 685800 h 892175"/>
              <a:gd name="connsiteX19" fmla="*/ 492125 w 1266825"/>
              <a:gd name="connsiteY19" fmla="*/ 644525 h 892175"/>
              <a:gd name="connsiteX20" fmla="*/ 523875 w 1266825"/>
              <a:gd name="connsiteY20" fmla="*/ 609600 h 892175"/>
              <a:gd name="connsiteX21" fmla="*/ 574675 w 1266825"/>
              <a:gd name="connsiteY21" fmla="*/ 549275 h 892175"/>
              <a:gd name="connsiteX22" fmla="*/ 622300 w 1266825"/>
              <a:gd name="connsiteY22" fmla="*/ 393700 h 892175"/>
              <a:gd name="connsiteX23" fmla="*/ 641350 w 1266825"/>
              <a:gd name="connsiteY23" fmla="*/ 463550 h 892175"/>
              <a:gd name="connsiteX24" fmla="*/ 676275 w 1266825"/>
              <a:gd name="connsiteY24" fmla="*/ 365125 h 892175"/>
              <a:gd name="connsiteX25" fmla="*/ 692150 w 1266825"/>
              <a:gd name="connsiteY25" fmla="*/ 355600 h 892175"/>
              <a:gd name="connsiteX26" fmla="*/ 720725 w 1266825"/>
              <a:gd name="connsiteY26" fmla="*/ 152400 h 892175"/>
              <a:gd name="connsiteX27" fmla="*/ 736600 w 1266825"/>
              <a:gd name="connsiteY27" fmla="*/ 184150 h 892175"/>
              <a:gd name="connsiteX28" fmla="*/ 749300 w 1266825"/>
              <a:gd name="connsiteY28" fmla="*/ 136525 h 892175"/>
              <a:gd name="connsiteX29" fmla="*/ 768350 w 1266825"/>
              <a:gd name="connsiteY29" fmla="*/ 139700 h 892175"/>
              <a:gd name="connsiteX30" fmla="*/ 812800 w 1266825"/>
              <a:gd name="connsiteY30" fmla="*/ 0 h 892175"/>
              <a:gd name="connsiteX31" fmla="*/ 828675 w 1266825"/>
              <a:gd name="connsiteY31" fmla="*/ 0 h 892175"/>
              <a:gd name="connsiteX32" fmla="*/ 850900 w 1266825"/>
              <a:gd name="connsiteY32" fmla="*/ 66675 h 892175"/>
              <a:gd name="connsiteX33" fmla="*/ 869950 w 1266825"/>
              <a:gd name="connsiteY33" fmla="*/ 47625 h 892175"/>
              <a:gd name="connsiteX34" fmla="*/ 876300 w 1266825"/>
              <a:gd name="connsiteY34" fmla="*/ 180975 h 892175"/>
              <a:gd name="connsiteX35" fmla="*/ 904875 w 1266825"/>
              <a:gd name="connsiteY35" fmla="*/ 327025 h 892175"/>
              <a:gd name="connsiteX36" fmla="*/ 923925 w 1266825"/>
              <a:gd name="connsiteY36" fmla="*/ 479425 h 892175"/>
              <a:gd name="connsiteX37" fmla="*/ 936625 w 1266825"/>
              <a:gd name="connsiteY37" fmla="*/ 603250 h 892175"/>
              <a:gd name="connsiteX38" fmla="*/ 965200 w 1266825"/>
              <a:gd name="connsiteY38" fmla="*/ 676275 h 892175"/>
              <a:gd name="connsiteX39" fmla="*/ 990600 w 1266825"/>
              <a:gd name="connsiteY39" fmla="*/ 762000 h 892175"/>
              <a:gd name="connsiteX40" fmla="*/ 1012825 w 1266825"/>
              <a:gd name="connsiteY40" fmla="*/ 828675 h 892175"/>
              <a:gd name="connsiteX41" fmla="*/ 1076325 w 1266825"/>
              <a:gd name="connsiteY41" fmla="*/ 857250 h 892175"/>
              <a:gd name="connsiteX42" fmla="*/ 1104900 w 1266825"/>
              <a:gd name="connsiteY42" fmla="*/ 892175 h 892175"/>
              <a:gd name="connsiteX43" fmla="*/ 1266825 w 1266825"/>
              <a:gd name="connsiteY43" fmla="*/ 892175 h 892175"/>
              <a:gd name="connsiteX44" fmla="*/ 1266825 w 1266825"/>
              <a:gd name="connsiteY44" fmla="*/ 885825 h 8921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1266825" h="892175">
                <a:moveTo>
                  <a:pt x="0" y="876300"/>
                </a:moveTo>
                <a:lnTo>
                  <a:pt x="12700" y="815975"/>
                </a:lnTo>
                <a:lnTo>
                  <a:pt x="34925" y="755650"/>
                </a:lnTo>
                <a:lnTo>
                  <a:pt x="53975" y="755650"/>
                </a:lnTo>
                <a:lnTo>
                  <a:pt x="79375" y="698500"/>
                </a:lnTo>
                <a:lnTo>
                  <a:pt x="92075" y="666750"/>
                </a:lnTo>
                <a:lnTo>
                  <a:pt x="120650" y="650875"/>
                </a:lnTo>
                <a:lnTo>
                  <a:pt x="142875" y="612775"/>
                </a:lnTo>
                <a:lnTo>
                  <a:pt x="161925" y="593725"/>
                </a:lnTo>
                <a:lnTo>
                  <a:pt x="174625" y="590550"/>
                </a:lnTo>
                <a:lnTo>
                  <a:pt x="222250" y="517525"/>
                </a:lnTo>
                <a:lnTo>
                  <a:pt x="250825" y="561975"/>
                </a:lnTo>
                <a:lnTo>
                  <a:pt x="266700" y="635000"/>
                </a:lnTo>
                <a:lnTo>
                  <a:pt x="304800" y="679450"/>
                </a:lnTo>
                <a:lnTo>
                  <a:pt x="333375" y="622300"/>
                </a:lnTo>
                <a:lnTo>
                  <a:pt x="355600" y="673100"/>
                </a:lnTo>
                <a:lnTo>
                  <a:pt x="393700" y="635000"/>
                </a:lnTo>
                <a:lnTo>
                  <a:pt x="441325" y="711200"/>
                </a:lnTo>
                <a:lnTo>
                  <a:pt x="469900" y="685800"/>
                </a:lnTo>
                <a:lnTo>
                  <a:pt x="492125" y="644525"/>
                </a:lnTo>
                <a:lnTo>
                  <a:pt x="523875" y="609600"/>
                </a:lnTo>
                <a:lnTo>
                  <a:pt x="574675" y="549275"/>
                </a:lnTo>
                <a:lnTo>
                  <a:pt x="622300" y="393700"/>
                </a:lnTo>
                <a:lnTo>
                  <a:pt x="641350" y="463550"/>
                </a:lnTo>
                <a:lnTo>
                  <a:pt x="676275" y="365125"/>
                </a:lnTo>
                <a:lnTo>
                  <a:pt x="692150" y="355600"/>
                </a:lnTo>
                <a:lnTo>
                  <a:pt x="720725" y="152400"/>
                </a:lnTo>
                <a:lnTo>
                  <a:pt x="736600" y="184150"/>
                </a:lnTo>
                <a:lnTo>
                  <a:pt x="749300" y="136525"/>
                </a:lnTo>
                <a:lnTo>
                  <a:pt x="768350" y="139700"/>
                </a:lnTo>
                <a:lnTo>
                  <a:pt x="812800" y="0"/>
                </a:lnTo>
                <a:lnTo>
                  <a:pt x="828675" y="0"/>
                </a:lnTo>
                <a:lnTo>
                  <a:pt x="850900" y="66675"/>
                </a:lnTo>
                <a:lnTo>
                  <a:pt x="869950" y="47625"/>
                </a:lnTo>
                <a:lnTo>
                  <a:pt x="876300" y="180975"/>
                </a:lnTo>
                <a:lnTo>
                  <a:pt x="904875" y="327025"/>
                </a:lnTo>
                <a:lnTo>
                  <a:pt x="923925" y="479425"/>
                </a:lnTo>
                <a:lnTo>
                  <a:pt x="936625" y="603250"/>
                </a:lnTo>
                <a:lnTo>
                  <a:pt x="965200" y="676275"/>
                </a:lnTo>
                <a:lnTo>
                  <a:pt x="990600" y="762000"/>
                </a:lnTo>
                <a:lnTo>
                  <a:pt x="1012825" y="828675"/>
                </a:lnTo>
                <a:lnTo>
                  <a:pt x="1076325" y="857250"/>
                </a:lnTo>
                <a:lnTo>
                  <a:pt x="1104900" y="892175"/>
                </a:lnTo>
                <a:lnTo>
                  <a:pt x="1266825" y="892175"/>
                </a:lnTo>
                <a:lnTo>
                  <a:pt x="1266825" y="88582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115" name="正方形/長方形 114">
            <a:extLst>
              <a:ext uri="{FF2B5EF4-FFF2-40B4-BE49-F238E27FC236}">
                <a16:creationId xmlns:a16="http://schemas.microsoft.com/office/drawing/2014/main" id="{88EA9C77-2BBA-D74C-A457-5CB3A746147D}"/>
              </a:ext>
            </a:extLst>
          </p:cNvPr>
          <p:cNvSpPr/>
          <p:nvPr/>
        </p:nvSpPr>
        <p:spPr>
          <a:xfrm>
            <a:off x="7572993" y="2258398"/>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cxnSp>
        <p:nvCxnSpPr>
          <p:cNvPr id="124" name="直線コネクタ 123">
            <a:extLst>
              <a:ext uri="{FF2B5EF4-FFF2-40B4-BE49-F238E27FC236}">
                <a16:creationId xmlns:a16="http://schemas.microsoft.com/office/drawing/2014/main" id="{200FB019-336C-E942-AE8A-DDCCCFD08D93}"/>
              </a:ext>
            </a:extLst>
          </p:cNvPr>
          <p:cNvCxnSpPr>
            <a:cxnSpLocks/>
          </p:cNvCxnSpPr>
          <p:nvPr/>
        </p:nvCxnSpPr>
        <p:spPr>
          <a:xfrm>
            <a:off x="2114033" y="4750031"/>
            <a:ext cx="0" cy="4640291"/>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25" name="直線コネクタ 124">
            <a:extLst>
              <a:ext uri="{FF2B5EF4-FFF2-40B4-BE49-F238E27FC236}">
                <a16:creationId xmlns:a16="http://schemas.microsoft.com/office/drawing/2014/main" id="{C8B556F1-C2AA-324B-ACB7-613605B50B19}"/>
              </a:ext>
            </a:extLst>
          </p:cNvPr>
          <p:cNvCxnSpPr>
            <a:cxnSpLocks/>
          </p:cNvCxnSpPr>
          <p:nvPr/>
        </p:nvCxnSpPr>
        <p:spPr>
          <a:xfrm>
            <a:off x="2044183" y="9383972"/>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26" name="直線コネクタ 125">
            <a:extLst>
              <a:ext uri="{FF2B5EF4-FFF2-40B4-BE49-F238E27FC236}">
                <a16:creationId xmlns:a16="http://schemas.microsoft.com/office/drawing/2014/main" id="{3A092E63-EE44-D54F-BB04-1B774F1158D9}"/>
              </a:ext>
            </a:extLst>
          </p:cNvPr>
          <p:cNvCxnSpPr>
            <a:cxnSpLocks/>
          </p:cNvCxnSpPr>
          <p:nvPr/>
        </p:nvCxnSpPr>
        <p:spPr>
          <a:xfrm>
            <a:off x="2044183" y="8750558"/>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27" name="直線コネクタ 126">
            <a:extLst>
              <a:ext uri="{FF2B5EF4-FFF2-40B4-BE49-F238E27FC236}">
                <a16:creationId xmlns:a16="http://schemas.microsoft.com/office/drawing/2014/main" id="{7A6FEB32-0D7C-524E-85F8-25FEE04EBFDC}"/>
              </a:ext>
            </a:extLst>
          </p:cNvPr>
          <p:cNvCxnSpPr>
            <a:cxnSpLocks/>
          </p:cNvCxnSpPr>
          <p:nvPr/>
        </p:nvCxnSpPr>
        <p:spPr>
          <a:xfrm>
            <a:off x="2044183" y="8117146"/>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28" name="直線コネクタ 127">
            <a:extLst>
              <a:ext uri="{FF2B5EF4-FFF2-40B4-BE49-F238E27FC236}">
                <a16:creationId xmlns:a16="http://schemas.microsoft.com/office/drawing/2014/main" id="{C58CD2BC-36C4-F84D-BE78-4085D4FEBEEF}"/>
              </a:ext>
            </a:extLst>
          </p:cNvPr>
          <p:cNvCxnSpPr>
            <a:cxnSpLocks/>
          </p:cNvCxnSpPr>
          <p:nvPr/>
        </p:nvCxnSpPr>
        <p:spPr>
          <a:xfrm>
            <a:off x="2044183" y="7483734"/>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29" name="直線コネクタ 128">
            <a:extLst>
              <a:ext uri="{FF2B5EF4-FFF2-40B4-BE49-F238E27FC236}">
                <a16:creationId xmlns:a16="http://schemas.microsoft.com/office/drawing/2014/main" id="{FFA91E00-5A4C-FA40-B818-481291093E48}"/>
              </a:ext>
            </a:extLst>
          </p:cNvPr>
          <p:cNvCxnSpPr>
            <a:cxnSpLocks/>
          </p:cNvCxnSpPr>
          <p:nvPr/>
        </p:nvCxnSpPr>
        <p:spPr>
          <a:xfrm>
            <a:off x="2044183" y="6850322"/>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130" name="テキスト ボックス 129">
            <a:extLst>
              <a:ext uri="{FF2B5EF4-FFF2-40B4-BE49-F238E27FC236}">
                <a16:creationId xmlns:a16="http://schemas.microsoft.com/office/drawing/2014/main" id="{E20A0C0F-DDE5-124B-B2F3-55AB15678419}"/>
              </a:ext>
            </a:extLst>
          </p:cNvPr>
          <p:cNvSpPr txBox="1"/>
          <p:nvPr/>
        </p:nvSpPr>
        <p:spPr>
          <a:xfrm>
            <a:off x="1760130" y="6696432"/>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4</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31" name="テキスト ボックス 130">
            <a:extLst>
              <a:ext uri="{FF2B5EF4-FFF2-40B4-BE49-F238E27FC236}">
                <a16:creationId xmlns:a16="http://schemas.microsoft.com/office/drawing/2014/main" id="{461312B3-628C-204B-A069-58612BCECDBE}"/>
              </a:ext>
            </a:extLst>
          </p:cNvPr>
          <p:cNvSpPr txBox="1"/>
          <p:nvPr/>
        </p:nvSpPr>
        <p:spPr>
          <a:xfrm>
            <a:off x="1760130" y="7331229"/>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3</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32" name="テキスト ボックス 131">
            <a:extLst>
              <a:ext uri="{FF2B5EF4-FFF2-40B4-BE49-F238E27FC236}">
                <a16:creationId xmlns:a16="http://schemas.microsoft.com/office/drawing/2014/main" id="{7C01779B-CA0D-FD4A-A55F-2D26A7E58A4D}"/>
              </a:ext>
            </a:extLst>
          </p:cNvPr>
          <p:cNvSpPr txBox="1"/>
          <p:nvPr/>
        </p:nvSpPr>
        <p:spPr>
          <a:xfrm>
            <a:off x="1760130" y="7957799"/>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2</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33" name="テキスト ボックス 132">
            <a:extLst>
              <a:ext uri="{FF2B5EF4-FFF2-40B4-BE49-F238E27FC236}">
                <a16:creationId xmlns:a16="http://schemas.microsoft.com/office/drawing/2014/main" id="{21247878-3C1D-DE44-9533-C0962EA32C5D}"/>
              </a:ext>
            </a:extLst>
          </p:cNvPr>
          <p:cNvSpPr txBox="1"/>
          <p:nvPr/>
        </p:nvSpPr>
        <p:spPr>
          <a:xfrm>
            <a:off x="1760130" y="8596670"/>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1</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34" name="テキスト ボックス 133">
            <a:extLst>
              <a:ext uri="{FF2B5EF4-FFF2-40B4-BE49-F238E27FC236}">
                <a16:creationId xmlns:a16="http://schemas.microsoft.com/office/drawing/2014/main" id="{D63D831A-2466-6B46-B62B-1E72E9976A28}"/>
              </a:ext>
            </a:extLst>
          </p:cNvPr>
          <p:cNvSpPr txBox="1"/>
          <p:nvPr/>
        </p:nvSpPr>
        <p:spPr>
          <a:xfrm>
            <a:off x="1760130" y="9230083"/>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0</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35" name="テキスト ボックス 134">
            <a:extLst>
              <a:ext uri="{FF2B5EF4-FFF2-40B4-BE49-F238E27FC236}">
                <a16:creationId xmlns:a16="http://schemas.microsoft.com/office/drawing/2014/main" id="{BEB5CE89-5C4E-EA47-B97B-644DFD5A461F}"/>
              </a:ext>
            </a:extLst>
          </p:cNvPr>
          <p:cNvSpPr txBox="1"/>
          <p:nvPr/>
        </p:nvSpPr>
        <p:spPr>
          <a:xfrm rot="16200000">
            <a:off x="883648" y="7009530"/>
            <a:ext cx="1337226"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IFN-</a:t>
            </a:r>
            <a:r>
              <a:rPr kumimoji="0" lang="el-GR"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γ</a:t>
            </a: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 (ng/mL)</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45" name="テキスト ボックス 144">
            <a:extLst>
              <a:ext uri="{FF2B5EF4-FFF2-40B4-BE49-F238E27FC236}">
                <a16:creationId xmlns:a16="http://schemas.microsoft.com/office/drawing/2014/main" id="{825A5F46-28B5-E041-87AA-142E6A898CC9}"/>
              </a:ext>
            </a:extLst>
          </p:cNvPr>
          <p:cNvSpPr txBox="1"/>
          <p:nvPr/>
        </p:nvSpPr>
        <p:spPr>
          <a:xfrm>
            <a:off x="2434708" y="10443796"/>
            <a:ext cx="1239442" cy="52322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Target: </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26-Jurkat</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46" name="正方形/長方形 145">
            <a:extLst>
              <a:ext uri="{FF2B5EF4-FFF2-40B4-BE49-F238E27FC236}">
                <a16:creationId xmlns:a16="http://schemas.microsoft.com/office/drawing/2014/main" id="{36CE6349-017B-9546-A638-B7B55B345956}"/>
              </a:ext>
            </a:extLst>
          </p:cNvPr>
          <p:cNvSpPr/>
          <p:nvPr/>
        </p:nvSpPr>
        <p:spPr>
          <a:xfrm>
            <a:off x="2434708" y="9331744"/>
            <a:ext cx="196850" cy="45719"/>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47" name="正方形/長方形 146">
            <a:extLst>
              <a:ext uri="{FF2B5EF4-FFF2-40B4-BE49-F238E27FC236}">
                <a16:creationId xmlns:a16="http://schemas.microsoft.com/office/drawing/2014/main" id="{0208F4DB-3DFA-CF40-A529-B6CBBF6AE907}"/>
              </a:ext>
            </a:extLst>
          </p:cNvPr>
          <p:cNvSpPr/>
          <p:nvPr/>
        </p:nvSpPr>
        <p:spPr>
          <a:xfrm>
            <a:off x="2755383" y="9331744"/>
            <a:ext cx="196850" cy="45719"/>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48" name="正方形/長方形 147">
            <a:extLst>
              <a:ext uri="{FF2B5EF4-FFF2-40B4-BE49-F238E27FC236}">
                <a16:creationId xmlns:a16="http://schemas.microsoft.com/office/drawing/2014/main" id="{5ED850BE-3731-A540-A84C-3A57364A9C0D}"/>
              </a:ext>
            </a:extLst>
          </p:cNvPr>
          <p:cNvSpPr/>
          <p:nvPr/>
        </p:nvSpPr>
        <p:spPr>
          <a:xfrm>
            <a:off x="3076058" y="8178203"/>
            <a:ext cx="196850" cy="1199261"/>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49" name="正方形/長方形 148">
            <a:extLst>
              <a:ext uri="{FF2B5EF4-FFF2-40B4-BE49-F238E27FC236}">
                <a16:creationId xmlns:a16="http://schemas.microsoft.com/office/drawing/2014/main" id="{C65106D7-D1EE-EF4D-B3AA-E8C27BEAF8CA}"/>
              </a:ext>
            </a:extLst>
          </p:cNvPr>
          <p:cNvSpPr/>
          <p:nvPr/>
        </p:nvSpPr>
        <p:spPr>
          <a:xfrm>
            <a:off x="3396734" y="7639006"/>
            <a:ext cx="196850" cy="1738458"/>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cxnSp>
        <p:nvCxnSpPr>
          <p:cNvPr id="150" name="直線コネクタ 149">
            <a:extLst>
              <a:ext uri="{FF2B5EF4-FFF2-40B4-BE49-F238E27FC236}">
                <a16:creationId xmlns:a16="http://schemas.microsoft.com/office/drawing/2014/main" id="{0BA8C8E4-2C68-034C-B149-6BD932370660}"/>
              </a:ext>
            </a:extLst>
          </p:cNvPr>
          <p:cNvCxnSpPr/>
          <p:nvPr/>
        </p:nvCxnSpPr>
        <p:spPr>
          <a:xfrm>
            <a:off x="3171308" y="7565621"/>
            <a:ext cx="0" cy="612582"/>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151" name="直線コネクタ 150">
            <a:extLst>
              <a:ext uri="{FF2B5EF4-FFF2-40B4-BE49-F238E27FC236}">
                <a16:creationId xmlns:a16="http://schemas.microsoft.com/office/drawing/2014/main" id="{AF5F1F34-0FBA-2643-8767-82D119F7144D}"/>
              </a:ext>
            </a:extLst>
          </p:cNvPr>
          <p:cNvCxnSpPr>
            <a:cxnSpLocks/>
          </p:cNvCxnSpPr>
          <p:nvPr/>
        </p:nvCxnSpPr>
        <p:spPr>
          <a:xfrm>
            <a:off x="3491983" y="6966796"/>
            <a:ext cx="0" cy="672210"/>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152" name="直線コネクタ 151">
            <a:extLst>
              <a:ext uri="{FF2B5EF4-FFF2-40B4-BE49-F238E27FC236}">
                <a16:creationId xmlns:a16="http://schemas.microsoft.com/office/drawing/2014/main" id="{2A8E5D31-AE25-DD4F-B53E-08C1EC717361}"/>
              </a:ext>
            </a:extLst>
          </p:cNvPr>
          <p:cNvCxnSpPr>
            <a:cxnSpLocks/>
          </p:cNvCxnSpPr>
          <p:nvPr/>
        </p:nvCxnSpPr>
        <p:spPr>
          <a:xfrm>
            <a:off x="2044183" y="6218268"/>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53" name="直線コネクタ 152">
            <a:extLst>
              <a:ext uri="{FF2B5EF4-FFF2-40B4-BE49-F238E27FC236}">
                <a16:creationId xmlns:a16="http://schemas.microsoft.com/office/drawing/2014/main" id="{CA7DA96E-2872-4847-B4C0-2F55B7267DAA}"/>
              </a:ext>
            </a:extLst>
          </p:cNvPr>
          <p:cNvCxnSpPr>
            <a:cxnSpLocks/>
          </p:cNvCxnSpPr>
          <p:nvPr/>
        </p:nvCxnSpPr>
        <p:spPr>
          <a:xfrm>
            <a:off x="2044183" y="5584856"/>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54" name="直線コネクタ 153">
            <a:extLst>
              <a:ext uri="{FF2B5EF4-FFF2-40B4-BE49-F238E27FC236}">
                <a16:creationId xmlns:a16="http://schemas.microsoft.com/office/drawing/2014/main" id="{19B353A8-2730-B142-B4E7-2E161104CAAF}"/>
              </a:ext>
            </a:extLst>
          </p:cNvPr>
          <p:cNvCxnSpPr>
            <a:cxnSpLocks/>
          </p:cNvCxnSpPr>
          <p:nvPr/>
        </p:nvCxnSpPr>
        <p:spPr>
          <a:xfrm>
            <a:off x="2044183" y="4951444"/>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155" name="テキスト ボックス 154">
            <a:extLst>
              <a:ext uri="{FF2B5EF4-FFF2-40B4-BE49-F238E27FC236}">
                <a16:creationId xmlns:a16="http://schemas.microsoft.com/office/drawing/2014/main" id="{01EEF9D5-4892-0D44-BE2F-39ACEF6916B1}"/>
              </a:ext>
            </a:extLst>
          </p:cNvPr>
          <p:cNvSpPr txBox="1"/>
          <p:nvPr/>
        </p:nvSpPr>
        <p:spPr>
          <a:xfrm>
            <a:off x="1760130" y="4797554"/>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7</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56" name="テキスト ボックス 155">
            <a:extLst>
              <a:ext uri="{FF2B5EF4-FFF2-40B4-BE49-F238E27FC236}">
                <a16:creationId xmlns:a16="http://schemas.microsoft.com/office/drawing/2014/main" id="{4F5777B9-88B1-CD4A-9B27-BBEC09CF160D}"/>
              </a:ext>
            </a:extLst>
          </p:cNvPr>
          <p:cNvSpPr txBox="1"/>
          <p:nvPr/>
        </p:nvSpPr>
        <p:spPr>
          <a:xfrm>
            <a:off x="1760130" y="5432351"/>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6</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57" name="テキスト ボックス 156">
            <a:extLst>
              <a:ext uri="{FF2B5EF4-FFF2-40B4-BE49-F238E27FC236}">
                <a16:creationId xmlns:a16="http://schemas.microsoft.com/office/drawing/2014/main" id="{9A978803-1B41-BF47-B4FC-BD86F67F8537}"/>
              </a:ext>
            </a:extLst>
          </p:cNvPr>
          <p:cNvSpPr txBox="1"/>
          <p:nvPr/>
        </p:nvSpPr>
        <p:spPr>
          <a:xfrm>
            <a:off x="1760130" y="6058921"/>
            <a:ext cx="284052"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5</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58" name="正方形/長方形 157">
            <a:extLst>
              <a:ext uri="{FF2B5EF4-FFF2-40B4-BE49-F238E27FC236}">
                <a16:creationId xmlns:a16="http://schemas.microsoft.com/office/drawing/2014/main" id="{E56B0C6F-7B30-8A48-988A-ABEC6D7F4443}"/>
              </a:ext>
            </a:extLst>
          </p:cNvPr>
          <p:cNvSpPr/>
          <p:nvPr/>
        </p:nvSpPr>
        <p:spPr>
          <a:xfrm>
            <a:off x="4001754" y="5542997"/>
            <a:ext cx="196850" cy="3834467"/>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59" name="正方形/長方形 158">
            <a:extLst>
              <a:ext uri="{FF2B5EF4-FFF2-40B4-BE49-F238E27FC236}">
                <a16:creationId xmlns:a16="http://schemas.microsoft.com/office/drawing/2014/main" id="{0E211DEA-B7BD-5B4F-ADC2-785A5A7137EE}"/>
              </a:ext>
            </a:extLst>
          </p:cNvPr>
          <p:cNvSpPr/>
          <p:nvPr/>
        </p:nvSpPr>
        <p:spPr>
          <a:xfrm>
            <a:off x="4322429" y="5497279"/>
            <a:ext cx="196850" cy="3880184"/>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60" name="正方形/長方形 159">
            <a:extLst>
              <a:ext uri="{FF2B5EF4-FFF2-40B4-BE49-F238E27FC236}">
                <a16:creationId xmlns:a16="http://schemas.microsoft.com/office/drawing/2014/main" id="{2D101D3E-514E-0647-A8DB-DC088B32DF4E}"/>
              </a:ext>
            </a:extLst>
          </p:cNvPr>
          <p:cNvSpPr/>
          <p:nvPr/>
        </p:nvSpPr>
        <p:spPr>
          <a:xfrm>
            <a:off x="4643103" y="5542997"/>
            <a:ext cx="196850" cy="3834468"/>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61" name="正方形/長方形 160">
            <a:extLst>
              <a:ext uri="{FF2B5EF4-FFF2-40B4-BE49-F238E27FC236}">
                <a16:creationId xmlns:a16="http://schemas.microsoft.com/office/drawing/2014/main" id="{4E104ED9-586F-3141-B557-9F3F237FA3BB}"/>
              </a:ext>
            </a:extLst>
          </p:cNvPr>
          <p:cNvSpPr/>
          <p:nvPr/>
        </p:nvSpPr>
        <p:spPr>
          <a:xfrm>
            <a:off x="4963778" y="5497280"/>
            <a:ext cx="196850" cy="3880185"/>
          </a:xfrm>
          <a:prstGeom prst="rect">
            <a:avLst/>
          </a:prstGeom>
          <a:solidFill>
            <a:schemeClr val="bg1">
              <a:lumMod val="75000"/>
            </a:schemeClr>
          </a:solidFill>
          <a:ln w="12700">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black"/>
              </a:solidFill>
              <a:effectLst/>
              <a:uLnTx/>
              <a:uFillTx/>
              <a:latin typeface="Calibri" panose="020F0502020204030204"/>
              <a:ea typeface="游ゴシック" panose="020B0400000000000000" pitchFamily="34" charset="-128"/>
              <a:cs typeface="+mn-cs"/>
            </a:endParaRPr>
          </a:p>
        </p:txBody>
      </p:sp>
      <p:cxnSp>
        <p:nvCxnSpPr>
          <p:cNvPr id="162" name="直線コネクタ 161">
            <a:extLst>
              <a:ext uri="{FF2B5EF4-FFF2-40B4-BE49-F238E27FC236}">
                <a16:creationId xmlns:a16="http://schemas.microsoft.com/office/drawing/2014/main" id="{C9659CD0-556D-264F-9655-0575B67EF82E}"/>
              </a:ext>
            </a:extLst>
          </p:cNvPr>
          <p:cNvCxnSpPr>
            <a:cxnSpLocks/>
          </p:cNvCxnSpPr>
          <p:nvPr/>
        </p:nvCxnSpPr>
        <p:spPr>
          <a:xfrm>
            <a:off x="4098922" y="5473564"/>
            <a:ext cx="0" cy="76797"/>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163" name="テキスト ボックス 162">
            <a:extLst>
              <a:ext uri="{FF2B5EF4-FFF2-40B4-BE49-F238E27FC236}">
                <a16:creationId xmlns:a16="http://schemas.microsoft.com/office/drawing/2014/main" id="{A30480D3-6DA8-3E44-AA73-8ABC482FF11D}"/>
              </a:ext>
            </a:extLst>
          </p:cNvPr>
          <p:cNvSpPr txBox="1"/>
          <p:nvPr/>
        </p:nvSpPr>
        <p:spPr>
          <a:xfrm>
            <a:off x="4001754" y="10443797"/>
            <a:ext cx="1635384" cy="52322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Positive control: </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P/I</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cxnSp>
        <p:nvCxnSpPr>
          <p:cNvPr id="164" name="直線コネクタ 163">
            <a:extLst>
              <a:ext uri="{FF2B5EF4-FFF2-40B4-BE49-F238E27FC236}">
                <a16:creationId xmlns:a16="http://schemas.microsoft.com/office/drawing/2014/main" id="{B8A08ED6-BF15-154E-A785-47D01235E383}"/>
              </a:ext>
            </a:extLst>
          </p:cNvPr>
          <p:cNvCxnSpPr>
            <a:cxnSpLocks/>
          </p:cNvCxnSpPr>
          <p:nvPr/>
        </p:nvCxnSpPr>
        <p:spPr>
          <a:xfrm>
            <a:off x="2114033" y="9383972"/>
            <a:ext cx="3470007"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166" name="TextBox 15">
            <a:extLst>
              <a:ext uri="{FF2B5EF4-FFF2-40B4-BE49-F238E27FC236}">
                <a16:creationId xmlns:a16="http://schemas.microsoft.com/office/drawing/2014/main" id="{7899F15E-AA79-AF4B-AFC8-5D944D57FA2E}"/>
              </a:ext>
            </a:extLst>
          </p:cNvPr>
          <p:cNvSpPr txBox="1"/>
          <p:nvPr/>
        </p:nvSpPr>
        <p:spPr>
          <a:xfrm>
            <a:off x="899323" y="4545361"/>
            <a:ext cx="536325" cy="369332"/>
          </a:xfrm>
          <a:prstGeom prst="rect">
            <a:avLst/>
          </a:prstGeom>
          <a:noFill/>
        </p:spPr>
        <p:txBody>
          <a:bodyPr wrap="square" rtlCol="0">
            <a:spAutoFit/>
          </a:bodyPr>
          <a:lstStyle/>
          <a:p>
            <a:pPr marL="0" marR="0" lvl="0" indent="0" algn="l" defTabSz="914361" rtl="0" eaLnBrk="1" fontAlgn="auto" latinLnBrk="0" hangingPunct="1">
              <a:lnSpc>
                <a:spcPct val="100000"/>
              </a:lnSpc>
              <a:spcBef>
                <a:spcPts val="0"/>
              </a:spcBef>
              <a:spcAft>
                <a:spcPts val="0"/>
              </a:spcAft>
              <a:buClrTx/>
              <a:buSzTx/>
              <a:buFontTx/>
              <a:buNone/>
              <a:tabLst/>
              <a:defRPr/>
            </a:pPr>
            <a:r>
              <a:rPr kumimoji="0" lang="en-US" altLang="ja-JP" sz="18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B)</a:t>
            </a:r>
          </a:p>
        </p:txBody>
      </p:sp>
      <p:sp>
        <p:nvSpPr>
          <p:cNvPr id="168" name="テキスト ボックス 167">
            <a:extLst>
              <a:ext uri="{FF2B5EF4-FFF2-40B4-BE49-F238E27FC236}">
                <a16:creationId xmlns:a16="http://schemas.microsoft.com/office/drawing/2014/main" id="{E351BA12-E0D4-A248-8F37-F11C85C4C0D5}"/>
              </a:ext>
            </a:extLst>
          </p:cNvPr>
          <p:cNvSpPr txBox="1"/>
          <p:nvPr/>
        </p:nvSpPr>
        <p:spPr>
          <a:xfrm rot="16200000">
            <a:off x="2113832" y="9652729"/>
            <a:ext cx="832279"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8 2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69" name="テキスト ボックス 168">
            <a:extLst>
              <a:ext uri="{FF2B5EF4-FFF2-40B4-BE49-F238E27FC236}">
                <a16:creationId xmlns:a16="http://schemas.microsoft.com/office/drawing/2014/main" id="{12E4DCC9-C532-5242-B80C-B03392184D91}"/>
              </a:ext>
            </a:extLst>
          </p:cNvPr>
          <p:cNvSpPr txBox="1"/>
          <p:nvPr/>
        </p:nvSpPr>
        <p:spPr>
          <a:xfrm rot="16200000">
            <a:off x="2436964" y="9652729"/>
            <a:ext cx="832279"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8 3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70" name="テキスト ボックス 169">
            <a:extLst>
              <a:ext uri="{FF2B5EF4-FFF2-40B4-BE49-F238E27FC236}">
                <a16:creationId xmlns:a16="http://schemas.microsoft.com/office/drawing/2014/main" id="{EA9F2276-ABDC-2D45-B994-58B91E988A0B}"/>
              </a:ext>
            </a:extLst>
          </p:cNvPr>
          <p:cNvSpPr txBox="1"/>
          <p:nvPr/>
        </p:nvSpPr>
        <p:spPr>
          <a:xfrm rot="16200000">
            <a:off x="2710403" y="9702422"/>
            <a:ext cx="931665"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26 2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71" name="テキスト ボックス 170">
            <a:extLst>
              <a:ext uri="{FF2B5EF4-FFF2-40B4-BE49-F238E27FC236}">
                <a16:creationId xmlns:a16="http://schemas.microsoft.com/office/drawing/2014/main" id="{8FBC193F-410D-6348-9EAB-86A6386F7311}"/>
              </a:ext>
            </a:extLst>
          </p:cNvPr>
          <p:cNvSpPr txBox="1"/>
          <p:nvPr/>
        </p:nvSpPr>
        <p:spPr>
          <a:xfrm rot="16200000">
            <a:off x="3033536" y="9702422"/>
            <a:ext cx="931665"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26 3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72" name="テキスト ボックス 171">
            <a:extLst>
              <a:ext uri="{FF2B5EF4-FFF2-40B4-BE49-F238E27FC236}">
                <a16:creationId xmlns:a16="http://schemas.microsoft.com/office/drawing/2014/main" id="{D2486205-0E2C-244F-9CF4-3E5F6D5BDDB4}"/>
              </a:ext>
            </a:extLst>
          </p:cNvPr>
          <p:cNvSpPr txBox="1"/>
          <p:nvPr/>
        </p:nvSpPr>
        <p:spPr>
          <a:xfrm rot="16200000">
            <a:off x="3685231" y="9651840"/>
            <a:ext cx="832279"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8 2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73" name="テキスト ボックス 172">
            <a:extLst>
              <a:ext uri="{FF2B5EF4-FFF2-40B4-BE49-F238E27FC236}">
                <a16:creationId xmlns:a16="http://schemas.microsoft.com/office/drawing/2014/main" id="{E5399EB0-86A9-8248-B660-3854DEFFAB8F}"/>
              </a:ext>
            </a:extLst>
          </p:cNvPr>
          <p:cNvSpPr txBox="1"/>
          <p:nvPr/>
        </p:nvSpPr>
        <p:spPr>
          <a:xfrm rot="16200000">
            <a:off x="4008363" y="9651840"/>
            <a:ext cx="832279"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8 3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74" name="テキスト ボックス 173">
            <a:extLst>
              <a:ext uri="{FF2B5EF4-FFF2-40B4-BE49-F238E27FC236}">
                <a16:creationId xmlns:a16="http://schemas.microsoft.com/office/drawing/2014/main" id="{08929B30-78B2-3F48-9BD3-B015EC88638B}"/>
              </a:ext>
            </a:extLst>
          </p:cNvPr>
          <p:cNvSpPr txBox="1"/>
          <p:nvPr/>
        </p:nvSpPr>
        <p:spPr>
          <a:xfrm rot="16200000">
            <a:off x="4281802" y="9701533"/>
            <a:ext cx="931665"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26 2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75" name="テキスト ボックス 174">
            <a:extLst>
              <a:ext uri="{FF2B5EF4-FFF2-40B4-BE49-F238E27FC236}">
                <a16:creationId xmlns:a16="http://schemas.microsoft.com/office/drawing/2014/main" id="{6DD43DE5-63E6-EC40-9894-50126F11340D}"/>
              </a:ext>
            </a:extLst>
          </p:cNvPr>
          <p:cNvSpPr txBox="1"/>
          <p:nvPr/>
        </p:nvSpPr>
        <p:spPr>
          <a:xfrm rot="16200000">
            <a:off x="4604935" y="9701533"/>
            <a:ext cx="931665" cy="307777"/>
          </a:xfrm>
          <a:prstGeom prst="rect">
            <a:avLst/>
          </a:prstGeom>
          <a:noFill/>
        </p:spPr>
        <p:txBody>
          <a:bodyPr wrap="non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CD26 3G</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5" name="テキスト ボックス 4">
            <a:extLst>
              <a:ext uri="{FF2B5EF4-FFF2-40B4-BE49-F238E27FC236}">
                <a16:creationId xmlns:a16="http://schemas.microsoft.com/office/drawing/2014/main" id="{4CEAFBEC-3C86-F0D9-3200-B421F2EDCB86}"/>
              </a:ext>
            </a:extLst>
          </p:cNvPr>
          <p:cNvSpPr txBox="1"/>
          <p:nvPr/>
        </p:nvSpPr>
        <p:spPr>
          <a:xfrm>
            <a:off x="2434708" y="11066196"/>
            <a:ext cx="2014911" cy="307777"/>
          </a:xfrm>
          <a:prstGeom prst="rect">
            <a:avLst/>
          </a:prstGeom>
          <a:noFill/>
        </p:spPr>
        <p:txBody>
          <a:bodyPr wrap="none" rtlCol="0">
            <a:spAutoFit/>
          </a:bodyPr>
          <a:lstStyle/>
          <a:p>
            <a:pPr>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Effector: Target = 1: 1</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3" name="テキスト ボックス 2">
            <a:extLst>
              <a:ext uri="{FF2B5EF4-FFF2-40B4-BE49-F238E27FC236}">
                <a16:creationId xmlns:a16="http://schemas.microsoft.com/office/drawing/2014/main" id="{98585DAC-A434-8335-EDAF-34993904E9DD}"/>
              </a:ext>
            </a:extLst>
          </p:cNvPr>
          <p:cNvSpPr txBox="1"/>
          <p:nvPr/>
        </p:nvSpPr>
        <p:spPr>
          <a:xfrm>
            <a:off x="6837367" y="3928176"/>
            <a:ext cx="2014911" cy="307777"/>
          </a:xfrm>
          <a:prstGeom prst="rect">
            <a:avLst/>
          </a:prstGeom>
          <a:noFill/>
        </p:spPr>
        <p:txBody>
          <a:bodyPr wrap="none" rtlCol="0">
            <a:spAutoFit/>
          </a:bodyPr>
          <a:lstStyle/>
          <a:p>
            <a:pPr algn="r">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Effector: Target = 1: 1</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4" name="テキスト ボックス 3">
            <a:extLst>
              <a:ext uri="{FF2B5EF4-FFF2-40B4-BE49-F238E27FC236}">
                <a16:creationId xmlns:a16="http://schemas.microsoft.com/office/drawing/2014/main" id="{CA0E1890-6DF3-484D-26EE-ADD615FA7F22}"/>
              </a:ext>
            </a:extLst>
          </p:cNvPr>
          <p:cNvSpPr txBox="1"/>
          <p:nvPr/>
        </p:nvSpPr>
        <p:spPr>
          <a:xfrm>
            <a:off x="617974" y="11518740"/>
            <a:ext cx="7824554" cy="1015663"/>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ＭＳ Ｐゴシック" panose="020B0600070205080204" pitchFamily="34" charset="-128"/>
              </a:rPr>
              <a:t>Figure S2: Activation of CD26 CAR-T cells.</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200" kern="0" dirty="0">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Effector cells (CD26 2/3G CAR-T cells and CD8 2/3G control cells) were cultured with both </a:t>
            </a:r>
            <a:r>
              <a:rPr lang="en-US" altLang="ja-JP" sz="1200" kern="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PMA and ionomycin</a:t>
            </a:r>
            <a:r>
              <a:rPr lang="en-US" altLang="ja-JP" sz="1200" kern="0" dirty="0">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 (P/I) as positive controls or with CD26-Jurkat cells as target cells </a:t>
            </a:r>
            <a:r>
              <a:rPr lang="en-US" altLang="ja-JP" sz="1200" kern="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at an effector: target ratio of 1:1</a:t>
            </a:r>
            <a:r>
              <a:rPr lang="en-US" altLang="ja-JP" sz="1200" kern="0" dirty="0">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 (A) CD69 expression on effector cells was analyzed by flow cytometry. (B) Secretion of IFN-</a:t>
            </a:r>
            <a:r>
              <a:rPr lang="en-US" altLang="ja-JP" sz="1200" kern="0" dirty="0" err="1">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γ</a:t>
            </a:r>
            <a:r>
              <a:rPr lang="en-US" altLang="ja-JP" sz="1200" kern="0" dirty="0">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 was evaluated by ELISA assay. </a:t>
            </a:r>
            <a:endParaRPr lang="ja-JP" altLang="en-US" sz="1200"/>
          </a:p>
        </p:txBody>
      </p:sp>
    </p:spTree>
    <p:extLst>
      <p:ext uri="{BB962C8B-B14F-4D97-AF65-F5344CB8AC3E}">
        <p14:creationId xmlns:p14="http://schemas.microsoft.com/office/powerpoint/2010/main" val="9168842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48">
            <a:extLst>
              <a:ext uri="{FF2B5EF4-FFF2-40B4-BE49-F238E27FC236}">
                <a16:creationId xmlns:a16="http://schemas.microsoft.com/office/drawing/2014/main" id="{FA8CF970-33E6-8B4E-A344-EEC3E8E08B53}"/>
              </a:ext>
            </a:extLst>
          </p:cNvPr>
          <p:cNvSpPr txBox="1"/>
          <p:nvPr/>
        </p:nvSpPr>
        <p:spPr>
          <a:xfrm>
            <a:off x="2814994" y="636203"/>
            <a:ext cx="1306436"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CD26-Jurkat</a:t>
            </a:r>
          </a:p>
        </p:txBody>
      </p:sp>
      <p:sp>
        <p:nvSpPr>
          <p:cNvPr id="18" name="TextBox 53">
            <a:extLst>
              <a:ext uri="{FF2B5EF4-FFF2-40B4-BE49-F238E27FC236}">
                <a16:creationId xmlns:a16="http://schemas.microsoft.com/office/drawing/2014/main" id="{EF2B270A-2354-6447-BE12-8AD3B19BE451}"/>
              </a:ext>
            </a:extLst>
          </p:cNvPr>
          <p:cNvSpPr txBox="1"/>
          <p:nvPr/>
        </p:nvSpPr>
        <p:spPr>
          <a:xfrm>
            <a:off x="2844752" y="2755155"/>
            <a:ext cx="1184237"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H9</a:t>
            </a:r>
          </a:p>
        </p:txBody>
      </p:sp>
      <p:sp>
        <p:nvSpPr>
          <p:cNvPr id="19" name="TextBox 48">
            <a:extLst>
              <a:ext uri="{FF2B5EF4-FFF2-40B4-BE49-F238E27FC236}">
                <a16:creationId xmlns:a16="http://schemas.microsoft.com/office/drawing/2014/main" id="{DC1C12DF-4218-AA47-88CB-0A6B1870FF5C}"/>
              </a:ext>
            </a:extLst>
          </p:cNvPr>
          <p:cNvSpPr txBox="1"/>
          <p:nvPr/>
        </p:nvSpPr>
        <p:spPr>
          <a:xfrm>
            <a:off x="1212673" y="2755154"/>
            <a:ext cx="1241774"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KARPAS299</a:t>
            </a:r>
          </a:p>
        </p:txBody>
      </p:sp>
      <p:sp>
        <p:nvSpPr>
          <p:cNvPr id="20" name="TextBox 53">
            <a:extLst>
              <a:ext uri="{FF2B5EF4-FFF2-40B4-BE49-F238E27FC236}">
                <a16:creationId xmlns:a16="http://schemas.microsoft.com/office/drawing/2014/main" id="{F08B023F-D8D0-B145-8070-9DE70EBEFD79}"/>
              </a:ext>
            </a:extLst>
          </p:cNvPr>
          <p:cNvSpPr txBox="1"/>
          <p:nvPr/>
        </p:nvSpPr>
        <p:spPr>
          <a:xfrm>
            <a:off x="4443264" y="2755155"/>
            <a:ext cx="1266379"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HSB2</a:t>
            </a:r>
          </a:p>
        </p:txBody>
      </p:sp>
      <p:sp>
        <p:nvSpPr>
          <p:cNvPr id="21" name="TextBox 15">
            <a:extLst>
              <a:ext uri="{FF2B5EF4-FFF2-40B4-BE49-F238E27FC236}">
                <a16:creationId xmlns:a16="http://schemas.microsoft.com/office/drawing/2014/main" id="{680408F5-5988-8842-98AD-9E3977602CA0}"/>
              </a:ext>
            </a:extLst>
          </p:cNvPr>
          <p:cNvSpPr txBox="1"/>
          <p:nvPr/>
        </p:nvSpPr>
        <p:spPr>
          <a:xfrm>
            <a:off x="943686" y="636202"/>
            <a:ext cx="1644450"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err="1">
                <a:ln>
                  <a:noFill/>
                </a:ln>
                <a:solidFill>
                  <a:prstClr val="black"/>
                </a:solidFill>
                <a:effectLst/>
                <a:uLnTx/>
                <a:uFillTx/>
                <a:latin typeface="Helvetica" pitchFamily="2" charset="0"/>
                <a:ea typeface="Meiryo" panose="020B0604030504040204" pitchFamily="34" charset="-128"/>
                <a:cs typeface="+mn-cs"/>
              </a:rPr>
              <a:t>Jurkat</a:t>
            </a:r>
            <a:endPar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22" name="TextBox 48">
            <a:extLst>
              <a:ext uri="{FF2B5EF4-FFF2-40B4-BE49-F238E27FC236}">
                <a16:creationId xmlns:a16="http://schemas.microsoft.com/office/drawing/2014/main" id="{3FAE5E52-DE2F-144D-B798-1EB4DD5F0609}"/>
              </a:ext>
            </a:extLst>
          </p:cNvPr>
          <p:cNvSpPr txBox="1"/>
          <p:nvPr/>
        </p:nvSpPr>
        <p:spPr>
          <a:xfrm>
            <a:off x="7781215" y="2777259"/>
            <a:ext cx="1184237"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PEER</a:t>
            </a:r>
          </a:p>
        </p:txBody>
      </p:sp>
      <p:sp>
        <p:nvSpPr>
          <p:cNvPr id="23" name="TextBox 15">
            <a:extLst>
              <a:ext uri="{FF2B5EF4-FFF2-40B4-BE49-F238E27FC236}">
                <a16:creationId xmlns:a16="http://schemas.microsoft.com/office/drawing/2014/main" id="{F1F7C87C-3786-F147-AAF1-D1BA9EECEA1D}"/>
              </a:ext>
            </a:extLst>
          </p:cNvPr>
          <p:cNvSpPr txBox="1"/>
          <p:nvPr/>
        </p:nvSpPr>
        <p:spPr>
          <a:xfrm>
            <a:off x="5909907" y="2777259"/>
            <a:ext cx="1644450" cy="307777"/>
          </a:xfrm>
          <a:prstGeom prst="rect">
            <a:avLst/>
          </a:prstGeom>
          <a:noFill/>
        </p:spPr>
        <p:txBody>
          <a:bodyPr wrap="square" rtlCol="0">
            <a:spAutoFit/>
          </a:bodyPr>
          <a:lstStyle/>
          <a:p>
            <a:pPr marL="0" marR="0" lvl="0" indent="0" algn="ctr" defTabSz="914361"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Ki-JK</a:t>
            </a:r>
          </a:p>
        </p:txBody>
      </p:sp>
      <p:sp>
        <p:nvSpPr>
          <p:cNvPr id="36" name="正方形/長方形 35">
            <a:extLst>
              <a:ext uri="{FF2B5EF4-FFF2-40B4-BE49-F238E27FC236}">
                <a16:creationId xmlns:a16="http://schemas.microsoft.com/office/drawing/2014/main" id="{41B8BA02-157E-F045-9879-7718CD2EB7B3}"/>
              </a:ext>
            </a:extLst>
          </p:cNvPr>
          <p:cNvSpPr/>
          <p:nvPr/>
        </p:nvSpPr>
        <p:spPr>
          <a:xfrm>
            <a:off x="1177322" y="1038595"/>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37" name="フリーフォーム 36">
            <a:extLst>
              <a:ext uri="{FF2B5EF4-FFF2-40B4-BE49-F238E27FC236}">
                <a16:creationId xmlns:a16="http://schemas.microsoft.com/office/drawing/2014/main" id="{14EFC88E-A832-3044-9458-77E531F193D9}"/>
              </a:ext>
            </a:extLst>
          </p:cNvPr>
          <p:cNvSpPr/>
          <p:nvPr/>
        </p:nvSpPr>
        <p:spPr>
          <a:xfrm>
            <a:off x="1183695" y="1225640"/>
            <a:ext cx="1254125" cy="1073150"/>
          </a:xfrm>
          <a:custGeom>
            <a:avLst/>
            <a:gdLst>
              <a:gd name="connsiteX0" fmla="*/ 0 w 1254125"/>
              <a:gd name="connsiteY0" fmla="*/ 1069975 h 1073150"/>
              <a:gd name="connsiteX1" fmla="*/ 31750 w 1254125"/>
              <a:gd name="connsiteY1" fmla="*/ 958850 h 1073150"/>
              <a:gd name="connsiteX2" fmla="*/ 63500 w 1254125"/>
              <a:gd name="connsiteY2" fmla="*/ 981075 h 1073150"/>
              <a:gd name="connsiteX3" fmla="*/ 114300 w 1254125"/>
              <a:gd name="connsiteY3" fmla="*/ 876300 h 1073150"/>
              <a:gd name="connsiteX4" fmla="*/ 158750 w 1254125"/>
              <a:gd name="connsiteY4" fmla="*/ 819150 h 1073150"/>
              <a:gd name="connsiteX5" fmla="*/ 184150 w 1254125"/>
              <a:gd name="connsiteY5" fmla="*/ 755650 h 1073150"/>
              <a:gd name="connsiteX6" fmla="*/ 206375 w 1254125"/>
              <a:gd name="connsiteY6" fmla="*/ 701675 h 1073150"/>
              <a:gd name="connsiteX7" fmla="*/ 228600 w 1254125"/>
              <a:gd name="connsiteY7" fmla="*/ 635000 h 1073150"/>
              <a:gd name="connsiteX8" fmla="*/ 241300 w 1254125"/>
              <a:gd name="connsiteY8" fmla="*/ 523875 h 1073150"/>
              <a:gd name="connsiteX9" fmla="*/ 257175 w 1254125"/>
              <a:gd name="connsiteY9" fmla="*/ 454025 h 1073150"/>
              <a:gd name="connsiteX10" fmla="*/ 269875 w 1254125"/>
              <a:gd name="connsiteY10" fmla="*/ 314325 h 1073150"/>
              <a:gd name="connsiteX11" fmla="*/ 285750 w 1254125"/>
              <a:gd name="connsiteY11" fmla="*/ 409575 h 1073150"/>
              <a:gd name="connsiteX12" fmla="*/ 307975 w 1254125"/>
              <a:gd name="connsiteY12" fmla="*/ 203200 h 1073150"/>
              <a:gd name="connsiteX13" fmla="*/ 320675 w 1254125"/>
              <a:gd name="connsiteY13" fmla="*/ 180975 h 1073150"/>
              <a:gd name="connsiteX14" fmla="*/ 336550 w 1254125"/>
              <a:gd name="connsiteY14" fmla="*/ 82550 h 1073150"/>
              <a:gd name="connsiteX15" fmla="*/ 361950 w 1254125"/>
              <a:gd name="connsiteY15" fmla="*/ 0 h 1073150"/>
              <a:gd name="connsiteX16" fmla="*/ 377825 w 1254125"/>
              <a:gd name="connsiteY16" fmla="*/ 73025 h 1073150"/>
              <a:gd name="connsiteX17" fmla="*/ 396875 w 1254125"/>
              <a:gd name="connsiteY17" fmla="*/ 47625 h 1073150"/>
              <a:gd name="connsiteX18" fmla="*/ 412750 w 1254125"/>
              <a:gd name="connsiteY18" fmla="*/ 104775 h 1073150"/>
              <a:gd name="connsiteX19" fmla="*/ 422275 w 1254125"/>
              <a:gd name="connsiteY19" fmla="*/ 88900 h 1073150"/>
              <a:gd name="connsiteX20" fmla="*/ 444500 w 1254125"/>
              <a:gd name="connsiteY20" fmla="*/ 361950 h 1073150"/>
              <a:gd name="connsiteX21" fmla="*/ 447675 w 1254125"/>
              <a:gd name="connsiteY21" fmla="*/ 536575 h 1073150"/>
              <a:gd name="connsiteX22" fmla="*/ 463550 w 1254125"/>
              <a:gd name="connsiteY22" fmla="*/ 708025 h 1073150"/>
              <a:gd name="connsiteX23" fmla="*/ 482600 w 1254125"/>
              <a:gd name="connsiteY23" fmla="*/ 800100 h 1073150"/>
              <a:gd name="connsiteX24" fmla="*/ 492125 w 1254125"/>
              <a:gd name="connsiteY24" fmla="*/ 892175 h 1073150"/>
              <a:gd name="connsiteX25" fmla="*/ 514350 w 1254125"/>
              <a:gd name="connsiteY25" fmla="*/ 1000125 h 1073150"/>
              <a:gd name="connsiteX26" fmla="*/ 530225 w 1254125"/>
              <a:gd name="connsiteY26" fmla="*/ 1044575 h 1073150"/>
              <a:gd name="connsiteX27" fmla="*/ 555625 w 1254125"/>
              <a:gd name="connsiteY27" fmla="*/ 1066800 h 1073150"/>
              <a:gd name="connsiteX28" fmla="*/ 603250 w 1254125"/>
              <a:gd name="connsiteY28" fmla="*/ 1073150 h 1073150"/>
              <a:gd name="connsiteX29" fmla="*/ 1254125 w 1254125"/>
              <a:gd name="connsiteY29" fmla="*/ 1073150 h 10731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Lst>
            <a:rect l="l" t="t" r="r" b="b"/>
            <a:pathLst>
              <a:path w="1254125" h="1073150">
                <a:moveTo>
                  <a:pt x="0" y="1069975"/>
                </a:moveTo>
                <a:lnTo>
                  <a:pt x="31750" y="958850"/>
                </a:lnTo>
                <a:lnTo>
                  <a:pt x="63500" y="981075"/>
                </a:lnTo>
                <a:lnTo>
                  <a:pt x="114300" y="876300"/>
                </a:lnTo>
                <a:lnTo>
                  <a:pt x="158750" y="819150"/>
                </a:lnTo>
                <a:lnTo>
                  <a:pt x="184150" y="755650"/>
                </a:lnTo>
                <a:lnTo>
                  <a:pt x="206375" y="701675"/>
                </a:lnTo>
                <a:lnTo>
                  <a:pt x="228600" y="635000"/>
                </a:lnTo>
                <a:lnTo>
                  <a:pt x="241300" y="523875"/>
                </a:lnTo>
                <a:lnTo>
                  <a:pt x="257175" y="454025"/>
                </a:lnTo>
                <a:lnTo>
                  <a:pt x="269875" y="314325"/>
                </a:lnTo>
                <a:lnTo>
                  <a:pt x="285750" y="409575"/>
                </a:lnTo>
                <a:lnTo>
                  <a:pt x="307975" y="203200"/>
                </a:lnTo>
                <a:lnTo>
                  <a:pt x="320675" y="180975"/>
                </a:lnTo>
                <a:lnTo>
                  <a:pt x="336550" y="82550"/>
                </a:lnTo>
                <a:lnTo>
                  <a:pt x="361950" y="0"/>
                </a:lnTo>
                <a:lnTo>
                  <a:pt x="377825" y="73025"/>
                </a:lnTo>
                <a:lnTo>
                  <a:pt x="396875" y="47625"/>
                </a:lnTo>
                <a:lnTo>
                  <a:pt x="412750" y="104775"/>
                </a:lnTo>
                <a:lnTo>
                  <a:pt x="422275" y="88900"/>
                </a:lnTo>
                <a:lnTo>
                  <a:pt x="444500" y="361950"/>
                </a:lnTo>
                <a:cubicBezTo>
                  <a:pt x="445558" y="420158"/>
                  <a:pt x="446617" y="478367"/>
                  <a:pt x="447675" y="536575"/>
                </a:cubicBezTo>
                <a:lnTo>
                  <a:pt x="463550" y="708025"/>
                </a:lnTo>
                <a:lnTo>
                  <a:pt x="482600" y="800100"/>
                </a:lnTo>
                <a:lnTo>
                  <a:pt x="492125" y="892175"/>
                </a:lnTo>
                <a:lnTo>
                  <a:pt x="514350" y="1000125"/>
                </a:lnTo>
                <a:lnTo>
                  <a:pt x="530225" y="1044575"/>
                </a:lnTo>
                <a:lnTo>
                  <a:pt x="555625" y="1066800"/>
                </a:lnTo>
                <a:lnTo>
                  <a:pt x="603250" y="1073150"/>
                </a:lnTo>
                <a:lnTo>
                  <a:pt x="1254125" y="107315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38" name="フリーフォーム 37">
            <a:extLst>
              <a:ext uri="{FF2B5EF4-FFF2-40B4-BE49-F238E27FC236}">
                <a16:creationId xmlns:a16="http://schemas.microsoft.com/office/drawing/2014/main" id="{586CD99D-1793-854D-BFFD-02105A5B8BFB}"/>
              </a:ext>
            </a:extLst>
          </p:cNvPr>
          <p:cNvSpPr/>
          <p:nvPr/>
        </p:nvSpPr>
        <p:spPr>
          <a:xfrm>
            <a:off x="1186870" y="1149440"/>
            <a:ext cx="1260475" cy="1149350"/>
          </a:xfrm>
          <a:custGeom>
            <a:avLst/>
            <a:gdLst>
              <a:gd name="connsiteX0" fmla="*/ 0 w 1260475"/>
              <a:gd name="connsiteY0" fmla="*/ 1143000 h 1149350"/>
              <a:gd name="connsiteX1" fmla="*/ 28575 w 1260475"/>
              <a:gd name="connsiteY1" fmla="*/ 1114425 h 1149350"/>
              <a:gd name="connsiteX2" fmla="*/ 50800 w 1260475"/>
              <a:gd name="connsiteY2" fmla="*/ 1120775 h 1149350"/>
              <a:gd name="connsiteX3" fmla="*/ 92075 w 1260475"/>
              <a:gd name="connsiteY3" fmla="*/ 1098550 h 1149350"/>
              <a:gd name="connsiteX4" fmla="*/ 130175 w 1260475"/>
              <a:gd name="connsiteY4" fmla="*/ 1076325 h 1149350"/>
              <a:gd name="connsiteX5" fmla="*/ 155575 w 1260475"/>
              <a:gd name="connsiteY5" fmla="*/ 1050925 h 1149350"/>
              <a:gd name="connsiteX6" fmla="*/ 177800 w 1260475"/>
              <a:gd name="connsiteY6" fmla="*/ 1044575 h 1149350"/>
              <a:gd name="connsiteX7" fmla="*/ 209550 w 1260475"/>
              <a:gd name="connsiteY7" fmla="*/ 996950 h 1149350"/>
              <a:gd name="connsiteX8" fmla="*/ 244475 w 1260475"/>
              <a:gd name="connsiteY8" fmla="*/ 971550 h 1149350"/>
              <a:gd name="connsiteX9" fmla="*/ 263525 w 1260475"/>
              <a:gd name="connsiteY9" fmla="*/ 936625 h 1149350"/>
              <a:gd name="connsiteX10" fmla="*/ 292100 w 1260475"/>
              <a:gd name="connsiteY10" fmla="*/ 825500 h 1149350"/>
              <a:gd name="connsiteX11" fmla="*/ 317500 w 1260475"/>
              <a:gd name="connsiteY11" fmla="*/ 825500 h 1149350"/>
              <a:gd name="connsiteX12" fmla="*/ 333375 w 1260475"/>
              <a:gd name="connsiteY12" fmla="*/ 711200 h 1149350"/>
              <a:gd name="connsiteX13" fmla="*/ 336550 w 1260475"/>
              <a:gd name="connsiteY13" fmla="*/ 647700 h 1149350"/>
              <a:gd name="connsiteX14" fmla="*/ 361950 w 1260475"/>
              <a:gd name="connsiteY14" fmla="*/ 622300 h 1149350"/>
              <a:gd name="connsiteX15" fmla="*/ 374650 w 1260475"/>
              <a:gd name="connsiteY15" fmla="*/ 511175 h 1149350"/>
              <a:gd name="connsiteX16" fmla="*/ 374650 w 1260475"/>
              <a:gd name="connsiteY16" fmla="*/ 482600 h 1149350"/>
              <a:gd name="connsiteX17" fmla="*/ 387350 w 1260475"/>
              <a:gd name="connsiteY17" fmla="*/ 460375 h 1149350"/>
              <a:gd name="connsiteX18" fmla="*/ 403225 w 1260475"/>
              <a:gd name="connsiteY18" fmla="*/ 384175 h 1149350"/>
              <a:gd name="connsiteX19" fmla="*/ 415925 w 1260475"/>
              <a:gd name="connsiteY19" fmla="*/ 304800 h 1149350"/>
              <a:gd name="connsiteX20" fmla="*/ 434975 w 1260475"/>
              <a:gd name="connsiteY20" fmla="*/ 260350 h 1149350"/>
              <a:gd name="connsiteX21" fmla="*/ 444500 w 1260475"/>
              <a:gd name="connsiteY21" fmla="*/ 196850 h 1149350"/>
              <a:gd name="connsiteX22" fmla="*/ 450850 w 1260475"/>
              <a:gd name="connsiteY22" fmla="*/ 85725 h 1149350"/>
              <a:gd name="connsiteX23" fmla="*/ 466725 w 1260475"/>
              <a:gd name="connsiteY23" fmla="*/ 98425 h 1149350"/>
              <a:gd name="connsiteX24" fmla="*/ 479425 w 1260475"/>
              <a:gd name="connsiteY24" fmla="*/ 0 h 1149350"/>
              <a:gd name="connsiteX25" fmla="*/ 492125 w 1260475"/>
              <a:gd name="connsiteY25" fmla="*/ 28575 h 1149350"/>
              <a:gd name="connsiteX26" fmla="*/ 504825 w 1260475"/>
              <a:gd name="connsiteY26" fmla="*/ 6350 h 1149350"/>
              <a:gd name="connsiteX27" fmla="*/ 514350 w 1260475"/>
              <a:gd name="connsiteY27" fmla="*/ 111125 h 1149350"/>
              <a:gd name="connsiteX28" fmla="*/ 533400 w 1260475"/>
              <a:gd name="connsiteY28" fmla="*/ 190500 h 1149350"/>
              <a:gd name="connsiteX29" fmla="*/ 542925 w 1260475"/>
              <a:gd name="connsiteY29" fmla="*/ 320675 h 1149350"/>
              <a:gd name="connsiteX30" fmla="*/ 561975 w 1260475"/>
              <a:gd name="connsiteY30" fmla="*/ 498475 h 1149350"/>
              <a:gd name="connsiteX31" fmla="*/ 574675 w 1260475"/>
              <a:gd name="connsiteY31" fmla="*/ 644525 h 1149350"/>
              <a:gd name="connsiteX32" fmla="*/ 587375 w 1260475"/>
              <a:gd name="connsiteY32" fmla="*/ 815975 h 1149350"/>
              <a:gd name="connsiteX33" fmla="*/ 593725 w 1260475"/>
              <a:gd name="connsiteY33" fmla="*/ 952500 h 1149350"/>
              <a:gd name="connsiteX34" fmla="*/ 609600 w 1260475"/>
              <a:gd name="connsiteY34" fmla="*/ 1057275 h 1149350"/>
              <a:gd name="connsiteX35" fmla="*/ 631825 w 1260475"/>
              <a:gd name="connsiteY35" fmla="*/ 1111250 h 1149350"/>
              <a:gd name="connsiteX36" fmla="*/ 679450 w 1260475"/>
              <a:gd name="connsiteY36" fmla="*/ 1149350 h 1149350"/>
              <a:gd name="connsiteX37" fmla="*/ 1260475 w 1260475"/>
              <a:gd name="connsiteY37" fmla="*/ 1149350 h 11493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260475" h="1149350">
                <a:moveTo>
                  <a:pt x="0" y="1143000"/>
                </a:moveTo>
                <a:lnTo>
                  <a:pt x="28575" y="1114425"/>
                </a:lnTo>
                <a:lnTo>
                  <a:pt x="50800" y="1120775"/>
                </a:lnTo>
                <a:lnTo>
                  <a:pt x="92075" y="1098550"/>
                </a:lnTo>
                <a:lnTo>
                  <a:pt x="130175" y="1076325"/>
                </a:lnTo>
                <a:lnTo>
                  <a:pt x="155575" y="1050925"/>
                </a:lnTo>
                <a:lnTo>
                  <a:pt x="177800" y="1044575"/>
                </a:lnTo>
                <a:lnTo>
                  <a:pt x="209550" y="996950"/>
                </a:lnTo>
                <a:lnTo>
                  <a:pt x="244475" y="971550"/>
                </a:lnTo>
                <a:lnTo>
                  <a:pt x="263525" y="936625"/>
                </a:lnTo>
                <a:lnTo>
                  <a:pt x="292100" y="825500"/>
                </a:lnTo>
                <a:lnTo>
                  <a:pt x="317500" y="825500"/>
                </a:lnTo>
                <a:lnTo>
                  <a:pt x="333375" y="711200"/>
                </a:lnTo>
                <a:lnTo>
                  <a:pt x="336550" y="647700"/>
                </a:lnTo>
                <a:lnTo>
                  <a:pt x="361950" y="622300"/>
                </a:lnTo>
                <a:lnTo>
                  <a:pt x="374650" y="511175"/>
                </a:lnTo>
                <a:lnTo>
                  <a:pt x="374650" y="482600"/>
                </a:lnTo>
                <a:lnTo>
                  <a:pt x="387350" y="460375"/>
                </a:lnTo>
                <a:lnTo>
                  <a:pt x="403225" y="384175"/>
                </a:lnTo>
                <a:lnTo>
                  <a:pt x="415925" y="304800"/>
                </a:lnTo>
                <a:lnTo>
                  <a:pt x="434975" y="260350"/>
                </a:lnTo>
                <a:lnTo>
                  <a:pt x="444500" y="196850"/>
                </a:lnTo>
                <a:lnTo>
                  <a:pt x="450850" y="85725"/>
                </a:lnTo>
                <a:lnTo>
                  <a:pt x="466725" y="98425"/>
                </a:lnTo>
                <a:lnTo>
                  <a:pt x="479425" y="0"/>
                </a:lnTo>
                <a:lnTo>
                  <a:pt x="492125" y="28575"/>
                </a:lnTo>
                <a:lnTo>
                  <a:pt x="504825" y="6350"/>
                </a:lnTo>
                <a:lnTo>
                  <a:pt x="514350" y="111125"/>
                </a:lnTo>
                <a:lnTo>
                  <a:pt x="533400" y="190500"/>
                </a:lnTo>
                <a:lnTo>
                  <a:pt x="542925" y="320675"/>
                </a:lnTo>
                <a:lnTo>
                  <a:pt x="561975" y="498475"/>
                </a:lnTo>
                <a:lnTo>
                  <a:pt x="574675" y="644525"/>
                </a:lnTo>
                <a:lnTo>
                  <a:pt x="587375" y="815975"/>
                </a:lnTo>
                <a:lnTo>
                  <a:pt x="593725" y="952500"/>
                </a:lnTo>
                <a:lnTo>
                  <a:pt x="609600" y="1057275"/>
                </a:lnTo>
                <a:lnTo>
                  <a:pt x="631825" y="1111250"/>
                </a:lnTo>
                <a:lnTo>
                  <a:pt x="679450" y="1149350"/>
                </a:lnTo>
                <a:lnTo>
                  <a:pt x="1260475" y="114935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39" name="フリーフォーム 38">
            <a:extLst>
              <a:ext uri="{FF2B5EF4-FFF2-40B4-BE49-F238E27FC236}">
                <a16:creationId xmlns:a16="http://schemas.microsoft.com/office/drawing/2014/main" id="{6534F720-DE18-BB48-BCB5-D4BE1729F880}"/>
              </a:ext>
            </a:extLst>
          </p:cNvPr>
          <p:cNvSpPr/>
          <p:nvPr/>
        </p:nvSpPr>
        <p:spPr>
          <a:xfrm>
            <a:off x="2841046" y="1152615"/>
            <a:ext cx="1260475" cy="1143000"/>
          </a:xfrm>
          <a:custGeom>
            <a:avLst/>
            <a:gdLst>
              <a:gd name="connsiteX0" fmla="*/ 0 w 1260475"/>
              <a:gd name="connsiteY0" fmla="*/ 1143000 h 1143000"/>
              <a:gd name="connsiteX1" fmla="*/ 25400 w 1260475"/>
              <a:gd name="connsiteY1" fmla="*/ 1079500 h 1143000"/>
              <a:gd name="connsiteX2" fmla="*/ 63500 w 1260475"/>
              <a:gd name="connsiteY2" fmla="*/ 1073150 h 1143000"/>
              <a:gd name="connsiteX3" fmla="*/ 92075 w 1260475"/>
              <a:gd name="connsiteY3" fmla="*/ 1019175 h 1143000"/>
              <a:gd name="connsiteX4" fmla="*/ 123825 w 1260475"/>
              <a:gd name="connsiteY4" fmla="*/ 996950 h 1143000"/>
              <a:gd name="connsiteX5" fmla="*/ 130175 w 1260475"/>
              <a:gd name="connsiteY5" fmla="*/ 1009650 h 1143000"/>
              <a:gd name="connsiteX6" fmla="*/ 161925 w 1260475"/>
              <a:gd name="connsiteY6" fmla="*/ 962025 h 1143000"/>
              <a:gd name="connsiteX7" fmla="*/ 180975 w 1260475"/>
              <a:gd name="connsiteY7" fmla="*/ 885825 h 1143000"/>
              <a:gd name="connsiteX8" fmla="*/ 196850 w 1260475"/>
              <a:gd name="connsiteY8" fmla="*/ 873125 h 1143000"/>
              <a:gd name="connsiteX9" fmla="*/ 247650 w 1260475"/>
              <a:gd name="connsiteY9" fmla="*/ 701675 h 1143000"/>
              <a:gd name="connsiteX10" fmla="*/ 260350 w 1260475"/>
              <a:gd name="connsiteY10" fmla="*/ 739775 h 1143000"/>
              <a:gd name="connsiteX11" fmla="*/ 301625 w 1260475"/>
              <a:gd name="connsiteY11" fmla="*/ 549275 h 1143000"/>
              <a:gd name="connsiteX12" fmla="*/ 336550 w 1260475"/>
              <a:gd name="connsiteY12" fmla="*/ 425450 h 1143000"/>
              <a:gd name="connsiteX13" fmla="*/ 361950 w 1260475"/>
              <a:gd name="connsiteY13" fmla="*/ 180975 h 1143000"/>
              <a:gd name="connsiteX14" fmla="*/ 374650 w 1260475"/>
              <a:gd name="connsiteY14" fmla="*/ 196850 h 1143000"/>
              <a:gd name="connsiteX15" fmla="*/ 393700 w 1260475"/>
              <a:gd name="connsiteY15" fmla="*/ 107950 h 1143000"/>
              <a:gd name="connsiteX16" fmla="*/ 409575 w 1260475"/>
              <a:gd name="connsiteY16" fmla="*/ 0 h 1143000"/>
              <a:gd name="connsiteX17" fmla="*/ 419100 w 1260475"/>
              <a:gd name="connsiteY17" fmla="*/ 38100 h 1143000"/>
              <a:gd name="connsiteX18" fmla="*/ 428625 w 1260475"/>
              <a:gd name="connsiteY18" fmla="*/ 47625 h 1143000"/>
              <a:gd name="connsiteX19" fmla="*/ 457200 w 1260475"/>
              <a:gd name="connsiteY19" fmla="*/ 231775 h 1143000"/>
              <a:gd name="connsiteX20" fmla="*/ 469900 w 1260475"/>
              <a:gd name="connsiteY20" fmla="*/ 282575 h 1143000"/>
              <a:gd name="connsiteX21" fmla="*/ 492125 w 1260475"/>
              <a:gd name="connsiteY21" fmla="*/ 561975 h 1143000"/>
              <a:gd name="connsiteX22" fmla="*/ 511175 w 1260475"/>
              <a:gd name="connsiteY22" fmla="*/ 746125 h 1143000"/>
              <a:gd name="connsiteX23" fmla="*/ 530225 w 1260475"/>
              <a:gd name="connsiteY23" fmla="*/ 914400 h 1143000"/>
              <a:gd name="connsiteX24" fmla="*/ 546100 w 1260475"/>
              <a:gd name="connsiteY24" fmla="*/ 1057275 h 1143000"/>
              <a:gd name="connsiteX25" fmla="*/ 584200 w 1260475"/>
              <a:gd name="connsiteY25" fmla="*/ 1139825 h 1143000"/>
              <a:gd name="connsiteX26" fmla="*/ 631825 w 1260475"/>
              <a:gd name="connsiteY26" fmla="*/ 1139825 h 1143000"/>
              <a:gd name="connsiteX27" fmla="*/ 1260475 w 1260475"/>
              <a:gd name="connsiteY27" fmla="*/ 1139825 h 1143000"/>
              <a:gd name="connsiteX28" fmla="*/ 1260475 w 1260475"/>
              <a:gd name="connsiteY28" fmla="*/ 1143000 h 1143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1260475" h="1143000">
                <a:moveTo>
                  <a:pt x="0" y="1143000"/>
                </a:moveTo>
                <a:lnTo>
                  <a:pt x="25400" y="1079500"/>
                </a:lnTo>
                <a:lnTo>
                  <a:pt x="63500" y="1073150"/>
                </a:lnTo>
                <a:lnTo>
                  <a:pt x="92075" y="1019175"/>
                </a:lnTo>
                <a:lnTo>
                  <a:pt x="123825" y="996950"/>
                </a:lnTo>
                <a:lnTo>
                  <a:pt x="130175" y="1009650"/>
                </a:lnTo>
                <a:lnTo>
                  <a:pt x="161925" y="962025"/>
                </a:lnTo>
                <a:lnTo>
                  <a:pt x="180975" y="885825"/>
                </a:lnTo>
                <a:lnTo>
                  <a:pt x="196850" y="873125"/>
                </a:lnTo>
                <a:lnTo>
                  <a:pt x="247650" y="701675"/>
                </a:lnTo>
                <a:lnTo>
                  <a:pt x="260350" y="739775"/>
                </a:lnTo>
                <a:lnTo>
                  <a:pt x="301625" y="549275"/>
                </a:lnTo>
                <a:lnTo>
                  <a:pt x="336550" y="425450"/>
                </a:lnTo>
                <a:lnTo>
                  <a:pt x="361950" y="180975"/>
                </a:lnTo>
                <a:lnTo>
                  <a:pt x="374650" y="196850"/>
                </a:lnTo>
                <a:lnTo>
                  <a:pt x="393700" y="107950"/>
                </a:lnTo>
                <a:lnTo>
                  <a:pt x="409575" y="0"/>
                </a:lnTo>
                <a:lnTo>
                  <a:pt x="419100" y="38100"/>
                </a:lnTo>
                <a:lnTo>
                  <a:pt x="428625" y="47625"/>
                </a:lnTo>
                <a:lnTo>
                  <a:pt x="457200" y="231775"/>
                </a:lnTo>
                <a:lnTo>
                  <a:pt x="469900" y="282575"/>
                </a:lnTo>
                <a:lnTo>
                  <a:pt x="492125" y="561975"/>
                </a:lnTo>
                <a:lnTo>
                  <a:pt x="511175" y="746125"/>
                </a:lnTo>
                <a:lnTo>
                  <a:pt x="530225" y="914400"/>
                </a:lnTo>
                <a:lnTo>
                  <a:pt x="546100" y="1057275"/>
                </a:lnTo>
                <a:lnTo>
                  <a:pt x="584200" y="1139825"/>
                </a:lnTo>
                <a:lnTo>
                  <a:pt x="631825" y="1139825"/>
                </a:lnTo>
                <a:lnTo>
                  <a:pt x="1260475" y="1139825"/>
                </a:lnTo>
                <a:lnTo>
                  <a:pt x="1260475" y="114300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0" name="フリーフォーム 39">
            <a:extLst>
              <a:ext uri="{FF2B5EF4-FFF2-40B4-BE49-F238E27FC236}">
                <a16:creationId xmlns:a16="http://schemas.microsoft.com/office/drawing/2014/main" id="{A9B362E4-C067-344A-815E-036385464610}"/>
              </a:ext>
            </a:extLst>
          </p:cNvPr>
          <p:cNvSpPr/>
          <p:nvPr/>
        </p:nvSpPr>
        <p:spPr>
          <a:xfrm>
            <a:off x="2844221" y="1143091"/>
            <a:ext cx="1260475" cy="1152525"/>
          </a:xfrm>
          <a:custGeom>
            <a:avLst/>
            <a:gdLst>
              <a:gd name="connsiteX0" fmla="*/ 0 w 1260475"/>
              <a:gd name="connsiteY0" fmla="*/ 1149350 h 1152525"/>
              <a:gd name="connsiteX1" fmla="*/ 219075 w 1260475"/>
              <a:gd name="connsiteY1" fmla="*/ 1149350 h 1152525"/>
              <a:gd name="connsiteX2" fmla="*/ 238125 w 1260475"/>
              <a:gd name="connsiteY2" fmla="*/ 1143000 h 1152525"/>
              <a:gd name="connsiteX3" fmla="*/ 298450 w 1260475"/>
              <a:gd name="connsiteY3" fmla="*/ 1143000 h 1152525"/>
              <a:gd name="connsiteX4" fmla="*/ 352425 w 1260475"/>
              <a:gd name="connsiteY4" fmla="*/ 1133475 h 1152525"/>
              <a:gd name="connsiteX5" fmla="*/ 396875 w 1260475"/>
              <a:gd name="connsiteY5" fmla="*/ 1130300 h 1152525"/>
              <a:gd name="connsiteX6" fmla="*/ 441325 w 1260475"/>
              <a:gd name="connsiteY6" fmla="*/ 1127125 h 1152525"/>
              <a:gd name="connsiteX7" fmla="*/ 498475 w 1260475"/>
              <a:gd name="connsiteY7" fmla="*/ 1117600 h 1152525"/>
              <a:gd name="connsiteX8" fmla="*/ 555625 w 1260475"/>
              <a:gd name="connsiteY8" fmla="*/ 1114425 h 1152525"/>
              <a:gd name="connsiteX9" fmla="*/ 584200 w 1260475"/>
              <a:gd name="connsiteY9" fmla="*/ 1111250 h 1152525"/>
              <a:gd name="connsiteX10" fmla="*/ 615950 w 1260475"/>
              <a:gd name="connsiteY10" fmla="*/ 1120775 h 1152525"/>
              <a:gd name="connsiteX11" fmla="*/ 635000 w 1260475"/>
              <a:gd name="connsiteY11" fmla="*/ 1120775 h 1152525"/>
              <a:gd name="connsiteX12" fmla="*/ 663575 w 1260475"/>
              <a:gd name="connsiteY12" fmla="*/ 1120775 h 1152525"/>
              <a:gd name="connsiteX13" fmla="*/ 698500 w 1260475"/>
              <a:gd name="connsiteY13" fmla="*/ 1114425 h 1152525"/>
              <a:gd name="connsiteX14" fmla="*/ 714375 w 1260475"/>
              <a:gd name="connsiteY14" fmla="*/ 1114425 h 1152525"/>
              <a:gd name="connsiteX15" fmla="*/ 749300 w 1260475"/>
              <a:gd name="connsiteY15" fmla="*/ 1104900 h 1152525"/>
              <a:gd name="connsiteX16" fmla="*/ 768350 w 1260475"/>
              <a:gd name="connsiteY16" fmla="*/ 1111250 h 1152525"/>
              <a:gd name="connsiteX17" fmla="*/ 809625 w 1260475"/>
              <a:gd name="connsiteY17" fmla="*/ 1111250 h 1152525"/>
              <a:gd name="connsiteX18" fmla="*/ 841375 w 1260475"/>
              <a:gd name="connsiteY18" fmla="*/ 1095375 h 1152525"/>
              <a:gd name="connsiteX19" fmla="*/ 885825 w 1260475"/>
              <a:gd name="connsiteY19" fmla="*/ 1057275 h 1152525"/>
              <a:gd name="connsiteX20" fmla="*/ 901700 w 1260475"/>
              <a:gd name="connsiteY20" fmla="*/ 1054100 h 1152525"/>
              <a:gd name="connsiteX21" fmla="*/ 936625 w 1260475"/>
              <a:gd name="connsiteY21" fmla="*/ 987425 h 1152525"/>
              <a:gd name="connsiteX22" fmla="*/ 968375 w 1260475"/>
              <a:gd name="connsiteY22" fmla="*/ 927100 h 1152525"/>
              <a:gd name="connsiteX23" fmla="*/ 996950 w 1260475"/>
              <a:gd name="connsiteY23" fmla="*/ 857250 h 1152525"/>
              <a:gd name="connsiteX24" fmla="*/ 1022350 w 1260475"/>
              <a:gd name="connsiteY24" fmla="*/ 666750 h 1152525"/>
              <a:gd name="connsiteX25" fmla="*/ 1038225 w 1260475"/>
              <a:gd name="connsiteY25" fmla="*/ 530225 h 1152525"/>
              <a:gd name="connsiteX26" fmla="*/ 1041400 w 1260475"/>
              <a:gd name="connsiteY26" fmla="*/ 447675 h 1152525"/>
              <a:gd name="connsiteX27" fmla="*/ 1073150 w 1260475"/>
              <a:gd name="connsiteY27" fmla="*/ 368300 h 1152525"/>
              <a:gd name="connsiteX28" fmla="*/ 1089025 w 1260475"/>
              <a:gd name="connsiteY28" fmla="*/ 263525 h 1152525"/>
              <a:gd name="connsiteX29" fmla="*/ 1095375 w 1260475"/>
              <a:gd name="connsiteY29" fmla="*/ 161925 h 1152525"/>
              <a:gd name="connsiteX30" fmla="*/ 1111250 w 1260475"/>
              <a:gd name="connsiteY30" fmla="*/ 136525 h 1152525"/>
              <a:gd name="connsiteX31" fmla="*/ 1127125 w 1260475"/>
              <a:gd name="connsiteY31" fmla="*/ 127000 h 1152525"/>
              <a:gd name="connsiteX32" fmla="*/ 1139825 w 1260475"/>
              <a:gd name="connsiteY32" fmla="*/ 0 h 1152525"/>
              <a:gd name="connsiteX33" fmla="*/ 1162050 w 1260475"/>
              <a:gd name="connsiteY33" fmla="*/ 88900 h 1152525"/>
              <a:gd name="connsiteX34" fmla="*/ 1174750 w 1260475"/>
              <a:gd name="connsiteY34" fmla="*/ 66675 h 1152525"/>
              <a:gd name="connsiteX35" fmla="*/ 1200150 w 1260475"/>
              <a:gd name="connsiteY35" fmla="*/ 120650 h 1152525"/>
              <a:gd name="connsiteX36" fmla="*/ 1212850 w 1260475"/>
              <a:gd name="connsiteY36" fmla="*/ 225425 h 1152525"/>
              <a:gd name="connsiteX37" fmla="*/ 1219200 w 1260475"/>
              <a:gd name="connsiteY37" fmla="*/ 317500 h 1152525"/>
              <a:gd name="connsiteX38" fmla="*/ 1235075 w 1260475"/>
              <a:gd name="connsiteY38" fmla="*/ 365125 h 1152525"/>
              <a:gd name="connsiteX39" fmla="*/ 1247775 w 1260475"/>
              <a:gd name="connsiteY39" fmla="*/ 466725 h 1152525"/>
              <a:gd name="connsiteX40" fmla="*/ 1260475 w 1260475"/>
              <a:gd name="connsiteY40" fmla="*/ 558800 h 1152525"/>
              <a:gd name="connsiteX41" fmla="*/ 1260475 w 1260475"/>
              <a:gd name="connsiteY41" fmla="*/ 1152525 h 11525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Lst>
            <a:rect l="l" t="t" r="r" b="b"/>
            <a:pathLst>
              <a:path w="1260475" h="1152525">
                <a:moveTo>
                  <a:pt x="0" y="1149350"/>
                </a:moveTo>
                <a:lnTo>
                  <a:pt x="219075" y="1149350"/>
                </a:lnTo>
                <a:lnTo>
                  <a:pt x="238125" y="1143000"/>
                </a:lnTo>
                <a:lnTo>
                  <a:pt x="298450" y="1143000"/>
                </a:lnTo>
                <a:lnTo>
                  <a:pt x="352425" y="1133475"/>
                </a:lnTo>
                <a:lnTo>
                  <a:pt x="396875" y="1130300"/>
                </a:lnTo>
                <a:lnTo>
                  <a:pt x="441325" y="1127125"/>
                </a:lnTo>
                <a:lnTo>
                  <a:pt x="498475" y="1117600"/>
                </a:lnTo>
                <a:lnTo>
                  <a:pt x="555625" y="1114425"/>
                </a:lnTo>
                <a:lnTo>
                  <a:pt x="584200" y="1111250"/>
                </a:lnTo>
                <a:lnTo>
                  <a:pt x="615950" y="1120775"/>
                </a:lnTo>
                <a:lnTo>
                  <a:pt x="635000" y="1120775"/>
                </a:lnTo>
                <a:lnTo>
                  <a:pt x="663575" y="1120775"/>
                </a:lnTo>
                <a:lnTo>
                  <a:pt x="698500" y="1114425"/>
                </a:lnTo>
                <a:lnTo>
                  <a:pt x="714375" y="1114425"/>
                </a:lnTo>
                <a:lnTo>
                  <a:pt x="749300" y="1104900"/>
                </a:lnTo>
                <a:lnTo>
                  <a:pt x="768350" y="1111250"/>
                </a:lnTo>
                <a:lnTo>
                  <a:pt x="809625" y="1111250"/>
                </a:lnTo>
                <a:lnTo>
                  <a:pt x="841375" y="1095375"/>
                </a:lnTo>
                <a:lnTo>
                  <a:pt x="885825" y="1057275"/>
                </a:lnTo>
                <a:lnTo>
                  <a:pt x="901700" y="1054100"/>
                </a:lnTo>
                <a:lnTo>
                  <a:pt x="936625" y="987425"/>
                </a:lnTo>
                <a:lnTo>
                  <a:pt x="968375" y="927100"/>
                </a:lnTo>
                <a:lnTo>
                  <a:pt x="996950" y="857250"/>
                </a:lnTo>
                <a:lnTo>
                  <a:pt x="1022350" y="666750"/>
                </a:lnTo>
                <a:lnTo>
                  <a:pt x="1038225" y="530225"/>
                </a:lnTo>
                <a:lnTo>
                  <a:pt x="1041400" y="447675"/>
                </a:lnTo>
                <a:lnTo>
                  <a:pt x="1073150" y="368300"/>
                </a:lnTo>
                <a:lnTo>
                  <a:pt x="1089025" y="263525"/>
                </a:lnTo>
                <a:lnTo>
                  <a:pt x="1095375" y="161925"/>
                </a:lnTo>
                <a:lnTo>
                  <a:pt x="1111250" y="136525"/>
                </a:lnTo>
                <a:lnTo>
                  <a:pt x="1127125" y="127000"/>
                </a:lnTo>
                <a:lnTo>
                  <a:pt x="1139825" y="0"/>
                </a:lnTo>
                <a:lnTo>
                  <a:pt x="1162050" y="88900"/>
                </a:lnTo>
                <a:lnTo>
                  <a:pt x="1174750" y="66675"/>
                </a:lnTo>
                <a:lnTo>
                  <a:pt x="1200150" y="120650"/>
                </a:lnTo>
                <a:lnTo>
                  <a:pt x="1212850" y="225425"/>
                </a:lnTo>
                <a:lnTo>
                  <a:pt x="1219200" y="317500"/>
                </a:lnTo>
                <a:lnTo>
                  <a:pt x="1235075" y="365125"/>
                </a:lnTo>
                <a:lnTo>
                  <a:pt x="1247775" y="466725"/>
                </a:lnTo>
                <a:lnTo>
                  <a:pt x="1260475" y="558800"/>
                </a:lnTo>
                <a:lnTo>
                  <a:pt x="1260475" y="115252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1" name="正方形/長方形 40">
            <a:extLst>
              <a:ext uri="{FF2B5EF4-FFF2-40B4-BE49-F238E27FC236}">
                <a16:creationId xmlns:a16="http://schemas.microsoft.com/office/drawing/2014/main" id="{96B6577E-DA24-104B-8243-588706ACCC98}"/>
              </a:ext>
            </a:extLst>
          </p:cNvPr>
          <p:cNvSpPr/>
          <p:nvPr/>
        </p:nvSpPr>
        <p:spPr>
          <a:xfrm>
            <a:off x="2836024" y="1032263"/>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2" name="フリーフォーム 41">
            <a:extLst>
              <a:ext uri="{FF2B5EF4-FFF2-40B4-BE49-F238E27FC236}">
                <a16:creationId xmlns:a16="http://schemas.microsoft.com/office/drawing/2014/main" id="{799D8FC2-4446-684B-A2DF-3466690E1C29}"/>
              </a:ext>
            </a:extLst>
          </p:cNvPr>
          <p:cNvSpPr/>
          <p:nvPr/>
        </p:nvSpPr>
        <p:spPr>
          <a:xfrm>
            <a:off x="1186870" y="3335956"/>
            <a:ext cx="1257300" cy="1076325"/>
          </a:xfrm>
          <a:custGeom>
            <a:avLst/>
            <a:gdLst>
              <a:gd name="connsiteX0" fmla="*/ 0 w 1257300"/>
              <a:gd name="connsiteY0" fmla="*/ 1076325 h 1076325"/>
              <a:gd name="connsiteX1" fmla="*/ 34925 w 1257300"/>
              <a:gd name="connsiteY1" fmla="*/ 1050925 h 1076325"/>
              <a:gd name="connsiteX2" fmla="*/ 66675 w 1257300"/>
              <a:gd name="connsiteY2" fmla="*/ 1050925 h 1076325"/>
              <a:gd name="connsiteX3" fmla="*/ 98425 w 1257300"/>
              <a:gd name="connsiteY3" fmla="*/ 1025525 h 1076325"/>
              <a:gd name="connsiteX4" fmla="*/ 130175 w 1257300"/>
              <a:gd name="connsiteY4" fmla="*/ 1006475 h 1076325"/>
              <a:gd name="connsiteX5" fmla="*/ 158750 w 1257300"/>
              <a:gd name="connsiteY5" fmla="*/ 1006475 h 1076325"/>
              <a:gd name="connsiteX6" fmla="*/ 219075 w 1257300"/>
              <a:gd name="connsiteY6" fmla="*/ 930275 h 1076325"/>
              <a:gd name="connsiteX7" fmla="*/ 241300 w 1257300"/>
              <a:gd name="connsiteY7" fmla="*/ 879475 h 1076325"/>
              <a:gd name="connsiteX8" fmla="*/ 241300 w 1257300"/>
              <a:gd name="connsiteY8" fmla="*/ 879475 h 1076325"/>
              <a:gd name="connsiteX9" fmla="*/ 250825 w 1257300"/>
              <a:gd name="connsiteY9" fmla="*/ 879475 h 1076325"/>
              <a:gd name="connsiteX10" fmla="*/ 276225 w 1257300"/>
              <a:gd name="connsiteY10" fmla="*/ 803275 h 1076325"/>
              <a:gd name="connsiteX11" fmla="*/ 295275 w 1257300"/>
              <a:gd name="connsiteY11" fmla="*/ 701675 h 1076325"/>
              <a:gd name="connsiteX12" fmla="*/ 304800 w 1257300"/>
              <a:gd name="connsiteY12" fmla="*/ 603250 h 1076325"/>
              <a:gd name="connsiteX13" fmla="*/ 314325 w 1257300"/>
              <a:gd name="connsiteY13" fmla="*/ 514350 h 1076325"/>
              <a:gd name="connsiteX14" fmla="*/ 327025 w 1257300"/>
              <a:gd name="connsiteY14" fmla="*/ 520700 h 1076325"/>
              <a:gd name="connsiteX15" fmla="*/ 346075 w 1257300"/>
              <a:gd name="connsiteY15" fmla="*/ 434975 h 1076325"/>
              <a:gd name="connsiteX16" fmla="*/ 355600 w 1257300"/>
              <a:gd name="connsiteY16" fmla="*/ 276225 h 1076325"/>
              <a:gd name="connsiteX17" fmla="*/ 374650 w 1257300"/>
              <a:gd name="connsiteY17" fmla="*/ 114300 h 1076325"/>
              <a:gd name="connsiteX18" fmla="*/ 390525 w 1257300"/>
              <a:gd name="connsiteY18" fmla="*/ 155575 h 1076325"/>
              <a:gd name="connsiteX19" fmla="*/ 403225 w 1257300"/>
              <a:gd name="connsiteY19" fmla="*/ 0 h 1076325"/>
              <a:gd name="connsiteX20" fmla="*/ 422275 w 1257300"/>
              <a:gd name="connsiteY20" fmla="*/ 82550 h 1076325"/>
              <a:gd name="connsiteX21" fmla="*/ 431800 w 1257300"/>
              <a:gd name="connsiteY21" fmla="*/ 6350 h 1076325"/>
              <a:gd name="connsiteX22" fmla="*/ 444500 w 1257300"/>
              <a:gd name="connsiteY22" fmla="*/ 152400 h 1076325"/>
              <a:gd name="connsiteX23" fmla="*/ 460375 w 1257300"/>
              <a:gd name="connsiteY23" fmla="*/ 273050 h 1076325"/>
              <a:gd name="connsiteX24" fmla="*/ 476250 w 1257300"/>
              <a:gd name="connsiteY24" fmla="*/ 444500 h 1076325"/>
              <a:gd name="connsiteX25" fmla="*/ 495300 w 1257300"/>
              <a:gd name="connsiteY25" fmla="*/ 635000 h 1076325"/>
              <a:gd name="connsiteX26" fmla="*/ 511175 w 1257300"/>
              <a:gd name="connsiteY26" fmla="*/ 822325 h 1076325"/>
              <a:gd name="connsiteX27" fmla="*/ 530225 w 1257300"/>
              <a:gd name="connsiteY27" fmla="*/ 965200 h 1076325"/>
              <a:gd name="connsiteX28" fmla="*/ 565150 w 1257300"/>
              <a:gd name="connsiteY28" fmla="*/ 1063625 h 1076325"/>
              <a:gd name="connsiteX29" fmla="*/ 612775 w 1257300"/>
              <a:gd name="connsiteY29" fmla="*/ 1073150 h 1076325"/>
              <a:gd name="connsiteX30" fmla="*/ 1257300 w 1257300"/>
              <a:gd name="connsiteY30" fmla="*/ 1073150 h 10763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1257300" h="1076325">
                <a:moveTo>
                  <a:pt x="0" y="1076325"/>
                </a:moveTo>
                <a:lnTo>
                  <a:pt x="34925" y="1050925"/>
                </a:lnTo>
                <a:lnTo>
                  <a:pt x="66675" y="1050925"/>
                </a:lnTo>
                <a:lnTo>
                  <a:pt x="98425" y="1025525"/>
                </a:lnTo>
                <a:lnTo>
                  <a:pt x="130175" y="1006475"/>
                </a:lnTo>
                <a:lnTo>
                  <a:pt x="158750" y="1006475"/>
                </a:lnTo>
                <a:lnTo>
                  <a:pt x="219075" y="930275"/>
                </a:lnTo>
                <a:lnTo>
                  <a:pt x="241300" y="879475"/>
                </a:lnTo>
                <a:lnTo>
                  <a:pt x="241300" y="879475"/>
                </a:lnTo>
                <a:lnTo>
                  <a:pt x="250825" y="879475"/>
                </a:lnTo>
                <a:lnTo>
                  <a:pt x="276225" y="803275"/>
                </a:lnTo>
                <a:lnTo>
                  <a:pt x="295275" y="701675"/>
                </a:lnTo>
                <a:lnTo>
                  <a:pt x="304800" y="603250"/>
                </a:lnTo>
                <a:lnTo>
                  <a:pt x="314325" y="514350"/>
                </a:lnTo>
                <a:lnTo>
                  <a:pt x="327025" y="520700"/>
                </a:lnTo>
                <a:lnTo>
                  <a:pt x="346075" y="434975"/>
                </a:lnTo>
                <a:lnTo>
                  <a:pt x="355600" y="276225"/>
                </a:lnTo>
                <a:lnTo>
                  <a:pt x="374650" y="114300"/>
                </a:lnTo>
                <a:lnTo>
                  <a:pt x="390525" y="155575"/>
                </a:lnTo>
                <a:lnTo>
                  <a:pt x="403225" y="0"/>
                </a:lnTo>
                <a:lnTo>
                  <a:pt x="422275" y="82550"/>
                </a:lnTo>
                <a:lnTo>
                  <a:pt x="431800" y="6350"/>
                </a:lnTo>
                <a:lnTo>
                  <a:pt x="444500" y="152400"/>
                </a:lnTo>
                <a:lnTo>
                  <a:pt x="460375" y="273050"/>
                </a:lnTo>
                <a:lnTo>
                  <a:pt x="476250" y="444500"/>
                </a:lnTo>
                <a:lnTo>
                  <a:pt x="495300" y="635000"/>
                </a:lnTo>
                <a:lnTo>
                  <a:pt x="511175" y="822325"/>
                </a:lnTo>
                <a:lnTo>
                  <a:pt x="530225" y="965200"/>
                </a:lnTo>
                <a:lnTo>
                  <a:pt x="565150" y="1063625"/>
                </a:lnTo>
                <a:lnTo>
                  <a:pt x="612775" y="1073150"/>
                </a:lnTo>
                <a:lnTo>
                  <a:pt x="1257300" y="107315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3" name="フリーフォーム 42">
            <a:extLst>
              <a:ext uri="{FF2B5EF4-FFF2-40B4-BE49-F238E27FC236}">
                <a16:creationId xmlns:a16="http://schemas.microsoft.com/office/drawing/2014/main" id="{BC49111B-63FD-CE49-8A84-6C47CCA8052B}"/>
              </a:ext>
            </a:extLst>
          </p:cNvPr>
          <p:cNvSpPr/>
          <p:nvPr/>
        </p:nvSpPr>
        <p:spPr>
          <a:xfrm>
            <a:off x="1186870" y="3259756"/>
            <a:ext cx="1250950" cy="1155700"/>
          </a:xfrm>
          <a:custGeom>
            <a:avLst/>
            <a:gdLst>
              <a:gd name="connsiteX0" fmla="*/ 0 w 1250950"/>
              <a:gd name="connsiteY0" fmla="*/ 1155700 h 1155700"/>
              <a:gd name="connsiteX1" fmla="*/ 809625 w 1250950"/>
              <a:gd name="connsiteY1" fmla="*/ 1155700 h 1155700"/>
              <a:gd name="connsiteX2" fmla="*/ 882650 w 1250950"/>
              <a:gd name="connsiteY2" fmla="*/ 1130300 h 1155700"/>
              <a:gd name="connsiteX3" fmla="*/ 908050 w 1250950"/>
              <a:gd name="connsiteY3" fmla="*/ 1095375 h 1155700"/>
              <a:gd name="connsiteX4" fmla="*/ 936625 w 1250950"/>
              <a:gd name="connsiteY4" fmla="*/ 1038225 h 1155700"/>
              <a:gd name="connsiteX5" fmla="*/ 952500 w 1250950"/>
              <a:gd name="connsiteY5" fmla="*/ 974725 h 1155700"/>
              <a:gd name="connsiteX6" fmla="*/ 968375 w 1250950"/>
              <a:gd name="connsiteY6" fmla="*/ 933450 h 1155700"/>
              <a:gd name="connsiteX7" fmla="*/ 981075 w 1250950"/>
              <a:gd name="connsiteY7" fmla="*/ 771525 h 1155700"/>
              <a:gd name="connsiteX8" fmla="*/ 1012825 w 1250950"/>
              <a:gd name="connsiteY8" fmla="*/ 498475 h 1155700"/>
              <a:gd name="connsiteX9" fmla="*/ 1022350 w 1250950"/>
              <a:gd name="connsiteY9" fmla="*/ 330200 h 1155700"/>
              <a:gd name="connsiteX10" fmla="*/ 1031875 w 1250950"/>
              <a:gd name="connsiteY10" fmla="*/ 155575 h 1155700"/>
              <a:gd name="connsiteX11" fmla="*/ 1057275 w 1250950"/>
              <a:gd name="connsiteY11" fmla="*/ 15875 h 1155700"/>
              <a:gd name="connsiteX12" fmla="*/ 1063625 w 1250950"/>
              <a:gd name="connsiteY12" fmla="*/ 0 h 1155700"/>
              <a:gd name="connsiteX13" fmla="*/ 1076325 w 1250950"/>
              <a:gd name="connsiteY13" fmla="*/ 228600 h 1155700"/>
              <a:gd name="connsiteX14" fmla="*/ 1089025 w 1250950"/>
              <a:gd name="connsiteY14" fmla="*/ 206375 h 1155700"/>
              <a:gd name="connsiteX15" fmla="*/ 1104900 w 1250950"/>
              <a:gd name="connsiteY15" fmla="*/ 412750 h 1155700"/>
              <a:gd name="connsiteX16" fmla="*/ 1120775 w 1250950"/>
              <a:gd name="connsiteY16" fmla="*/ 565150 h 1155700"/>
              <a:gd name="connsiteX17" fmla="*/ 1130300 w 1250950"/>
              <a:gd name="connsiteY17" fmla="*/ 688975 h 1155700"/>
              <a:gd name="connsiteX18" fmla="*/ 1149350 w 1250950"/>
              <a:gd name="connsiteY18" fmla="*/ 815975 h 1155700"/>
              <a:gd name="connsiteX19" fmla="*/ 1155700 w 1250950"/>
              <a:gd name="connsiteY19" fmla="*/ 920750 h 1155700"/>
              <a:gd name="connsiteX20" fmla="*/ 1177925 w 1250950"/>
              <a:gd name="connsiteY20" fmla="*/ 1009650 h 1155700"/>
              <a:gd name="connsiteX21" fmla="*/ 1200150 w 1250950"/>
              <a:gd name="connsiteY21" fmla="*/ 1092200 h 1155700"/>
              <a:gd name="connsiteX22" fmla="*/ 1250950 w 1250950"/>
              <a:gd name="connsiteY22" fmla="*/ 1149350 h 11557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1250950" h="1155700">
                <a:moveTo>
                  <a:pt x="0" y="1155700"/>
                </a:moveTo>
                <a:lnTo>
                  <a:pt x="809625" y="1155700"/>
                </a:lnTo>
                <a:lnTo>
                  <a:pt x="882650" y="1130300"/>
                </a:lnTo>
                <a:lnTo>
                  <a:pt x="908050" y="1095375"/>
                </a:lnTo>
                <a:lnTo>
                  <a:pt x="936625" y="1038225"/>
                </a:lnTo>
                <a:lnTo>
                  <a:pt x="952500" y="974725"/>
                </a:lnTo>
                <a:lnTo>
                  <a:pt x="968375" y="933450"/>
                </a:lnTo>
                <a:lnTo>
                  <a:pt x="981075" y="771525"/>
                </a:lnTo>
                <a:lnTo>
                  <a:pt x="1012825" y="498475"/>
                </a:lnTo>
                <a:lnTo>
                  <a:pt x="1022350" y="330200"/>
                </a:lnTo>
                <a:lnTo>
                  <a:pt x="1031875" y="155575"/>
                </a:lnTo>
                <a:lnTo>
                  <a:pt x="1057275" y="15875"/>
                </a:lnTo>
                <a:lnTo>
                  <a:pt x="1063625" y="0"/>
                </a:lnTo>
                <a:lnTo>
                  <a:pt x="1076325" y="228600"/>
                </a:lnTo>
                <a:lnTo>
                  <a:pt x="1089025" y="206375"/>
                </a:lnTo>
                <a:lnTo>
                  <a:pt x="1104900" y="412750"/>
                </a:lnTo>
                <a:lnTo>
                  <a:pt x="1120775" y="565150"/>
                </a:lnTo>
                <a:lnTo>
                  <a:pt x="1130300" y="688975"/>
                </a:lnTo>
                <a:lnTo>
                  <a:pt x="1149350" y="815975"/>
                </a:lnTo>
                <a:lnTo>
                  <a:pt x="1155700" y="920750"/>
                </a:lnTo>
                <a:lnTo>
                  <a:pt x="1177925" y="1009650"/>
                </a:lnTo>
                <a:lnTo>
                  <a:pt x="1200150" y="1092200"/>
                </a:lnTo>
                <a:lnTo>
                  <a:pt x="1250950" y="114935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4" name="正方形/長方形 43">
            <a:extLst>
              <a:ext uri="{FF2B5EF4-FFF2-40B4-BE49-F238E27FC236}">
                <a16:creationId xmlns:a16="http://schemas.microsoft.com/office/drawing/2014/main" id="{E4F07C3B-784A-9441-BD49-A1B2F8AC4C68}"/>
              </a:ext>
            </a:extLst>
          </p:cNvPr>
          <p:cNvSpPr/>
          <p:nvPr/>
        </p:nvSpPr>
        <p:spPr>
          <a:xfrm>
            <a:off x="1177345" y="3151142"/>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5" name="フリーフォーム 44">
            <a:extLst>
              <a:ext uri="{FF2B5EF4-FFF2-40B4-BE49-F238E27FC236}">
                <a16:creationId xmlns:a16="http://schemas.microsoft.com/office/drawing/2014/main" id="{1071CF59-F69B-2243-9F58-9F6BF7CCDAED}"/>
              </a:ext>
            </a:extLst>
          </p:cNvPr>
          <p:cNvSpPr/>
          <p:nvPr/>
        </p:nvSpPr>
        <p:spPr>
          <a:xfrm>
            <a:off x="2844221" y="3329607"/>
            <a:ext cx="1260475" cy="1082675"/>
          </a:xfrm>
          <a:custGeom>
            <a:avLst/>
            <a:gdLst>
              <a:gd name="connsiteX0" fmla="*/ 0 w 1260475"/>
              <a:gd name="connsiteY0" fmla="*/ 1082675 h 1082675"/>
              <a:gd name="connsiteX1" fmla="*/ 25400 w 1260475"/>
              <a:gd name="connsiteY1" fmla="*/ 1054100 h 1082675"/>
              <a:gd name="connsiteX2" fmla="*/ 53975 w 1260475"/>
              <a:gd name="connsiteY2" fmla="*/ 1054100 h 1082675"/>
              <a:gd name="connsiteX3" fmla="*/ 95250 w 1260475"/>
              <a:gd name="connsiteY3" fmla="*/ 1019175 h 1082675"/>
              <a:gd name="connsiteX4" fmla="*/ 130175 w 1260475"/>
              <a:gd name="connsiteY4" fmla="*/ 1016000 h 1082675"/>
              <a:gd name="connsiteX5" fmla="*/ 165100 w 1260475"/>
              <a:gd name="connsiteY5" fmla="*/ 984250 h 1082675"/>
              <a:gd name="connsiteX6" fmla="*/ 203200 w 1260475"/>
              <a:gd name="connsiteY6" fmla="*/ 939800 h 1082675"/>
              <a:gd name="connsiteX7" fmla="*/ 241300 w 1260475"/>
              <a:gd name="connsiteY7" fmla="*/ 873125 h 1082675"/>
              <a:gd name="connsiteX8" fmla="*/ 260350 w 1260475"/>
              <a:gd name="connsiteY8" fmla="*/ 825500 h 1082675"/>
              <a:gd name="connsiteX9" fmla="*/ 276225 w 1260475"/>
              <a:gd name="connsiteY9" fmla="*/ 828675 h 1082675"/>
              <a:gd name="connsiteX10" fmla="*/ 298450 w 1260475"/>
              <a:gd name="connsiteY10" fmla="*/ 695325 h 1082675"/>
              <a:gd name="connsiteX11" fmla="*/ 311150 w 1260475"/>
              <a:gd name="connsiteY11" fmla="*/ 688975 h 1082675"/>
              <a:gd name="connsiteX12" fmla="*/ 342900 w 1260475"/>
              <a:gd name="connsiteY12" fmla="*/ 501650 h 1082675"/>
              <a:gd name="connsiteX13" fmla="*/ 342900 w 1260475"/>
              <a:gd name="connsiteY13" fmla="*/ 447675 h 1082675"/>
              <a:gd name="connsiteX14" fmla="*/ 371475 w 1260475"/>
              <a:gd name="connsiteY14" fmla="*/ 342900 h 1082675"/>
              <a:gd name="connsiteX15" fmla="*/ 387350 w 1260475"/>
              <a:gd name="connsiteY15" fmla="*/ 298450 h 1082675"/>
              <a:gd name="connsiteX16" fmla="*/ 396875 w 1260475"/>
              <a:gd name="connsiteY16" fmla="*/ 158750 h 1082675"/>
              <a:gd name="connsiteX17" fmla="*/ 396875 w 1260475"/>
              <a:gd name="connsiteY17" fmla="*/ 168275 h 1082675"/>
              <a:gd name="connsiteX18" fmla="*/ 396875 w 1260475"/>
              <a:gd name="connsiteY18" fmla="*/ 174625 h 1082675"/>
              <a:gd name="connsiteX19" fmla="*/ 422275 w 1260475"/>
              <a:gd name="connsiteY19" fmla="*/ 0 h 1082675"/>
              <a:gd name="connsiteX20" fmla="*/ 438150 w 1260475"/>
              <a:gd name="connsiteY20" fmla="*/ 38100 h 1082675"/>
              <a:gd name="connsiteX21" fmla="*/ 444500 w 1260475"/>
              <a:gd name="connsiteY21" fmla="*/ 3175 h 1082675"/>
              <a:gd name="connsiteX22" fmla="*/ 466725 w 1260475"/>
              <a:gd name="connsiteY22" fmla="*/ 98425 h 1082675"/>
              <a:gd name="connsiteX23" fmla="*/ 485775 w 1260475"/>
              <a:gd name="connsiteY23" fmla="*/ 244475 h 1082675"/>
              <a:gd name="connsiteX24" fmla="*/ 501650 w 1260475"/>
              <a:gd name="connsiteY24" fmla="*/ 438150 h 1082675"/>
              <a:gd name="connsiteX25" fmla="*/ 517525 w 1260475"/>
              <a:gd name="connsiteY25" fmla="*/ 622300 h 1082675"/>
              <a:gd name="connsiteX26" fmla="*/ 539750 w 1260475"/>
              <a:gd name="connsiteY26" fmla="*/ 819150 h 1082675"/>
              <a:gd name="connsiteX27" fmla="*/ 555625 w 1260475"/>
              <a:gd name="connsiteY27" fmla="*/ 971550 h 1082675"/>
              <a:gd name="connsiteX28" fmla="*/ 577850 w 1260475"/>
              <a:gd name="connsiteY28" fmla="*/ 1047750 h 1082675"/>
              <a:gd name="connsiteX29" fmla="*/ 593725 w 1260475"/>
              <a:gd name="connsiteY29" fmla="*/ 1066800 h 1082675"/>
              <a:gd name="connsiteX30" fmla="*/ 619125 w 1260475"/>
              <a:gd name="connsiteY30" fmla="*/ 1082675 h 1082675"/>
              <a:gd name="connsiteX31" fmla="*/ 1260475 w 1260475"/>
              <a:gd name="connsiteY31" fmla="*/ 1082675 h 1082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1260475" h="1082675">
                <a:moveTo>
                  <a:pt x="0" y="1082675"/>
                </a:moveTo>
                <a:lnTo>
                  <a:pt x="25400" y="1054100"/>
                </a:lnTo>
                <a:lnTo>
                  <a:pt x="53975" y="1054100"/>
                </a:lnTo>
                <a:lnTo>
                  <a:pt x="95250" y="1019175"/>
                </a:lnTo>
                <a:lnTo>
                  <a:pt x="130175" y="1016000"/>
                </a:lnTo>
                <a:lnTo>
                  <a:pt x="165100" y="984250"/>
                </a:lnTo>
                <a:lnTo>
                  <a:pt x="203200" y="939800"/>
                </a:lnTo>
                <a:lnTo>
                  <a:pt x="241300" y="873125"/>
                </a:lnTo>
                <a:lnTo>
                  <a:pt x="260350" y="825500"/>
                </a:lnTo>
                <a:lnTo>
                  <a:pt x="276225" y="828675"/>
                </a:lnTo>
                <a:lnTo>
                  <a:pt x="298450" y="695325"/>
                </a:lnTo>
                <a:lnTo>
                  <a:pt x="311150" y="688975"/>
                </a:lnTo>
                <a:lnTo>
                  <a:pt x="342900" y="501650"/>
                </a:lnTo>
                <a:lnTo>
                  <a:pt x="342900" y="447675"/>
                </a:lnTo>
                <a:lnTo>
                  <a:pt x="371475" y="342900"/>
                </a:lnTo>
                <a:lnTo>
                  <a:pt x="387350" y="298450"/>
                </a:lnTo>
                <a:lnTo>
                  <a:pt x="396875" y="158750"/>
                </a:lnTo>
                <a:lnTo>
                  <a:pt x="396875" y="168275"/>
                </a:lnTo>
                <a:lnTo>
                  <a:pt x="396875" y="174625"/>
                </a:lnTo>
                <a:lnTo>
                  <a:pt x="422275" y="0"/>
                </a:lnTo>
                <a:lnTo>
                  <a:pt x="438150" y="38100"/>
                </a:lnTo>
                <a:lnTo>
                  <a:pt x="444500" y="3175"/>
                </a:lnTo>
                <a:lnTo>
                  <a:pt x="466725" y="98425"/>
                </a:lnTo>
                <a:lnTo>
                  <a:pt x="485775" y="244475"/>
                </a:lnTo>
                <a:lnTo>
                  <a:pt x="501650" y="438150"/>
                </a:lnTo>
                <a:lnTo>
                  <a:pt x="517525" y="622300"/>
                </a:lnTo>
                <a:lnTo>
                  <a:pt x="539750" y="819150"/>
                </a:lnTo>
                <a:lnTo>
                  <a:pt x="555625" y="971550"/>
                </a:lnTo>
                <a:lnTo>
                  <a:pt x="577850" y="1047750"/>
                </a:lnTo>
                <a:lnTo>
                  <a:pt x="593725" y="1066800"/>
                </a:lnTo>
                <a:lnTo>
                  <a:pt x="619125" y="1082675"/>
                </a:lnTo>
                <a:lnTo>
                  <a:pt x="1260475" y="108267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6" name="フリーフォーム 45">
            <a:extLst>
              <a:ext uri="{FF2B5EF4-FFF2-40B4-BE49-F238E27FC236}">
                <a16:creationId xmlns:a16="http://schemas.microsoft.com/office/drawing/2014/main" id="{A5FB7964-21CA-FF44-A267-1D604A16CC43}"/>
              </a:ext>
            </a:extLst>
          </p:cNvPr>
          <p:cNvSpPr/>
          <p:nvPr/>
        </p:nvSpPr>
        <p:spPr>
          <a:xfrm>
            <a:off x="2844221" y="3323256"/>
            <a:ext cx="1260475" cy="1089025"/>
          </a:xfrm>
          <a:custGeom>
            <a:avLst/>
            <a:gdLst>
              <a:gd name="connsiteX0" fmla="*/ 0 w 1260475"/>
              <a:gd name="connsiteY0" fmla="*/ 1085850 h 1089025"/>
              <a:gd name="connsiteX1" fmla="*/ 425450 w 1260475"/>
              <a:gd name="connsiteY1" fmla="*/ 1089025 h 1089025"/>
              <a:gd name="connsiteX2" fmla="*/ 434975 w 1260475"/>
              <a:gd name="connsiteY2" fmla="*/ 1069975 h 1089025"/>
              <a:gd name="connsiteX3" fmla="*/ 473075 w 1260475"/>
              <a:gd name="connsiteY3" fmla="*/ 1076325 h 1089025"/>
              <a:gd name="connsiteX4" fmla="*/ 514350 w 1260475"/>
              <a:gd name="connsiteY4" fmla="*/ 1073150 h 1089025"/>
              <a:gd name="connsiteX5" fmla="*/ 561975 w 1260475"/>
              <a:gd name="connsiteY5" fmla="*/ 1031875 h 1089025"/>
              <a:gd name="connsiteX6" fmla="*/ 622300 w 1260475"/>
              <a:gd name="connsiteY6" fmla="*/ 981075 h 1089025"/>
              <a:gd name="connsiteX7" fmla="*/ 654050 w 1260475"/>
              <a:gd name="connsiteY7" fmla="*/ 911225 h 1089025"/>
              <a:gd name="connsiteX8" fmla="*/ 676275 w 1260475"/>
              <a:gd name="connsiteY8" fmla="*/ 822325 h 1089025"/>
              <a:gd name="connsiteX9" fmla="*/ 701675 w 1260475"/>
              <a:gd name="connsiteY9" fmla="*/ 698500 h 1089025"/>
              <a:gd name="connsiteX10" fmla="*/ 714375 w 1260475"/>
              <a:gd name="connsiteY10" fmla="*/ 682625 h 1089025"/>
              <a:gd name="connsiteX11" fmla="*/ 730250 w 1260475"/>
              <a:gd name="connsiteY11" fmla="*/ 600075 h 1089025"/>
              <a:gd name="connsiteX12" fmla="*/ 749300 w 1260475"/>
              <a:gd name="connsiteY12" fmla="*/ 492125 h 1089025"/>
              <a:gd name="connsiteX13" fmla="*/ 755650 w 1260475"/>
              <a:gd name="connsiteY13" fmla="*/ 419100 h 1089025"/>
              <a:gd name="connsiteX14" fmla="*/ 765175 w 1260475"/>
              <a:gd name="connsiteY14" fmla="*/ 409575 h 1089025"/>
              <a:gd name="connsiteX15" fmla="*/ 790575 w 1260475"/>
              <a:gd name="connsiteY15" fmla="*/ 346075 h 1089025"/>
              <a:gd name="connsiteX16" fmla="*/ 809625 w 1260475"/>
              <a:gd name="connsiteY16" fmla="*/ 250825 h 1089025"/>
              <a:gd name="connsiteX17" fmla="*/ 822325 w 1260475"/>
              <a:gd name="connsiteY17" fmla="*/ 107950 h 1089025"/>
              <a:gd name="connsiteX18" fmla="*/ 850900 w 1260475"/>
              <a:gd name="connsiteY18" fmla="*/ 0 h 1089025"/>
              <a:gd name="connsiteX19" fmla="*/ 857250 w 1260475"/>
              <a:gd name="connsiteY19" fmla="*/ 73025 h 1089025"/>
              <a:gd name="connsiteX20" fmla="*/ 873125 w 1260475"/>
              <a:gd name="connsiteY20" fmla="*/ 28575 h 1089025"/>
              <a:gd name="connsiteX21" fmla="*/ 892175 w 1260475"/>
              <a:gd name="connsiteY21" fmla="*/ 161925 h 1089025"/>
              <a:gd name="connsiteX22" fmla="*/ 917575 w 1260475"/>
              <a:gd name="connsiteY22" fmla="*/ 260350 h 1089025"/>
              <a:gd name="connsiteX23" fmla="*/ 933450 w 1260475"/>
              <a:gd name="connsiteY23" fmla="*/ 422275 h 1089025"/>
              <a:gd name="connsiteX24" fmla="*/ 942975 w 1260475"/>
              <a:gd name="connsiteY24" fmla="*/ 473075 h 1089025"/>
              <a:gd name="connsiteX25" fmla="*/ 962025 w 1260475"/>
              <a:gd name="connsiteY25" fmla="*/ 527050 h 1089025"/>
              <a:gd name="connsiteX26" fmla="*/ 977900 w 1260475"/>
              <a:gd name="connsiteY26" fmla="*/ 692150 h 1089025"/>
              <a:gd name="connsiteX27" fmla="*/ 1003300 w 1260475"/>
              <a:gd name="connsiteY27" fmla="*/ 800100 h 1089025"/>
              <a:gd name="connsiteX28" fmla="*/ 1022350 w 1260475"/>
              <a:gd name="connsiteY28" fmla="*/ 914400 h 1089025"/>
              <a:gd name="connsiteX29" fmla="*/ 1050925 w 1260475"/>
              <a:gd name="connsiteY29" fmla="*/ 981075 h 1089025"/>
              <a:gd name="connsiteX30" fmla="*/ 1092200 w 1260475"/>
              <a:gd name="connsiteY30" fmla="*/ 1041400 h 1089025"/>
              <a:gd name="connsiteX31" fmla="*/ 1136650 w 1260475"/>
              <a:gd name="connsiteY31" fmla="*/ 1085850 h 1089025"/>
              <a:gd name="connsiteX32" fmla="*/ 1260475 w 1260475"/>
              <a:gd name="connsiteY32" fmla="*/ 1085850 h 10890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Lst>
            <a:rect l="l" t="t" r="r" b="b"/>
            <a:pathLst>
              <a:path w="1260475" h="1089025">
                <a:moveTo>
                  <a:pt x="0" y="1085850"/>
                </a:moveTo>
                <a:lnTo>
                  <a:pt x="425450" y="1089025"/>
                </a:lnTo>
                <a:lnTo>
                  <a:pt x="434975" y="1069975"/>
                </a:lnTo>
                <a:lnTo>
                  <a:pt x="473075" y="1076325"/>
                </a:lnTo>
                <a:lnTo>
                  <a:pt x="514350" y="1073150"/>
                </a:lnTo>
                <a:lnTo>
                  <a:pt x="561975" y="1031875"/>
                </a:lnTo>
                <a:lnTo>
                  <a:pt x="622300" y="981075"/>
                </a:lnTo>
                <a:lnTo>
                  <a:pt x="654050" y="911225"/>
                </a:lnTo>
                <a:lnTo>
                  <a:pt x="676275" y="822325"/>
                </a:lnTo>
                <a:lnTo>
                  <a:pt x="701675" y="698500"/>
                </a:lnTo>
                <a:lnTo>
                  <a:pt x="714375" y="682625"/>
                </a:lnTo>
                <a:lnTo>
                  <a:pt x="730250" y="600075"/>
                </a:lnTo>
                <a:lnTo>
                  <a:pt x="749300" y="492125"/>
                </a:lnTo>
                <a:lnTo>
                  <a:pt x="755650" y="419100"/>
                </a:lnTo>
                <a:lnTo>
                  <a:pt x="765175" y="409575"/>
                </a:lnTo>
                <a:lnTo>
                  <a:pt x="790575" y="346075"/>
                </a:lnTo>
                <a:lnTo>
                  <a:pt x="809625" y="250825"/>
                </a:lnTo>
                <a:lnTo>
                  <a:pt x="822325" y="107950"/>
                </a:lnTo>
                <a:lnTo>
                  <a:pt x="850900" y="0"/>
                </a:lnTo>
                <a:lnTo>
                  <a:pt x="857250" y="73025"/>
                </a:lnTo>
                <a:lnTo>
                  <a:pt x="873125" y="28575"/>
                </a:lnTo>
                <a:lnTo>
                  <a:pt x="892175" y="161925"/>
                </a:lnTo>
                <a:lnTo>
                  <a:pt x="917575" y="260350"/>
                </a:lnTo>
                <a:lnTo>
                  <a:pt x="933450" y="422275"/>
                </a:lnTo>
                <a:lnTo>
                  <a:pt x="942975" y="473075"/>
                </a:lnTo>
                <a:lnTo>
                  <a:pt x="962025" y="527050"/>
                </a:lnTo>
                <a:lnTo>
                  <a:pt x="977900" y="692150"/>
                </a:lnTo>
                <a:lnTo>
                  <a:pt x="1003300" y="800100"/>
                </a:lnTo>
                <a:lnTo>
                  <a:pt x="1022350" y="914400"/>
                </a:lnTo>
                <a:lnTo>
                  <a:pt x="1050925" y="981075"/>
                </a:lnTo>
                <a:lnTo>
                  <a:pt x="1092200" y="1041400"/>
                </a:lnTo>
                <a:lnTo>
                  <a:pt x="1136650" y="1085850"/>
                </a:lnTo>
                <a:lnTo>
                  <a:pt x="1260475" y="108585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7" name="正方形/長方形 46">
            <a:extLst>
              <a:ext uri="{FF2B5EF4-FFF2-40B4-BE49-F238E27FC236}">
                <a16:creationId xmlns:a16="http://schemas.microsoft.com/office/drawing/2014/main" id="{614DEB9F-B3D7-B64C-8604-1757EDF9204C}"/>
              </a:ext>
            </a:extLst>
          </p:cNvPr>
          <p:cNvSpPr/>
          <p:nvPr/>
        </p:nvSpPr>
        <p:spPr>
          <a:xfrm>
            <a:off x="2837871" y="3150989"/>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8" name="フリーフォーム 47">
            <a:extLst>
              <a:ext uri="{FF2B5EF4-FFF2-40B4-BE49-F238E27FC236}">
                <a16:creationId xmlns:a16="http://schemas.microsoft.com/office/drawing/2014/main" id="{4299A5E6-2B5A-7D42-AB7D-9E0C141499C0}"/>
              </a:ext>
            </a:extLst>
          </p:cNvPr>
          <p:cNvSpPr/>
          <p:nvPr/>
        </p:nvSpPr>
        <p:spPr>
          <a:xfrm>
            <a:off x="4482520" y="3234357"/>
            <a:ext cx="1263650" cy="1177925"/>
          </a:xfrm>
          <a:custGeom>
            <a:avLst/>
            <a:gdLst>
              <a:gd name="connsiteX0" fmla="*/ 0 w 1263650"/>
              <a:gd name="connsiteY0" fmla="*/ 1177925 h 1177925"/>
              <a:gd name="connsiteX1" fmla="*/ 22225 w 1263650"/>
              <a:gd name="connsiteY1" fmla="*/ 1073150 h 1177925"/>
              <a:gd name="connsiteX2" fmla="*/ 38100 w 1263650"/>
              <a:gd name="connsiteY2" fmla="*/ 1076325 h 1177925"/>
              <a:gd name="connsiteX3" fmla="*/ 69850 w 1263650"/>
              <a:gd name="connsiteY3" fmla="*/ 1025525 h 1177925"/>
              <a:gd name="connsiteX4" fmla="*/ 82550 w 1263650"/>
              <a:gd name="connsiteY4" fmla="*/ 1031875 h 1177925"/>
              <a:gd name="connsiteX5" fmla="*/ 111125 w 1263650"/>
              <a:gd name="connsiteY5" fmla="*/ 981075 h 1177925"/>
              <a:gd name="connsiteX6" fmla="*/ 117475 w 1263650"/>
              <a:gd name="connsiteY6" fmla="*/ 981075 h 1177925"/>
              <a:gd name="connsiteX7" fmla="*/ 139700 w 1263650"/>
              <a:gd name="connsiteY7" fmla="*/ 904875 h 1177925"/>
              <a:gd name="connsiteX8" fmla="*/ 161925 w 1263650"/>
              <a:gd name="connsiteY8" fmla="*/ 889000 h 1177925"/>
              <a:gd name="connsiteX9" fmla="*/ 187325 w 1263650"/>
              <a:gd name="connsiteY9" fmla="*/ 790575 h 1177925"/>
              <a:gd name="connsiteX10" fmla="*/ 196850 w 1263650"/>
              <a:gd name="connsiteY10" fmla="*/ 806450 h 1177925"/>
              <a:gd name="connsiteX11" fmla="*/ 241300 w 1263650"/>
              <a:gd name="connsiteY11" fmla="*/ 590550 h 1177925"/>
              <a:gd name="connsiteX12" fmla="*/ 260350 w 1263650"/>
              <a:gd name="connsiteY12" fmla="*/ 558800 h 1177925"/>
              <a:gd name="connsiteX13" fmla="*/ 282575 w 1263650"/>
              <a:gd name="connsiteY13" fmla="*/ 292100 h 1177925"/>
              <a:gd name="connsiteX14" fmla="*/ 307975 w 1263650"/>
              <a:gd name="connsiteY14" fmla="*/ 184150 h 1177925"/>
              <a:gd name="connsiteX15" fmla="*/ 320675 w 1263650"/>
              <a:gd name="connsiteY15" fmla="*/ 225425 h 1177925"/>
              <a:gd name="connsiteX16" fmla="*/ 330200 w 1263650"/>
              <a:gd name="connsiteY16" fmla="*/ 187325 h 1177925"/>
              <a:gd name="connsiteX17" fmla="*/ 349250 w 1263650"/>
              <a:gd name="connsiteY17" fmla="*/ 196850 h 1177925"/>
              <a:gd name="connsiteX18" fmla="*/ 355600 w 1263650"/>
              <a:gd name="connsiteY18" fmla="*/ 0 h 1177925"/>
              <a:gd name="connsiteX19" fmla="*/ 374650 w 1263650"/>
              <a:gd name="connsiteY19" fmla="*/ 88900 h 1177925"/>
              <a:gd name="connsiteX20" fmla="*/ 396875 w 1263650"/>
              <a:gd name="connsiteY20" fmla="*/ 41275 h 1177925"/>
              <a:gd name="connsiteX21" fmla="*/ 412750 w 1263650"/>
              <a:gd name="connsiteY21" fmla="*/ 133350 h 1177925"/>
              <a:gd name="connsiteX22" fmla="*/ 428625 w 1263650"/>
              <a:gd name="connsiteY22" fmla="*/ 323850 h 1177925"/>
              <a:gd name="connsiteX23" fmla="*/ 441325 w 1263650"/>
              <a:gd name="connsiteY23" fmla="*/ 488950 h 1177925"/>
              <a:gd name="connsiteX24" fmla="*/ 457200 w 1263650"/>
              <a:gd name="connsiteY24" fmla="*/ 647700 h 1177925"/>
              <a:gd name="connsiteX25" fmla="*/ 466725 w 1263650"/>
              <a:gd name="connsiteY25" fmla="*/ 784225 h 1177925"/>
              <a:gd name="connsiteX26" fmla="*/ 479425 w 1263650"/>
              <a:gd name="connsiteY26" fmla="*/ 917575 h 1177925"/>
              <a:gd name="connsiteX27" fmla="*/ 495300 w 1263650"/>
              <a:gd name="connsiteY27" fmla="*/ 1041400 h 1177925"/>
              <a:gd name="connsiteX28" fmla="*/ 520700 w 1263650"/>
              <a:gd name="connsiteY28" fmla="*/ 1111250 h 1177925"/>
              <a:gd name="connsiteX29" fmla="*/ 546100 w 1263650"/>
              <a:gd name="connsiteY29" fmla="*/ 1158875 h 1177925"/>
              <a:gd name="connsiteX30" fmla="*/ 568325 w 1263650"/>
              <a:gd name="connsiteY30" fmla="*/ 1168400 h 1177925"/>
              <a:gd name="connsiteX31" fmla="*/ 619125 w 1263650"/>
              <a:gd name="connsiteY31" fmla="*/ 1177925 h 1177925"/>
              <a:gd name="connsiteX32" fmla="*/ 1263650 w 1263650"/>
              <a:gd name="connsiteY32" fmla="*/ 1177925 h 11779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Lst>
            <a:rect l="l" t="t" r="r" b="b"/>
            <a:pathLst>
              <a:path w="1263650" h="1177925">
                <a:moveTo>
                  <a:pt x="0" y="1177925"/>
                </a:moveTo>
                <a:lnTo>
                  <a:pt x="22225" y="1073150"/>
                </a:lnTo>
                <a:lnTo>
                  <a:pt x="38100" y="1076325"/>
                </a:lnTo>
                <a:lnTo>
                  <a:pt x="69850" y="1025525"/>
                </a:lnTo>
                <a:lnTo>
                  <a:pt x="82550" y="1031875"/>
                </a:lnTo>
                <a:lnTo>
                  <a:pt x="111125" y="981075"/>
                </a:lnTo>
                <a:lnTo>
                  <a:pt x="117475" y="981075"/>
                </a:lnTo>
                <a:lnTo>
                  <a:pt x="139700" y="904875"/>
                </a:lnTo>
                <a:lnTo>
                  <a:pt x="161925" y="889000"/>
                </a:lnTo>
                <a:lnTo>
                  <a:pt x="187325" y="790575"/>
                </a:lnTo>
                <a:lnTo>
                  <a:pt x="196850" y="806450"/>
                </a:lnTo>
                <a:lnTo>
                  <a:pt x="241300" y="590550"/>
                </a:lnTo>
                <a:lnTo>
                  <a:pt x="260350" y="558800"/>
                </a:lnTo>
                <a:lnTo>
                  <a:pt x="282575" y="292100"/>
                </a:lnTo>
                <a:lnTo>
                  <a:pt x="307975" y="184150"/>
                </a:lnTo>
                <a:lnTo>
                  <a:pt x="320675" y="225425"/>
                </a:lnTo>
                <a:lnTo>
                  <a:pt x="330200" y="187325"/>
                </a:lnTo>
                <a:lnTo>
                  <a:pt x="349250" y="196850"/>
                </a:lnTo>
                <a:lnTo>
                  <a:pt x="355600" y="0"/>
                </a:lnTo>
                <a:lnTo>
                  <a:pt x="374650" y="88900"/>
                </a:lnTo>
                <a:lnTo>
                  <a:pt x="396875" y="41275"/>
                </a:lnTo>
                <a:lnTo>
                  <a:pt x="412750" y="133350"/>
                </a:lnTo>
                <a:lnTo>
                  <a:pt x="428625" y="323850"/>
                </a:lnTo>
                <a:lnTo>
                  <a:pt x="441325" y="488950"/>
                </a:lnTo>
                <a:lnTo>
                  <a:pt x="457200" y="647700"/>
                </a:lnTo>
                <a:lnTo>
                  <a:pt x="466725" y="784225"/>
                </a:lnTo>
                <a:lnTo>
                  <a:pt x="479425" y="917575"/>
                </a:lnTo>
                <a:lnTo>
                  <a:pt x="495300" y="1041400"/>
                </a:lnTo>
                <a:lnTo>
                  <a:pt x="520700" y="1111250"/>
                </a:lnTo>
                <a:lnTo>
                  <a:pt x="546100" y="1158875"/>
                </a:lnTo>
                <a:lnTo>
                  <a:pt x="568325" y="1168400"/>
                </a:lnTo>
                <a:lnTo>
                  <a:pt x="619125" y="1177925"/>
                </a:lnTo>
                <a:lnTo>
                  <a:pt x="1263650" y="117792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49" name="フリーフォーム 48">
            <a:extLst>
              <a:ext uri="{FF2B5EF4-FFF2-40B4-BE49-F238E27FC236}">
                <a16:creationId xmlns:a16="http://schemas.microsoft.com/office/drawing/2014/main" id="{14E3B182-4702-A145-91C2-2C99FABB97D7}"/>
              </a:ext>
            </a:extLst>
          </p:cNvPr>
          <p:cNvSpPr/>
          <p:nvPr/>
        </p:nvSpPr>
        <p:spPr>
          <a:xfrm>
            <a:off x="4485695" y="3301032"/>
            <a:ext cx="1260475" cy="1114425"/>
          </a:xfrm>
          <a:custGeom>
            <a:avLst/>
            <a:gdLst>
              <a:gd name="connsiteX0" fmla="*/ 0 w 1260475"/>
              <a:gd name="connsiteY0" fmla="*/ 1108075 h 1114425"/>
              <a:gd name="connsiteX1" fmla="*/ 431800 w 1260475"/>
              <a:gd name="connsiteY1" fmla="*/ 1114425 h 1114425"/>
              <a:gd name="connsiteX2" fmla="*/ 476250 w 1260475"/>
              <a:gd name="connsiteY2" fmla="*/ 1101725 h 1114425"/>
              <a:gd name="connsiteX3" fmla="*/ 514350 w 1260475"/>
              <a:gd name="connsiteY3" fmla="*/ 1098550 h 1114425"/>
              <a:gd name="connsiteX4" fmla="*/ 549275 w 1260475"/>
              <a:gd name="connsiteY4" fmla="*/ 1085850 h 1114425"/>
              <a:gd name="connsiteX5" fmla="*/ 593725 w 1260475"/>
              <a:gd name="connsiteY5" fmla="*/ 1085850 h 1114425"/>
              <a:gd name="connsiteX6" fmla="*/ 631825 w 1260475"/>
              <a:gd name="connsiteY6" fmla="*/ 1066800 h 1114425"/>
              <a:gd name="connsiteX7" fmla="*/ 676275 w 1260475"/>
              <a:gd name="connsiteY7" fmla="*/ 1012825 h 1114425"/>
              <a:gd name="connsiteX8" fmla="*/ 720725 w 1260475"/>
              <a:gd name="connsiteY8" fmla="*/ 901700 h 1114425"/>
              <a:gd name="connsiteX9" fmla="*/ 739775 w 1260475"/>
              <a:gd name="connsiteY9" fmla="*/ 803275 h 1114425"/>
              <a:gd name="connsiteX10" fmla="*/ 758825 w 1260475"/>
              <a:gd name="connsiteY10" fmla="*/ 768350 h 1114425"/>
              <a:gd name="connsiteX11" fmla="*/ 774700 w 1260475"/>
              <a:gd name="connsiteY11" fmla="*/ 625475 h 1114425"/>
              <a:gd name="connsiteX12" fmla="*/ 781050 w 1260475"/>
              <a:gd name="connsiteY12" fmla="*/ 546100 h 1114425"/>
              <a:gd name="connsiteX13" fmla="*/ 793750 w 1260475"/>
              <a:gd name="connsiteY13" fmla="*/ 501650 h 1114425"/>
              <a:gd name="connsiteX14" fmla="*/ 803275 w 1260475"/>
              <a:gd name="connsiteY14" fmla="*/ 406400 h 1114425"/>
              <a:gd name="connsiteX15" fmla="*/ 812800 w 1260475"/>
              <a:gd name="connsiteY15" fmla="*/ 339725 h 1114425"/>
              <a:gd name="connsiteX16" fmla="*/ 838200 w 1260475"/>
              <a:gd name="connsiteY16" fmla="*/ 292100 h 1114425"/>
              <a:gd name="connsiteX17" fmla="*/ 850900 w 1260475"/>
              <a:gd name="connsiteY17" fmla="*/ 130175 h 1114425"/>
              <a:gd name="connsiteX18" fmla="*/ 857250 w 1260475"/>
              <a:gd name="connsiteY18" fmla="*/ 98425 h 1114425"/>
              <a:gd name="connsiteX19" fmla="*/ 876300 w 1260475"/>
              <a:gd name="connsiteY19" fmla="*/ 88900 h 1114425"/>
              <a:gd name="connsiteX20" fmla="*/ 882650 w 1260475"/>
              <a:gd name="connsiteY20" fmla="*/ 0 h 1114425"/>
              <a:gd name="connsiteX21" fmla="*/ 911225 w 1260475"/>
              <a:gd name="connsiteY21" fmla="*/ 209550 h 1114425"/>
              <a:gd name="connsiteX22" fmla="*/ 933450 w 1260475"/>
              <a:gd name="connsiteY22" fmla="*/ 203200 h 1114425"/>
              <a:gd name="connsiteX23" fmla="*/ 958850 w 1260475"/>
              <a:gd name="connsiteY23" fmla="*/ 349250 h 1114425"/>
              <a:gd name="connsiteX24" fmla="*/ 971550 w 1260475"/>
              <a:gd name="connsiteY24" fmla="*/ 469900 h 1114425"/>
              <a:gd name="connsiteX25" fmla="*/ 981075 w 1260475"/>
              <a:gd name="connsiteY25" fmla="*/ 596900 h 1114425"/>
              <a:gd name="connsiteX26" fmla="*/ 1000125 w 1260475"/>
              <a:gd name="connsiteY26" fmla="*/ 717550 h 1114425"/>
              <a:gd name="connsiteX27" fmla="*/ 1025525 w 1260475"/>
              <a:gd name="connsiteY27" fmla="*/ 825500 h 1114425"/>
              <a:gd name="connsiteX28" fmla="*/ 1031875 w 1260475"/>
              <a:gd name="connsiteY28" fmla="*/ 914400 h 1114425"/>
              <a:gd name="connsiteX29" fmla="*/ 1050925 w 1260475"/>
              <a:gd name="connsiteY29" fmla="*/ 1003300 h 1114425"/>
              <a:gd name="connsiteX30" fmla="*/ 1092200 w 1260475"/>
              <a:gd name="connsiteY30" fmla="*/ 1069975 h 1114425"/>
              <a:gd name="connsiteX31" fmla="*/ 1111250 w 1260475"/>
              <a:gd name="connsiteY31" fmla="*/ 1095375 h 1114425"/>
              <a:gd name="connsiteX32" fmla="*/ 1165225 w 1260475"/>
              <a:gd name="connsiteY32" fmla="*/ 1114425 h 1114425"/>
              <a:gd name="connsiteX33" fmla="*/ 1260475 w 1260475"/>
              <a:gd name="connsiteY33" fmla="*/ 1114425 h 11144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Lst>
            <a:rect l="l" t="t" r="r" b="b"/>
            <a:pathLst>
              <a:path w="1260475" h="1114425">
                <a:moveTo>
                  <a:pt x="0" y="1108075"/>
                </a:moveTo>
                <a:lnTo>
                  <a:pt x="431800" y="1114425"/>
                </a:lnTo>
                <a:lnTo>
                  <a:pt x="476250" y="1101725"/>
                </a:lnTo>
                <a:lnTo>
                  <a:pt x="514350" y="1098550"/>
                </a:lnTo>
                <a:lnTo>
                  <a:pt x="549275" y="1085850"/>
                </a:lnTo>
                <a:lnTo>
                  <a:pt x="593725" y="1085850"/>
                </a:lnTo>
                <a:lnTo>
                  <a:pt x="631825" y="1066800"/>
                </a:lnTo>
                <a:lnTo>
                  <a:pt x="676275" y="1012825"/>
                </a:lnTo>
                <a:lnTo>
                  <a:pt x="720725" y="901700"/>
                </a:lnTo>
                <a:lnTo>
                  <a:pt x="739775" y="803275"/>
                </a:lnTo>
                <a:lnTo>
                  <a:pt x="758825" y="768350"/>
                </a:lnTo>
                <a:lnTo>
                  <a:pt x="774700" y="625475"/>
                </a:lnTo>
                <a:lnTo>
                  <a:pt x="781050" y="546100"/>
                </a:lnTo>
                <a:lnTo>
                  <a:pt x="793750" y="501650"/>
                </a:lnTo>
                <a:lnTo>
                  <a:pt x="803275" y="406400"/>
                </a:lnTo>
                <a:lnTo>
                  <a:pt x="812800" y="339725"/>
                </a:lnTo>
                <a:lnTo>
                  <a:pt x="838200" y="292100"/>
                </a:lnTo>
                <a:lnTo>
                  <a:pt x="850900" y="130175"/>
                </a:lnTo>
                <a:lnTo>
                  <a:pt x="857250" y="98425"/>
                </a:lnTo>
                <a:lnTo>
                  <a:pt x="876300" y="88900"/>
                </a:lnTo>
                <a:lnTo>
                  <a:pt x="882650" y="0"/>
                </a:lnTo>
                <a:lnTo>
                  <a:pt x="911225" y="209550"/>
                </a:lnTo>
                <a:lnTo>
                  <a:pt x="933450" y="203200"/>
                </a:lnTo>
                <a:lnTo>
                  <a:pt x="958850" y="349250"/>
                </a:lnTo>
                <a:lnTo>
                  <a:pt x="971550" y="469900"/>
                </a:lnTo>
                <a:lnTo>
                  <a:pt x="981075" y="596900"/>
                </a:lnTo>
                <a:lnTo>
                  <a:pt x="1000125" y="717550"/>
                </a:lnTo>
                <a:lnTo>
                  <a:pt x="1025525" y="825500"/>
                </a:lnTo>
                <a:lnTo>
                  <a:pt x="1031875" y="914400"/>
                </a:lnTo>
                <a:lnTo>
                  <a:pt x="1050925" y="1003300"/>
                </a:lnTo>
                <a:lnTo>
                  <a:pt x="1092200" y="1069975"/>
                </a:lnTo>
                <a:lnTo>
                  <a:pt x="1111250" y="1095375"/>
                </a:lnTo>
                <a:lnTo>
                  <a:pt x="1165225" y="1114425"/>
                </a:lnTo>
                <a:lnTo>
                  <a:pt x="1260475" y="111442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50" name="正方形/長方形 49">
            <a:extLst>
              <a:ext uri="{FF2B5EF4-FFF2-40B4-BE49-F238E27FC236}">
                <a16:creationId xmlns:a16="http://schemas.microsoft.com/office/drawing/2014/main" id="{5746AB51-6C79-7A45-8B78-B4DE5B7EA9B5}"/>
              </a:ext>
            </a:extLst>
          </p:cNvPr>
          <p:cNvSpPr/>
          <p:nvPr/>
        </p:nvSpPr>
        <p:spPr>
          <a:xfrm>
            <a:off x="4473199" y="3159316"/>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cxnSp>
        <p:nvCxnSpPr>
          <p:cNvPr id="51" name="直線矢印コネクタ 50">
            <a:extLst>
              <a:ext uri="{FF2B5EF4-FFF2-40B4-BE49-F238E27FC236}">
                <a16:creationId xmlns:a16="http://schemas.microsoft.com/office/drawing/2014/main" id="{77E01DEB-5E03-D147-A68B-65CFAABAC4FD}"/>
              </a:ext>
            </a:extLst>
          </p:cNvPr>
          <p:cNvCxnSpPr>
            <a:cxnSpLocks/>
          </p:cNvCxnSpPr>
          <p:nvPr/>
        </p:nvCxnSpPr>
        <p:spPr>
          <a:xfrm>
            <a:off x="4777126" y="1505732"/>
            <a:ext cx="667730" cy="0"/>
          </a:xfrm>
          <a:prstGeom prst="straightConnector1">
            <a:avLst/>
          </a:prstGeom>
          <a:ln w="12700">
            <a:solidFill>
              <a:schemeClr val="tx1"/>
            </a:solidFill>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52" name="直線矢印コネクタ 51">
            <a:extLst>
              <a:ext uri="{FF2B5EF4-FFF2-40B4-BE49-F238E27FC236}">
                <a16:creationId xmlns:a16="http://schemas.microsoft.com/office/drawing/2014/main" id="{EB225B1E-E932-5B43-8A7C-3B7C3F1E1F46}"/>
              </a:ext>
            </a:extLst>
          </p:cNvPr>
          <p:cNvCxnSpPr/>
          <p:nvPr/>
        </p:nvCxnSpPr>
        <p:spPr>
          <a:xfrm>
            <a:off x="4777126" y="1768374"/>
            <a:ext cx="667730" cy="0"/>
          </a:xfrm>
          <a:prstGeom prst="straightConnector1">
            <a:avLst/>
          </a:prstGeom>
          <a:ln w="12700">
            <a:solidFill>
              <a:schemeClr val="tx1"/>
            </a:solidFill>
            <a:prstDash val="sysDash"/>
            <a:headEnd type="none" w="med" len="med"/>
            <a:tailEnd type="none" w="med" len="med"/>
          </a:ln>
        </p:spPr>
        <p:style>
          <a:lnRef idx="1">
            <a:schemeClr val="dk1"/>
          </a:lnRef>
          <a:fillRef idx="0">
            <a:schemeClr val="dk1"/>
          </a:fillRef>
          <a:effectRef idx="0">
            <a:schemeClr val="dk1"/>
          </a:effectRef>
          <a:fontRef idx="minor">
            <a:schemeClr val="tx1"/>
          </a:fontRef>
        </p:style>
      </p:cxnSp>
      <p:sp>
        <p:nvSpPr>
          <p:cNvPr id="53" name="TextBox 15">
            <a:extLst>
              <a:ext uri="{FF2B5EF4-FFF2-40B4-BE49-F238E27FC236}">
                <a16:creationId xmlns:a16="http://schemas.microsoft.com/office/drawing/2014/main" id="{C4951592-8559-DD4A-85DA-B985E1971293}"/>
              </a:ext>
            </a:extLst>
          </p:cNvPr>
          <p:cNvSpPr txBox="1"/>
          <p:nvPr/>
        </p:nvSpPr>
        <p:spPr>
          <a:xfrm>
            <a:off x="5488371" y="1351845"/>
            <a:ext cx="1900474"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nti-CD26 antibody</a:t>
            </a:r>
            <a:endPar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54" name="TextBox 15">
            <a:extLst>
              <a:ext uri="{FF2B5EF4-FFF2-40B4-BE49-F238E27FC236}">
                <a16:creationId xmlns:a16="http://schemas.microsoft.com/office/drawing/2014/main" id="{65E63DB1-B7D2-154C-83FA-01F2C255469C}"/>
              </a:ext>
            </a:extLst>
          </p:cNvPr>
          <p:cNvSpPr txBox="1"/>
          <p:nvPr/>
        </p:nvSpPr>
        <p:spPr>
          <a:xfrm>
            <a:off x="5488372" y="1614487"/>
            <a:ext cx="1510168"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Isotype control</a:t>
            </a:r>
            <a:endParaRPr kumimoji="0" lang="en-US" sz="14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endParaRPr>
          </a:p>
        </p:txBody>
      </p:sp>
      <p:sp>
        <p:nvSpPr>
          <p:cNvPr id="55" name="フリーフォーム 54">
            <a:extLst>
              <a:ext uri="{FF2B5EF4-FFF2-40B4-BE49-F238E27FC236}">
                <a16:creationId xmlns:a16="http://schemas.microsoft.com/office/drawing/2014/main" id="{D782205F-F7C4-1644-8251-69BD7AA34DA3}"/>
              </a:ext>
            </a:extLst>
          </p:cNvPr>
          <p:cNvSpPr/>
          <p:nvPr/>
        </p:nvSpPr>
        <p:spPr>
          <a:xfrm>
            <a:off x="6146220" y="3205781"/>
            <a:ext cx="1263650" cy="1209675"/>
          </a:xfrm>
          <a:custGeom>
            <a:avLst/>
            <a:gdLst>
              <a:gd name="connsiteX0" fmla="*/ 0 w 1263650"/>
              <a:gd name="connsiteY0" fmla="*/ 1209675 h 1209675"/>
              <a:gd name="connsiteX1" fmla="*/ 209550 w 1263650"/>
              <a:gd name="connsiteY1" fmla="*/ 1209675 h 1209675"/>
              <a:gd name="connsiteX2" fmla="*/ 219075 w 1263650"/>
              <a:gd name="connsiteY2" fmla="*/ 1200150 h 1209675"/>
              <a:gd name="connsiteX3" fmla="*/ 225425 w 1263650"/>
              <a:gd name="connsiteY3" fmla="*/ 1206500 h 1209675"/>
              <a:gd name="connsiteX4" fmla="*/ 238125 w 1263650"/>
              <a:gd name="connsiteY4" fmla="*/ 1181100 h 1209675"/>
              <a:gd name="connsiteX5" fmla="*/ 250825 w 1263650"/>
              <a:gd name="connsiteY5" fmla="*/ 1143000 h 1209675"/>
              <a:gd name="connsiteX6" fmla="*/ 254000 w 1263650"/>
              <a:gd name="connsiteY6" fmla="*/ 1085850 h 1209675"/>
              <a:gd name="connsiteX7" fmla="*/ 263525 w 1263650"/>
              <a:gd name="connsiteY7" fmla="*/ 1050925 h 1209675"/>
              <a:gd name="connsiteX8" fmla="*/ 269875 w 1263650"/>
              <a:gd name="connsiteY8" fmla="*/ 1003300 h 1209675"/>
              <a:gd name="connsiteX9" fmla="*/ 276225 w 1263650"/>
              <a:gd name="connsiteY9" fmla="*/ 904875 h 1209675"/>
              <a:gd name="connsiteX10" fmla="*/ 279400 w 1263650"/>
              <a:gd name="connsiteY10" fmla="*/ 793750 h 1209675"/>
              <a:gd name="connsiteX11" fmla="*/ 279400 w 1263650"/>
              <a:gd name="connsiteY11" fmla="*/ 793750 h 1209675"/>
              <a:gd name="connsiteX12" fmla="*/ 285750 w 1263650"/>
              <a:gd name="connsiteY12" fmla="*/ 765175 h 1209675"/>
              <a:gd name="connsiteX13" fmla="*/ 285750 w 1263650"/>
              <a:gd name="connsiteY13" fmla="*/ 650875 h 1209675"/>
              <a:gd name="connsiteX14" fmla="*/ 292100 w 1263650"/>
              <a:gd name="connsiteY14" fmla="*/ 558800 h 1209675"/>
              <a:gd name="connsiteX15" fmla="*/ 295275 w 1263650"/>
              <a:gd name="connsiteY15" fmla="*/ 587375 h 1209675"/>
              <a:gd name="connsiteX16" fmla="*/ 301625 w 1263650"/>
              <a:gd name="connsiteY16" fmla="*/ 415925 h 1209675"/>
              <a:gd name="connsiteX17" fmla="*/ 304800 w 1263650"/>
              <a:gd name="connsiteY17" fmla="*/ 209550 h 1209675"/>
              <a:gd name="connsiteX18" fmla="*/ 304800 w 1263650"/>
              <a:gd name="connsiteY18" fmla="*/ 180975 h 1209675"/>
              <a:gd name="connsiteX19" fmla="*/ 320675 w 1263650"/>
              <a:gd name="connsiteY19" fmla="*/ 120650 h 1209675"/>
              <a:gd name="connsiteX20" fmla="*/ 327025 w 1263650"/>
              <a:gd name="connsiteY20" fmla="*/ 0 h 1209675"/>
              <a:gd name="connsiteX21" fmla="*/ 333375 w 1263650"/>
              <a:gd name="connsiteY21" fmla="*/ 142875 h 1209675"/>
              <a:gd name="connsiteX22" fmla="*/ 342900 w 1263650"/>
              <a:gd name="connsiteY22" fmla="*/ 53975 h 1209675"/>
              <a:gd name="connsiteX23" fmla="*/ 349250 w 1263650"/>
              <a:gd name="connsiteY23" fmla="*/ 161925 h 1209675"/>
              <a:gd name="connsiteX24" fmla="*/ 352425 w 1263650"/>
              <a:gd name="connsiteY24" fmla="*/ 184150 h 1209675"/>
              <a:gd name="connsiteX25" fmla="*/ 361950 w 1263650"/>
              <a:gd name="connsiteY25" fmla="*/ 165100 h 1209675"/>
              <a:gd name="connsiteX26" fmla="*/ 361950 w 1263650"/>
              <a:gd name="connsiteY26" fmla="*/ 273050 h 1209675"/>
              <a:gd name="connsiteX27" fmla="*/ 365125 w 1263650"/>
              <a:gd name="connsiteY27" fmla="*/ 384175 h 1209675"/>
              <a:gd name="connsiteX28" fmla="*/ 371475 w 1263650"/>
              <a:gd name="connsiteY28" fmla="*/ 530225 h 1209675"/>
              <a:gd name="connsiteX29" fmla="*/ 377825 w 1263650"/>
              <a:gd name="connsiteY29" fmla="*/ 647700 h 1209675"/>
              <a:gd name="connsiteX30" fmla="*/ 381000 w 1263650"/>
              <a:gd name="connsiteY30" fmla="*/ 762000 h 1209675"/>
              <a:gd name="connsiteX31" fmla="*/ 384175 w 1263650"/>
              <a:gd name="connsiteY31" fmla="*/ 746125 h 1209675"/>
              <a:gd name="connsiteX32" fmla="*/ 390525 w 1263650"/>
              <a:gd name="connsiteY32" fmla="*/ 879475 h 1209675"/>
              <a:gd name="connsiteX33" fmla="*/ 393700 w 1263650"/>
              <a:gd name="connsiteY33" fmla="*/ 873125 h 1209675"/>
              <a:gd name="connsiteX34" fmla="*/ 396875 w 1263650"/>
              <a:gd name="connsiteY34" fmla="*/ 965200 h 1209675"/>
              <a:gd name="connsiteX35" fmla="*/ 409575 w 1263650"/>
              <a:gd name="connsiteY35" fmla="*/ 1035050 h 1209675"/>
              <a:gd name="connsiteX36" fmla="*/ 409575 w 1263650"/>
              <a:gd name="connsiteY36" fmla="*/ 1079500 h 1209675"/>
              <a:gd name="connsiteX37" fmla="*/ 422275 w 1263650"/>
              <a:gd name="connsiteY37" fmla="*/ 1104900 h 1209675"/>
              <a:gd name="connsiteX38" fmla="*/ 428625 w 1263650"/>
              <a:gd name="connsiteY38" fmla="*/ 1136650 h 1209675"/>
              <a:gd name="connsiteX39" fmla="*/ 454025 w 1263650"/>
              <a:gd name="connsiteY39" fmla="*/ 1206500 h 1209675"/>
              <a:gd name="connsiteX40" fmla="*/ 1263650 w 1263650"/>
              <a:gd name="connsiteY40" fmla="*/ 1206500 h 1209675"/>
              <a:gd name="connsiteX41" fmla="*/ 1263650 w 1263650"/>
              <a:gd name="connsiteY41" fmla="*/ 1209675 h 1209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Lst>
            <a:rect l="l" t="t" r="r" b="b"/>
            <a:pathLst>
              <a:path w="1263650" h="1209675">
                <a:moveTo>
                  <a:pt x="0" y="1209675"/>
                </a:moveTo>
                <a:lnTo>
                  <a:pt x="209550" y="1209675"/>
                </a:lnTo>
                <a:lnTo>
                  <a:pt x="219075" y="1200150"/>
                </a:lnTo>
                <a:lnTo>
                  <a:pt x="225425" y="1206500"/>
                </a:lnTo>
                <a:lnTo>
                  <a:pt x="238125" y="1181100"/>
                </a:lnTo>
                <a:lnTo>
                  <a:pt x="250825" y="1143000"/>
                </a:lnTo>
                <a:lnTo>
                  <a:pt x="254000" y="1085850"/>
                </a:lnTo>
                <a:lnTo>
                  <a:pt x="263525" y="1050925"/>
                </a:lnTo>
                <a:lnTo>
                  <a:pt x="269875" y="1003300"/>
                </a:lnTo>
                <a:lnTo>
                  <a:pt x="276225" y="904875"/>
                </a:lnTo>
                <a:cubicBezTo>
                  <a:pt x="277283" y="867833"/>
                  <a:pt x="278342" y="830792"/>
                  <a:pt x="279400" y="793750"/>
                </a:cubicBezTo>
                <a:lnTo>
                  <a:pt x="279400" y="793750"/>
                </a:lnTo>
                <a:lnTo>
                  <a:pt x="285750" y="765175"/>
                </a:lnTo>
                <a:lnTo>
                  <a:pt x="285750" y="650875"/>
                </a:lnTo>
                <a:lnTo>
                  <a:pt x="292100" y="558800"/>
                </a:lnTo>
                <a:lnTo>
                  <a:pt x="295275" y="587375"/>
                </a:lnTo>
                <a:lnTo>
                  <a:pt x="301625" y="415925"/>
                </a:lnTo>
                <a:cubicBezTo>
                  <a:pt x="302683" y="347133"/>
                  <a:pt x="303742" y="278342"/>
                  <a:pt x="304800" y="209550"/>
                </a:cubicBezTo>
                <a:lnTo>
                  <a:pt x="304800" y="180975"/>
                </a:lnTo>
                <a:lnTo>
                  <a:pt x="320675" y="120650"/>
                </a:lnTo>
                <a:lnTo>
                  <a:pt x="327025" y="0"/>
                </a:lnTo>
                <a:lnTo>
                  <a:pt x="333375" y="142875"/>
                </a:lnTo>
                <a:lnTo>
                  <a:pt x="342900" y="53975"/>
                </a:lnTo>
                <a:lnTo>
                  <a:pt x="349250" y="161925"/>
                </a:lnTo>
                <a:lnTo>
                  <a:pt x="352425" y="184150"/>
                </a:lnTo>
                <a:lnTo>
                  <a:pt x="361950" y="165100"/>
                </a:lnTo>
                <a:lnTo>
                  <a:pt x="361950" y="273050"/>
                </a:lnTo>
                <a:cubicBezTo>
                  <a:pt x="363008" y="310092"/>
                  <a:pt x="364067" y="347133"/>
                  <a:pt x="365125" y="384175"/>
                </a:cubicBezTo>
                <a:lnTo>
                  <a:pt x="371475" y="530225"/>
                </a:lnTo>
                <a:lnTo>
                  <a:pt x="377825" y="647700"/>
                </a:lnTo>
                <a:cubicBezTo>
                  <a:pt x="378883" y="685800"/>
                  <a:pt x="379942" y="723900"/>
                  <a:pt x="381000" y="762000"/>
                </a:cubicBezTo>
                <a:lnTo>
                  <a:pt x="384175" y="746125"/>
                </a:lnTo>
                <a:lnTo>
                  <a:pt x="390525" y="879475"/>
                </a:lnTo>
                <a:lnTo>
                  <a:pt x="393700" y="873125"/>
                </a:lnTo>
                <a:lnTo>
                  <a:pt x="396875" y="965200"/>
                </a:lnTo>
                <a:lnTo>
                  <a:pt x="409575" y="1035050"/>
                </a:lnTo>
                <a:lnTo>
                  <a:pt x="409575" y="1079500"/>
                </a:lnTo>
                <a:lnTo>
                  <a:pt x="422275" y="1104900"/>
                </a:lnTo>
                <a:lnTo>
                  <a:pt x="428625" y="1136650"/>
                </a:lnTo>
                <a:lnTo>
                  <a:pt x="454025" y="1206500"/>
                </a:lnTo>
                <a:lnTo>
                  <a:pt x="1263650" y="1206500"/>
                </a:lnTo>
                <a:lnTo>
                  <a:pt x="1263650" y="1209675"/>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56" name="フリーフォーム 55">
            <a:extLst>
              <a:ext uri="{FF2B5EF4-FFF2-40B4-BE49-F238E27FC236}">
                <a16:creationId xmlns:a16="http://schemas.microsoft.com/office/drawing/2014/main" id="{C10286EF-5ACF-2B45-BE5A-F6F5E0A169A8}"/>
              </a:ext>
            </a:extLst>
          </p:cNvPr>
          <p:cNvSpPr/>
          <p:nvPr/>
        </p:nvSpPr>
        <p:spPr>
          <a:xfrm>
            <a:off x="6143045" y="3580432"/>
            <a:ext cx="1266825" cy="828675"/>
          </a:xfrm>
          <a:custGeom>
            <a:avLst/>
            <a:gdLst>
              <a:gd name="connsiteX0" fmla="*/ 0 w 1266825"/>
              <a:gd name="connsiteY0" fmla="*/ 828675 h 828675"/>
              <a:gd name="connsiteX1" fmla="*/ 666750 w 1266825"/>
              <a:gd name="connsiteY1" fmla="*/ 828675 h 828675"/>
              <a:gd name="connsiteX2" fmla="*/ 682625 w 1266825"/>
              <a:gd name="connsiteY2" fmla="*/ 825500 h 828675"/>
              <a:gd name="connsiteX3" fmla="*/ 711200 w 1266825"/>
              <a:gd name="connsiteY3" fmla="*/ 809625 h 828675"/>
              <a:gd name="connsiteX4" fmla="*/ 730250 w 1266825"/>
              <a:gd name="connsiteY4" fmla="*/ 787400 h 828675"/>
              <a:gd name="connsiteX5" fmla="*/ 755650 w 1266825"/>
              <a:gd name="connsiteY5" fmla="*/ 730250 h 828675"/>
              <a:gd name="connsiteX6" fmla="*/ 777875 w 1266825"/>
              <a:gd name="connsiteY6" fmla="*/ 673100 h 828675"/>
              <a:gd name="connsiteX7" fmla="*/ 777875 w 1266825"/>
              <a:gd name="connsiteY7" fmla="*/ 619125 h 828675"/>
              <a:gd name="connsiteX8" fmla="*/ 793750 w 1266825"/>
              <a:gd name="connsiteY8" fmla="*/ 523875 h 828675"/>
              <a:gd name="connsiteX9" fmla="*/ 803275 w 1266825"/>
              <a:gd name="connsiteY9" fmla="*/ 612775 h 828675"/>
              <a:gd name="connsiteX10" fmla="*/ 815975 w 1266825"/>
              <a:gd name="connsiteY10" fmla="*/ 463550 h 828675"/>
              <a:gd name="connsiteX11" fmla="*/ 822325 w 1266825"/>
              <a:gd name="connsiteY11" fmla="*/ 422275 h 828675"/>
              <a:gd name="connsiteX12" fmla="*/ 828675 w 1266825"/>
              <a:gd name="connsiteY12" fmla="*/ 457200 h 828675"/>
              <a:gd name="connsiteX13" fmla="*/ 838200 w 1266825"/>
              <a:gd name="connsiteY13" fmla="*/ 333375 h 828675"/>
              <a:gd name="connsiteX14" fmla="*/ 838200 w 1266825"/>
              <a:gd name="connsiteY14" fmla="*/ 219075 h 828675"/>
              <a:gd name="connsiteX15" fmla="*/ 850900 w 1266825"/>
              <a:gd name="connsiteY15" fmla="*/ 180975 h 828675"/>
              <a:gd name="connsiteX16" fmla="*/ 860425 w 1266825"/>
              <a:gd name="connsiteY16" fmla="*/ 152400 h 828675"/>
              <a:gd name="connsiteX17" fmla="*/ 885825 w 1266825"/>
              <a:gd name="connsiteY17" fmla="*/ 133350 h 828675"/>
              <a:gd name="connsiteX18" fmla="*/ 892175 w 1266825"/>
              <a:gd name="connsiteY18" fmla="*/ 0 h 828675"/>
              <a:gd name="connsiteX19" fmla="*/ 901700 w 1266825"/>
              <a:gd name="connsiteY19" fmla="*/ 76200 h 828675"/>
              <a:gd name="connsiteX20" fmla="*/ 908050 w 1266825"/>
              <a:gd name="connsiteY20" fmla="*/ 117475 h 828675"/>
              <a:gd name="connsiteX21" fmla="*/ 908050 w 1266825"/>
              <a:gd name="connsiteY21" fmla="*/ 155575 h 828675"/>
              <a:gd name="connsiteX22" fmla="*/ 923925 w 1266825"/>
              <a:gd name="connsiteY22" fmla="*/ 187325 h 828675"/>
              <a:gd name="connsiteX23" fmla="*/ 927100 w 1266825"/>
              <a:gd name="connsiteY23" fmla="*/ 228600 h 828675"/>
              <a:gd name="connsiteX24" fmla="*/ 936625 w 1266825"/>
              <a:gd name="connsiteY24" fmla="*/ 260350 h 828675"/>
              <a:gd name="connsiteX25" fmla="*/ 939800 w 1266825"/>
              <a:gd name="connsiteY25" fmla="*/ 368300 h 828675"/>
              <a:gd name="connsiteX26" fmla="*/ 946150 w 1266825"/>
              <a:gd name="connsiteY26" fmla="*/ 323850 h 828675"/>
              <a:gd name="connsiteX27" fmla="*/ 955675 w 1266825"/>
              <a:gd name="connsiteY27" fmla="*/ 517525 h 828675"/>
              <a:gd name="connsiteX28" fmla="*/ 965200 w 1266825"/>
              <a:gd name="connsiteY28" fmla="*/ 517525 h 828675"/>
              <a:gd name="connsiteX29" fmla="*/ 974725 w 1266825"/>
              <a:gd name="connsiteY29" fmla="*/ 565150 h 828675"/>
              <a:gd name="connsiteX30" fmla="*/ 984250 w 1266825"/>
              <a:gd name="connsiteY30" fmla="*/ 593725 h 828675"/>
              <a:gd name="connsiteX31" fmla="*/ 993775 w 1266825"/>
              <a:gd name="connsiteY31" fmla="*/ 657225 h 828675"/>
              <a:gd name="connsiteX32" fmla="*/ 1003300 w 1266825"/>
              <a:gd name="connsiteY32" fmla="*/ 698500 h 828675"/>
              <a:gd name="connsiteX33" fmla="*/ 1025525 w 1266825"/>
              <a:gd name="connsiteY33" fmla="*/ 752475 h 828675"/>
              <a:gd name="connsiteX34" fmla="*/ 1041400 w 1266825"/>
              <a:gd name="connsiteY34" fmla="*/ 762000 h 828675"/>
              <a:gd name="connsiteX35" fmla="*/ 1060450 w 1266825"/>
              <a:gd name="connsiteY35" fmla="*/ 787400 h 828675"/>
              <a:gd name="connsiteX36" fmla="*/ 1076325 w 1266825"/>
              <a:gd name="connsiteY36" fmla="*/ 815975 h 828675"/>
              <a:gd name="connsiteX37" fmla="*/ 1104900 w 1266825"/>
              <a:gd name="connsiteY37" fmla="*/ 828675 h 828675"/>
              <a:gd name="connsiteX38" fmla="*/ 1266825 w 1266825"/>
              <a:gd name="connsiteY38" fmla="*/ 828675 h 828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Lst>
            <a:rect l="l" t="t" r="r" b="b"/>
            <a:pathLst>
              <a:path w="1266825" h="828675">
                <a:moveTo>
                  <a:pt x="0" y="828675"/>
                </a:moveTo>
                <a:lnTo>
                  <a:pt x="666750" y="828675"/>
                </a:lnTo>
                <a:lnTo>
                  <a:pt x="682625" y="825500"/>
                </a:lnTo>
                <a:lnTo>
                  <a:pt x="711200" y="809625"/>
                </a:lnTo>
                <a:lnTo>
                  <a:pt x="730250" y="787400"/>
                </a:lnTo>
                <a:lnTo>
                  <a:pt x="755650" y="730250"/>
                </a:lnTo>
                <a:lnTo>
                  <a:pt x="777875" y="673100"/>
                </a:lnTo>
                <a:lnTo>
                  <a:pt x="777875" y="619125"/>
                </a:lnTo>
                <a:lnTo>
                  <a:pt x="793750" y="523875"/>
                </a:lnTo>
                <a:lnTo>
                  <a:pt x="803275" y="612775"/>
                </a:lnTo>
                <a:lnTo>
                  <a:pt x="815975" y="463550"/>
                </a:lnTo>
                <a:lnTo>
                  <a:pt x="822325" y="422275"/>
                </a:lnTo>
                <a:lnTo>
                  <a:pt x="828675" y="457200"/>
                </a:lnTo>
                <a:lnTo>
                  <a:pt x="838200" y="333375"/>
                </a:lnTo>
                <a:lnTo>
                  <a:pt x="838200" y="219075"/>
                </a:lnTo>
                <a:lnTo>
                  <a:pt x="850900" y="180975"/>
                </a:lnTo>
                <a:lnTo>
                  <a:pt x="860425" y="152400"/>
                </a:lnTo>
                <a:lnTo>
                  <a:pt x="885825" y="133350"/>
                </a:lnTo>
                <a:lnTo>
                  <a:pt x="892175" y="0"/>
                </a:lnTo>
                <a:lnTo>
                  <a:pt x="901700" y="76200"/>
                </a:lnTo>
                <a:lnTo>
                  <a:pt x="908050" y="117475"/>
                </a:lnTo>
                <a:lnTo>
                  <a:pt x="908050" y="155575"/>
                </a:lnTo>
                <a:lnTo>
                  <a:pt x="923925" y="187325"/>
                </a:lnTo>
                <a:lnTo>
                  <a:pt x="927100" y="228600"/>
                </a:lnTo>
                <a:lnTo>
                  <a:pt x="936625" y="260350"/>
                </a:lnTo>
                <a:cubicBezTo>
                  <a:pt x="937683" y="296333"/>
                  <a:pt x="938742" y="332317"/>
                  <a:pt x="939800" y="368300"/>
                </a:cubicBezTo>
                <a:lnTo>
                  <a:pt x="946150" y="323850"/>
                </a:lnTo>
                <a:lnTo>
                  <a:pt x="955675" y="517525"/>
                </a:lnTo>
                <a:lnTo>
                  <a:pt x="965200" y="517525"/>
                </a:lnTo>
                <a:lnTo>
                  <a:pt x="974725" y="565150"/>
                </a:lnTo>
                <a:lnTo>
                  <a:pt x="984250" y="593725"/>
                </a:lnTo>
                <a:lnTo>
                  <a:pt x="993775" y="657225"/>
                </a:lnTo>
                <a:lnTo>
                  <a:pt x="1003300" y="698500"/>
                </a:lnTo>
                <a:lnTo>
                  <a:pt x="1025525" y="752475"/>
                </a:lnTo>
                <a:lnTo>
                  <a:pt x="1041400" y="762000"/>
                </a:lnTo>
                <a:lnTo>
                  <a:pt x="1060450" y="787400"/>
                </a:lnTo>
                <a:lnTo>
                  <a:pt x="1076325" y="815975"/>
                </a:lnTo>
                <a:lnTo>
                  <a:pt x="1104900" y="828675"/>
                </a:lnTo>
                <a:lnTo>
                  <a:pt x="1266825" y="82867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57" name="正方形/長方形 56">
            <a:extLst>
              <a:ext uri="{FF2B5EF4-FFF2-40B4-BE49-F238E27FC236}">
                <a16:creationId xmlns:a16="http://schemas.microsoft.com/office/drawing/2014/main" id="{2851033C-FD8A-8946-B585-9858E535589F}"/>
              </a:ext>
            </a:extLst>
          </p:cNvPr>
          <p:cNvSpPr/>
          <p:nvPr/>
        </p:nvSpPr>
        <p:spPr>
          <a:xfrm>
            <a:off x="6135640" y="3150989"/>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58" name="フリーフォーム 57">
            <a:extLst>
              <a:ext uri="{FF2B5EF4-FFF2-40B4-BE49-F238E27FC236}">
                <a16:creationId xmlns:a16="http://schemas.microsoft.com/office/drawing/2014/main" id="{2682A9C4-296B-C449-B2C4-9D1B98E20366}"/>
              </a:ext>
            </a:extLst>
          </p:cNvPr>
          <p:cNvSpPr/>
          <p:nvPr/>
        </p:nvSpPr>
        <p:spPr>
          <a:xfrm>
            <a:off x="7800395" y="3202606"/>
            <a:ext cx="1263650" cy="1212850"/>
          </a:xfrm>
          <a:custGeom>
            <a:avLst/>
            <a:gdLst>
              <a:gd name="connsiteX0" fmla="*/ 0 w 1263650"/>
              <a:gd name="connsiteY0" fmla="*/ 1206500 h 1212850"/>
              <a:gd name="connsiteX1" fmla="*/ 190500 w 1263650"/>
              <a:gd name="connsiteY1" fmla="*/ 1206500 h 1212850"/>
              <a:gd name="connsiteX2" fmla="*/ 200025 w 1263650"/>
              <a:gd name="connsiteY2" fmla="*/ 1171575 h 1212850"/>
              <a:gd name="connsiteX3" fmla="*/ 212725 w 1263650"/>
              <a:gd name="connsiteY3" fmla="*/ 1146175 h 1212850"/>
              <a:gd name="connsiteX4" fmla="*/ 215900 w 1263650"/>
              <a:gd name="connsiteY4" fmla="*/ 1076325 h 1212850"/>
              <a:gd name="connsiteX5" fmla="*/ 234950 w 1263650"/>
              <a:gd name="connsiteY5" fmla="*/ 1031875 h 1212850"/>
              <a:gd name="connsiteX6" fmla="*/ 241300 w 1263650"/>
              <a:gd name="connsiteY6" fmla="*/ 828675 h 1212850"/>
              <a:gd name="connsiteX7" fmla="*/ 247650 w 1263650"/>
              <a:gd name="connsiteY7" fmla="*/ 860425 h 1212850"/>
              <a:gd name="connsiteX8" fmla="*/ 257175 w 1263650"/>
              <a:gd name="connsiteY8" fmla="*/ 615950 h 1212850"/>
              <a:gd name="connsiteX9" fmla="*/ 260350 w 1263650"/>
              <a:gd name="connsiteY9" fmla="*/ 495300 h 1212850"/>
              <a:gd name="connsiteX10" fmla="*/ 273050 w 1263650"/>
              <a:gd name="connsiteY10" fmla="*/ 431800 h 1212850"/>
              <a:gd name="connsiteX11" fmla="*/ 279400 w 1263650"/>
              <a:gd name="connsiteY11" fmla="*/ 301625 h 1212850"/>
              <a:gd name="connsiteX12" fmla="*/ 285750 w 1263650"/>
              <a:gd name="connsiteY12" fmla="*/ 215900 h 1212850"/>
              <a:gd name="connsiteX13" fmla="*/ 285750 w 1263650"/>
              <a:gd name="connsiteY13" fmla="*/ 63500 h 1212850"/>
              <a:gd name="connsiteX14" fmla="*/ 285750 w 1263650"/>
              <a:gd name="connsiteY14" fmla="*/ 0 h 1212850"/>
              <a:gd name="connsiteX15" fmla="*/ 301625 w 1263650"/>
              <a:gd name="connsiteY15" fmla="*/ 25400 h 1212850"/>
              <a:gd name="connsiteX16" fmla="*/ 317500 w 1263650"/>
              <a:gd name="connsiteY16" fmla="*/ 38100 h 1212850"/>
              <a:gd name="connsiteX17" fmla="*/ 333375 w 1263650"/>
              <a:gd name="connsiteY17" fmla="*/ 136525 h 1212850"/>
              <a:gd name="connsiteX18" fmla="*/ 336550 w 1263650"/>
              <a:gd name="connsiteY18" fmla="*/ 101600 h 1212850"/>
              <a:gd name="connsiteX19" fmla="*/ 342900 w 1263650"/>
              <a:gd name="connsiteY19" fmla="*/ 327025 h 1212850"/>
              <a:gd name="connsiteX20" fmla="*/ 342900 w 1263650"/>
              <a:gd name="connsiteY20" fmla="*/ 431800 h 1212850"/>
              <a:gd name="connsiteX21" fmla="*/ 352425 w 1263650"/>
              <a:gd name="connsiteY21" fmla="*/ 498475 h 1212850"/>
              <a:gd name="connsiteX22" fmla="*/ 358775 w 1263650"/>
              <a:gd name="connsiteY22" fmla="*/ 600075 h 1212850"/>
              <a:gd name="connsiteX23" fmla="*/ 361950 w 1263650"/>
              <a:gd name="connsiteY23" fmla="*/ 720725 h 1212850"/>
              <a:gd name="connsiteX24" fmla="*/ 368300 w 1263650"/>
              <a:gd name="connsiteY24" fmla="*/ 663575 h 1212850"/>
              <a:gd name="connsiteX25" fmla="*/ 368300 w 1263650"/>
              <a:gd name="connsiteY25" fmla="*/ 831850 h 1212850"/>
              <a:gd name="connsiteX26" fmla="*/ 374650 w 1263650"/>
              <a:gd name="connsiteY26" fmla="*/ 914400 h 1212850"/>
              <a:gd name="connsiteX27" fmla="*/ 374650 w 1263650"/>
              <a:gd name="connsiteY27" fmla="*/ 914400 h 1212850"/>
              <a:gd name="connsiteX28" fmla="*/ 384175 w 1263650"/>
              <a:gd name="connsiteY28" fmla="*/ 1003300 h 1212850"/>
              <a:gd name="connsiteX29" fmla="*/ 396875 w 1263650"/>
              <a:gd name="connsiteY29" fmla="*/ 1089025 h 1212850"/>
              <a:gd name="connsiteX30" fmla="*/ 415925 w 1263650"/>
              <a:gd name="connsiteY30" fmla="*/ 1162050 h 1212850"/>
              <a:gd name="connsiteX31" fmla="*/ 428625 w 1263650"/>
              <a:gd name="connsiteY31" fmla="*/ 1184275 h 1212850"/>
              <a:gd name="connsiteX32" fmla="*/ 444500 w 1263650"/>
              <a:gd name="connsiteY32" fmla="*/ 1200150 h 1212850"/>
              <a:gd name="connsiteX33" fmla="*/ 457200 w 1263650"/>
              <a:gd name="connsiteY33" fmla="*/ 1212850 h 1212850"/>
              <a:gd name="connsiteX34" fmla="*/ 1263650 w 1263650"/>
              <a:gd name="connsiteY34" fmla="*/ 1212850 h 1212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263650" h="1212850">
                <a:moveTo>
                  <a:pt x="0" y="1206500"/>
                </a:moveTo>
                <a:lnTo>
                  <a:pt x="190500" y="1206500"/>
                </a:lnTo>
                <a:lnTo>
                  <a:pt x="200025" y="1171575"/>
                </a:lnTo>
                <a:lnTo>
                  <a:pt x="212725" y="1146175"/>
                </a:lnTo>
                <a:lnTo>
                  <a:pt x="215900" y="1076325"/>
                </a:lnTo>
                <a:lnTo>
                  <a:pt x="234950" y="1031875"/>
                </a:lnTo>
                <a:lnTo>
                  <a:pt x="241300" y="828675"/>
                </a:lnTo>
                <a:lnTo>
                  <a:pt x="247650" y="860425"/>
                </a:lnTo>
                <a:lnTo>
                  <a:pt x="257175" y="615950"/>
                </a:lnTo>
                <a:cubicBezTo>
                  <a:pt x="258233" y="575733"/>
                  <a:pt x="259292" y="535517"/>
                  <a:pt x="260350" y="495300"/>
                </a:cubicBezTo>
                <a:lnTo>
                  <a:pt x="273050" y="431800"/>
                </a:lnTo>
                <a:lnTo>
                  <a:pt x="279400" y="301625"/>
                </a:lnTo>
                <a:lnTo>
                  <a:pt x="285750" y="215900"/>
                </a:lnTo>
                <a:lnTo>
                  <a:pt x="285750" y="63500"/>
                </a:lnTo>
                <a:lnTo>
                  <a:pt x="285750" y="0"/>
                </a:lnTo>
                <a:lnTo>
                  <a:pt x="301625" y="25400"/>
                </a:lnTo>
                <a:lnTo>
                  <a:pt x="317500" y="38100"/>
                </a:lnTo>
                <a:lnTo>
                  <a:pt x="333375" y="136525"/>
                </a:lnTo>
                <a:lnTo>
                  <a:pt x="336550" y="101600"/>
                </a:lnTo>
                <a:lnTo>
                  <a:pt x="342900" y="327025"/>
                </a:lnTo>
                <a:lnTo>
                  <a:pt x="342900" y="431800"/>
                </a:lnTo>
                <a:lnTo>
                  <a:pt x="352425" y="498475"/>
                </a:lnTo>
                <a:lnTo>
                  <a:pt x="358775" y="600075"/>
                </a:lnTo>
                <a:cubicBezTo>
                  <a:pt x="359833" y="640292"/>
                  <a:pt x="360892" y="680508"/>
                  <a:pt x="361950" y="720725"/>
                </a:cubicBezTo>
                <a:lnTo>
                  <a:pt x="368300" y="663575"/>
                </a:lnTo>
                <a:lnTo>
                  <a:pt x="368300" y="831850"/>
                </a:lnTo>
                <a:lnTo>
                  <a:pt x="374650" y="914400"/>
                </a:lnTo>
                <a:lnTo>
                  <a:pt x="374650" y="914400"/>
                </a:lnTo>
                <a:lnTo>
                  <a:pt x="384175" y="1003300"/>
                </a:lnTo>
                <a:lnTo>
                  <a:pt x="396875" y="1089025"/>
                </a:lnTo>
                <a:lnTo>
                  <a:pt x="415925" y="1162050"/>
                </a:lnTo>
                <a:lnTo>
                  <a:pt x="428625" y="1184275"/>
                </a:lnTo>
                <a:lnTo>
                  <a:pt x="444500" y="1200150"/>
                </a:lnTo>
                <a:lnTo>
                  <a:pt x="457200" y="1212850"/>
                </a:lnTo>
                <a:lnTo>
                  <a:pt x="1263650" y="1212850"/>
                </a:lnTo>
              </a:path>
            </a:pathLst>
          </a:cu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59" name="フリーフォーム 58">
            <a:extLst>
              <a:ext uri="{FF2B5EF4-FFF2-40B4-BE49-F238E27FC236}">
                <a16:creationId xmlns:a16="http://schemas.microsoft.com/office/drawing/2014/main" id="{4F67A798-3450-DB41-9AAF-92AC687A6E4F}"/>
              </a:ext>
            </a:extLst>
          </p:cNvPr>
          <p:cNvSpPr/>
          <p:nvPr/>
        </p:nvSpPr>
        <p:spPr>
          <a:xfrm>
            <a:off x="7803570" y="3958256"/>
            <a:ext cx="1260475" cy="457200"/>
          </a:xfrm>
          <a:custGeom>
            <a:avLst/>
            <a:gdLst>
              <a:gd name="connsiteX0" fmla="*/ 0 w 1260475"/>
              <a:gd name="connsiteY0" fmla="*/ 450850 h 457200"/>
              <a:gd name="connsiteX1" fmla="*/ 203200 w 1260475"/>
              <a:gd name="connsiteY1" fmla="*/ 457200 h 457200"/>
              <a:gd name="connsiteX2" fmla="*/ 219075 w 1260475"/>
              <a:gd name="connsiteY2" fmla="*/ 438150 h 457200"/>
              <a:gd name="connsiteX3" fmla="*/ 231775 w 1260475"/>
              <a:gd name="connsiteY3" fmla="*/ 447675 h 457200"/>
              <a:gd name="connsiteX4" fmla="*/ 266700 w 1260475"/>
              <a:gd name="connsiteY4" fmla="*/ 438150 h 457200"/>
              <a:gd name="connsiteX5" fmla="*/ 276225 w 1260475"/>
              <a:gd name="connsiteY5" fmla="*/ 415925 h 457200"/>
              <a:gd name="connsiteX6" fmla="*/ 285750 w 1260475"/>
              <a:gd name="connsiteY6" fmla="*/ 374650 h 457200"/>
              <a:gd name="connsiteX7" fmla="*/ 288925 w 1260475"/>
              <a:gd name="connsiteY7" fmla="*/ 387350 h 457200"/>
              <a:gd name="connsiteX8" fmla="*/ 304800 w 1260475"/>
              <a:gd name="connsiteY8" fmla="*/ 368300 h 457200"/>
              <a:gd name="connsiteX9" fmla="*/ 317500 w 1260475"/>
              <a:gd name="connsiteY9" fmla="*/ 377825 h 457200"/>
              <a:gd name="connsiteX10" fmla="*/ 333375 w 1260475"/>
              <a:gd name="connsiteY10" fmla="*/ 352425 h 457200"/>
              <a:gd name="connsiteX11" fmla="*/ 349250 w 1260475"/>
              <a:gd name="connsiteY11" fmla="*/ 323850 h 457200"/>
              <a:gd name="connsiteX12" fmla="*/ 374650 w 1260475"/>
              <a:gd name="connsiteY12" fmla="*/ 304800 h 457200"/>
              <a:gd name="connsiteX13" fmla="*/ 381000 w 1260475"/>
              <a:gd name="connsiteY13" fmla="*/ 285750 h 457200"/>
              <a:gd name="connsiteX14" fmla="*/ 400050 w 1260475"/>
              <a:gd name="connsiteY14" fmla="*/ 266700 h 457200"/>
              <a:gd name="connsiteX15" fmla="*/ 419100 w 1260475"/>
              <a:gd name="connsiteY15" fmla="*/ 247650 h 457200"/>
              <a:gd name="connsiteX16" fmla="*/ 428625 w 1260475"/>
              <a:gd name="connsiteY16" fmla="*/ 241300 h 457200"/>
              <a:gd name="connsiteX17" fmla="*/ 434975 w 1260475"/>
              <a:gd name="connsiteY17" fmla="*/ 266700 h 457200"/>
              <a:gd name="connsiteX18" fmla="*/ 444500 w 1260475"/>
              <a:gd name="connsiteY18" fmla="*/ 228600 h 457200"/>
              <a:gd name="connsiteX19" fmla="*/ 460375 w 1260475"/>
              <a:gd name="connsiteY19" fmla="*/ 222250 h 457200"/>
              <a:gd name="connsiteX20" fmla="*/ 469900 w 1260475"/>
              <a:gd name="connsiteY20" fmla="*/ 190500 h 457200"/>
              <a:gd name="connsiteX21" fmla="*/ 482600 w 1260475"/>
              <a:gd name="connsiteY21" fmla="*/ 219075 h 457200"/>
              <a:gd name="connsiteX22" fmla="*/ 492125 w 1260475"/>
              <a:gd name="connsiteY22" fmla="*/ 158750 h 457200"/>
              <a:gd name="connsiteX23" fmla="*/ 501650 w 1260475"/>
              <a:gd name="connsiteY23" fmla="*/ 212725 h 457200"/>
              <a:gd name="connsiteX24" fmla="*/ 508000 w 1260475"/>
              <a:gd name="connsiteY24" fmla="*/ 149225 h 457200"/>
              <a:gd name="connsiteX25" fmla="*/ 514350 w 1260475"/>
              <a:gd name="connsiteY25" fmla="*/ 200025 h 457200"/>
              <a:gd name="connsiteX26" fmla="*/ 533400 w 1260475"/>
              <a:gd name="connsiteY26" fmla="*/ 152400 h 457200"/>
              <a:gd name="connsiteX27" fmla="*/ 555625 w 1260475"/>
              <a:gd name="connsiteY27" fmla="*/ 123825 h 457200"/>
              <a:gd name="connsiteX28" fmla="*/ 555625 w 1260475"/>
              <a:gd name="connsiteY28" fmla="*/ 28575 h 457200"/>
              <a:gd name="connsiteX29" fmla="*/ 568325 w 1260475"/>
              <a:gd name="connsiteY29" fmla="*/ 88900 h 457200"/>
              <a:gd name="connsiteX30" fmla="*/ 577850 w 1260475"/>
              <a:gd name="connsiteY30" fmla="*/ 44450 h 457200"/>
              <a:gd name="connsiteX31" fmla="*/ 593725 w 1260475"/>
              <a:gd name="connsiteY31" fmla="*/ 92075 h 457200"/>
              <a:gd name="connsiteX32" fmla="*/ 600075 w 1260475"/>
              <a:gd name="connsiteY32" fmla="*/ 0 h 457200"/>
              <a:gd name="connsiteX33" fmla="*/ 609600 w 1260475"/>
              <a:gd name="connsiteY33" fmla="*/ 73025 h 457200"/>
              <a:gd name="connsiteX34" fmla="*/ 625475 w 1260475"/>
              <a:gd name="connsiteY34" fmla="*/ 28575 h 457200"/>
              <a:gd name="connsiteX35" fmla="*/ 635000 w 1260475"/>
              <a:gd name="connsiteY35" fmla="*/ 101600 h 457200"/>
              <a:gd name="connsiteX36" fmla="*/ 644525 w 1260475"/>
              <a:gd name="connsiteY36" fmla="*/ 34925 h 457200"/>
              <a:gd name="connsiteX37" fmla="*/ 654050 w 1260475"/>
              <a:gd name="connsiteY37" fmla="*/ 127000 h 457200"/>
              <a:gd name="connsiteX38" fmla="*/ 669925 w 1260475"/>
              <a:gd name="connsiteY38" fmla="*/ 69850 h 457200"/>
              <a:gd name="connsiteX39" fmla="*/ 676275 w 1260475"/>
              <a:gd name="connsiteY39" fmla="*/ 155575 h 457200"/>
              <a:gd name="connsiteX40" fmla="*/ 688975 w 1260475"/>
              <a:gd name="connsiteY40" fmla="*/ 123825 h 457200"/>
              <a:gd name="connsiteX41" fmla="*/ 695325 w 1260475"/>
              <a:gd name="connsiteY41" fmla="*/ 180975 h 457200"/>
              <a:gd name="connsiteX42" fmla="*/ 708025 w 1260475"/>
              <a:gd name="connsiteY42" fmla="*/ 158750 h 457200"/>
              <a:gd name="connsiteX43" fmla="*/ 711200 w 1260475"/>
              <a:gd name="connsiteY43" fmla="*/ 203200 h 457200"/>
              <a:gd name="connsiteX44" fmla="*/ 717550 w 1260475"/>
              <a:gd name="connsiteY44" fmla="*/ 231775 h 457200"/>
              <a:gd name="connsiteX45" fmla="*/ 723900 w 1260475"/>
              <a:gd name="connsiteY45" fmla="*/ 269875 h 457200"/>
              <a:gd name="connsiteX46" fmla="*/ 733425 w 1260475"/>
              <a:gd name="connsiteY46" fmla="*/ 311150 h 457200"/>
              <a:gd name="connsiteX47" fmla="*/ 736600 w 1260475"/>
              <a:gd name="connsiteY47" fmla="*/ 276225 h 457200"/>
              <a:gd name="connsiteX48" fmla="*/ 746125 w 1260475"/>
              <a:gd name="connsiteY48" fmla="*/ 320675 h 457200"/>
              <a:gd name="connsiteX49" fmla="*/ 749300 w 1260475"/>
              <a:gd name="connsiteY49" fmla="*/ 317500 h 457200"/>
              <a:gd name="connsiteX50" fmla="*/ 762000 w 1260475"/>
              <a:gd name="connsiteY50" fmla="*/ 358775 h 457200"/>
              <a:gd name="connsiteX51" fmla="*/ 774700 w 1260475"/>
              <a:gd name="connsiteY51" fmla="*/ 333375 h 457200"/>
              <a:gd name="connsiteX52" fmla="*/ 777875 w 1260475"/>
              <a:gd name="connsiteY52" fmla="*/ 377825 h 457200"/>
              <a:gd name="connsiteX53" fmla="*/ 796925 w 1260475"/>
              <a:gd name="connsiteY53" fmla="*/ 400050 h 457200"/>
              <a:gd name="connsiteX54" fmla="*/ 812800 w 1260475"/>
              <a:gd name="connsiteY54" fmla="*/ 441325 h 457200"/>
              <a:gd name="connsiteX55" fmla="*/ 828675 w 1260475"/>
              <a:gd name="connsiteY55" fmla="*/ 457200 h 457200"/>
              <a:gd name="connsiteX56" fmla="*/ 1260475 w 1260475"/>
              <a:gd name="connsiteY56" fmla="*/ 454025 h 45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Lst>
            <a:rect l="l" t="t" r="r" b="b"/>
            <a:pathLst>
              <a:path w="1260475" h="457200">
                <a:moveTo>
                  <a:pt x="0" y="450850"/>
                </a:moveTo>
                <a:lnTo>
                  <a:pt x="203200" y="457200"/>
                </a:lnTo>
                <a:lnTo>
                  <a:pt x="219075" y="438150"/>
                </a:lnTo>
                <a:lnTo>
                  <a:pt x="231775" y="447675"/>
                </a:lnTo>
                <a:lnTo>
                  <a:pt x="266700" y="438150"/>
                </a:lnTo>
                <a:lnTo>
                  <a:pt x="276225" y="415925"/>
                </a:lnTo>
                <a:lnTo>
                  <a:pt x="285750" y="374650"/>
                </a:lnTo>
                <a:lnTo>
                  <a:pt x="288925" y="387350"/>
                </a:lnTo>
                <a:lnTo>
                  <a:pt x="304800" y="368300"/>
                </a:lnTo>
                <a:lnTo>
                  <a:pt x="317500" y="377825"/>
                </a:lnTo>
                <a:lnTo>
                  <a:pt x="333375" y="352425"/>
                </a:lnTo>
                <a:lnTo>
                  <a:pt x="349250" y="323850"/>
                </a:lnTo>
                <a:lnTo>
                  <a:pt x="374650" y="304800"/>
                </a:lnTo>
                <a:lnTo>
                  <a:pt x="381000" y="285750"/>
                </a:lnTo>
                <a:lnTo>
                  <a:pt x="400050" y="266700"/>
                </a:lnTo>
                <a:lnTo>
                  <a:pt x="419100" y="247650"/>
                </a:lnTo>
                <a:lnTo>
                  <a:pt x="428625" y="241300"/>
                </a:lnTo>
                <a:lnTo>
                  <a:pt x="434975" y="266700"/>
                </a:lnTo>
                <a:lnTo>
                  <a:pt x="444500" y="228600"/>
                </a:lnTo>
                <a:lnTo>
                  <a:pt x="460375" y="222250"/>
                </a:lnTo>
                <a:lnTo>
                  <a:pt x="469900" y="190500"/>
                </a:lnTo>
                <a:lnTo>
                  <a:pt x="482600" y="219075"/>
                </a:lnTo>
                <a:lnTo>
                  <a:pt x="492125" y="158750"/>
                </a:lnTo>
                <a:lnTo>
                  <a:pt x="501650" y="212725"/>
                </a:lnTo>
                <a:lnTo>
                  <a:pt x="508000" y="149225"/>
                </a:lnTo>
                <a:lnTo>
                  <a:pt x="514350" y="200025"/>
                </a:lnTo>
                <a:lnTo>
                  <a:pt x="533400" y="152400"/>
                </a:lnTo>
                <a:lnTo>
                  <a:pt x="555625" y="123825"/>
                </a:lnTo>
                <a:lnTo>
                  <a:pt x="555625" y="28575"/>
                </a:lnTo>
                <a:lnTo>
                  <a:pt x="568325" y="88900"/>
                </a:lnTo>
                <a:lnTo>
                  <a:pt x="577850" y="44450"/>
                </a:lnTo>
                <a:lnTo>
                  <a:pt x="593725" y="92075"/>
                </a:lnTo>
                <a:lnTo>
                  <a:pt x="600075" y="0"/>
                </a:lnTo>
                <a:lnTo>
                  <a:pt x="609600" y="73025"/>
                </a:lnTo>
                <a:lnTo>
                  <a:pt x="625475" y="28575"/>
                </a:lnTo>
                <a:lnTo>
                  <a:pt x="635000" y="101600"/>
                </a:lnTo>
                <a:lnTo>
                  <a:pt x="644525" y="34925"/>
                </a:lnTo>
                <a:lnTo>
                  <a:pt x="654050" y="127000"/>
                </a:lnTo>
                <a:lnTo>
                  <a:pt x="669925" y="69850"/>
                </a:lnTo>
                <a:lnTo>
                  <a:pt x="676275" y="155575"/>
                </a:lnTo>
                <a:lnTo>
                  <a:pt x="688975" y="123825"/>
                </a:lnTo>
                <a:lnTo>
                  <a:pt x="695325" y="180975"/>
                </a:lnTo>
                <a:lnTo>
                  <a:pt x="708025" y="158750"/>
                </a:lnTo>
                <a:lnTo>
                  <a:pt x="711200" y="203200"/>
                </a:lnTo>
                <a:lnTo>
                  <a:pt x="717550" y="231775"/>
                </a:lnTo>
                <a:lnTo>
                  <a:pt x="723900" y="269875"/>
                </a:lnTo>
                <a:lnTo>
                  <a:pt x="733425" y="311150"/>
                </a:lnTo>
                <a:lnTo>
                  <a:pt x="736600" y="276225"/>
                </a:lnTo>
                <a:lnTo>
                  <a:pt x="746125" y="320675"/>
                </a:lnTo>
                <a:lnTo>
                  <a:pt x="749300" y="317500"/>
                </a:lnTo>
                <a:lnTo>
                  <a:pt x="762000" y="358775"/>
                </a:lnTo>
                <a:lnTo>
                  <a:pt x="774700" y="333375"/>
                </a:lnTo>
                <a:lnTo>
                  <a:pt x="777875" y="377825"/>
                </a:lnTo>
                <a:lnTo>
                  <a:pt x="796925" y="400050"/>
                </a:lnTo>
                <a:lnTo>
                  <a:pt x="812800" y="441325"/>
                </a:lnTo>
                <a:lnTo>
                  <a:pt x="828675" y="457200"/>
                </a:lnTo>
                <a:lnTo>
                  <a:pt x="1260475" y="454025"/>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60" name="正方形/長方形 59">
            <a:extLst>
              <a:ext uri="{FF2B5EF4-FFF2-40B4-BE49-F238E27FC236}">
                <a16:creationId xmlns:a16="http://schemas.microsoft.com/office/drawing/2014/main" id="{5996179E-559D-7246-BDDA-D585235E39CA}"/>
              </a:ext>
            </a:extLst>
          </p:cNvPr>
          <p:cNvSpPr/>
          <p:nvPr/>
        </p:nvSpPr>
        <p:spPr>
          <a:xfrm>
            <a:off x="7792577" y="3155361"/>
            <a:ext cx="1279285" cy="1259777"/>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34" charset="-128"/>
              <a:cs typeface="+mn-cs"/>
            </a:endParaRPr>
          </a:p>
        </p:txBody>
      </p:sp>
      <p:sp>
        <p:nvSpPr>
          <p:cNvPr id="2" name="TextBox 15">
            <a:extLst>
              <a:ext uri="{FF2B5EF4-FFF2-40B4-BE49-F238E27FC236}">
                <a16:creationId xmlns:a16="http://schemas.microsoft.com/office/drawing/2014/main" id="{C7465937-5C33-2AE2-4C6F-680D1C82AE40}"/>
              </a:ext>
            </a:extLst>
          </p:cNvPr>
          <p:cNvSpPr txBox="1"/>
          <p:nvPr/>
        </p:nvSpPr>
        <p:spPr>
          <a:xfrm>
            <a:off x="439903" y="636202"/>
            <a:ext cx="536325" cy="369332"/>
          </a:xfrm>
          <a:prstGeom prst="rect">
            <a:avLst/>
          </a:prstGeom>
          <a:noFill/>
        </p:spPr>
        <p:txBody>
          <a:bodyPr wrap="square" rtlCol="0">
            <a:spAutoFit/>
          </a:bodyPr>
          <a:lstStyle/>
          <a:p>
            <a:pPr marL="0" marR="0" lvl="0" indent="0" algn="l" defTabSz="914361" rtl="0" eaLnBrk="1" fontAlgn="auto" latinLnBrk="0" hangingPunct="1">
              <a:lnSpc>
                <a:spcPct val="100000"/>
              </a:lnSpc>
              <a:spcBef>
                <a:spcPts val="0"/>
              </a:spcBef>
              <a:spcAft>
                <a:spcPts val="0"/>
              </a:spcAft>
              <a:buClrTx/>
              <a:buSzTx/>
              <a:buFontTx/>
              <a:buNone/>
              <a:tabLst/>
              <a:defRPr/>
            </a:pPr>
            <a:r>
              <a:rPr kumimoji="0" lang="en-US" altLang="ja-JP" sz="18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A)</a:t>
            </a:r>
          </a:p>
        </p:txBody>
      </p:sp>
      <p:sp>
        <p:nvSpPr>
          <p:cNvPr id="3" name="TextBox 15">
            <a:extLst>
              <a:ext uri="{FF2B5EF4-FFF2-40B4-BE49-F238E27FC236}">
                <a16:creationId xmlns:a16="http://schemas.microsoft.com/office/drawing/2014/main" id="{E5BD1201-94F6-BB47-6160-976B52DFEB95}"/>
              </a:ext>
            </a:extLst>
          </p:cNvPr>
          <p:cNvSpPr txBox="1"/>
          <p:nvPr/>
        </p:nvSpPr>
        <p:spPr>
          <a:xfrm>
            <a:off x="439926" y="2755154"/>
            <a:ext cx="536325" cy="369332"/>
          </a:xfrm>
          <a:prstGeom prst="rect">
            <a:avLst/>
          </a:prstGeom>
          <a:noFill/>
        </p:spPr>
        <p:txBody>
          <a:bodyPr wrap="square" rtlCol="0">
            <a:spAutoFit/>
          </a:bodyPr>
          <a:lstStyle/>
          <a:p>
            <a:pPr marL="0" marR="0" lvl="0" indent="0" algn="l" defTabSz="914361" rtl="0" eaLnBrk="1" fontAlgn="auto" latinLnBrk="0" hangingPunct="1">
              <a:lnSpc>
                <a:spcPct val="100000"/>
              </a:lnSpc>
              <a:spcBef>
                <a:spcPts val="0"/>
              </a:spcBef>
              <a:spcAft>
                <a:spcPts val="0"/>
              </a:spcAft>
              <a:buClrTx/>
              <a:buSzTx/>
              <a:buFontTx/>
              <a:buNone/>
              <a:tabLst/>
              <a:defRPr/>
            </a:pPr>
            <a:r>
              <a:rPr kumimoji="0" lang="en-US" altLang="ja-JP" sz="1800" b="1" i="0" u="none" strike="noStrike" kern="1200" cap="none" spc="0" normalizeH="0" baseline="0" noProof="0" dirty="0">
                <a:ln>
                  <a:noFill/>
                </a:ln>
                <a:solidFill>
                  <a:prstClr val="black"/>
                </a:solidFill>
                <a:effectLst/>
                <a:uLnTx/>
                <a:uFillTx/>
                <a:latin typeface="Helvetica" pitchFamily="2" charset="0"/>
                <a:ea typeface="Meiryo" panose="020B0604030504040204" pitchFamily="34" charset="-128"/>
                <a:cs typeface="+mn-cs"/>
              </a:rPr>
              <a:t>(B)</a:t>
            </a:r>
          </a:p>
        </p:txBody>
      </p:sp>
      <p:sp>
        <p:nvSpPr>
          <p:cNvPr id="5" name="テキスト ボックス 4">
            <a:extLst>
              <a:ext uri="{FF2B5EF4-FFF2-40B4-BE49-F238E27FC236}">
                <a16:creationId xmlns:a16="http://schemas.microsoft.com/office/drawing/2014/main" id="{B4980FC6-D5F4-D7CD-C550-8E54DC048DAB}"/>
              </a:ext>
            </a:extLst>
          </p:cNvPr>
          <p:cNvSpPr txBox="1"/>
          <p:nvPr/>
        </p:nvSpPr>
        <p:spPr>
          <a:xfrm>
            <a:off x="1177322" y="4986119"/>
            <a:ext cx="5130881" cy="276999"/>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ＭＳ Ｐゴシック" panose="020B0600070205080204" pitchFamily="34" charset="-128"/>
              </a:rPr>
              <a:t>Figure S3: Expression of CD26 on various T cell lines</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
        <p:nvSpPr>
          <p:cNvPr id="32" name="テキスト ボックス 31">
            <a:extLst>
              <a:ext uri="{FF2B5EF4-FFF2-40B4-BE49-F238E27FC236}">
                <a16:creationId xmlns:a16="http://schemas.microsoft.com/office/drawing/2014/main" id="{BAA25456-FD85-77C8-75E4-3A271789027D}"/>
              </a:ext>
            </a:extLst>
          </p:cNvPr>
          <p:cNvSpPr txBox="1"/>
          <p:nvPr/>
        </p:nvSpPr>
        <p:spPr>
          <a:xfrm rot="16200000">
            <a:off x="669261" y="1514594"/>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33" name="テキスト ボックス 32">
            <a:extLst>
              <a:ext uri="{FF2B5EF4-FFF2-40B4-BE49-F238E27FC236}">
                <a16:creationId xmlns:a16="http://schemas.microsoft.com/office/drawing/2014/main" id="{8F2301AD-053C-136C-F4D2-78EC5FCD2884}"/>
              </a:ext>
            </a:extLst>
          </p:cNvPr>
          <p:cNvSpPr txBox="1"/>
          <p:nvPr/>
        </p:nvSpPr>
        <p:spPr>
          <a:xfrm>
            <a:off x="1495402" y="2295615"/>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
        <p:nvSpPr>
          <p:cNvPr id="65" name="テキスト ボックス 64">
            <a:extLst>
              <a:ext uri="{FF2B5EF4-FFF2-40B4-BE49-F238E27FC236}">
                <a16:creationId xmlns:a16="http://schemas.microsoft.com/office/drawing/2014/main" id="{7B97EF3B-AFCA-9DF2-5AFE-BABE05078B57}"/>
              </a:ext>
            </a:extLst>
          </p:cNvPr>
          <p:cNvSpPr txBox="1"/>
          <p:nvPr/>
        </p:nvSpPr>
        <p:spPr>
          <a:xfrm rot="16200000">
            <a:off x="2328306" y="1510744"/>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66" name="テキスト ボックス 65">
            <a:extLst>
              <a:ext uri="{FF2B5EF4-FFF2-40B4-BE49-F238E27FC236}">
                <a16:creationId xmlns:a16="http://schemas.microsoft.com/office/drawing/2014/main" id="{6BD2FDF7-1D72-5F5A-702B-AC7AC3B20868}"/>
              </a:ext>
            </a:extLst>
          </p:cNvPr>
          <p:cNvSpPr txBox="1"/>
          <p:nvPr/>
        </p:nvSpPr>
        <p:spPr>
          <a:xfrm>
            <a:off x="3154447" y="2291765"/>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
        <p:nvSpPr>
          <p:cNvPr id="70" name="テキスト ボックス 69">
            <a:extLst>
              <a:ext uri="{FF2B5EF4-FFF2-40B4-BE49-F238E27FC236}">
                <a16:creationId xmlns:a16="http://schemas.microsoft.com/office/drawing/2014/main" id="{0B3B24FD-D6DB-437C-8637-E6556909B7CA}"/>
              </a:ext>
            </a:extLst>
          </p:cNvPr>
          <p:cNvSpPr txBox="1"/>
          <p:nvPr/>
        </p:nvSpPr>
        <p:spPr>
          <a:xfrm rot="16200000">
            <a:off x="670455" y="3633387"/>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71" name="テキスト ボックス 70">
            <a:extLst>
              <a:ext uri="{FF2B5EF4-FFF2-40B4-BE49-F238E27FC236}">
                <a16:creationId xmlns:a16="http://schemas.microsoft.com/office/drawing/2014/main" id="{EEA74B45-6502-930F-3C43-3E1762CB6365}"/>
              </a:ext>
            </a:extLst>
          </p:cNvPr>
          <p:cNvSpPr txBox="1"/>
          <p:nvPr/>
        </p:nvSpPr>
        <p:spPr>
          <a:xfrm>
            <a:off x="1496596" y="4414408"/>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
        <p:nvSpPr>
          <p:cNvPr id="75" name="テキスト ボックス 74">
            <a:extLst>
              <a:ext uri="{FF2B5EF4-FFF2-40B4-BE49-F238E27FC236}">
                <a16:creationId xmlns:a16="http://schemas.microsoft.com/office/drawing/2014/main" id="{07AD04D3-1C5F-AEA4-03F0-A48CFBB51E2B}"/>
              </a:ext>
            </a:extLst>
          </p:cNvPr>
          <p:cNvSpPr txBox="1"/>
          <p:nvPr/>
        </p:nvSpPr>
        <p:spPr>
          <a:xfrm rot="16200000">
            <a:off x="2329500" y="3629537"/>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76" name="テキスト ボックス 75">
            <a:extLst>
              <a:ext uri="{FF2B5EF4-FFF2-40B4-BE49-F238E27FC236}">
                <a16:creationId xmlns:a16="http://schemas.microsoft.com/office/drawing/2014/main" id="{7615E207-5FFA-A1DD-1550-BA84AA341EE2}"/>
              </a:ext>
            </a:extLst>
          </p:cNvPr>
          <p:cNvSpPr txBox="1"/>
          <p:nvPr/>
        </p:nvSpPr>
        <p:spPr>
          <a:xfrm>
            <a:off x="3155641" y="4410558"/>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
        <p:nvSpPr>
          <p:cNvPr id="80" name="テキスト ボックス 79">
            <a:extLst>
              <a:ext uri="{FF2B5EF4-FFF2-40B4-BE49-F238E27FC236}">
                <a16:creationId xmlns:a16="http://schemas.microsoft.com/office/drawing/2014/main" id="{2CC0BF6C-E6B4-1B6E-EA02-8355A8C7B0F3}"/>
              </a:ext>
            </a:extLst>
          </p:cNvPr>
          <p:cNvSpPr txBox="1"/>
          <p:nvPr/>
        </p:nvSpPr>
        <p:spPr>
          <a:xfrm rot="16200000">
            <a:off x="3964655" y="3632396"/>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81" name="テキスト ボックス 80">
            <a:extLst>
              <a:ext uri="{FF2B5EF4-FFF2-40B4-BE49-F238E27FC236}">
                <a16:creationId xmlns:a16="http://schemas.microsoft.com/office/drawing/2014/main" id="{CD6D1472-130B-A4E4-7417-FCAA1DB1F2B8}"/>
              </a:ext>
            </a:extLst>
          </p:cNvPr>
          <p:cNvSpPr txBox="1"/>
          <p:nvPr/>
        </p:nvSpPr>
        <p:spPr>
          <a:xfrm>
            <a:off x="4790796" y="4413417"/>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
        <p:nvSpPr>
          <p:cNvPr id="85" name="テキスト ボックス 84">
            <a:extLst>
              <a:ext uri="{FF2B5EF4-FFF2-40B4-BE49-F238E27FC236}">
                <a16:creationId xmlns:a16="http://schemas.microsoft.com/office/drawing/2014/main" id="{22166881-647E-D0A9-8671-AE0C24865B8C}"/>
              </a:ext>
            </a:extLst>
          </p:cNvPr>
          <p:cNvSpPr txBox="1"/>
          <p:nvPr/>
        </p:nvSpPr>
        <p:spPr>
          <a:xfrm rot="16200000">
            <a:off x="5623700" y="3628546"/>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86" name="テキスト ボックス 85">
            <a:extLst>
              <a:ext uri="{FF2B5EF4-FFF2-40B4-BE49-F238E27FC236}">
                <a16:creationId xmlns:a16="http://schemas.microsoft.com/office/drawing/2014/main" id="{6565503B-9621-0E77-2AC4-2EDE46511FBB}"/>
              </a:ext>
            </a:extLst>
          </p:cNvPr>
          <p:cNvSpPr txBox="1"/>
          <p:nvPr/>
        </p:nvSpPr>
        <p:spPr>
          <a:xfrm>
            <a:off x="6449841" y="4409567"/>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
        <p:nvSpPr>
          <p:cNvPr id="90" name="テキスト ボックス 89">
            <a:extLst>
              <a:ext uri="{FF2B5EF4-FFF2-40B4-BE49-F238E27FC236}">
                <a16:creationId xmlns:a16="http://schemas.microsoft.com/office/drawing/2014/main" id="{79FA789C-3C4D-2A6E-38E4-8DE67FB9D4E5}"/>
              </a:ext>
            </a:extLst>
          </p:cNvPr>
          <p:cNvSpPr txBox="1"/>
          <p:nvPr/>
        </p:nvSpPr>
        <p:spPr>
          <a:xfrm rot="16200000">
            <a:off x="7287134" y="3631721"/>
            <a:ext cx="700833" cy="307777"/>
          </a:xfrm>
          <a:prstGeom prst="rect">
            <a:avLst/>
          </a:prstGeom>
          <a:noFill/>
        </p:spPr>
        <p:txBody>
          <a:bodyPr wrap="none" rtlCol="0">
            <a:spAutoFit/>
          </a:bodyPr>
          <a:lstStyle/>
          <a:p>
            <a:r>
              <a:rPr kumimoji="1" lang="en-US" altLang="ja-JP" sz="1400" b="1" dirty="0">
                <a:latin typeface="Helvetica" pitchFamily="2" charset="0"/>
              </a:rPr>
              <a:t>Count</a:t>
            </a:r>
            <a:endParaRPr kumimoji="1" lang="ja-JP" altLang="en-US" sz="1400" b="1">
              <a:latin typeface="Helvetica" pitchFamily="2" charset="0"/>
            </a:endParaRPr>
          </a:p>
        </p:txBody>
      </p:sp>
      <p:sp>
        <p:nvSpPr>
          <p:cNvPr id="91" name="テキスト ボックス 90">
            <a:extLst>
              <a:ext uri="{FF2B5EF4-FFF2-40B4-BE49-F238E27FC236}">
                <a16:creationId xmlns:a16="http://schemas.microsoft.com/office/drawing/2014/main" id="{62583C78-6FA5-7EFD-DBDE-4EE39CBDB3E9}"/>
              </a:ext>
            </a:extLst>
          </p:cNvPr>
          <p:cNvSpPr txBox="1"/>
          <p:nvPr/>
        </p:nvSpPr>
        <p:spPr>
          <a:xfrm>
            <a:off x="8113275" y="4412742"/>
            <a:ext cx="643125" cy="307777"/>
          </a:xfrm>
          <a:prstGeom prst="rect">
            <a:avLst/>
          </a:prstGeom>
          <a:noFill/>
        </p:spPr>
        <p:txBody>
          <a:bodyPr wrap="none" rtlCol="0">
            <a:spAutoFit/>
          </a:bodyPr>
          <a:lstStyle/>
          <a:p>
            <a:r>
              <a:rPr kumimoji="1" lang="en-US" altLang="ja-JP" sz="1400" b="1" dirty="0">
                <a:latin typeface="Helvetica" pitchFamily="2" charset="0"/>
              </a:rPr>
              <a:t>CD26</a:t>
            </a:r>
            <a:endParaRPr kumimoji="1" lang="ja-JP" altLang="en-US" sz="1400" b="1">
              <a:latin typeface="Helvetica" pitchFamily="2" charset="0"/>
            </a:endParaRPr>
          </a:p>
        </p:txBody>
      </p:sp>
    </p:spTree>
    <p:extLst>
      <p:ext uri="{BB962C8B-B14F-4D97-AF65-F5344CB8AC3E}">
        <p14:creationId xmlns:p14="http://schemas.microsoft.com/office/powerpoint/2010/main" val="26268726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正方形/長方形 9">
            <a:extLst>
              <a:ext uri="{FF2B5EF4-FFF2-40B4-BE49-F238E27FC236}">
                <a16:creationId xmlns:a16="http://schemas.microsoft.com/office/drawing/2014/main" id="{DAC59E46-4CD7-AD43-8E00-BC25B08BBBB7}"/>
              </a:ext>
            </a:extLst>
          </p:cNvPr>
          <p:cNvSpPr/>
          <p:nvPr/>
        </p:nvSpPr>
        <p:spPr>
          <a:xfrm>
            <a:off x="2899492" y="2471328"/>
            <a:ext cx="196850" cy="1266665"/>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sp>
        <p:nvSpPr>
          <p:cNvPr id="11" name="正方形/長方形 10">
            <a:extLst>
              <a:ext uri="{FF2B5EF4-FFF2-40B4-BE49-F238E27FC236}">
                <a16:creationId xmlns:a16="http://schemas.microsoft.com/office/drawing/2014/main" id="{8202A81A-2FC9-2946-9427-A27F8107953F}"/>
              </a:ext>
            </a:extLst>
          </p:cNvPr>
          <p:cNvSpPr/>
          <p:nvPr/>
        </p:nvSpPr>
        <p:spPr>
          <a:xfrm>
            <a:off x="3220166" y="2061911"/>
            <a:ext cx="196850" cy="1676082"/>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cxnSp>
        <p:nvCxnSpPr>
          <p:cNvPr id="14" name="直線コネクタ 13">
            <a:extLst>
              <a:ext uri="{FF2B5EF4-FFF2-40B4-BE49-F238E27FC236}">
                <a16:creationId xmlns:a16="http://schemas.microsoft.com/office/drawing/2014/main" id="{049FA5A7-63B3-2C47-9C90-623465DDC239}"/>
              </a:ext>
            </a:extLst>
          </p:cNvPr>
          <p:cNvCxnSpPr>
            <a:cxnSpLocks/>
          </p:cNvCxnSpPr>
          <p:nvPr/>
        </p:nvCxnSpPr>
        <p:spPr>
          <a:xfrm>
            <a:off x="3313828" y="2015381"/>
            <a:ext cx="0" cy="36511"/>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16" name="正方形/長方形 15">
            <a:extLst>
              <a:ext uri="{FF2B5EF4-FFF2-40B4-BE49-F238E27FC236}">
                <a16:creationId xmlns:a16="http://schemas.microsoft.com/office/drawing/2014/main" id="{EFA17203-4735-7D4D-9780-070F29E0A8B4}"/>
              </a:ext>
            </a:extLst>
          </p:cNvPr>
          <p:cNvSpPr/>
          <p:nvPr/>
        </p:nvSpPr>
        <p:spPr>
          <a:xfrm>
            <a:off x="6142565" y="1554825"/>
            <a:ext cx="196850" cy="2183170"/>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sp>
        <p:nvSpPr>
          <p:cNvPr id="17" name="正方形/長方形 16">
            <a:extLst>
              <a:ext uri="{FF2B5EF4-FFF2-40B4-BE49-F238E27FC236}">
                <a16:creationId xmlns:a16="http://schemas.microsoft.com/office/drawing/2014/main" id="{5CBF1692-BBD2-7245-9A44-EFEABFEFCD02}"/>
              </a:ext>
            </a:extLst>
          </p:cNvPr>
          <p:cNvSpPr/>
          <p:nvPr/>
        </p:nvSpPr>
        <p:spPr>
          <a:xfrm>
            <a:off x="6463240" y="2809310"/>
            <a:ext cx="196850" cy="928683"/>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cxnSp>
        <p:nvCxnSpPr>
          <p:cNvPr id="20" name="直線コネクタ 19">
            <a:extLst>
              <a:ext uri="{FF2B5EF4-FFF2-40B4-BE49-F238E27FC236}">
                <a16:creationId xmlns:a16="http://schemas.microsoft.com/office/drawing/2014/main" id="{646E6697-19D1-CA4D-8F15-CB80F2B912D0}"/>
              </a:ext>
            </a:extLst>
          </p:cNvPr>
          <p:cNvCxnSpPr>
            <a:cxnSpLocks/>
          </p:cNvCxnSpPr>
          <p:nvPr/>
        </p:nvCxnSpPr>
        <p:spPr>
          <a:xfrm>
            <a:off x="6239403" y="1486448"/>
            <a:ext cx="0" cy="59464"/>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22" name="直線コネクタ 21">
            <a:extLst>
              <a:ext uri="{FF2B5EF4-FFF2-40B4-BE49-F238E27FC236}">
                <a16:creationId xmlns:a16="http://schemas.microsoft.com/office/drawing/2014/main" id="{F4FADD39-BE87-7040-8429-120A961ECE51}"/>
              </a:ext>
            </a:extLst>
          </p:cNvPr>
          <p:cNvCxnSpPr>
            <a:cxnSpLocks/>
          </p:cNvCxnSpPr>
          <p:nvPr/>
        </p:nvCxnSpPr>
        <p:spPr>
          <a:xfrm>
            <a:off x="6559040" y="2734630"/>
            <a:ext cx="0" cy="67564"/>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24" name="正方形/長方形 23">
            <a:extLst>
              <a:ext uri="{FF2B5EF4-FFF2-40B4-BE49-F238E27FC236}">
                <a16:creationId xmlns:a16="http://schemas.microsoft.com/office/drawing/2014/main" id="{525A313B-25B5-BE41-8AEB-FBCB98E284D4}"/>
              </a:ext>
            </a:extLst>
          </p:cNvPr>
          <p:cNvSpPr/>
          <p:nvPr/>
        </p:nvSpPr>
        <p:spPr>
          <a:xfrm>
            <a:off x="4520802" y="1847208"/>
            <a:ext cx="196850" cy="1890785"/>
          </a:xfrm>
          <a:prstGeom prst="rect">
            <a:avLst/>
          </a:prstGeom>
          <a:solidFill>
            <a:schemeClr val="tx1">
              <a:lumMod val="50000"/>
              <a:lumOff val="50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sp>
        <p:nvSpPr>
          <p:cNvPr id="25" name="正方形/長方形 24">
            <a:extLst>
              <a:ext uri="{FF2B5EF4-FFF2-40B4-BE49-F238E27FC236}">
                <a16:creationId xmlns:a16="http://schemas.microsoft.com/office/drawing/2014/main" id="{EB50269D-34C6-AC44-A387-AE2A9D2052B6}"/>
              </a:ext>
            </a:extLst>
          </p:cNvPr>
          <p:cNvSpPr/>
          <p:nvPr/>
        </p:nvSpPr>
        <p:spPr>
          <a:xfrm>
            <a:off x="4841478" y="2642635"/>
            <a:ext cx="196850" cy="1095359"/>
          </a:xfrm>
          <a:prstGeom prst="rect">
            <a:avLst/>
          </a:prstGeom>
          <a:solidFill>
            <a:schemeClr val="tx1">
              <a:lumMod val="50000"/>
              <a:lumOff val="50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cxnSp>
        <p:nvCxnSpPr>
          <p:cNvPr id="28" name="直線コネクタ 27">
            <a:extLst>
              <a:ext uri="{FF2B5EF4-FFF2-40B4-BE49-F238E27FC236}">
                <a16:creationId xmlns:a16="http://schemas.microsoft.com/office/drawing/2014/main" id="{8D8718DF-156F-8345-9182-9E88F75DF5E2}"/>
              </a:ext>
            </a:extLst>
          </p:cNvPr>
          <p:cNvCxnSpPr>
            <a:cxnSpLocks/>
          </p:cNvCxnSpPr>
          <p:nvPr/>
        </p:nvCxnSpPr>
        <p:spPr>
          <a:xfrm>
            <a:off x="4938315" y="2563402"/>
            <a:ext cx="0" cy="74073"/>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29" name="直線コネクタ 28">
            <a:extLst>
              <a:ext uri="{FF2B5EF4-FFF2-40B4-BE49-F238E27FC236}">
                <a16:creationId xmlns:a16="http://schemas.microsoft.com/office/drawing/2014/main" id="{2917B5D1-3C60-DC41-A281-E145258B77E6}"/>
              </a:ext>
            </a:extLst>
          </p:cNvPr>
          <p:cNvCxnSpPr>
            <a:cxnSpLocks/>
          </p:cNvCxnSpPr>
          <p:nvPr/>
        </p:nvCxnSpPr>
        <p:spPr>
          <a:xfrm>
            <a:off x="4614465" y="1629222"/>
            <a:ext cx="0" cy="208194"/>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30" name="直線コネクタ 29">
            <a:extLst>
              <a:ext uri="{FF2B5EF4-FFF2-40B4-BE49-F238E27FC236}">
                <a16:creationId xmlns:a16="http://schemas.microsoft.com/office/drawing/2014/main" id="{FBD7F272-AE56-904D-A7F2-FFC03C807BAD}"/>
              </a:ext>
            </a:extLst>
          </p:cNvPr>
          <p:cNvCxnSpPr/>
          <p:nvPr/>
        </p:nvCxnSpPr>
        <p:spPr>
          <a:xfrm>
            <a:off x="2633200" y="1121952"/>
            <a:ext cx="0" cy="262890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31" name="直線コネクタ 30">
            <a:extLst>
              <a:ext uri="{FF2B5EF4-FFF2-40B4-BE49-F238E27FC236}">
                <a16:creationId xmlns:a16="http://schemas.microsoft.com/office/drawing/2014/main" id="{CEA76BAE-94F3-7249-A211-08A5B7603B14}"/>
              </a:ext>
            </a:extLst>
          </p:cNvPr>
          <p:cNvCxnSpPr>
            <a:cxnSpLocks/>
          </p:cNvCxnSpPr>
          <p:nvPr/>
        </p:nvCxnSpPr>
        <p:spPr>
          <a:xfrm>
            <a:off x="2563350" y="3744502"/>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2" name="直線コネクタ 31">
            <a:extLst>
              <a:ext uri="{FF2B5EF4-FFF2-40B4-BE49-F238E27FC236}">
                <a16:creationId xmlns:a16="http://schemas.microsoft.com/office/drawing/2014/main" id="{4CA5491B-15EB-CF47-8F87-E022DD780BD4}"/>
              </a:ext>
            </a:extLst>
          </p:cNvPr>
          <p:cNvCxnSpPr>
            <a:cxnSpLocks/>
          </p:cNvCxnSpPr>
          <p:nvPr/>
        </p:nvCxnSpPr>
        <p:spPr>
          <a:xfrm>
            <a:off x="2563350" y="3322227"/>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3" name="直線コネクタ 32">
            <a:extLst>
              <a:ext uri="{FF2B5EF4-FFF2-40B4-BE49-F238E27FC236}">
                <a16:creationId xmlns:a16="http://schemas.microsoft.com/office/drawing/2014/main" id="{698E07EE-400C-B146-8F7A-438799E5C1FA}"/>
              </a:ext>
            </a:extLst>
          </p:cNvPr>
          <p:cNvCxnSpPr>
            <a:cxnSpLocks/>
          </p:cNvCxnSpPr>
          <p:nvPr/>
        </p:nvCxnSpPr>
        <p:spPr>
          <a:xfrm>
            <a:off x="2563350" y="2899952"/>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4" name="直線コネクタ 33">
            <a:extLst>
              <a:ext uri="{FF2B5EF4-FFF2-40B4-BE49-F238E27FC236}">
                <a16:creationId xmlns:a16="http://schemas.microsoft.com/office/drawing/2014/main" id="{39B17F6B-1FAF-2D48-9888-BABBD1C48AB5}"/>
              </a:ext>
            </a:extLst>
          </p:cNvPr>
          <p:cNvCxnSpPr>
            <a:cxnSpLocks/>
          </p:cNvCxnSpPr>
          <p:nvPr/>
        </p:nvCxnSpPr>
        <p:spPr>
          <a:xfrm>
            <a:off x="2563350" y="2055402"/>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5" name="直線コネクタ 34">
            <a:extLst>
              <a:ext uri="{FF2B5EF4-FFF2-40B4-BE49-F238E27FC236}">
                <a16:creationId xmlns:a16="http://schemas.microsoft.com/office/drawing/2014/main" id="{C287605C-E155-D243-8F80-39637A6E9E23}"/>
              </a:ext>
            </a:extLst>
          </p:cNvPr>
          <p:cNvCxnSpPr>
            <a:cxnSpLocks/>
          </p:cNvCxnSpPr>
          <p:nvPr/>
        </p:nvCxnSpPr>
        <p:spPr>
          <a:xfrm>
            <a:off x="2563350" y="1210852"/>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36" name="テキスト ボックス 35">
            <a:extLst>
              <a:ext uri="{FF2B5EF4-FFF2-40B4-BE49-F238E27FC236}">
                <a16:creationId xmlns:a16="http://schemas.microsoft.com/office/drawing/2014/main" id="{E8B881A9-C632-C54A-A975-7D69EB8D70E6}"/>
              </a:ext>
            </a:extLst>
          </p:cNvPr>
          <p:cNvSpPr txBox="1"/>
          <p:nvPr/>
        </p:nvSpPr>
        <p:spPr>
          <a:xfrm>
            <a:off x="2279297" y="1056962"/>
            <a:ext cx="284052" cy="307777"/>
          </a:xfrm>
          <a:prstGeom prst="rect">
            <a:avLst/>
          </a:prstGeom>
          <a:noFill/>
        </p:spPr>
        <p:txBody>
          <a:bodyPr wrap="none" rtlCol="0">
            <a:spAutoFit/>
          </a:bodyPr>
          <a:lstStyle/>
          <a:p>
            <a:pPr algn="r"/>
            <a:r>
              <a:rPr lang="en-US" altLang="ja-JP" sz="1400" b="1" dirty="0">
                <a:latin typeface="Helvetica" pitchFamily="2" charset="0"/>
              </a:rPr>
              <a:t>6</a:t>
            </a:r>
            <a:endParaRPr lang="ja-JP" altLang="en-US" sz="1400" b="1">
              <a:latin typeface="Helvetica" pitchFamily="2" charset="0"/>
            </a:endParaRPr>
          </a:p>
        </p:txBody>
      </p:sp>
      <p:sp>
        <p:nvSpPr>
          <p:cNvPr id="38" name="テキスト ボックス 37">
            <a:extLst>
              <a:ext uri="{FF2B5EF4-FFF2-40B4-BE49-F238E27FC236}">
                <a16:creationId xmlns:a16="http://schemas.microsoft.com/office/drawing/2014/main" id="{8A3B29E8-DEF8-7E49-BDAE-024B98EC0DD5}"/>
              </a:ext>
            </a:extLst>
          </p:cNvPr>
          <p:cNvSpPr txBox="1"/>
          <p:nvPr/>
        </p:nvSpPr>
        <p:spPr>
          <a:xfrm>
            <a:off x="2279297" y="2746062"/>
            <a:ext cx="284052" cy="307777"/>
          </a:xfrm>
          <a:prstGeom prst="rect">
            <a:avLst/>
          </a:prstGeom>
          <a:noFill/>
        </p:spPr>
        <p:txBody>
          <a:bodyPr wrap="none" rtlCol="0">
            <a:spAutoFit/>
          </a:bodyPr>
          <a:lstStyle/>
          <a:p>
            <a:pPr algn="r"/>
            <a:r>
              <a:rPr lang="en-US" altLang="ja-JP" sz="1400" b="1" dirty="0">
                <a:latin typeface="Helvetica" pitchFamily="2" charset="0"/>
              </a:rPr>
              <a:t>2</a:t>
            </a:r>
            <a:endParaRPr lang="ja-JP" altLang="en-US" sz="1400" b="1">
              <a:latin typeface="Helvetica" pitchFamily="2" charset="0"/>
            </a:endParaRPr>
          </a:p>
        </p:txBody>
      </p:sp>
      <p:sp>
        <p:nvSpPr>
          <p:cNvPr id="40" name="テキスト ボックス 39">
            <a:extLst>
              <a:ext uri="{FF2B5EF4-FFF2-40B4-BE49-F238E27FC236}">
                <a16:creationId xmlns:a16="http://schemas.microsoft.com/office/drawing/2014/main" id="{3FD7982C-42F3-614B-BC3C-CC7532A65DEE}"/>
              </a:ext>
            </a:extLst>
          </p:cNvPr>
          <p:cNvSpPr txBox="1"/>
          <p:nvPr/>
        </p:nvSpPr>
        <p:spPr>
          <a:xfrm>
            <a:off x="2279297" y="3590613"/>
            <a:ext cx="284052" cy="307777"/>
          </a:xfrm>
          <a:prstGeom prst="rect">
            <a:avLst/>
          </a:prstGeom>
          <a:noFill/>
        </p:spPr>
        <p:txBody>
          <a:bodyPr wrap="none" rtlCol="0">
            <a:spAutoFit/>
          </a:bodyPr>
          <a:lstStyle/>
          <a:p>
            <a:pPr algn="r"/>
            <a:r>
              <a:rPr lang="en-US" altLang="ja-JP" sz="1400" b="1" dirty="0">
                <a:latin typeface="Helvetica" pitchFamily="2" charset="0"/>
              </a:rPr>
              <a:t>0</a:t>
            </a:r>
            <a:endParaRPr lang="ja-JP" altLang="en-US" sz="1400" b="1">
              <a:latin typeface="Helvetica" pitchFamily="2" charset="0"/>
            </a:endParaRPr>
          </a:p>
        </p:txBody>
      </p:sp>
      <p:sp>
        <p:nvSpPr>
          <p:cNvPr id="41" name="テキスト ボックス 40">
            <a:extLst>
              <a:ext uri="{FF2B5EF4-FFF2-40B4-BE49-F238E27FC236}">
                <a16:creationId xmlns:a16="http://schemas.microsoft.com/office/drawing/2014/main" id="{5E45CBA1-CF66-7F4D-B0C5-FA3056191DB9}"/>
              </a:ext>
            </a:extLst>
          </p:cNvPr>
          <p:cNvSpPr txBox="1"/>
          <p:nvPr/>
        </p:nvSpPr>
        <p:spPr>
          <a:xfrm rot="16200000">
            <a:off x="661310" y="2165394"/>
            <a:ext cx="2579552" cy="523220"/>
          </a:xfrm>
          <a:prstGeom prst="rect">
            <a:avLst/>
          </a:prstGeom>
          <a:noFill/>
        </p:spPr>
        <p:txBody>
          <a:bodyPr wrap="none" rtlCol="0">
            <a:spAutoFit/>
          </a:bodyPr>
          <a:lstStyle/>
          <a:p>
            <a:pPr algn="r"/>
            <a:r>
              <a:rPr lang="en-US" altLang="ja-JP" sz="1400" b="1" dirty="0">
                <a:latin typeface="Helvetica" pitchFamily="2" charset="0"/>
              </a:rPr>
              <a:t>Relative luminescence units</a:t>
            </a:r>
          </a:p>
          <a:p>
            <a:pPr algn="r"/>
            <a:r>
              <a:rPr lang="en-US" altLang="ja-JP" sz="1400" b="1" dirty="0">
                <a:latin typeface="Helvetica" pitchFamily="2" charset="0"/>
              </a:rPr>
              <a:t>(×10</a:t>
            </a:r>
            <a:r>
              <a:rPr lang="en-US" altLang="ja-JP" sz="1400" b="1" baseline="30000" dirty="0">
                <a:latin typeface="Helvetica" pitchFamily="2" charset="0"/>
              </a:rPr>
              <a:t>3</a:t>
            </a:r>
            <a:r>
              <a:rPr lang="en-US" altLang="ja-JP" sz="1400" b="1" dirty="0">
                <a:latin typeface="Helvetica" pitchFamily="2" charset="0"/>
              </a:rPr>
              <a:t>)</a:t>
            </a:r>
            <a:endParaRPr lang="ja-JP" altLang="en-US" sz="1400" b="1">
              <a:latin typeface="Helvetica" pitchFamily="2" charset="0"/>
            </a:endParaRPr>
          </a:p>
        </p:txBody>
      </p:sp>
      <p:sp>
        <p:nvSpPr>
          <p:cNvPr id="46" name="テキスト ボックス 45">
            <a:extLst>
              <a:ext uri="{FF2B5EF4-FFF2-40B4-BE49-F238E27FC236}">
                <a16:creationId xmlns:a16="http://schemas.microsoft.com/office/drawing/2014/main" id="{32CBEF18-ED5A-E646-B0EA-39B5FF6C1CE6}"/>
              </a:ext>
            </a:extLst>
          </p:cNvPr>
          <p:cNvSpPr txBox="1"/>
          <p:nvPr/>
        </p:nvSpPr>
        <p:spPr>
          <a:xfrm>
            <a:off x="748711" y="4690630"/>
            <a:ext cx="970137" cy="307777"/>
          </a:xfrm>
          <a:prstGeom prst="rect">
            <a:avLst/>
          </a:prstGeom>
          <a:noFill/>
        </p:spPr>
        <p:txBody>
          <a:bodyPr wrap="none" rtlCol="0">
            <a:spAutoFit/>
          </a:bodyPr>
          <a:lstStyle/>
          <a:p>
            <a:r>
              <a:rPr lang="en-US" altLang="ja-JP" sz="1400" b="1" dirty="0">
                <a:latin typeface="Helvetica" pitchFamily="2" charset="0"/>
              </a:rPr>
              <a:t>Effector: </a:t>
            </a:r>
            <a:endParaRPr lang="ja-JP" altLang="en-US" sz="1400" b="1">
              <a:latin typeface="Helvetica" pitchFamily="2" charset="0"/>
            </a:endParaRPr>
          </a:p>
        </p:txBody>
      </p:sp>
      <p:cxnSp>
        <p:nvCxnSpPr>
          <p:cNvPr id="52" name="直線コネクタ 51">
            <a:extLst>
              <a:ext uri="{FF2B5EF4-FFF2-40B4-BE49-F238E27FC236}">
                <a16:creationId xmlns:a16="http://schemas.microsoft.com/office/drawing/2014/main" id="{959C135D-7D80-9D41-BC5B-B56E2D1DB963}"/>
              </a:ext>
            </a:extLst>
          </p:cNvPr>
          <p:cNvCxnSpPr>
            <a:cxnSpLocks/>
          </p:cNvCxnSpPr>
          <p:nvPr/>
        </p:nvCxnSpPr>
        <p:spPr>
          <a:xfrm>
            <a:off x="2563350" y="2477677"/>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53" name="テキスト ボックス 52">
            <a:extLst>
              <a:ext uri="{FF2B5EF4-FFF2-40B4-BE49-F238E27FC236}">
                <a16:creationId xmlns:a16="http://schemas.microsoft.com/office/drawing/2014/main" id="{47C566AE-8145-6F4F-A3D9-03336A5A9FAA}"/>
              </a:ext>
            </a:extLst>
          </p:cNvPr>
          <p:cNvSpPr txBox="1"/>
          <p:nvPr/>
        </p:nvSpPr>
        <p:spPr>
          <a:xfrm>
            <a:off x="2279297" y="1901512"/>
            <a:ext cx="284052" cy="307777"/>
          </a:xfrm>
          <a:prstGeom prst="rect">
            <a:avLst/>
          </a:prstGeom>
          <a:noFill/>
        </p:spPr>
        <p:txBody>
          <a:bodyPr wrap="none" rtlCol="0">
            <a:spAutoFit/>
          </a:bodyPr>
          <a:lstStyle/>
          <a:p>
            <a:pPr algn="r"/>
            <a:r>
              <a:rPr lang="en-US" altLang="ja-JP" sz="1400" b="1" dirty="0">
                <a:latin typeface="Helvetica" pitchFamily="2" charset="0"/>
              </a:rPr>
              <a:t>4</a:t>
            </a:r>
            <a:endParaRPr lang="ja-JP" altLang="en-US" sz="1400" b="1">
              <a:latin typeface="Helvetica" pitchFamily="2" charset="0"/>
            </a:endParaRPr>
          </a:p>
        </p:txBody>
      </p:sp>
      <p:sp>
        <p:nvSpPr>
          <p:cNvPr id="134" name="テキスト ボックス 133">
            <a:extLst>
              <a:ext uri="{FF2B5EF4-FFF2-40B4-BE49-F238E27FC236}">
                <a16:creationId xmlns:a16="http://schemas.microsoft.com/office/drawing/2014/main" id="{DAAB513C-2E6B-7E45-8ADA-45581686F294}"/>
              </a:ext>
            </a:extLst>
          </p:cNvPr>
          <p:cNvSpPr txBox="1"/>
          <p:nvPr/>
        </p:nvSpPr>
        <p:spPr>
          <a:xfrm rot="16200000">
            <a:off x="2582243" y="4697150"/>
            <a:ext cx="832279"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135" name="テキスト ボックス 134">
            <a:extLst>
              <a:ext uri="{FF2B5EF4-FFF2-40B4-BE49-F238E27FC236}">
                <a16:creationId xmlns:a16="http://schemas.microsoft.com/office/drawing/2014/main" id="{7D5D40DA-ADF7-B549-ACE4-1F2CA56711D8}"/>
              </a:ext>
            </a:extLst>
          </p:cNvPr>
          <p:cNvSpPr txBox="1"/>
          <p:nvPr/>
        </p:nvSpPr>
        <p:spPr>
          <a:xfrm rot="16200000">
            <a:off x="2855682" y="4746451"/>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sp>
        <p:nvSpPr>
          <p:cNvPr id="138" name="テキスト ボックス 137">
            <a:extLst>
              <a:ext uri="{FF2B5EF4-FFF2-40B4-BE49-F238E27FC236}">
                <a16:creationId xmlns:a16="http://schemas.microsoft.com/office/drawing/2014/main" id="{DDEF664C-04EB-9846-84B5-79117CBC362D}"/>
              </a:ext>
            </a:extLst>
          </p:cNvPr>
          <p:cNvSpPr txBox="1"/>
          <p:nvPr/>
        </p:nvSpPr>
        <p:spPr>
          <a:xfrm rot="16200000">
            <a:off x="4207999" y="4695013"/>
            <a:ext cx="832279"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139" name="テキスト ボックス 138">
            <a:extLst>
              <a:ext uri="{FF2B5EF4-FFF2-40B4-BE49-F238E27FC236}">
                <a16:creationId xmlns:a16="http://schemas.microsoft.com/office/drawing/2014/main" id="{3EA9CD8E-2192-AF42-8732-03C9D9FC3C3E}"/>
              </a:ext>
            </a:extLst>
          </p:cNvPr>
          <p:cNvSpPr txBox="1"/>
          <p:nvPr/>
        </p:nvSpPr>
        <p:spPr>
          <a:xfrm rot="16200000">
            <a:off x="4481438" y="4746451"/>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sp>
        <p:nvSpPr>
          <p:cNvPr id="142" name="テキスト ボックス 141">
            <a:extLst>
              <a:ext uri="{FF2B5EF4-FFF2-40B4-BE49-F238E27FC236}">
                <a16:creationId xmlns:a16="http://schemas.microsoft.com/office/drawing/2014/main" id="{1EE77553-36B4-B647-B8F1-99A32027183A}"/>
              </a:ext>
            </a:extLst>
          </p:cNvPr>
          <p:cNvSpPr txBox="1"/>
          <p:nvPr/>
        </p:nvSpPr>
        <p:spPr>
          <a:xfrm rot="16200000">
            <a:off x="5826483" y="4696758"/>
            <a:ext cx="832279"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143" name="テキスト ボックス 142">
            <a:extLst>
              <a:ext uri="{FF2B5EF4-FFF2-40B4-BE49-F238E27FC236}">
                <a16:creationId xmlns:a16="http://schemas.microsoft.com/office/drawing/2014/main" id="{F25A3A6E-1E2B-8846-978E-CC9FD4536878}"/>
              </a:ext>
            </a:extLst>
          </p:cNvPr>
          <p:cNvSpPr txBox="1"/>
          <p:nvPr/>
        </p:nvSpPr>
        <p:spPr>
          <a:xfrm rot="16200000">
            <a:off x="6099922" y="4746451"/>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sp>
        <p:nvSpPr>
          <p:cNvPr id="163" name="テキスト ボックス 162">
            <a:extLst>
              <a:ext uri="{FF2B5EF4-FFF2-40B4-BE49-F238E27FC236}">
                <a16:creationId xmlns:a16="http://schemas.microsoft.com/office/drawing/2014/main" id="{BAD9886C-EBEA-B948-808B-C639B889E13E}"/>
              </a:ext>
            </a:extLst>
          </p:cNvPr>
          <p:cNvSpPr txBox="1"/>
          <p:nvPr/>
        </p:nvSpPr>
        <p:spPr>
          <a:xfrm>
            <a:off x="748711" y="5088632"/>
            <a:ext cx="1881862" cy="307777"/>
          </a:xfrm>
          <a:prstGeom prst="rect">
            <a:avLst/>
          </a:prstGeom>
          <a:noFill/>
        </p:spPr>
        <p:txBody>
          <a:bodyPr wrap="none" rtlCol="0">
            <a:spAutoFit/>
          </a:bodyPr>
          <a:lstStyle/>
          <a:p>
            <a:r>
              <a:rPr lang="en-US" altLang="ja-JP" sz="1400" b="1" dirty="0">
                <a:latin typeface="Helvetica" pitchFamily="2" charset="0"/>
              </a:rPr>
              <a:t>Target: KARPAS299</a:t>
            </a:r>
            <a:endParaRPr lang="ja-JP" altLang="en-US" sz="1400" b="1">
              <a:solidFill>
                <a:srgbClr val="FF0000"/>
              </a:solidFill>
              <a:latin typeface="Helvetica" pitchFamily="2" charset="0"/>
            </a:endParaRPr>
          </a:p>
        </p:txBody>
      </p:sp>
      <p:sp>
        <p:nvSpPr>
          <p:cNvPr id="164" name="テキスト ボックス 163">
            <a:extLst>
              <a:ext uri="{FF2B5EF4-FFF2-40B4-BE49-F238E27FC236}">
                <a16:creationId xmlns:a16="http://schemas.microsoft.com/office/drawing/2014/main" id="{130A782D-FC75-ED43-B896-15714EDE3901}"/>
              </a:ext>
            </a:extLst>
          </p:cNvPr>
          <p:cNvSpPr txBox="1"/>
          <p:nvPr/>
        </p:nvSpPr>
        <p:spPr>
          <a:xfrm>
            <a:off x="2879683" y="5422327"/>
            <a:ext cx="492443" cy="307777"/>
          </a:xfrm>
          <a:prstGeom prst="rect">
            <a:avLst/>
          </a:prstGeom>
          <a:noFill/>
        </p:spPr>
        <p:txBody>
          <a:bodyPr wrap="none" rtlCol="0">
            <a:spAutoFit/>
          </a:bodyPr>
          <a:lstStyle/>
          <a:p>
            <a:pPr algn="ctr"/>
            <a:r>
              <a:rPr lang="en-US" altLang="ja-JP" sz="1400" b="1" dirty="0">
                <a:latin typeface="Helvetica" pitchFamily="2" charset="0"/>
              </a:rPr>
              <a:t>1: 1</a:t>
            </a:r>
            <a:endParaRPr lang="ja-JP" altLang="en-US" sz="1400" b="1">
              <a:latin typeface="Helvetica" pitchFamily="2" charset="0"/>
            </a:endParaRPr>
          </a:p>
        </p:txBody>
      </p:sp>
      <p:sp>
        <p:nvSpPr>
          <p:cNvPr id="165" name="テキスト ボックス 164">
            <a:extLst>
              <a:ext uri="{FF2B5EF4-FFF2-40B4-BE49-F238E27FC236}">
                <a16:creationId xmlns:a16="http://schemas.microsoft.com/office/drawing/2014/main" id="{66871347-FC57-9C47-B402-70D70C12E61D}"/>
              </a:ext>
            </a:extLst>
          </p:cNvPr>
          <p:cNvSpPr txBox="1"/>
          <p:nvPr/>
        </p:nvSpPr>
        <p:spPr>
          <a:xfrm>
            <a:off x="6073062" y="5422327"/>
            <a:ext cx="591829" cy="307777"/>
          </a:xfrm>
          <a:prstGeom prst="rect">
            <a:avLst/>
          </a:prstGeom>
          <a:noFill/>
        </p:spPr>
        <p:txBody>
          <a:bodyPr wrap="none" rtlCol="0">
            <a:spAutoFit/>
          </a:bodyPr>
          <a:lstStyle/>
          <a:p>
            <a:pPr algn="ctr"/>
            <a:r>
              <a:rPr lang="en-US" altLang="ja-JP" sz="1400" b="1" dirty="0">
                <a:latin typeface="Helvetica" pitchFamily="2" charset="0"/>
              </a:rPr>
              <a:t>10: 1</a:t>
            </a:r>
            <a:endParaRPr lang="ja-JP" altLang="en-US" sz="1400" b="1">
              <a:latin typeface="Helvetica" pitchFamily="2" charset="0"/>
            </a:endParaRPr>
          </a:p>
        </p:txBody>
      </p:sp>
      <p:sp>
        <p:nvSpPr>
          <p:cNvPr id="166" name="テキスト ボックス 165">
            <a:extLst>
              <a:ext uri="{FF2B5EF4-FFF2-40B4-BE49-F238E27FC236}">
                <a16:creationId xmlns:a16="http://schemas.microsoft.com/office/drawing/2014/main" id="{FA34D791-D4AF-974D-BB4F-5E3CE648CB48}"/>
              </a:ext>
            </a:extLst>
          </p:cNvPr>
          <p:cNvSpPr txBox="1"/>
          <p:nvPr/>
        </p:nvSpPr>
        <p:spPr>
          <a:xfrm>
            <a:off x="4500993" y="5422327"/>
            <a:ext cx="492443" cy="307777"/>
          </a:xfrm>
          <a:prstGeom prst="rect">
            <a:avLst/>
          </a:prstGeom>
          <a:noFill/>
        </p:spPr>
        <p:txBody>
          <a:bodyPr wrap="none" rtlCol="0">
            <a:spAutoFit/>
          </a:bodyPr>
          <a:lstStyle/>
          <a:p>
            <a:pPr algn="ctr"/>
            <a:r>
              <a:rPr lang="en-US" altLang="ja-JP" sz="1400" b="1" dirty="0">
                <a:latin typeface="Helvetica" pitchFamily="2" charset="0"/>
              </a:rPr>
              <a:t>5: 1</a:t>
            </a:r>
            <a:endParaRPr lang="ja-JP" altLang="en-US" sz="1400" b="1">
              <a:latin typeface="Helvetica" pitchFamily="2" charset="0"/>
            </a:endParaRPr>
          </a:p>
        </p:txBody>
      </p:sp>
      <p:sp>
        <p:nvSpPr>
          <p:cNvPr id="167" name="テキスト ボックス 166">
            <a:extLst>
              <a:ext uri="{FF2B5EF4-FFF2-40B4-BE49-F238E27FC236}">
                <a16:creationId xmlns:a16="http://schemas.microsoft.com/office/drawing/2014/main" id="{B27BD733-93DB-1F4B-9A15-0CFBD665B847}"/>
              </a:ext>
            </a:extLst>
          </p:cNvPr>
          <p:cNvSpPr txBox="1"/>
          <p:nvPr/>
        </p:nvSpPr>
        <p:spPr>
          <a:xfrm>
            <a:off x="748711" y="5422327"/>
            <a:ext cx="1503553" cy="307777"/>
          </a:xfrm>
          <a:prstGeom prst="rect">
            <a:avLst/>
          </a:prstGeom>
          <a:noFill/>
        </p:spPr>
        <p:txBody>
          <a:bodyPr wrap="none" rtlCol="0">
            <a:spAutoFit/>
          </a:bodyPr>
          <a:lstStyle/>
          <a:p>
            <a:r>
              <a:rPr lang="en-US" altLang="ja-JP" sz="1400" b="1" dirty="0">
                <a:latin typeface="Helvetica" pitchFamily="2" charset="0"/>
              </a:rPr>
              <a:t>Effector: Target</a:t>
            </a:r>
            <a:endParaRPr lang="ja-JP" altLang="en-US" sz="1400" b="1">
              <a:latin typeface="Helvetica" pitchFamily="2" charset="0"/>
            </a:endParaRPr>
          </a:p>
        </p:txBody>
      </p:sp>
      <p:cxnSp>
        <p:nvCxnSpPr>
          <p:cNvPr id="57" name="直線コネクタ 56">
            <a:extLst>
              <a:ext uri="{FF2B5EF4-FFF2-40B4-BE49-F238E27FC236}">
                <a16:creationId xmlns:a16="http://schemas.microsoft.com/office/drawing/2014/main" id="{E9BEF0F9-1203-944F-8A7A-977EB1A38EE8}"/>
              </a:ext>
            </a:extLst>
          </p:cNvPr>
          <p:cNvCxnSpPr>
            <a:cxnSpLocks/>
          </p:cNvCxnSpPr>
          <p:nvPr/>
        </p:nvCxnSpPr>
        <p:spPr>
          <a:xfrm>
            <a:off x="2633200" y="3744502"/>
            <a:ext cx="5055121"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213" name="直線コネクタ 212">
            <a:extLst>
              <a:ext uri="{FF2B5EF4-FFF2-40B4-BE49-F238E27FC236}">
                <a16:creationId xmlns:a16="http://schemas.microsoft.com/office/drawing/2014/main" id="{4CF903B8-8392-2944-9974-BA6C179CD7FC}"/>
              </a:ext>
            </a:extLst>
          </p:cNvPr>
          <p:cNvCxnSpPr>
            <a:cxnSpLocks/>
          </p:cNvCxnSpPr>
          <p:nvPr/>
        </p:nvCxnSpPr>
        <p:spPr>
          <a:xfrm>
            <a:off x="2563350" y="1633127"/>
            <a:ext cx="6985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39" name="直線コネクタ 238">
            <a:extLst>
              <a:ext uri="{FF2B5EF4-FFF2-40B4-BE49-F238E27FC236}">
                <a16:creationId xmlns:a16="http://schemas.microsoft.com/office/drawing/2014/main" id="{6246AE74-FDB1-EB4E-A1D5-FF0010F5B426}"/>
              </a:ext>
            </a:extLst>
          </p:cNvPr>
          <p:cNvCxnSpPr>
            <a:cxnSpLocks/>
          </p:cNvCxnSpPr>
          <p:nvPr/>
        </p:nvCxnSpPr>
        <p:spPr>
          <a:xfrm>
            <a:off x="2996330" y="2378747"/>
            <a:ext cx="0" cy="86498"/>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264" name="正方形/長方形 263">
            <a:extLst>
              <a:ext uri="{FF2B5EF4-FFF2-40B4-BE49-F238E27FC236}">
                <a16:creationId xmlns:a16="http://schemas.microsoft.com/office/drawing/2014/main" id="{C905787E-344E-0C41-B54E-4DAF92EB5255}"/>
              </a:ext>
            </a:extLst>
          </p:cNvPr>
          <p:cNvSpPr/>
          <p:nvPr/>
        </p:nvSpPr>
        <p:spPr>
          <a:xfrm>
            <a:off x="3618956" y="2244089"/>
            <a:ext cx="196850" cy="1490437"/>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sp>
        <p:nvSpPr>
          <p:cNvPr id="265" name="正方形/長方形 264">
            <a:extLst>
              <a:ext uri="{FF2B5EF4-FFF2-40B4-BE49-F238E27FC236}">
                <a16:creationId xmlns:a16="http://schemas.microsoft.com/office/drawing/2014/main" id="{B04B4ED8-7779-8947-AB9E-A70FEC9BDFE1}"/>
              </a:ext>
            </a:extLst>
          </p:cNvPr>
          <p:cNvSpPr/>
          <p:nvPr/>
        </p:nvSpPr>
        <p:spPr>
          <a:xfrm>
            <a:off x="3939630" y="2195638"/>
            <a:ext cx="196850" cy="1538888"/>
          </a:xfrm>
          <a:prstGeom prst="rect">
            <a:avLst/>
          </a:prstGeom>
          <a:solidFill>
            <a:schemeClr val="bg1">
              <a:lumMod val="75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cxnSp>
        <p:nvCxnSpPr>
          <p:cNvPr id="266" name="直線コネクタ 265">
            <a:extLst>
              <a:ext uri="{FF2B5EF4-FFF2-40B4-BE49-F238E27FC236}">
                <a16:creationId xmlns:a16="http://schemas.microsoft.com/office/drawing/2014/main" id="{F6717DA7-8D80-9B49-B8DA-CDFBF99F3DBE}"/>
              </a:ext>
            </a:extLst>
          </p:cNvPr>
          <p:cNvCxnSpPr>
            <a:cxnSpLocks/>
          </p:cNvCxnSpPr>
          <p:nvPr/>
        </p:nvCxnSpPr>
        <p:spPr>
          <a:xfrm>
            <a:off x="4036467" y="2100769"/>
            <a:ext cx="0" cy="94869"/>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267" name="正方形/長方形 266">
            <a:extLst>
              <a:ext uri="{FF2B5EF4-FFF2-40B4-BE49-F238E27FC236}">
                <a16:creationId xmlns:a16="http://schemas.microsoft.com/office/drawing/2014/main" id="{FE7F876B-7505-F747-B4A4-92868CAB0BDE}"/>
              </a:ext>
            </a:extLst>
          </p:cNvPr>
          <p:cNvSpPr/>
          <p:nvPr/>
        </p:nvSpPr>
        <p:spPr>
          <a:xfrm>
            <a:off x="6862029" y="1500850"/>
            <a:ext cx="196850" cy="2233678"/>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sp>
        <p:nvSpPr>
          <p:cNvPr id="268" name="正方形/長方形 267">
            <a:extLst>
              <a:ext uri="{FF2B5EF4-FFF2-40B4-BE49-F238E27FC236}">
                <a16:creationId xmlns:a16="http://schemas.microsoft.com/office/drawing/2014/main" id="{437660BC-EA02-E84A-A1FC-B745B68EE91D}"/>
              </a:ext>
            </a:extLst>
          </p:cNvPr>
          <p:cNvSpPr/>
          <p:nvPr/>
        </p:nvSpPr>
        <p:spPr>
          <a:xfrm>
            <a:off x="7182704" y="1802473"/>
            <a:ext cx="196850" cy="1932053"/>
          </a:xfrm>
          <a:prstGeom prst="rect">
            <a:avLst/>
          </a:prstGeom>
          <a:solidFill>
            <a:schemeClr val="tx1"/>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cxnSp>
        <p:nvCxnSpPr>
          <p:cNvPr id="269" name="直線コネクタ 268">
            <a:extLst>
              <a:ext uri="{FF2B5EF4-FFF2-40B4-BE49-F238E27FC236}">
                <a16:creationId xmlns:a16="http://schemas.microsoft.com/office/drawing/2014/main" id="{8C771560-52A2-B344-91AE-76028F1818C6}"/>
              </a:ext>
            </a:extLst>
          </p:cNvPr>
          <p:cNvCxnSpPr>
            <a:cxnSpLocks/>
          </p:cNvCxnSpPr>
          <p:nvPr/>
        </p:nvCxnSpPr>
        <p:spPr>
          <a:xfrm>
            <a:off x="6955914" y="1254456"/>
            <a:ext cx="0" cy="238495"/>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270" name="直線コネクタ 269">
            <a:extLst>
              <a:ext uri="{FF2B5EF4-FFF2-40B4-BE49-F238E27FC236}">
                <a16:creationId xmlns:a16="http://schemas.microsoft.com/office/drawing/2014/main" id="{92D9CDF7-AC49-8D49-BCBA-8B362B974B89}"/>
              </a:ext>
            </a:extLst>
          </p:cNvPr>
          <p:cNvCxnSpPr>
            <a:cxnSpLocks/>
          </p:cNvCxnSpPr>
          <p:nvPr/>
        </p:nvCxnSpPr>
        <p:spPr>
          <a:xfrm>
            <a:off x="7278290" y="1445459"/>
            <a:ext cx="0" cy="348234"/>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271" name="正方形/長方形 270">
            <a:extLst>
              <a:ext uri="{FF2B5EF4-FFF2-40B4-BE49-F238E27FC236}">
                <a16:creationId xmlns:a16="http://schemas.microsoft.com/office/drawing/2014/main" id="{0C8552B1-936A-A745-9135-6D339249DF35}"/>
              </a:ext>
            </a:extLst>
          </p:cNvPr>
          <p:cNvSpPr/>
          <p:nvPr/>
        </p:nvSpPr>
        <p:spPr>
          <a:xfrm>
            <a:off x="5240266" y="1876110"/>
            <a:ext cx="196850" cy="1858416"/>
          </a:xfrm>
          <a:prstGeom prst="rect">
            <a:avLst/>
          </a:prstGeom>
          <a:solidFill>
            <a:schemeClr val="tx1">
              <a:lumMod val="50000"/>
              <a:lumOff val="50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sp>
        <p:nvSpPr>
          <p:cNvPr id="272" name="正方形/長方形 271">
            <a:extLst>
              <a:ext uri="{FF2B5EF4-FFF2-40B4-BE49-F238E27FC236}">
                <a16:creationId xmlns:a16="http://schemas.microsoft.com/office/drawing/2014/main" id="{E023C01F-B53C-0443-8EC1-23CB3B5A378F}"/>
              </a:ext>
            </a:extLst>
          </p:cNvPr>
          <p:cNvSpPr/>
          <p:nvPr/>
        </p:nvSpPr>
        <p:spPr>
          <a:xfrm>
            <a:off x="5560942" y="2019482"/>
            <a:ext cx="196850" cy="1715046"/>
          </a:xfrm>
          <a:prstGeom prst="rect">
            <a:avLst/>
          </a:prstGeom>
          <a:solidFill>
            <a:schemeClr val="tx1">
              <a:lumMod val="50000"/>
              <a:lumOff val="50000"/>
            </a:schemeClr>
          </a:solidFill>
          <a:ln>
            <a:solidFill>
              <a:schemeClr val="tx1"/>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ja-JP" altLang="en-US"/>
          </a:p>
        </p:txBody>
      </p:sp>
      <p:cxnSp>
        <p:nvCxnSpPr>
          <p:cNvPr id="273" name="直線コネクタ 272">
            <a:extLst>
              <a:ext uri="{FF2B5EF4-FFF2-40B4-BE49-F238E27FC236}">
                <a16:creationId xmlns:a16="http://schemas.microsoft.com/office/drawing/2014/main" id="{97388792-EB4B-6549-92DE-FBF462AF6651}"/>
              </a:ext>
            </a:extLst>
          </p:cNvPr>
          <p:cNvCxnSpPr>
            <a:cxnSpLocks/>
          </p:cNvCxnSpPr>
          <p:nvPr/>
        </p:nvCxnSpPr>
        <p:spPr>
          <a:xfrm>
            <a:off x="5655391" y="1965772"/>
            <a:ext cx="0" cy="44319"/>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274" name="直線コネクタ 273">
            <a:extLst>
              <a:ext uri="{FF2B5EF4-FFF2-40B4-BE49-F238E27FC236}">
                <a16:creationId xmlns:a16="http://schemas.microsoft.com/office/drawing/2014/main" id="{E5095B94-4D15-6940-853F-B5959F118CA3}"/>
              </a:ext>
            </a:extLst>
          </p:cNvPr>
          <p:cNvCxnSpPr>
            <a:cxnSpLocks/>
          </p:cNvCxnSpPr>
          <p:nvPr/>
        </p:nvCxnSpPr>
        <p:spPr>
          <a:xfrm>
            <a:off x="5333128" y="1771262"/>
            <a:ext cx="0" cy="101346"/>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275" name="テキスト ボックス 274">
            <a:extLst>
              <a:ext uri="{FF2B5EF4-FFF2-40B4-BE49-F238E27FC236}">
                <a16:creationId xmlns:a16="http://schemas.microsoft.com/office/drawing/2014/main" id="{6609DF20-804B-EE4A-AF1A-02A1FE1A27EC}"/>
              </a:ext>
            </a:extLst>
          </p:cNvPr>
          <p:cNvSpPr txBox="1"/>
          <p:nvPr/>
        </p:nvSpPr>
        <p:spPr>
          <a:xfrm rot="16200000">
            <a:off x="3301707" y="4693683"/>
            <a:ext cx="832279"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276" name="テキスト ボックス 275">
            <a:extLst>
              <a:ext uri="{FF2B5EF4-FFF2-40B4-BE49-F238E27FC236}">
                <a16:creationId xmlns:a16="http://schemas.microsoft.com/office/drawing/2014/main" id="{22D18246-5A33-C641-82FE-693D834304D5}"/>
              </a:ext>
            </a:extLst>
          </p:cNvPr>
          <p:cNvSpPr txBox="1"/>
          <p:nvPr/>
        </p:nvSpPr>
        <p:spPr>
          <a:xfrm rot="16200000">
            <a:off x="3575146" y="4742984"/>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sp>
        <p:nvSpPr>
          <p:cNvPr id="277" name="テキスト ボックス 276">
            <a:extLst>
              <a:ext uri="{FF2B5EF4-FFF2-40B4-BE49-F238E27FC236}">
                <a16:creationId xmlns:a16="http://schemas.microsoft.com/office/drawing/2014/main" id="{497B9746-9F35-674E-9D35-AC7E545EAAA8}"/>
              </a:ext>
            </a:extLst>
          </p:cNvPr>
          <p:cNvSpPr txBox="1"/>
          <p:nvPr/>
        </p:nvSpPr>
        <p:spPr>
          <a:xfrm rot="16200000">
            <a:off x="4927463" y="4691546"/>
            <a:ext cx="832279"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278" name="テキスト ボックス 277">
            <a:extLst>
              <a:ext uri="{FF2B5EF4-FFF2-40B4-BE49-F238E27FC236}">
                <a16:creationId xmlns:a16="http://schemas.microsoft.com/office/drawing/2014/main" id="{73DEF810-48AB-9849-96A6-180CB38948EF}"/>
              </a:ext>
            </a:extLst>
          </p:cNvPr>
          <p:cNvSpPr txBox="1"/>
          <p:nvPr/>
        </p:nvSpPr>
        <p:spPr>
          <a:xfrm rot="16200000">
            <a:off x="5200902" y="4742984"/>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sp>
        <p:nvSpPr>
          <p:cNvPr id="279" name="テキスト ボックス 278">
            <a:extLst>
              <a:ext uri="{FF2B5EF4-FFF2-40B4-BE49-F238E27FC236}">
                <a16:creationId xmlns:a16="http://schemas.microsoft.com/office/drawing/2014/main" id="{C9324027-00E3-5B49-85A7-8CCBF7E3EE80}"/>
              </a:ext>
            </a:extLst>
          </p:cNvPr>
          <p:cNvSpPr txBox="1"/>
          <p:nvPr/>
        </p:nvSpPr>
        <p:spPr>
          <a:xfrm rot="16200000">
            <a:off x="6545947" y="4693291"/>
            <a:ext cx="832279"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280" name="テキスト ボックス 279">
            <a:extLst>
              <a:ext uri="{FF2B5EF4-FFF2-40B4-BE49-F238E27FC236}">
                <a16:creationId xmlns:a16="http://schemas.microsoft.com/office/drawing/2014/main" id="{3CB3BC84-1218-3046-8E21-209F7461FCEB}"/>
              </a:ext>
            </a:extLst>
          </p:cNvPr>
          <p:cNvSpPr txBox="1"/>
          <p:nvPr/>
        </p:nvSpPr>
        <p:spPr>
          <a:xfrm rot="16200000">
            <a:off x="6819386" y="4742984"/>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cxnSp>
        <p:nvCxnSpPr>
          <p:cNvPr id="281" name="直線コネクタ 280">
            <a:extLst>
              <a:ext uri="{FF2B5EF4-FFF2-40B4-BE49-F238E27FC236}">
                <a16:creationId xmlns:a16="http://schemas.microsoft.com/office/drawing/2014/main" id="{954D65EF-F14F-C447-967B-9CD599A7B026}"/>
              </a:ext>
            </a:extLst>
          </p:cNvPr>
          <p:cNvCxnSpPr>
            <a:cxnSpLocks/>
          </p:cNvCxnSpPr>
          <p:nvPr/>
        </p:nvCxnSpPr>
        <p:spPr>
          <a:xfrm>
            <a:off x="3711562" y="2032110"/>
            <a:ext cx="0" cy="211659"/>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145" name="テキスト ボックス 144">
            <a:extLst>
              <a:ext uri="{FF2B5EF4-FFF2-40B4-BE49-F238E27FC236}">
                <a16:creationId xmlns:a16="http://schemas.microsoft.com/office/drawing/2014/main" id="{DC88A4D1-64A0-AD46-A586-011E23C8CA7D}"/>
              </a:ext>
            </a:extLst>
          </p:cNvPr>
          <p:cNvSpPr txBox="1"/>
          <p:nvPr/>
        </p:nvSpPr>
        <p:spPr>
          <a:xfrm>
            <a:off x="748711" y="3785677"/>
            <a:ext cx="1277914" cy="307777"/>
          </a:xfrm>
          <a:prstGeom prst="rect">
            <a:avLst/>
          </a:prstGeom>
          <a:noFill/>
        </p:spPr>
        <p:txBody>
          <a:bodyPr wrap="none" rtlCol="0">
            <a:spAutoFit/>
          </a:bodyPr>
          <a:lstStyle/>
          <a:p>
            <a:r>
              <a:rPr lang="en-US" altLang="ja-JP" sz="1400" b="1" dirty="0">
                <a:latin typeface="Helvetica" pitchFamily="2" charset="0"/>
              </a:rPr>
              <a:t>Control IgG: </a:t>
            </a:r>
            <a:endParaRPr lang="ja-JP" altLang="en-US" sz="1400" b="1">
              <a:latin typeface="Helvetica" pitchFamily="2" charset="0"/>
            </a:endParaRPr>
          </a:p>
        </p:txBody>
      </p:sp>
      <p:sp>
        <p:nvSpPr>
          <p:cNvPr id="244" name="テキスト ボックス 243">
            <a:extLst>
              <a:ext uri="{FF2B5EF4-FFF2-40B4-BE49-F238E27FC236}">
                <a16:creationId xmlns:a16="http://schemas.microsoft.com/office/drawing/2014/main" id="{65887653-5C3B-DB4B-9616-BC975DB17550}"/>
              </a:ext>
            </a:extLst>
          </p:cNvPr>
          <p:cNvSpPr txBox="1"/>
          <p:nvPr/>
        </p:nvSpPr>
        <p:spPr>
          <a:xfrm>
            <a:off x="748711" y="4044401"/>
            <a:ext cx="822469" cy="307777"/>
          </a:xfrm>
          <a:prstGeom prst="rect">
            <a:avLst/>
          </a:prstGeom>
          <a:noFill/>
        </p:spPr>
        <p:txBody>
          <a:bodyPr wrap="none" rtlCol="0">
            <a:spAutoFit/>
          </a:bodyPr>
          <a:lstStyle/>
          <a:p>
            <a:r>
              <a:rPr lang="en-US" altLang="ja-JP" sz="1400" b="1" dirty="0">
                <a:latin typeface="Helvetica" pitchFamily="2" charset="0"/>
              </a:rPr>
              <a:t>YS110: </a:t>
            </a:r>
            <a:endParaRPr lang="ja-JP" altLang="en-US" sz="1400" b="1">
              <a:latin typeface="Helvetica" pitchFamily="2" charset="0"/>
            </a:endParaRPr>
          </a:p>
        </p:txBody>
      </p:sp>
      <p:sp>
        <p:nvSpPr>
          <p:cNvPr id="146" name="テキスト ボックス 145">
            <a:extLst>
              <a:ext uri="{FF2B5EF4-FFF2-40B4-BE49-F238E27FC236}">
                <a16:creationId xmlns:a16="http://schemas.microsoft.com/office/drawing/2014/main" id="{134DEAAD-C394-154A-8333-050747A94B62}"/>
              </a:ext>
            </a:extLst>
          </p:cNvPr>
          <p:cNvSpPr txBox="1"/>
          <p:nvPr/>
        </p:nvSpPr>
        <p:spPr>
          <a:xfrm>
            <a:off x="2854844" y="3785677"/>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28" name="テキスト ボックス 227">
            <a:extLst>
              <a:ext uri="{FF2B5EF4-FFF2-40B4-BE49-F238E27FC236}">
                <a16:creationId xmlns:a16="http://schemas.microsoft.com/office/drawing/2014/main" id="{FBE86AB9-887D-A445-96F8-E56252716A33}"/>
              </a:ext>
            </a:extLst>
          </p:cNvPr>
          <p:cNvSpPr txBox="1"/>
          <p:nvPr/>
        </p:nvSpPr>
        <p:spPr>
          <a:xfrm>
            <a:off x="3174164" y="3785677"/>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0" name="テキスト ボックス 239">
            <a:extLst>
              <a:ext uri="{FF2B5EF4-FFF2-40B4-BE49-F238E27FC236}">
                <a16:creationId xmlns:a16="http://schemas.microsoft.com/office/drawing/2014/main" id="{DAA7A5B0-C182-A64B-9F74-C8BE6FC830AF}"/>
              </a:ext>
            </a:extLst>
          </p:cNvPr>
          <p:cNvSpPr txBox="1"/>
          <p:nvPr/>
        </p:nvSpPr>
        <p:spPr>
          <a:xfrm>
            <a:off x="4486107" y="3785677"/>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1" name="テキスト ボックス 240">
            <a:extLst>
              <a:ext uri="{FF2B5EF4-FFF2-40B4-BE49-F238E27FC236}">
                <a16:creationId xmlns:a16="http://schemas.microsoft.com/office/drawing/2014/main" id="{D8F195F5-6DA3-C04E-86E1-2641E9477230}"/>
              </a:ext>
            </a:extLst>
          </p:cNvPr>
          <p:cNvSpPr txBox="1"/>
          <p:nvPr/>
        </p:nvSpPr>
        <p:spPr>
          <a:xfrm>
            <a:off x="4800744" y="3785677"/>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2" name="テキスト ボックス 241">
            <a:extLst>
              <a:ext uri="{FF2B5EF4-FFF2-40B4-BE49-F238E27FC236}">
                <a16:creationId xmlns:a16="http://schemas.microsoft.com/office/drawing/2014/main" id="{DBEEDBA7-25D6-4146-97F1-A5BD6C0C4D98}"/>
              </a:ext>
            </a:extLst>
          </p:cNvPr>
          <p:cNvSpPr txBox="1"/>
          <p:nvPr/>
        </p:nvSpPr>
        <p:spPr>
          <a:xfrm>
            <a:off x="6098148" y="3785677"/>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3" name="テキスト ボックス 242">
            <a:extLst>
              <a:ext uri="{FF2B5EF4-FFF2-40B4-BE49-F238E27FC236}">
                <a16:creationId xmlns:a16="http://schemas.microsoft.com/office/drawing/2014/main" id="{871C949A-D4DF-E64F-995A-868A1F2BA1FA}"/>
              </a:ext>
            </a:extLst>
          </p:cNvPr>
          <p:cNvSpPr txBox="1"/>
          <p:nvPr/>
        </p:nvSpPr>
        <p:spPr>
          <a:xfrm>
            <a:off x="6421210" y="3785677"/>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5" name="テキスト ボックス 244">
            <a:extLst>
              <a:ext uri="{FF2B5EF4-FFF2-40B4-BE49-F238E27FC236}">
                <a16:creationId xmlns:a16="http://schemas.microsoft.com/office/drawing/2014/main" id="{68B6CB5E-654E-D041-B39F-84B72C5BACD1}"/>
              </a:ext>
            </a:extLst>
          </p:cNvPr>
          <p:cNvSpPr txBox="1"/>
          <p:nvPr/>
        </p:nvSpPr>
        <p:spPr>
          <a:xfrm>
            <a:off x="2877286" y="4044401"/>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6" name="テキスト ボックス 245">
            <a:extLst>
              <a:ext uri="{FF2B5EF4-FFF2-40B4-BE49-F238E27FC236}">
                <a16:creationId xmlns:a16="http://schemas.microsoft.com/office/drawing/2014/main" id="{1AC49F27-B58E-9346-B075-455701B0C70F}"/>
              </a:ext>
            </a:extLst>
          </p:cNvPr>
          <p:cNvSpPr txBox="1"/>
          <p:nvPr/>
        </p:nvSpPr>
        <p:spPr>
          <a:xfrm>
            <a:off x="3196606" y="4044401"/>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7" name="テキスト ボックス 246">
            <a:extLst>
              <a:ext uri="{FF2B5EF4-FFF2-40B4-BE49-F238E27FC236}">
                <a16:creationId xmlns:a16="http://schemas.microsoft.com/office/drawing/2014/main" id="{7C0E2F0B-499B-524D-8E4C-6AF1E0A2E441}"/>
              </a:ext>
            </a:extLst>
          </p:cNvPr>
          <p:cNvSpPr txBox="1"/>
          <p:nvPr/>
        </p:nvSpPr>
        <p:spPr>
          <a:xfrm>
            <a:off x="4508549" y="4044401"/>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8" name="テキスト ボックス 247">
            <a:extLst>
              <a:ext uri="{FF2B5EF4-FFF2-40B4-BE49-F238E27FC236}">
                <a16:creationId xmlns:a16="http://schemas.microsoft.com/office/drawing/2014/main" id="{2F41FB3B-0DAD-1F4B-A5DA-C03E2B1E3AB9}"/>
              </a:ext>
            </a:extLst>
          </p:cNvPr>
          <p:cNvSpPr txBox="1"/>
          <p:nvPr/>
        </p:nvSpPr>
        <p:spPr>
          <a:xfrm>
            <a:off x="4823186" y="4044401"/>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49" name="テキスト ボックス 248">
            <a:extLst>
              <a:ext uri="{FF2B5EF4-FFF2-40B4-BE49-F238E27FC236}">
                <a16:creationId xmlns:a16="http://schemas.microsoft.com/office/drawing/2014/main" id="{01F4024A-9096-4E42-9288-74157728119C}"/>
              </a:ext>
            </a:extLst>
          </p:cNvPr>
          <p:cNvSpPr txBox="1"/>
          <p:nvPr/>
        </p:nvSpPr>
        <p:spPr>
          <a:xfrm>
            <a:off x="6120590" y="4044401"/>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50" name="テキスト ボックス 249">
            <a:extLst>
              <a:ext uri="{FF2B5EF4-FFF2-40B4-BE49-F238E27FC236}">
                <a16:creationId xmlns:a16="http://schemas.microsoft.com/office/drawing/2014/main" id="{CA43576B-7376-D94A-AB56-F882CFC110F9}"/>
              </a:ext>
            </a:extLst>
          </p:cNvPr>
          <p:cNvSpPr txBox="1"/>
          <p:nvPr/>
        </p:nvSpPr>
        <p:spPr>
          <a:xfrm>
            <a:off x="6443652" y="4044401"/>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2" name="テキスト ボックス 281">
            <a:extLst>
              <a:ext uri="{FF2B5EF4-FFF2-40B4-BE49-F238E27FC236}">
                <a16:creationId xmlns:a16="http://schemas.microsoft.com/office/drawing/2014/main" id="{5892233C-2A74-BC4F-8006-5759C62B2DEA}"/>
              </a:ext>
            </a:extLst>
          </p:cNvPr>
          <p:cNvSpPr txBox="1"/>
          <p:nvPr/>
        </p:nvSpPr>
        <p:spPr>
          <a:xfrm>
            <a:off x="3596750" y="3782210"/>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3" name="テキスト ボックス 282">
            <a:extLst>
              <a:ext uri="{FF2B5EF4-FFF2-40B4-BE49-F238E27FC236}">
                <a16:creationId xmlns:a16="http://schemas.microsoft.com/office/drawing/2014/main" id="{FF66B863-538C-F14B-9B1E-53A384441A9C}"/>
              </a:ext>
            </a:extLst>
          </p:cNvPr>
          <p:cNvSpPr txBox="1"/>
          <p:nvPr/>
        </p:nvSpPr>
        <p:spPr>
          <a:xfrm>
            <a:off x="3916070" y="3782210"/>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4" name="テキスト ボックス 283">
            <a:extLst>
              <a:ext uri="{FF2B5EF4-FFF2-40B4-BE49-F238E27FC236}">
                <a16:creationId xmlns:a16="http://schemas.microsoft.com/office/drawing/2014/main" id="{C30B9D0C-C3B6-E949-9AE9-9893A00E9C6B}"/>
              </a:ext>
            </a:extLst>
          </p:cNvPr>
          <p:cNvSpPr txBox="1"/>
          <p:nvPr/>
        </p:nvSpPr>
        <p:spPr>
          <a:xfrm>
            <a:off x="5228013" y="3782210"/>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5" name="テキスト ボックス 284">
            <a:extLst>
              <a:ext uri="{FF2B5EF4-FFF2-40B4-BE49-F238E27FC236}">
                <a16:creationId xmlns:a16="http://schemas.microsoft.com/office/drawing/2014/main" id="{B202372D-887E-7E41-B797-022797F01091}"/>
              </a:ext>
            </a:extLst>
          </p:cNvPr>
          <p:cNvSpPr txBox="1"/>
          <p:nvPr/>
        </p:nvSpPr>
        <p:spPr>
          <a:xfrm>
            <a:off x="5542650" y="3782210"/>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6" name="テキスト ボックス 285">
            <a:extLst>
              <a:ext uri="{FF2B5EF4-FFF2-40B4-BE49-F238E27FC236}">
                <a16:creationId xmlns:a16="http://schemas.microsoft.com/office/drawing/2014/main" id="{CA55FAAE-85D5-8940-9B77-7AD8ED75541F}"/>
              </a:ext>
            </a:extLst>
          </p:cNvPr>
          <p:cNvSpPr txBox="1"/>
          <p:nvPr/>
        </p:nvSpPr>
        <p:spPr>
          <a:xfrm>
            <a:off x="6840054" y="3782210"/>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7" name="テキスト ボックス 286">
            <a:extLst>
              <a:ext uri="{FF2B5EF4-FFF2-40B4-BE49-F238E27FC236}">
                <a16:creationId xmlns:a16="http://schemas.microsoft.com/office/drawing/2014/main" id="{2D121A75-A20F-D747-9F0D-F04A4703BEE2}"/>
              </a:ext>
            </a:extLst>
          </p:cNvPr>
          <p:cNvSpPr txBox="1"/>
          <p:nvPr/>
        </p:nvSpPr>
        <p:spPr>
          <a:xfrm>
            <a:off x="7163116" y="3782210"/>
            <a:ext cx="243978"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8" name="テキスト ボックス 287">
            <a:extLst>
              <a:ext uri="{FF2B5EF4-FFF2-40B4-BE49-F238E27FC236}">
                <a16:creationId xmlns:a16="http://schemas.microsoft.com/office/drawing/2014/main" id="{4D5E6BB4-1E6B-3C43-9590-A6768A34529E}"/>
              </a:ext>
            </a:extLst>
          </p:cNvPr>
          <p:cNvSpPr txBox="1"/>
          <p:nvPr/>
        </p:nvSpPr>
        <p:spPr>
          <a:xfrm>
            <a:off x="3574308" y="4040934"/>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89" name="テキスト ボックス 288">
            <a:extLst>
              <a:ext uri="{FF2B5EF4-FFF2-40B4-BE49-F238E27FC236}">
                <a16:creationId xmlns:a16="http://schemas.microsoft.com/office/drawing/2014/main" id="{9E6A74FC-FC6F-D54E-837F-56FD03A06617}"/>
              </a:ext>
            </a:extLst>
          </p:cNvPr>
          <p:cNvSpPr txBox="1"/>
          <p:nvPr/>
        </p:nvSpPr>
        <p:spPr>
          <a:xfrm>
            <a:off x="3893628" y="4040934"/>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90" name="テキスト ボックス 289">
            <a:extLst>
              <a:ext uri="{FF2B5EF4-FFF2-40B4-BE49-F238E27FC236}">
                <a16:creationId xmlns:a16="http://schemas.microsoft.com/office/drawing/2014/main" id="{51D4B50B-478A-5444-B415-4E6BDAA9F989}"/>
              </a:ext>
            </a:extLst>
          </p:cNvPr>
          <p:cNvSpPr txBox="1"/>
          <p:nvPr/>
        </p:nvSpPr>
        <p:spPr>
          <a:xfrm>
            <a:off x="5205571" y="4040934"/>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91" name="テキスト ボックス 290">
            <a:extLst>
              <a:ext uri="{FF2B5EF4-FFF2-40B4-BE49-F238E27FC236}">
                <a16:creationId xmlns:a16="http://schemas.microsoft.com/office/drawing/2014/main" id="{5A2F7FBA-7948-0C40-A235-D30D670E2DBA}"/>
              </a:ext>
            </a:extLst>
          </p:cNvPr>
          <p:cNvSpPr txBox="1"/>
          <p:nvPr/>
        </p:nvSpPr>
        <p:spPr>
          <a:xfrm>
            <a:off x="5520208" y="4040934"/>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92" name="テキスト ボックス 291">
            <a:extLst>
              <a:ext uri="{FF2B5EF4-FFF2-40B4-BE49-F238E27FC236}">
                <a16:creationId xmlns:a16="http://schemas.microsoft.com/office/drawing/2014/main" id="{A306064C-39D4-4A4D-9F5B-5CE751ED618A}"/>
              </a:ext>
            </a:extLst>
          </p:cNvPr>
          <p:cNvSpPr txBox="1"/>
          <p:nvPr/>
        </p:nvSpPr>
        <p:spPr>
          <a:xfrm>
            <a:off x="6817612" y="4040934"/>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sp>
        <p:nvSpPr>
          <p:cNvPr id="293" name="テキスト ボックス 292">
            <a:extLst>
              <a:ext uri="{FF2B5EF4-FFF2-40B4-BE49-F238E27FC236}">
                <a16:creationId xmlns:a16="http://schemas.microsoft.com/office/drawing/2014/main" id="{B2EB4C20-4600-564E-BBD6-696A1AD170A4}"/>
              </a:ext>
            </a:extLst>
          </p:cNvPr>
          <p:cNvSpPr txBox="1"/>
          <p:nvPr/>
        </p:nvSpPr>
        <p:spPr>
          <a:xfrm>
            <a:off x="7140674" y="4040934"/>
            <a:ext cx="288862" cy="307777"/>
          </a:xfrm>
          <a:prstGeom prst="rect">
            <a:avLst/>
          </a:prstGeom>
          <a:noFill/>
        </p:spPr>
        <p:txBody>
          <a:bodyPr wrap="none" rtlCol="0">
            <a:spAutoFit/>
          </a:bodyPr>
          <a:lstStyle/>
          <a:p>
            <a:pPr algn="ctr"/>
            <a:r>
              <a:rPr lang="en-US" altLang="ja-JP" sz="1400" b="1" dirty="0">
                <a:latin typeface="Helvetica" pitchFamily="2" charset="0"/>
              </a:rPr>
              <a:t>+</a:t>
            </a:r>
            <a:endParaRPr lang="ja-JP" altLang="en-US" sz="1400" b="1">
              <a:latin typeface="Helvetica" pitchFamily="2" charset="0"/>
            </a:endParaRPr>
          </a:p>
        </p:txBody>
      </p:sp>
      <p:cxnSp>
        <p:nvCxnSpPr>
          <p:cNvPr id="295" name="直線コネクタ 294">
            <a:extLst>
              <a:ext uri="{FF2B5EF4-FFF2-40B4-BE49-F238E27FC236}">
                <a16:creationId xmlns:a16="http://schemas.microsoft.com/office/drawing/2014/main" id="{B24D9CFF-E8E2-994C-9B33-EC89F451D118}"/>
              </a:ext>
            </a:extLst>
          </p:cNvPr>
          <p:cNvCxnSpPr>
            <a:cxnSpLocks/>
          </p:cNvCxnSpPr>
          <p:nvPr/>
        </p:nvCxnSpPr>
        <p:spPr>
          <a:xfrm>
            <a:off x="4935633" y="976675"/>
            <a:ext cx="0" cy="18000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99" name="直線コネクタ 298">
            <a:extLst>
              <a:ext uri="{FF2B5EF4-FFF2-40B4-BE49-F238E27FC236}">
                <a16:creationId xmlns:a16="http://schemas.microsoft.com/office/drawing/2014/main" id="{61B4E4E0-864B-014C-8845-C2D7C9CD5768}"/>
              </a:ext>
            </a:extLst>
          </p:cNvPr>
          <p:cNvCxnSpPr>
            <a:cxnSpLocks/>
          </p:cNvCxnSpPr>
          <p:nvPr/>
        </p:nvCxnSpPr>
        <p:spPr>
          <a:xfrm>
            <a:off x="5655012" y="976573"/>
            <a:ext cx="0" cy="18000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01" name="直線コネクタ 300">
            <a:extLst>
              <a:ext uri="{FF2B5EF4-FFF2-40B4-BE49-F238E27FC236}">
                <a16:creationId xmlns:a16="http://schemas.microsoft.com/office/drawing/2014/main" id="{6CF278D7-06E9-F14F-A083-E122E7063140}"/>
              </a:ext>
            </a:extLst>
          </p:cNvPr>
          <p:cNvCxnSpPr>
            <a:cxnSpLocks/>
          </p:cNvCxnSpPr>
          <p:nvPr/>
        </p:nvCxnSpPr>
        <p:spPr>
          <a:xfrm flipH="1">
            <a:off x="4940737" y="973236"/>
            <a:ext cx="710613"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03" name="直線コネクタ 302">
            <a:extLst>
              <a:ext uri="{FF2B5EF4-FFF2-40B4-BE49-F238E27FC236}">
                <a16:creationId xmlns:a16="http://schemas.microsoft.com/office/drawing/2014/main" id="{8E9D30C2-4237-D447-9C8C-1D776DF3134F}"/>
              </a:ext>
            </a:extLst>
          </p:cNvPr>
          <p:cNvCxnSpPr>
            <a:cxnSpLocks/>
          </p:cNvCxnSpPr>
          <p:nvPr/>
        </p:nvCxnSpPr>
        <p:spPr>
          <a:xfrm>
            <a:off x="6559274" y="975783"/>
            <a:ext cx="0" cy="18000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07" name="直線コネクタ 306">
            <a:extLst>
              <a:ext uri="{FF2B5EF4-FFF2-40B4-BE49-F238E27FC236}">
                <a16:creationId xmlns:a16="http://schemas.microsoft.com/office/drawing/2014/main" id="{0EF21355-3139-234B-8E8B-F75A5096205A}"/>
              </a:ext>
            </a:extLst>
          </p:cNvPr>
          <p:cNvCxnSpPr>
            <a:cxnSpLocks/>
          </p:cNvCxnSpPr>
          <p:nvPr/>
        </p:nvCxnSpPr>
        <p:spPr>
          <a:xfrm>
            <a:off x="7278653" y="975681"/>
            <a:ext cx="0" cy="18000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309" name="直線コネクタ 308">
            <a:extLst>
              <a:ext uri="{FF2B5EF4-FFF2-40B4-BE49-F238E27FC236}">
                <a16:creationId xmlns:a16="http://schemas.microsoft.com/office/drawing/2014/main" id="{C6E24C08-3252-7144-B80F-29E6C2B2AFA4}"/>
              </a:ext>
            </a:extLst>
          </p:cNvPr>
          <p:cNvCxnSpPr>
            <a:cxnSpLocks/>
          </p:cNvCxnSpPr>
          <p:nvPr/>
        </p:nvCxnSpPr>
        <p:spPr>
          <a:xfrm flipH="1">
            <a:off x="6559040" y="972344"/>
            <a:ext cx="713529"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311" name="テキスト ボックス 310">
            <a:extLst>
              <a:ext uri="{FF2B5EF4-FFF2-40B4-BE49-F238E27FC236}">
                <a16:creationId xmlns:a16="http://schemas.microsoft.com/office/drawing/2014/main" id="{23BCC1CA-B8F3-A84B-8A67-D34C0149D815}"/>
              </a:ext>
            </a:extLst>
          </p:cNvPr>
          <p:cNvSpPr txBox="1"/>
          <p:nvPr/>
        </p:nvSpPr>
        <p:spPr>
          <a:xfrm>
            <a:off x="2279297" y="1479237"/>
            <a:ext cx="284052" cy="307777"/>
          </a:xfrm>
          <a:prstGeom prst="rect">
            <a:avLst/>
          </a:prstGeom>
          <a:noFill/>
        </p:spPr>
        <p:txBody>
          <a:bodyPr wrap="none" rtlCol="0">
            <a:spAutoFit/>
          </a:bodyPr>
          <a:lstStyle/>
          <a:p>
            <a:pPr algn="r"/>
            <a:r>
              <a:rPr lang="en-US" altLang="ja-JP" sz="1400" b="1" dirty="0">
                <a:latin typeface="Helvetica" pitchFamily="2" charset="0"/>
              </a:rPr>
              <a:t>5</a:t>
            </a:r>
            <a:endParaRPr lang="ja-JP" altLang="en-US" sz="1400" b="1">
              <a:latin typeface="Helvetica" pitchFamily="2" charset="0"/>
            </a:endParaRPr>
          </a:p>
        </p:txBody>
      </p:sp>
      <p:sp>
        <p:nvSpPr>
          <p:cNvPr id="312" name="テキスト ボックス 311">
            <a:extLst>
              <a:ext uri="{FF2B5EF4-FFF2-40B4-BE49-F238E27FC236}">
                <a16:creationId xmlns:a16="http://schemas.microsoft.com/office/drawing/2014/main" id="{1C4AE41E-9CA7-F54E-8697-361EF908BBCB}"/>
              </a:ext>
            </a:extLst>
          </p:cNvPr>
          <p:cNvSpPr txBox="1"/>
          <p:nvPr/>
        </p:nvSpPr>
        <p:spPr>
          <a:xfrm>
            <a:off x="2279297" y="3168337"/>
            <a:ext cx="284052" cy="307777"/>
          </a:xfrm>
          <a:prstGeom prst="rect">
            <a:avLst/>
          </a:prstGeom>
          <a:noFill/>
        </p:spPr>
        <p:txBody>
          <a:bodyPr wrap="none" rtlCol="0">
            <a:spAutoFit/>
          </a:bodyPr>
          <a:lstStyle/>
          <a:p>
            <a:pPr algn="r"/>
            <a:r>
              <a:rPr lang="en-US" altLang="ja-JP" sz="1400" b="1" dirty="0">
                <a:latin typeface="Helvetica" pitchFamily="2" charset="0"/>
              </a:rPr>
              <a:t>1</a:t>
            </a:r>
            <a:endParaRPr lang="ja-JP" altLang="en-US" sz="1400" b="1">
              <a:latin typeface="Helvetica" pitchFamily="2" charset="0"/>
            </a:endParaRPr>
          </a:p>
        </p:txBody>
      </p:sp>
      <p:sp>
        <p:nvSpPr>
          <p:cNvPr id="313" name="テキスト ボックス 312">
            <a:extLst>
              <a:ext uri="{FF2B5EF4-FFF2-40B4-BE49-F238E27FC236}">
                <a16:creationId xmlns:a16="http://schemas.microsoft.com/office/drawing/2014/main" id="{E69EAD0C-A2DB-7E4D-9BF8-9BF6394FA886}"/>
              </a:ext>
            </a:extLst>
          </p:cNvPr>
          <p:cNvSpPr txBox="1"/>
          <p:nvPr/>
        </p:nvSpPr>
        <p:spPr>
          <a:xfrm>
            <a:off x="2279297" y="2323787"/>
            <a:ext cx="284052" cy="307777"/>
          </a:xfrm>
          <a:prstGeom prst="rect">
            <a:avLst/>
          </a:prstGeom>
          <a:noFill/>
        </p:spPr>
        <p:txBody>
          <a:bodyPr wrap="none" rtlCol="0">
            <a:spAutoFit/>
          </a:bodyPr>
          <a:lstStyle/>
          <a:p>
            <a:pPr algn="r"/>
            <a:r>
              <a:rPr lang="en-US" altLang="ja-JP" sz="1400" b="1" dirty="0">
                <a:latin typeface="Helvetica" pitchFamily="2" charset="0"/>
              </a:rPr>
              <a:t>3</a:t>
            </a:r>
            <a:endParaRPr lang="ja-JP" altLang="en-US" sz="1400" b="1">
              <a:latin typeface="Helvetica" pitchFamily="2" charset="0"/>
            </a:endParaRPr>
          </a:p>
        </p:txBody>
      </p:sp>
      <p:sp>
        <p:nvSpPr>
          <p:cNvPr id="2" name="テキスト ボックス 1">
            <a:extLst>
              <a:ext uri="{FF2B5EF4-FFF2-40B4-BE49-F238E27FC236}">
                <a16:creationId xmlns:a16="http://schemas.microsoft.com/office/drawing/2014/main" id="{7C98A1DB-9A85-DD78-F973-DEF76F2FD7E4}"/>
              </a:ext>
            </a:extLst>
          </p:cNvPr>
          <p:cNvSpPr txBox="1"/>
          <p:nvPr/>
        </p:nvSpPr>
        <p:spPr>
          <a:xfrm>
            <a:off x="4873491" y="664378"/>
            <a:ext cx="845103" cy="307777"/>
          </a:xfrm>
          <a:prstGeom prst="rect">
            <a:avLst/>
          </a:prstGeom>
          <a:noFill/>
        </p:spPr>
        <p:txBody>
          <a:bodyPr wrap="none" rtlCol="0">
            <a:spAutoFit/>
          </a:bodyPr>
          <a:lstStyle/>
          <a:p>
            <a:pPr algn="ctr"/>
            <a:r>
              <a:rPr lang="en-US" altLang="ja-JP" sz="1400" b="1" dirty="0">
                <a:latin typeface="Helvetica" pitchFamily="2" charset="0"/>
              </a:rPr>
              <a:t>p&lt;0.001</a:t>
            </a:r>
            <a:endParaRPr lang="ja-JP" altLang="en-US" sz="1400" b="1">
              <a:latin typeface="Helvetica" pitchFamily="2" charset="0"/>
            </a:endParaRPr>
          </a:p>
        </p:txBody>
      </p:sp>
      <p:sp>
        <p:nvSpPr>
          <p:cNvPr id="9" name="テキスト ボックス 8">
            <a:extLst>
              <a:ext uri="{FF2B5EF4-FFF2-40B4-BE49-F238E27FC236}">
                <a16:creationId xmlns:a16="http://schemas.microsoft.com/office/drawing/2014/main" id="{1F43FB5F-5200-D672-114E-B2E7C8BDD2A0}"/>
              </a:ext>
            </a:extLst>
          </p:cNvPr>
          <p:cNvSpPr txBox="1"/>
          <p:nvPr/>
        </p:nvSpPr>
        <p:spPr>
          <a:xfrm>
            <a:off x="6501367" y="663486"/>
            <a:ext cx="845104" cy="307777"/>
          </a:xfrm>
          <a:prstGeom prst="rect">
            <a:avLst/>
          </a:prstGeom>
          <a:noFill/>
        </p:spPr>
        <p:txBody>
          <a:bodyPr wrap="none" rtlCol="0">
            <a:spAutoFit/>
          </a:bodyPr>
          <a:lstStyle/>
          <a:p>
            <a:pPr algn="ctr"/>
            <a:r>
              <a:rPr lang="en-US" altLang="ja-JP" sz="1400" b="1" dirty="0">
                <a:latin typeface="Helvetica" pitchFamily="2" charset="0"/>
              </a:rPr>
              <a:t>p=0.006</a:t>
            </a:r>
            <a:endParaRPr lang="ja-JP" altLang="en-US" sz="1400" b="1">
              <a:latin typeface="Helvetica" pitchFamily="2" charset="0"/>
            </a:endParaRPr>
          </a:p>
        </p:txBody>
      </p:sp>
      <p:sp>
        <p:nvSpPr>
          <p:cNvPr id="4" name="テキスト ボックス 3">
            <a:extLst>
              <a:ext uri="{FF2B5EF4-FFF2-40B4-BE49-F238E27FC236}">
                <a16:creationId xmlns:a16="http://schemas.microsoft.com/office/drawing/2014/main" id="{2498D44D-1A31-16A2-CD0B-8D8156A12216}"/>
              </a:ext>
            </a:extLst>
          </p:cNvPr>
          <p:cNvSpPr txBox="1"/>
          <p:nvPr/>
        </p:nvSpPr>
        <p:spPr>
          <a:xfrm>
            <a:off x="920197" y="6111107"/>
            <a:ext cx="7176051" cy="1015663"/>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ＭＳ Ｐゴシック" panose="020B0600070205080204" pitchFamily="34" charset="-128"/>
              </a:rPr>
              <a:t>Figure S4: Blocking effect of YS110 against CD26 3G CAR-T cells.</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20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Target cells (KARPAS299 cells) were co-cultured with effector cells (CD26 3G CAR-T cells or CD8 3G control cells) at an effector: target ratio of 1:1, 5:1, and 10:1 with </a:t>
            </a:r>
            <a:r>
              <a:rPr lang="en-US" altLang="ja-JP" sz="1200" dirty="0">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control IgG or YS110. </a:t>
            </a:r>
            <a:r>
              <a:rPr lang="en-US" altLang="ja-JP" sz="120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Anti-tumor activity of effector cells was evaluated by measurement of luciferase activity from the target cells. </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42412003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1" name="グループ化 100">
            <a:extLst>
              <a:ext uri="{FF2B5EF4-FFF2-40B4-BE49-F238E27FC236}">
                <a16:creationId xmlns:a16="http://schemas.microsoft.com/office/drawing/2014/main" id="{66745FD4-F887-A51E-CF90-9186D6391273}"/>
              </a:ext>
            </a:extLst>
          </p:cNvPr>
          <p:cNvGrpSpPr/>
          <p:nvPr/>
        </p:nvGrpSpPr>
        <p:grpSpPr>
          <a:xfrm>
            <a:off x="778622" y="506906"/>
            <a:ext cx="5873650" cy="2503747"/>
            <a:chOff x="1510142" y="6125331"/>
            <a:chExt cx="5873650" cy="2503747"/>
          </a:xfrm>
        </p:grpSpPr>
        <p:grpSp>
          <p:nvGrpSpPr>
            <p:cNvPr id="70" name="グループ化 69">
              <a:extLst>
                <a:ext uri="{FF2B5EF4-FFF2-40B4-BE49-F238E27FC236}">
                  <a16:creationId xmlns:a16="http://schemas.microsoft.com/office/drawing/2014/main" id="{958FEB05-FE0B-39C9-73CE-19C23EB1CD7F}"/>
                </a:ext>
              </a:extLst>
            </p:cNvPr>
            <p:cNvGrpSpPr/>
            <p:nvPr/>
          </p:nvGrpSpPr>
          <p:grpSpPr>
            <a:xfrm>
              <a:off x="1510142" y="6468153"/>
              <a:ext cx="1080000" cy="2160925"/>
              <a:chOff x="494542" y="375034"/>
              <a:chExt cx="1080000" cy="2160925"/>
            </a:xfrm>
          </p:grpSpPr>
          <p:pic>
            <p:nvPicPr>
              <p:cNvPr id="71" name="図 70">
                <a:extLst>
                  <a:ext uri="{FF2B5EF4-FFF2-40B4-BE49-F238E27FC236}">
                    <a16:creationId xmlns:a16="http://schemas.microsoft.com/office/drawing/2014/main" id="{796D2185-BCCA-9D42-2492-13B7F893659B}"/>
                  </a:ext>
                </a:extLst>
              </p:cNvPr>
              <p:cNvPicPr>
                <a:picLocks/>
              </p:cNvPicPr>
              <p:nvPr/>
            </p:nvPicPr>
            <p:blipFill>
              <a:blip r:embed="rId2"/>
              <a:stretch>
                <a:fillRect/>
              </a:stretch>
            </p:blipFill>
            <p:spPr>
              <a:xfrm>
                <a:off x="494542" y="375034"/>
                <a:ext cx="1080000" cy="1080925"/>
              </a:xfrm>
              <a:prstGeom prst="rect">
                <a:avLst/>
              </a:prstGeom>
            </p:spPr>
          </p:pic>
          <p:pic>
            <p:nvPicPr>
              <p:cNvPr id="72" name="図 71">
                <a:extLst>
                  <a:ext uri="{FF2B5EF4-FFF2-40B4-BE49-F238E27FC236}">
                    <a16:creationId xmlns:a16="http://schemas.microsoft.com/office/drawing/2014/main" id="{41950A02-F4E5-F13B-F5D6-E1699A66AA27}"/>
                  </a:ext>
                </a:extLst>
              </p:cNvPr>
              <p:cNvPicPr>
                <a:picLocks noChangeAspect="1"/>
              </p:cNvPicPr>
              <p:nvPr/>
            </p:nvPicPr>
            <p:blipFill>
              <a:blip r:embed="rId3"/>
              <a:stretch>
                <a:fillRect/>
              </a:stretch>
            </p:blipFill>
            <p:spPr>
              <a:xfrm>
                <a:off x="494542" y="1455959"/>
                <a:ext cx="1080000" cy="1080000"/>
              </a:xfrm>
              <a:prstGeom prst="rect">
                <a:avLst/>
              </a:prstGeom>
            </p:spPr>
          </p:pic>
        </p:grpSp>
        <p:grpSp>
          <p:nvGrpSpPr>
            <p:cNvPr id="74" name="グループ化 73">
              <a:extLst>
                <a:ext uri="{FF2B5EF4-FFF2-40B4-BE49-F238E27FC236}">
                  <a16:creationId xmlns:a16="http://schemas.microsoft.com/office/drawing/2014/main" id="{7796B4AB-DA72-78DC-7B1F-B7AFA95C264F}"/>
                </a:ext>
              </a:extLst>
            </p:cNvPr>
            <p:cNvGrpSpPr/>
            <p:nvPr/>
          </p:nvGrpSpPr>
          <p:grpSpPr>
            <a:xfrm>
              <a:off x="2710596" y="6468153"/>
              <a:ext cx="1080000" cy="2160925"/>
              <a:chOff x="1820716" y="375034"/>
              <a:chExt cx="1080000" cy="2160925"/>
            </a:xfrm>
          </p:grpSpPr>
          <p:pic>
            <p:nvPicPr>
              <p:cNvPr id="75" name="図 74">
                <a:extLst>
                  <a:ext uri="{FF2B5EF4-FFF2-40B4-BE49-F238E27FC236}">
                    <a16:creationId xmlns:a16="http://schemas.microsoft.com/office/drawing/2014/main" id="{30597123-93DB-0062-9032-9759EAEBF113}"/>
                  </a:ext>
                </a:extLst>
              </p:cNvPr>
              <p:cNvPicPr>
                <a:picLocks noChangeAspect="1"/>
              </p:cNvPicPr>
              <p:nvPr/>
            </p:nvPicPr>
            <p:blipFill>
              <a:blip r:embed="rId4"/>
              <a:stretch>
                <a:fillRect/>
              </a:stretch>
            </p:blipFill>
            <p:spPr>
              <a:xfrm>
                <a:off x="1820716" y="375034"/>
                <a:ext cx="1080000" cy="1080000"/>
              </a:xfrm>
              <a:prstGeom prst="rect">
                <a:avLst/>
              </a:prstGeom>
            </p:spPr>
          </p:pic>
          <p:pic>
            <p:nvPicPr>
              <p:cNvPr id="76" name="図 75">
                <a:extLst>
                  <a:ext uri="{FF2B5EF4-FFF2-40B4-BE49-F238E27FC236}">
                    <a16:creationId xmlns:a16="http://schemas.microsoft.com/office/drawing/2014/main" id="{9C64F985-8C16-BD09-69E8-7746C3BE3D92}"/>
                  </a:ext>
                </a:extLst>
              </p:cNvPr>
              <p:cNvPicPr>
                <a:picLocks/>
              </p:cNvPicPr>
              <p:nvPr/>
            </p:nvPicPr>
            <p:blipFill>
              <a:blip r:embed="rId5"/>
              <a:stretch>
                <a:fillRect/>
              </a:stretch>
            </p:blipFill>
            <p:spPr>
              <a:xfrm>
                <a:off x="1820716" y="1455959"/>
                <a:ext cx="1080000" cy="1080000"/>
              </a:xfrm>
              <a:prstGeom prst="rect">
                <a:avLst/>
              </a:prstGeom>
            </p:spPr>
          </p:pic>
        </p:grpSp>
        <p:grpSp>
          <p:nvGrpSpPr>
            <p:cNvPr id="78" name="グループ化 77">
              <a:extLst>
                <a:ext uri="{FF2B5EF4-FFF2-40B4-BE49-F238E27FC236}">
                  <a16:creationId xmlns:a16="http://schemas.microsoft.com/office/drawing/2014/main" id="{6EA7E8FD-08BB-C31A-D1C4-E81009CF0837}"/>
                </a:ext>
              </a:extLst>
            </p:cNvPr>
            <p:cNvGrpSpPr/>
            <p:nvPr/>
          </p:nvGrpSpPr>
          <p:grpSpPr>
            <a:xfrm>
              <a:off x="3908328" y="6468153"/>
              <a:ext cx="1080000" cy="2160925"/>
              <a:chOff x="3173488" y="375034"/>
              <a:chExt cx="1080000" cy="2160925"/>
            </a:xfrm>
          </p:grpSpPr>
          <p:pic>
            <p:nvPicPr>
              <p:cNvPr id="79" name="図 78">
                <a:extLst>
                  <a:ext uri="{FF2B5EF4-FFF2-40B4-BE49-F238E27FC236}">
                    <a16:creationId xmlns:a16="http://schemas.microsoft.com/office/drawing/2014/main" id="{C9DF4178-6D1F-ACCF-7F6C-C851A64FA01F}"/>
                  </a:ext>
                </a:extLst>
              </p:cNvPr>
              <p:cNvPicPr>
                <a:picLocks noChangeAspect="1"/>
              </p:cNvPicPr>
              <p:nvPr/>
            </p:nvPicPr>
            <p:blipFill>
              <a:blip r:embed="rId6"/>
              <a:stretch>
                <a:fillRect/>
              </a:stretch>
            </p:blipFill>
            <p:spPr>
              <a:xfrm>
                <a:off x="3173488" y="375034"/>
                <a:ext cx="363600" cy="1076096"/>
              </a:xfrm>
              <a:prstGeom prst="rect">
                <a:avLst/>
              </a:prstGeom>
            </p:spPr>
          </p:pic>
          <p:pic>
            <p:nvPicPr>
              <p:cNvPr id="80" name="図 79">
                <a:extLst>
                  <a:ext uri="{FF2B5EF4-FFF2-40B4-BE49-F238E27FC236}">
                    <a16:creationId xmlns:a16="http://schemas.microsoft.com/office/drawing/2014/main" id="{56F7EB04-3150-676F-06A7-F453E3FABE13}"/>
                  </a:ext>
                </a:extLst>
              </p:cNvPr>
              <p:cNvPicPr>
                <a:picLocks noChangeAspect="1"/>
              </p:cNvPicPr>
              <p:nvPr/>
            </p:nvPicPr>
            <p:blipFill>
              <a:blip r:embed="rId7"/>
              <a:stretch>
                <a:fillRect/>
              </a:stretch>
            </p:blipFill>
            <p:spPr>
              <a:xfrm>
                <a:off x="3540688" y="375034"/>
                <a:ext cx="712800" cy="1077892"/>
              </a:xfrm>
              <a:prstGeom prst="rect">
                <a:avLst/>
              </a:prstGeom>
            </p:spPr>
          </p:pic>
          <p:pic>
            <p:nvPicPr>
              <p:cNvPr id="81" name="図 80">
                <a:extLst>
                  <a:ext uri="{FF2B5EF4-FFF2-40B4-BE49-F238E27FC236}">
                    <a16:creationId xmlns:a16="http://schemas.microsoft.com/office/drawing/2014/main" id="{F5D5155C-F878-F72C-5E5B-0EB66D148012}"/>
                  </a:ext>
                </a:extLst>
              </p:cNvPr>
              <p:cNvPicPr>
                <a:picLocks noChangeAspect="1"/>
              </p:cNvPicPr>
              <p:nvPr/>
            </p:nvPicPr>
            <p:blipFill>
              <a:blip r:embed="rId8"/>
              <a:stretch>
                <a:fillRect/>
              </a:stretch>
            </p:blipFill>
            <p:spPr>
              <a:xfrm>
                <a:off x="3173488" y="1454619"/>
                <a:ext cx="1080000" cy="1081340"/>
              </a:xfrm>
              <a:prstGeom prst="rect">
                <a:avLst/>
              </a:prstGeom>
            </p:spPr>
          </p:pic>
        </p:grpSp>
        <p:grpSp>
          <p:nvGrpSpPr>
            <p:cNvPr id="83" name="グループ化 82">
              <a:extLst>
                <a:ext uri="{FF2B5EF4-FFF2-40B4-BE49-F238E27FC236}">
                  <a16:creationId xmlns:a16="http://schemas.microsoft.com/office/drawing/2014/main" id="{F33BD888-A699-4D8B-361C-5FC9FC7BDF4D}"/>
                </a:ext>
              </a:extLst>
            </p:cNvPr>
            <p:cNvGrpSpPr/>
            <p:nvPr/>
          </p:nvGrpSpPr>
          <p:grpSpPr>
            <a:xfrm>
              <a:off x="5106060" y="6468153"/>
              <a:ext cx="1080000" cy="2160925"/>
              <a:chOff x="4590924" y="375034"/>
              <a:chExt cx="1080000" cy="2160925"/>
            </a:xfrm>
          </p:grpSpPr>
          <p:pic>
            <p:nvPicPr>
              <p:cNvPr id="84" name="図 83">
                <a:extLst>
                  <a:ext uri="{FF2B5EF4-FFF2-40B4-BE49-F238E27FC236}">
                    <a16:creationId xmlns:a16="http://schemas.microsoft.com/office/drawing/2014/main" id="{88312CD4-C2AA-985D-41EB-E3151067C928}"/>
                  </a:ext>
                </a:extLst>
              </p:cNvPr>
              <p:cNvPicPr>
                <a:picLocks/>
              </p:cNvPicPr>
              <p:nvPr/>
            </p:nvPicPr>
            <p:blipFill>
              <a:blip r:embed="rId9"/>
              <a:stretch>
                <a:fillRect/>
              </a:stretch>
            </p:blipFill>
            <p:spPr>
              <a:xfrm>
                <a:off x="4590924" y="375034"/>
                <a:ext cx="1080000" cy="1080000"/>
              </a:xfrm>
              <a:prstGeom prst="rect">
                <a:avLst/>
              </a:prstGeom>
            </p:spPr>
          </p:pic>
          <p:pic>
            <p:nvPicPr>
              <p:cNvPr id="85" name="図 84">
                <a:extLst>
                  <a:ext uri="{FF2B5EF4-FFF2-40B4-BE49-F238E27FC236}">
                    <a16:creationId xmlns:a16="http://schemas.microsoft.com/office/drawing/2014/main" id="{2495704E-7D7F-64C1-EA48-4946A05DED1A}"/>
                  </a:ext>
                </a:extLst>
              </p:cNvPr>
              <p:cNvPicPr>
                <a:picLocks/>
              </p:cNvPicPr>
              <p:nvPr/>
            </p:nvPicPr>
            <p:blipFill>
              <a:blip r:embed="rId10"/>
              <a:stretch>
                <a:fillRect/>
              </a:stretch>
            </p:blipFill>
            <p:spPr>
              <a:xfrm>
                <a:off x="4590924" y="1455959"/>
                <a:ext cx="1080000" cy="1080000"/>
              </a:xfrm>
              <a:prstGeom prst="rect">
                <a:avLst/>
              </a:prstGeom>
            </p:spPr>
          </p:pic>
        </p:grpSp>
        <p:grpSp>
          <p:nvGrpSpPr>
            <p:cNvPr id="87" name="グループ化 86">
              <a:extLst>
                <a:ext uri="{FF2B5EF4-FFF2-40B4-BE49-F238E27FC236}">
                  <a16:creationId xmlns:a16="http://schemas.microsoft.com/office/drawing/2014/main" id="{0EF4BEF7-24EE-B03B-7195-F2ED69382E01}"/>
                </a:ext>
              </a:extLst>
            </p:cNvPr>
            <p:cNvGrpSpPr/>
            <p:nvPr/>
          </p:nvGrpSpPr>
          <p:grpSpPr>
            <a:xfrm>
              <a:off x="6303792" y="6468153"/>
              <a:ext cx="1080000" cy="2160925"/>
              <a:chOff x="6135862" y="375034"/>
              <a:chExt cx="1080000" cy="2160925"/>
            </a:xfrm>
          </p:grpSpPr>
          <p:pic>
            <p:nvPicPr>
              <p:cNvPr id="88" name="図 87">
                <a:extLst>
                  <a:ext uri="{FF2B5EF4-FFF2-40B4-BE49-F238E27FC236}">
                    <a16:creationId xmlns:a16="http://schemas.microsoft.com/office/drawing/2014/main" id="{E547A6B4-0EAE-5BF2-B890-350B68200EEF}"/>
                  </a:ext>
                </a:extLst>
              </p:cNvPr>
              <p:cNvPicPr>
                <a:picLocks noChangeAspect="1"/>
              </p:cNvPicPr>
              <p:nvPr/>
            </p:nvPicPr>
            <p:blipFill>
              <a:blip r:embed="rId11"/>
              <a:stretch>
                <a:fillRect/>
              </a:stretch>
            </p:blipFill>
            <p:spPr>
              <a:xfrm>
                <a:off x="6135862" y="375034"/>
                <a:ext cx="720000" cy="1082011"/>
              </a:xfrm>
              <a:prstGeom prst="rect">
                <a:avLst/>
              </a:prstGeom>
            </p:spPr>
          </p:pic>
          <p:pic>
            <p:nvPicPr>
              <p:cNvPr id="89" name="図 88">
                <a:extLst>
                  <a:ext uri="{FF2B5EF4-FFF2-40B4-BE49-F238E27FC236}">
                    <a16:creationId xmlns:a16="http://schemas.microsoft.com/office/drawing/2014/main" id="{60B21484-85AE-63C8-F134-8FE38A4D6F49}"/>
                  </a:ext>
                </a:extLst>
              </p:cNvPr>
              <p:cNvPicPr>
                <a:picLocks noChangeAspect="1"/>
              </p:cNvPicPr>
              <p:nvPr/>
            </p:nvPicPr>
            <p:blipFill>
              <a:blip r:embed="rId12"/>
              <a:stretch>
                <a:fillRect/>
              </a:stretch>
            </p:blipFill>
            <p:spPr>
              <a:xfrm>
                <a:off x="6852262" y="375034"/>
                <a:ext cx="363600" cy="1077384"/>
              </a:xfrm>
              <a:prstGeom prst="rect">
                <a:avLst/>
              </a:prstGeom>
            </p:spPr>
          </p:pic>
          <p:pic>
            <p:nvPicPr>
              <p:cNvPr id="91" name="図 90">
                <a:extLst>
                  <a:ext uri="{FF2B5EF4-FFF2-40B4-BE49-F238E27FC236}">
                    <a16:creationId xmlns:a16="http://schemas.microsoft.com/office/drawing/2014/main" id="{FA8736A5-8C1B-98CE-B366-7E58E350C9DE}"/>
                  </a:ext>
                </a:extLst>
              </p:cNvPr>
              <p:cNvPicPr>
                <a:picLocks/>
              </p:cNvPicPr>
              <p:nvPr/>
            </p:nvPicPr>
            <p:blipFill>
              <a:blip r:embed="rId13"/>
              <a:stretch>
                <a:fillRect/>
              </a:stretch>
            </p:blipFill>
            <p:spPr>
              <a:xfrm>
                <a:off x="6135862" y="1455959"/>
                <a:ext cx="1080000" cy="1080000"/>
              </a:xfrm>
              <a:prstGeom prst="rect">
                <a:avLst/>
              </a:prstGeom>
            </p:spPr>
          </p:pic>
        </p:grpSp>
        <p:sp>
          <p:nvSpPr>
            <p:cNvPr id="93" name="テキスト ボックス 92">
              <a:extLst>
                <a:ext uri="{FF2B5EF4-FFF2-40B4-BE49-F238E27FC236}">
                  <a16:creationId xmlns:a16="http://schemas.microsoft.com/office/drawing/2014/main" id="{1B8711FF-66A7-95A8-91EB-73CB5A6BBDEE}"/>
                </a:ext>
              </a:extLst>
            </p:cNvPr>
            <p:cNvSpPr txBox="1"/>
            <p:nvPr/>
          </p:nvSpPr>
          <p:spPr>
            <a:xfrm>
              <a:off x="2834456" y="6125331"/>
              <a:ext cx="832280" cy="307777"/>
            </a:xfrm>
            <a:prstGeom prst="rect">
              <a:avLst/>
            </a:prstGeom>
            <a:noFill/>
          </p:spPr>
          <p:txBody>
            <a:bodyPr wrap="none" rtlCol="0">
              <a:spAutoFit/>
            </a:bodyPr>
            <a:lstStyle/>
            <a:p>
              <a:pPr algn="r"/>
              <a:r>
                <a:rPr lang="en-US" altLang="ja-JP" sz="1400" b="1" dirty="0">
                  <a:latin typeface="Helvetica" pitchFamily="2" charset="0"/>
                </a:rPr>
                <a:t>CD8 2G</a:t>
              </a:r>
              <a:endParaRPr lang="ja-JP" altLang="en-US" sz="1400" b="1">
                <a:latin typeface="Helvetica" pitchFamily="2" charset="0"/>
              </a:endParaRPr>
            </a:p>
          </p:txBody>
        </p:sp>
        <p:sp>
          <p:nvSpPr>
            <p:cNvPr id="94" name="テキスト ボックス 93">
              <a:extLst>
                <a:ext uri="{FF2B5EF4-FFF2-40B4-BE49-F238E27FC236}">
                  <a16:creationId xmlns:a16="http://schemas.microsoft.com/office/drawing/2014/main" id="{26DF6B67-C075-94E4-1C7B-AE697ED4B106}"/>
                </a:ext>
              </a:extLst>
            </p:cNvPr>
            <p:cNvSpPr txBox="1"/>
            <p:nvPr/>
          </p:nvSpPr>
          <p:spPr>
            <a:xfrm>
              <a:off x="4032188" y="6125331"/>
              <a:ext cx="832280" cy="307777"/>
            </a:xfrm>
            <a:prstGeom prst="rect">
              <a:avLst/>
            </a:prstGeom>
            <a:noFill/>
          </p:spPr>
          <p:txBody>
            <a:bodyPr wrap="none" rtlCol="0">
              <a:spAutoFit/>
            </a:bodyPr>
            <a:lstStyle/>
            <a:p>
              <a:pPr algn="r"/>
              <a:r>
                <a:rPr lang="en-US" altLang="ja-JP" sz="1400" b="1" dirty="0">
                  <a:latin typeface="Helvetica" pitchFamily="2" charset="0"/>
                </a:rPr>
                <a:t>CD8 3G</a:t>
              </a:r>
              <a:endParaRPr lang="ja-JP" altLang="en-US" sz="1400" b="1">
                <a:latin typeface="Helvetica" pitchFamily="2" charset="0"/>
              </a:endParaRPr>
            </a:p>
          </p:txBody>
        </p:sp>
        <p:sp>
          <p:nvSpPr>
            <p:cNvPr id="95" name="テキスト ボックス 94">
              <a:extLst>
                <a:ext uri="{FF2B5EF4-FFF2-40B4-BE49-F238E27FC236}">
                  <a16:creationId xmlns:a16="http://schemas.microsoft.com/office/drawing/2014/main" id="{AC6597CB-75F1-E107-7B9B-D0EF6AF6647C}"/>
                </a:ext>
              </a:extLst>
            </p:cNvPr>
            <p:cNvSpPr txBox="1"/>
            <p:nvPr/>
          </p:nvSpPr>
          <p:spPr>
            <a:xfrm>
              <a:off x="5180227" y="6125331"/>
              <a:ext cx="931666" cy="307777"/>
            </a:xfrm>
            <a:prstGeom prst="rect">
              <a:avLst/>
            </a:prstGeom>
            <a:noFill/>
          </p:spPr>
          <p:txBody>
            <a:bodyPr wrap="none" rtlCol="0">
              <a:spAutoFit/>
            </a:bodyPr>
            <a:lstStyle/>
            <a:p>
              <a:pPr algn="r"/>
              <a:r>
                <a:rPr lang="en-US" altLang="ja-JP" sz="1400" b="1" dirty="0">
                  <a:latin typeface="Helvetica" pitchFamily="2" charset="0"/>
                </a:rPr>
                <a:t>CD26 2G</a:t>
              </a:r>
              <a:endParaRPr lang="ja-JP" altLang="en-US" sz="1400" b="1">
                <a:latin typeface="Helvetica" pitchFamily="2" charset="0"/>
              </a:endParaRPr>
            </a:p>
          </p:txBody>
        </p:sp>
        <p:sp>
          <p:nvSpPr>
            <p:cNvPr id="96" name="テキスト ボックス 95">
              <a:extLst>
                <a:ext uri="{FF2B5EF4-FFF2-40B4-BE49-F238E27FC236}">
                  <a16:creationId xmlns:a16="http://schemas.microsoft.com/office/drawing/2014/main" id="{316E9C25-EA3E-95FA-291D-1757B01A1837}"/>
                </a:ext>
              </a:extLst>
            </p:cNvPr>
            <p:cNvSpPr txBox="1"/>
            <p:nvPr/>
          </p:nvSpPr>
          <p:spPr>
            <a:xfrm>
              <a:off x="1838385" y="6125331"/>
              <a:ext cx="423514" cy="307777"/>
            </a:xfrm>
            <a:prstGeom prst="rect">
              <a:avLst/>
            </a:prstGeom>
            <a:noFill/>
          </p:spPr>
          <p:txBody>
            <a:bodyPr wrap="none" rtlCol="0">
              <a:spAutoFit/>
            </a:bodyPr>
            <a:lstStyle/>
            <a:p>
              <a:pPr algn="r"/>
              <a:r>
                <a:rPr lang="en-US" altLang="ja-JP" sz="1400" b="1" dirty="0">
                  <a:latin typeface="Helvetica" pitchFamily="2" charset="0"/>
                </a:rPr>
                <a:t>NT</a:t>
              </a:r>
              <a:endParaRPr lang="ja-JP" altLang="en-US" sz="1400" b="1">
                <a:latin typeface="Helvetica" pitchFamily="2" charset="0"/>
              </a:endParaRPr>
            </a:p>
          </p:txBody>
        </p:sp>
        <p:sp>
          <p:nvSpPr>
            <p:cNvPr id="97" name="テキスト ボックス 96">
              <a:extLst>
                <a:ext uri="{FF2B5EF4-FFF2-40B4-BE49-F238E27FC236}">
                  <a16:creationId xmlns:a16="http://schemas.microsoft.com/office/drawing/2014/main" id="{EF672B71-45F0-4C49-0DFF-2205EF3D7CA9}"/>
                </a:ext>
              </a:extLst>
            </p:cNvPr>
            <p:cNvSpPr txBox="1"/>
            <p:nvPr/>
          </p:nvSpPr>
          <p:spPr>
            <a:xfrm>
              <a:off x="6377959" y="6125331"/>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grpSp>
      <p:pic>
        <p:nvPicPr>
          <p:cNvPr id="2" name="Picture 25" descr="A picture containing text, screenshot&#10;&#10;Description automatically generated">
            <a:extLst>
              <a:ext uri="{FF2B5EF4-FFF2-40B4-BE49-F238E27FC236}">
                <a16:creationId xmlns:a16="http://schemas.microsoft.com/office/drawing/2014/main" id="{B8D1691F-C4FC-45C2-7EA8-ED4EDCD7FAA6}"/>
              </a:ext>
            </a:extLst>
          </p:cNvPr>
          <p:cNvPicPr>
            <a:picLocks noChangeAspect="1"/>
          </p:cNvPicPr>
          <p:nvPr/>
        </p:nvPicPr>
        <p:blipFill rotWithShape="1">
          <a:blip r:embed="rId14"/>
          <a:srcRect l="89859" t="18845"/>
          <a:stretch/>
        </p:blipFill>
        <p:spPr>
          <a:xfrm>
            <a:off x="6750955" y="849728"/>
            <a:ext cx="474234" cy="2160925"/>
          </a:xfrm>
          <a:prstGeom prst="rect">
            <a:avLst/>
          </a:prstGeom>
        </p:spPr>
      </p:pic>
      <p:sp>
        <p:nvSpPr>
          <p:cNvPr id="4" name="テキスト ボックス 3">
            <a:extLst>
              <a:ext uri="{FF2B5EF4-FFF2-40B4-BE49-F238E27FC236}">
                <a16:creationId xmlns:a16="http://schemas.microsoft.com/office/drawing/2014/main" id="{1C2A80ED-CAD6-5DCE-79C9-7DD019BB049E}"/>
              </a:ext>
            </a:extLst>
          </p:cNvPr>
          <p:cNvSpPr txBox="1"/>
          <p:nvPr/>
        </p:nvSpPr>
        <p:spPr>
          <a:xfrm>
            <a:off x="723644" y="3534663"/>
            <a:ext cx="6422278" cy="461665"/>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ＭＳ Ｐゴシック" panose="020B0600070205080204" pitchFamily="34" charset="-128"/>
              </a:rPr>
              <a:t>Figure S5: Monitoring of mice transplanted with HSB2 cells by IVIS.</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200" dirty="0">
                <a:solidFill>
                  <a:srgbClr val="000000"/>
                </a:solidFill>
                <a:effectLst/>
                <a:latin typeface="Century" panose="02040604050505020304" pitchFamily="18" charset="0"/>
                <a:ea typeface="ＭＳ 明朝" panose="02020609040205080304" pitchFamily="49" charset="-128"/>
                <a:cs typeface="ＭＳ Ｐゴシック" panose="020B0600070205080204" pitchFamily="34" charset="-128"/>
              </a:rPr>
              <a:t>Actual photographic data of luciferase luminescence of Figure 5C. </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31004557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594F8C3-51FF-142A-1DC8-70FBE0843DBD}"/>
              </a:ext>
            </a:extLst>
          </p:cNvPr>
          <p:cNvPicPr>
            <a:picLocks noChangeAspect="1"/>
          </p:cNvPicPr>
          <p:nvPr/>
        </p:nvPicPr>
        <p:blipFill>
          <a:blip r:embed="rId2"/>
          <a:stretch>
            <a:fillRect/>
          </a:stretch>
        </p:blipFill>
        <p:spPr>
          <a:xfrm>
            <a:off x="785040" y="3400447"/>
            <a:ext cx="2032000" cy="1981200"/>
          </a:xfrm>
          <a:prstGeom prst="rect">
            <a:avLst/>
          </a:prstGeom>
        </p:spPr>
      </p:pic>
      <p:pic>
        <p:nvPicPr>
          <p:cNvPr id="3" name="Picture 7">
            <a:extLst>
              <a:ext uri="{FF2B5EF4-FFF2-40B4-BE49-F238E27FC236}">
                <a16:creationId xmlns:a16="http://schemas.microsoft.com/office/drawing/2014/main" id="{D0620C53-6333-D8A6-B6F7-BC313C846AB0}"/>
              </a:ext>
            </a:extLst>
          </p:cNvPr>
          <p:cNvPicPr>
            <a:picLocks noChangeAspect="1"/>
          </p:cNvPicPr>
          <p:nvPr/>
        </p:nvPicPr>
        <p:blipFill>
          <a:blip r:embed="rId3"/>
          <a:stretch>
            <a:fillRect/>
          </a:stretch>
        </p:blipFill>
        <p:spPr>
          <a:xfrm>
            <a:off x="753178" y="686052"/>
            <a:ext cx="2057400" cy="1981200"/>
          </a:xfrm>
          <a:prstGeom prst="rect">
            <a:avLst/>
          </a:prstGeom>
        </p:spPr>
      </p:pic>
      <p:pic>
        <p:nvPicPr>
          <p:cNvPr id="4" name="Picture 8">
            <a:extLst>
              <a:ext uri="{FF2B5EF4-FFF2-40B4-BE49-F238E27FC236}">
                <a16:creationId xmlns:a16="http://schemas.microsoft.com/office/drawing/2014/main" id="{A746D332-CB66-8DA3-7A54-3D88F65ABEE4}"/>
              </a:ext>
            </a:extLst>
          </p:cNvPr>
          <p:cNvPicPr>
            <a:picLocks noChangeAspect="1"/>
          </p:cNvPicPr>
          <p:nvPr/>
        </p:nvPicPr>
        <p:blipFill>
          <a:blip r:embed="rId4"/>
          <a:stretch>
            <a:fillRect/>
          </a:stretch>
        </p:blipFill>
        <p:spPr>
          <a:xfrm>
            <a:off x="3503499" y="686052"/>
            <a:ext cx="2032000" cy="1981200"/>
          </a:xfrm>
          <a:prstGeom prst="rect">
            <a:avLst/>
          </a:prstGeom>
        </p:spPr>
      </p:pic>
      <p:pic>
        <p:nvPicPr>
          <p:cNvPr id="5" name="Picture 9">
            <a:extLst>
              <a:ext uri="{FF2B5EF4-FFF2-40B4-BE49-F238E27FC236}">
                <a16:creationId xmlns:a16="http://schemas.microsoft.com/office/drawing/2014/main" id="{EB6D79BA-0954-944D-33A4-2B4DB8BCCF69}"/>
              </a:ext>
            </a:extLst>
          </p:cNvPr>
          <p:cNvPicPr>
            <a:picLocks noChangeAspect="1"/>
          </p:cNvPicPr>
          <p:nvPr/>
        </p:nvPicPr>
        <p:blipFill>
          <a:blip r:embed="rId5"/>
          <a:stretch>
            <a:fillRect/>
          </a:stretch>
        </p:blipFill>
        <p:spPr>
          <a:xfrm>
            <a:off x="6228420" y="686052"/>
            <a:ext cx="2032000" cy="1981200"/>
          </a:xfrm>
          <a:prstGeom prst="rect">
            <a:avLst/>
          </a:prstGeom>
        </p:spPr>
      </p:pic>
      <p:pic>
        <p:nvPicPr>
          <p:cNvPr id="6" name="Picture 13">
            <a:extLst>
              <a:ext uri="{FF2B5EF4-FFF2-40B4-BE49-F238E27FC236}">
                <a16:creationId xmlns:a16="http://schemas.microsoft.com/office/drawing/2014/main" id="{CD9BBFF9-FE24-C789-7B85-3E057D99FF1F}"/>
              </a:ext>
            </a:extLst>
          </p:cNvPr>
          <p:cNvPicPr>
            <a:picLocks noChangeAspect="1"/>
          </p:cNvPicPr>
          <p:nvPr/>
        </p:nvPicPr>
        <p:blipFill>
          <a:blip r:embed="rId6"/>
          <a:stretch>
            <a:fillRect/>
          </a:stretch>
        </p:blipFill>
        <p:spPr>
          <a:xfrm>
            <a:off x="3503499" y="3376661"/>
            <a:ext cx="2032000" cy="1981200"/>
          </a:xfrm>
          <a:prstGeom prst="rect">
            <a:avLst/>
          </a:prstGeom>
        </p:spPr>
      </p:pic>
      <p:sp>
        <p:nvSpPr>
          <p:cNvPr id="7" name="TextBox 15">
            <a:extLst>
              <a:ext uri="{FF2B5EF4-FFF2-40B4-BE49-F238E27FC236}">
                <a16:creationId xmlns:a16="http://schemas.microsoft.com/office/drawing/2014/main" id="{C5AE53C5-8A93-540E-66A4-9FE1FCFE8814}"/>
              </a:ext>
            </a:extLst>
          </p:cNvPr>
          <p:cNvSpPr txBox="1"/>
          <p:nvPr/>
        </p:nvSpPr>
        <p:spPr>
          <a:xfrm>
            <a:off x="416257" y="316892"/>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a:t>
            </a:r>
            <a:r>
              <a:rPr lang="en-US" altLang="ja-JP" b="1" dirty="0">
                <a:latin typeface="Helvetica" pitchFamily="2" charset="0"/>
                <a:ea typeface="Meiryo" panose="020B0604030504040204" pitchFamily="34" charset="-128"/>
              </a:rPr>
              <a:t>A</a:t>
            </a:r>
            <a:r>
              <a:rPr lang="en-US" altLang="ja-JP" b="1" dirty="0">
                <a:solidFill>
                  <a:prstClr val="black"/>
                </a:solidFill>
                <a:latin typeface="Helvetica" pitchFamily="2" charset="0"/>
                <a:ea typeface="Meiryo" panose="020B0604030504040204" pitchFamily="34" charset="-128"/>
              </a:rPr>
              <a:t>)</a:t>
            </a:r>
          </a:p>
        </p:txBody>
      </p:sp>
      <p:sp>
        <p:nvSpPr>
          <p:cNvPr id="9" name="テキスト ボックス 8">
            <a:extLst>
              <a:ext uri="{FF2B5EF4-FFF2-40B4-BE49-F238E27FC236}">
                <a16:creationId xmlns:a16="http://schemas.microsoft.com/office/drawing/2014/main" id="{FE910396-D5AB-2D8E-6099-E2C21079AAF2}"/>
              </a:ext>
            </a:extLst>
          </p:cNvPr>
          <p:cNvSpPr txBox="1"/>
          <p:nvPr/>
        </p:nvSpPr>
        <p:spPr>
          <a:xfrm>
            <a:off x="6773289" y="2667252"/>
            <a:ext cx="1329210" cy="307777"/>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human CD45 </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0" name="テキスト ボックス 9">
            <a:extLst>
              <a:ext uri="{FF2B5EF4-FFF2-40B4-BE49-F238E27FC236}">
                <a16:creationId xmlns:a16="http://schemas.microsoft.com/office/drawing/2014/main" id="{D1C290A5-5222-10FE-BF61-A64A6A4E59C9}"/>
              </a:ext>
            </a:extLst>
          </p:cNvPr>
          <p:cNvSpPr txBox="1"/>
          <p:nvPr/>
        </p:nvSpPr>
        <p:spPr>
          <a:xfrm rot="16200000">
            <a:off x="5414735" y="1432612"/>
            <a:ext cx="1319593" cy="307777"/>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mouse CD45 </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1" name="テキスト ボックス 10">
            <a:extLst>
              <a:ext uri="{FF2B5EF4-FFF2-40B4-BE49-F238E27FC236}">
                <a16:creationId xmlns:a16="http://schemas.microsoft.com/office/drawing/2014/main" id="{13BBE743-5632-F5ED-AC28-F0D86BE3C26B}"/>
              </a:ext>
            </a:extLst>
          </p:cNvPr>
          <p:cNvSpPr txBox="1"/>
          <p:nvPr/>
        </p:nvSpPr>
        <p:spPr>
          <a:xfrm rot="16200000">
            <a:off x="2699500" y="1432613"/>
            <a:ext cx="1295611" cy="307777"/>
          </a:xfrm>
          <a:prstGeom prst="rect">
            <a:avLst/>
          </a:prstGeom>
          <a:noFill/>
        </p:spPr>
        <p:txBody>
          <a:bodyPr wrap="none" rtlCol="0">
            <a:spAutoFit/>
          </a:bodyPr>
          <a:lstStyle/>
          <a:p>
            <a:pPr lvl="0" algn="ctr">
              <a:defRPr/>
            </a:pPr>
            <a:r>
              <a:rPr lang="en-US" altLang="ja-JP" sz="1400" b="1" dirty="0">
                <a:solidFill>
                  <a:prstClr val="black"/>
                </a:solidFill>
                <a:latin typeface="Helvetica" pitchFamily="2" charset="0"/>
                <a:ea typeface="游ゴシック" panose="020B0400000000000000" pitchFamily="34" charset="-128"/>
              </a:rPr>
              <a:t>Viability Dye </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13" name="TextBox 15">
            <a:extLst>
              <a:ext uri="{FF2B5EF4-FFF2-40B4-BE49-F238E27FC236}">
                <a16:creationId xmlns:a16="http://schemas.microsoft.com/office/drawing/2014/main" id="{A8078DEA-C2F3-005D-081C-2260EB0C5220}"/>
              </a:ext>
            </a:extLst>
          </p:cNvPr>
          <p:cNvSpPr txBox="1"/>
          <p:nvPr/>
        </p:nvSpPr>
        <p:spPr>
          <a:xfrm>
            <a:off x="416628" y="3016559"/>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B)</a:t>
            </a:r>
          </a:p>
        </p:txBody>
      </p:sp>
      <p:sp>
        <p:nvSpPr>
          <p:cNvPr id="14" name="TextBox 15">
            <a:extLst>
              <a:ext uri="{FF2B5EF4-FFF2-40B4-BE49-F238E27FC236}">
                <a16:creationId xmlns:a16="http://schemas.microsoft.com/office/drawing/2014/main" id="{C09629AD-5C38-4A11-BD9C-1A08ADCCAC5E}"/>
              </a:ext>
            </a:extLst>
          </p:cNvPr>
          <p:cNvSpPr txBox="1"/>
          <p:nvPr/>
        </p:nvSpPr>
        <p:spPr>
          <a:xfrm>
            <a:off x="3166949" y="3016559"/>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C)</a:t>
            </a:r>
          </a:p>
        </p:txBody>
      </p:sp>
      <p:sp>
        <p:nvSpPr>
          <p:cNvPr id="16" name="テキスト ボックス 15">
            <a:extLst>
              <a:ext uri="{FF2B5EF4-FFF2-40B4-BE49-F238E27FC236}">
                <a16:creationId xmlns:a16="http://schemas.microsoft.com/office/drawing/2014/main" id="{871B63E0-506F-4898-F517-B42C425CDDD5}"/>
              </a:ext>
            </a:extLst>
          </p:cNvPr>
          <p:cNvSpPr txBox="1"/>
          <p:nvPr/>
        </p:nvSpPr>
        <p:spPr>
          <a:xfrm>
            <a:off x="2375238" y="3170069"/>
            <a:ext cx="423514" cy="307777"/>
          </a:xfrm>
          <a:prstGeom prst="rect">
            <a:avLst/>
          </a:prstGeom>
          <a:noFill/>
        </p:spPr>
        <p:txBody>
          <a:bodyPr wrap="none" rtlCol="0">
            <a:spAutoFit/>
          </a:bodyPr>
          <a:lstStyle/>
          <a:p>
            <a:pPr algn="r"/>
            <a:r>
              <a:rPr lang="en-US" altLang="ja-JP" sz="1400" b="1" dirty="0">
                <a:latin typeface="Helvetica" pitchFamily="2" charset="0"/>
              </a:rPr>
              <a:t>NT</a:t>
            </a:r>
            <a:endParaRPr lang="ja-JP" altLang="en-US" sz="1400" b="1">
              <a:latin typeface="Helvetica" pitchFamily="2" charset="0"/>
            </a:endParaRPr>
          </a:p>
        </p:txBody>
      </p:sp>
      <p:sp>
        <p:nvSpPr>
          <p:cNvPr id="17" name="テキスト ボックス 16">
            <a:extLst>
              <a:ext uri="{FF2B5EF4-FFF2-40B4-BE49-F238E27FC236}">
                <a16:creationId xmlns:a16="http://schemas.microsoft.com/office/drawing/2014/main" id="{5034EBB0-5807-4C38-BFA0-82396AA0F2BF}"/>
              </a:ext>
            </a:extLst>
          </p:cNvPr>
          <p:cNvSpPr txBox="1"/>
          <p:nvPr/>
        </p:nvSpPr>
        <p:spPr>
          <a:xfrm>
            <a:off x="4585545" y="3146283"/>
            <a:ext cx="931666" cy="307777"/>
          </a:xfrm>
          <a:prstGeom prst="rect">
            <a:avLst/>
          </a:prstGeom>
          <a:noFill/>
        </p:spPr>
        <p:txBody>
          <a:bodyPr wrap="none" rtlCol="0">
            <a:spAutoFit/>
          </a:bodyPr>
          <a:lstStyle/>
          <a:p>
            <a:pPr algn="r"/>
            <a:r>
              <a:rPr lang="en-US" altLang="ja-JP" sz="1400" b="1" dirty="0">
                <a:latin typeface="Helvetica" pitchFamily="2" charset="0"/>
              </a:rPr>
              <a:t>CD26 3G</a:t>
            </a:r>
            <a:endParaRPr lang="ja-JP" altLang="en-US" sz="1400" b="1">
              <a:latin typeface="Helvetica" pitchFamily="2" charset="0"/>
            </a:endParaRPr>
          </a:p>
        </p:txBody>
      </p:sp>
      <p:sp>
        <p:nvSpPr>
          <p:cNvPr id="20" name="テキスト ボックス 19">
            <a:extLst>
              <a:ext uri="{FF2B5EF4-FFF2-40B4-BE49-F238E27FC236}">
                <a16:creationId xmlns:a16="http://schemas.microsoft.com/office/drawing/2014/main" id="{1CC7C99D-DE07-CDD5-0A46-5A474CA6EB0B}"/>
              </a:ext>
            </a:extLst>
          </p:cNvPr>
          <p:cNvSpPr txBox="1"/>
          <p:nvPr/>
        </p:nvSpPr>
        <p:spPr>
          <a:xfrm>
            <a:off x="1711374" y="5381647"/>
            <a:ext cx="553357" cy="307777"/>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GFP</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21" name="テキスト ボックス 20">
            <a:extLst>
              <a:ext uri="{FF2B5EF4-FFF2-40B4-BE49-F238E27FC236}">
                <a16:creationId xmlns:a16="http://schemas.microsoft.com/office/drawing/2014/main" id="{A02AC88E-02F9-E6BF-B1F3-CDA57F621EF2}"/>
              </a:ext>
            </a:extLst>
          </p:cNvPr>
          <p:cNvSpPr txBox="1"/>
          <p:nvPr/>
        </p:nvSpPr>
        <p:spPr>
          <a:xfrm rot="16200000">
            <a:off x="348011" y="4147007"/>
            <a:ext cx="553357" cy="307777"/>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KO2</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22" name="テキスト ボックス 21">
            <a:extLst>
              <a:ext uri="{FF2B5EF4-FFF2-40B4-BE49-F238E27FC236}">
                <a16:creationId xmlns:a16="http://schemas.microsoft.com/office/drawing/2014/main" id="{8DF9797A-57A3-EB01-0D08-7B62749AEB6B}"/>
              </a:ext>
            </a:extLst>
          </p:cNvPr>
          <p:cNvSpPr txBox="1"/>
          <p:nvPr/>
        </p:nvSpPr>
        <p:spPr>
          <a:xfrm>
            <a:off x="1528642" y="3790610"/>
            <a:ext cx="663964" cy="307777"/>
          </a:xfrm>
          <a:prstGeom prst="rect">
            <a:avLst/>
          </a:prstGeom>
          <a:noFill/>
        </p:spPr>
        <p:txBody>
          <a:bodyPr wrap="none" rtlCol="0">
            <a:spAutoFit/>
          </a:bodyPr>
          <a:lstStyle/>
          <a:p>
            <a:pPr algn="r"/>
            <a:r>
              <a:rPr lang="en-US" altLang="ja-JP" sz="1400" b="1" dirty="0">
                <a:latin typeface="Helvetica" pitchFamily="2" charset="0"/>
              </a:rPr>
              <a:t>HSB2</a:t>
            </a:r>
            <a:endParaRPr lang="ja-JP" altLang="en-US" sz="1400" b="1">
              <a:latin typeface="Helvetica" pitchFamily="2" charset="0"/>
            </a:endParaRPr>
          </a:p>
        </p:txBody>
      </p:sp>
      <p:sp>
        <p:nvSpPr>
          <p:cNvPr id="23" name="テキスト ボックス 22">
            <a:extLst>
              <a:ext uri="{FF2B5EF4-FFF2-40B4-BE49-F238E27FC236}">
                <a16:creationId xmlns:a16="http://schemas.microsoft.com/office/drawing/2014/main" id="{684B2D33-F178-B94D-8003-AA64B6EEBC8D}"/>
              </a:ext>
            </a:extLst>
          </p:cNvPr>
          <p:cNvSpPr txBox="1"/>
          <p:nvPr/>
        </p:nvSpPr>
        <p:spPr>
          <a:xfrm>
            <a:off x="2080990" y="4160948"/>
            <a:ext cx="742512" cy="307777"/>
          </a:xfrm>
          <a:prstGeom prst="rect">
            <a:avLst/>
          </a:prstGeom>
          <a:noFill/>
        </p:spPr>
        <p:txBody>
          <a:bodyPr wrap="none" rtlCol="0">
            <a:spAutoFit/>
          </a:bodyPr>
          <a:lstStyle/>
          <a:p>
            <a:pPr algn="r"/>
            <a:r>
              <a:rPr lang="en-US" altLang="ja-JP" sz="1400" b="1" dirty="0">
                <a:latin typeface="Helvetica" pitchFamily="2" charset="0"/>
              </a:rPr>
              <a:t>CAR-T</a:t>
            </a:r>
            <a:endParaRPr lang="ja-JP" altLang="en-US" sz="1400" b="1">
              <a:latin typeface="Helvetica" pitchFamily="2" charset="0"/>
            </a:endParaRPr>
          </a:p>
        </p:txBody>
      </p:sp>
      <p:sp>
        <p:nvSpPr>
          <p:cNvPr id="25" name="テキスト ボックス 24">
            <a:extLst>
              <a:ext uri="{FF2B5EF4-FFF2-40B4-BE49-F238E27FC236}">
                <a16:creationId xmlns:a16="http://schemas.microsoft.com/office/drawing/2014/main" id="{AE55D5BA-89A8-1065-F443-2CE020096C0C}"/>
              </a:ext>
            </a:extLst>
          </p:cNvPr>
          <p:cNvSpPr txBox="1"/>
          <p:nvPr/>
        </p:nvSpPr>
        <p:spPr>
          <a:xfrm>
            <a:off x="4429833" y="5357861"/>
            <a:ext cx="553357" cy="307777"/>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GFP</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26" name="テキスト ボックス 25">
            <a:extLst>
              <a:ext uri="{FF2B5EF4-FFF2-40B4-BE49-F238E27FC236}">
                <a16:creationId xmlns:a16="http://schemas.microsoft.com/office/drawing/2014/main" id="{4E67EA2C-9645-C552-768D-FB218134B25C}"/>
              </a:ext>
            </a:extLst>
          </p:cNvPr>
          <p:cNvSpPr txBox="1"/>
          <p:nvPr/>
        </p:nvSpPr>
        <p:spPr>
          <a:xfrm rot="16200000">
            <a:off x="3066470" y="4123221"/>
            <a:ext cx="553357" cy="307777"/>
          </a:xfrm>
          <a:prstGeom prst="rect">
            <a:avLst/>
          </a:prstGeom>
          <a:noFill/>
        </p:spPr>
        <p:txBody>
          <a:bodyPr wrap="non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altLang="ja-JP" sz="1400" b="1" i="0" u="none" strike="noStrike" kern="1200" cap="none" spc="0" normalizeH="0" baseline="0" noProof="0" dirty="0">
                <a:ln>
                  <a:noFill/>
                </a:ln>
                <a:solidFill>
                  <a:prstClr val="black"/>
                </a:solidFill>
                <a:effectLst/>
                <a:uLnTx/>
                <a:uFillTx/>
                <a:latin typeface="Helvetica" pitchFamily="2" charset="0"/>
                <a:ea typeface="游ゴシック" panose="020B0400000000000000" pitchFamily="34" charset="-128"/>
                <a:cs typeface="+mn-cs"/>
              </a:rPr>
              <a:t>KO2</a:t>
            </a:r>
            <a:endParaRPr kumimoji="0" lang="ja-JP" altLang="en-US" sz="1400" b="1" i="0" u="none" strike="noStrike" kern="1200" cap="none" spc="0" normalizeH="0" baseline="0" noProof="0">
              <a:ln>
                <a:noFill/>
              </a:ln>
              <a:solidFill>
                <a:prstClr val="black"/>
              </a:solidFill>
              <a:effectLst/>
              <a:uLnTx/>
              <a:uFillTx/>
              <a:latin typeface="Helvetica" pitchFamily="2" charset="0"/>
              <a:ea typeface="游ゴシック" panose="020B0400000000000000" pitchFamily="34" charset="-128"/>
              <a:cs typeface="+mn-cs"/>
            </a:endParaRPr>
          </a:p>
        </p:txBody>
      </p:sp>
      <p:sp>
        <p:nvSpPr>
          <p:cNvPr id="27" name="テキスト ボックス 26">
            <a:extLst>
              <a:ext uri="{FF2B5EF4-FFF2-40B4-BE49-F238E27FC236}">
                <a16:creationId xmlns:a16="http://schemas.microsoft.com/office/drawing/2014/main" id="{EF02D110-BE03-DF28-0F7A-DACFA05E2127}"/>
              </a:ext>
            </a:extLst>
          </p:cNvPr>
          <p:cNvSpPr txBox="1"/>
          <p:nvPr/>
        </p:nvSpPr>
        <p:spPr>
          <a:xfrm>
            <a:off x="4247101" y="3766824"/>
            <a:ext cx="663964" cy="307777"/>
          </a:xfrm>
          <a:prstGeom prst="rect">
            <a:avLst/>
          </a:prstGeom>
          <a:noFill/>
        </p:spPr>
        <p:txBody>
          <a:bodyPr wrap="none" rtlCol="0">
            <a:spAutoFit/>
          </a:bodyPr>
          <a:lstStyle/>
          <a:p>
            <a:pPr algn="r"/>
            <a:r>
              <a:rPr lang="en-US" altLang="ja-JP" sz="1400" b="1" dirty="0">
                <a:latin typeface="Helvetica" pitchFamily="2" charset="0"/>
              </a:rPr>
              <a:t>HSB2</a:t>
            </a:r>
            <a:endParaRPr lang="ja-JP" altLang="en-US" sz="1400" b="1">
              <a:latin typeface="Helvetica" pitchFamily="2" charset="0"/>
            </a:endParaRPr>
          </a:p>
        </p:txBody>
      </p:sp>
      <p:sp>
        <p:nvSpPr>
          <p:cNvPr id="28" name="テキスト ボックス 27">
            <a:extLst>
              <a:ext uri="{FF2B5EF4-FFF2-40B4-BE49-F238E27FC236}">
                <a16:creationId xmlns:a16="http://schemas.microsoft.com/office/drawing/2014/main" id="{F15BE05A-55C5-1665-C56D-C187223EDA99}"/>
              </a:ext>
            </a:extLst>
          </p:cNvPr>
          <p:cNvSpPr txBox="1"/>
          <p:nvPr/>
        </p:nvSpPr>
        <p:spPr>
          <a:xfrm>
            <a:off x="4799449" y="4137162"/>
            <a:ext cx="742512" cy="307777"/>
          </a:xfrm>
          <a:prstGeom prst="rect">
            <a:avLst/>
          </a:prstGeom>
          <a:noFill/>
        </p:spPr>
        <p:txBody>
          <a:bodyPr wrap="none" rtlCol="0">
            <a:spAutoFit/>
          </a:bodyPr>
          <a:lstStyle/>
          <a:p>
            <a:pPr algn="r"/>
            <a:r>
              <a:rPr lang="en-US" altLang="ja-JP" sz="1400" b="1" dirty="0">
                <a:latin typeface="Helvetica" pitchFamily="2" charset="0"/>
              </a:rPr>
              <a:t>CAR-T</a:t>
            </a:r>
            <a:endParaRPr lang="ja-JP" altLang="en-US" sz="1400" b="1">
              <a:latin typeface="Helvetica" pitchFamily="2" charset="0"/>
            </a:endParaRPr>
          </a:p>
        </p:txBody>
      </p:sp>
      <p:sp>
        <p:nvSpPr>
          <p:cNvPr id="12" name="テキスト ボックス 11">
            <a:extLst>
              <a:ext uri="{FF2B5EF4-FFF2-40B4-BE49-F238E27FC236}">
                <a16:creationId xmlns:a16="http://schemas.microsoft.com/office/drawing/2014/main" id="{70883512-171E-F99C-FF84-599655A9E7EF}"/>
              </a:ext>
            </a:extLst>
          </p:cNvPr>
          <p:cNvSpPr txBox="1"/>
          <p:nvPr/>
        </p:nvSpPr>
        <p:spPr>
          <a:xfrm>
            <a:off x="535023" y="6040963"/>
            <a:ext cx="7789619" cy="1384995"/>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ＭＳ Ｐゴシック" panose="020B0600070205080204" pitchFamily="34" charset="-128"/>
              </a:rPr>
              <a:t>Figure S6: Identification of CD26 3G CAR-T cells in mice.</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20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In experiments described in Figure 5C, D and E, </a:t>
            </a:r>
            <a:r>
              <a:rPr lang="en-US" altLang="ja-JP" sz="1200" dirty="0">
                <a:solidFill>
                  <a:srgbClr val="000000"/>
                </a:solidFill>
                <a:effectLst/>
                <a:latin typeface="Century" panose="02040604050505020304" pitchFamily="18" charset="0"/>
                <a:ea typeface="ＭＳ 明朝" panose="02020609040205080304" pitchFamily="49" charset="-128"/>
                <a:cs typeface="Times New Roman" panose="02020603050405020304" pitchFamily="18" charset="0"/>
              </a:rPr>
              <a:t>CD26 3G CAR-T cells injected into mice were identified. (A) In peripheral blood of mice collected at day 15, human cells were selected by flow cytometry from live lymphocytes as both human CD45-positive and mouse CD45-negative cells. (B) and (C). In human cells, HSB2 cells were identified as the KO2-positive cells and CAR-T cells were identified as the GFP-positive cells. (B) Control mice without injection of CD26 3G CAR-T cells (NT). (C) Mice with injection of CD26 3G CAR-T cells. </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32314055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グループ化 22">
            <a:extLst>
              <a:ext uri="{FF2B5EF4-FFF2-40B4-BE49-F238E27FC236}">
                <a16:creationId xmlns:a16="http://schemas.microsoft.com/office/drawing/2014/main" id="{3ABA321E-74EC-1345-B43C-284D583FD43B}"/>
              </a:ext>
            </a:extLst>
          </p:cNvPr>
          <p:cNvGrpSpPr>
            <a:grpSpLocks noChangeAspect="1"/>
          </p:cNvGrpSpPr>
          <p:nvPr/>
        </p:nvGrpSpPr>
        <p:grpSpPr>
          <a:xfrm>
            <a:off x="266700" y="933450"/>
            <a:ext cx="4320000" cy="2160000"/>
            <a:chOff x="0" y="3258000"/>
            <a:chExt cx="7200000" cy="3600000"/>
          </a:xfrm>
        </p:grpSpPr>
        <p:pic>
          <p:nvPicPr>
            <p:cNvPr id="3" name="図 2">
              <a:extLst>
                <a:ext uri="{FF2B5EF4-FFF2-40B4-BE49-F238E27FC236}">
                  <a16:creationId xmlns:a16="http://schemas.microsoft.com/office/drawing/2014/main" id="{1C09A7DD-826D-7846-BF9E-96EF6AF5C75F}"/>
                </a:ext>
              </a:extLst>
            </p:cNvPr>
            <p:cNvPicPr>
              <a:picLocks noChangeAspect="1"/>
            </p:cNvPicPr>
            <p:nvPr/>
          </p:nvPicPr>
          <p:blipFill>
            <a:blip r:embed="rId2"/>
            <a:stretch>
              <a:fillRect/>
            </a:stretch>
          </p:blipFill>
          <p:spPr>
            <a:xfrm>
              <a:off x="0" y="3258000"/>
              <a:ext cx="3600000" cy="3600000"/>
            </a:xfrm>
            <a:prstGeom prst="rect">
              <a:avLst/>
            </a:prstGeom>
            <a:ln w="12700">
              <a:solidFill>
                <a:schemeClr val="tx1"/>
              </a:solidFill>
            </a:ln>
          </p:spPr>
        </p:pic>
        <p:pic>
          <p:nvPicPr>
            <p:cNvPr id="4" name="図 3">
              <a:extLst>
                <a:ext uri="{FF2B5EF4-FFF2-40B4-BE49-F238E27FC236}">
                  <a16:creationId xmlns:a16="http://schemas.microsoft.com/office/drawing/2014/main" id="{F99AD990-FF44-B84A-A230-1E457E6F2395}"/>
                </a:ext>
              </a:extLst>
            </p:cNvPr>
            <p:cNvPicPr>
              <a:picLocks noChangeAspect="1"/>
            </p:cNvPicPr>
            <p:nvPr/>
          </p:nvPicPr>
          <p:blipFill>
            <a:blip r:embed="rId3"/>
            <a:stretch>
              <a:fillRect/>
            </a:stretch>
          </p:blipFill>
          <p:spPr>
            <a:xfrm>
              <a:off x="3600000" y="3258000"/>
              <a:ext cx="3600000" cy="3600000"/>
            </a:xfrm>
            <a:prstGeom prst="rect">
              <a:avLst/>
            </a:prstGeom>
            <a:ln w="12700">
              <a:solidFill>
                <a:schemeClr val="tx1"/>
              </a:solidFill>
            </a:ln>
          </p:spPr>
        </p:pic>
        <p:sp>
          <p:nvSpPr>
            <p:cNvPr id="5" name="正方形/長方形 4">
              <a:extLst>
                <a:ext uri="{FF2B5EF4-FFF2-40B4-BE49-F238E27FC236}">
                  <a16:creationId xmlns:a16="http://schemas.microsoft.com/office/drawing/2014/main" id="{DC174FDF-FF0B-A44A-A381-D8CE7294D36A}"/>
                </a:ext>
              </a:extLst>
            </p:cNvPr>
            <p:cNvSpPr>
              <a:spLocks/>
            </p:cNvSpPr>
            <p:nvPr/>
          </p:nvSpPr>
          <p:spPr>
            <a:xfrm>
              <a:off x="826766" y="5331828"/>
              <a:ext cx="907087" cy="90708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7" name="直線コネクタ 6">
              <a:extLst>
                <a:ext uri="{FF2B5EF4-FFF2-40B4-BE49-F238E27FC236}">
                  <a16:creationId xmlns:a16="http://schemas.microsoft.com/office/drawing/2014/main" id="{7F666C5E-8097-6845-B17D-D49EDC2EEC45}"/>
                </a:ext>
              </a:extLst>
            </p:cNvPr>
            <p:cNvCxnSpPr>
              <a:cxnSpLocks/>
            </p:cNvCxnSpPr>
            <p:nvPr/>
          </p:nvCxnSpPr>
          <p:spPr>
            <a:xfrm flipV="1">
              <a:off x="1733853" y="3258007"/>
              <a:ext cx="1866147" cy="2073821"/>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8" name="直線コネクタ 7">
              <a:extLst>
                <a:ext uri="{FF2B5EF4-FFF2-40B4-BE49-F238E27FC236}">
                  <a16:creationId xmlns:a16="http://schemas.microsoft.com/office/drawing/2014/main" id="{DAFC7C10-A564-0848-9923-8431C9637515}"/>
                </a:ext>
              </a:extLst>
            </p:cNvPr>
            <p:cNvCxnSpPr>
              <a:cxnSpLocks/>
            </p:cNvCxnSpPr>
            <p:nvPr/>
          </p:nvCxnSpPr>
          <p:spPr>
            <a:xfrm>
              <a:off x="1733853" y="6238915"/>
              <a:ext cx="1851855" cy="619085"/>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grpSp>
      <p:grpSp>
        <p:nvGrpSpPr>
          <p:cNvPr id="24" name="グループ化 23">
            <a:extLst>
              <a:ext uri="{FF2B5EF4-FFF2-40B4-BE49-F238E27FC236}">
                <a16:creationId xmlns:a16="http://schemas.microsoft.com/office/drawing/2014/main" id="{2F456DBA-23BA-9E44-8624-2E079EE9F915}"/>
              </a:ext>
            </a:extLst>
          </p:cNvPr>
          <p:cNvGrpSpPr>
            <a:grpSpLocks noChangeAspect="1"/>
          </p:cNvGrpSpPr>
          <p:nvPr/>
        </p:nvGrpSpPr>
        <p:grpSpPr>
          <a:xfrm>
            <a:off x="4919250" y="933450"/>
            <a:ext cx="4320000" cy="2160000"/>
            <a:chOff x="0" y="10291925"/>
            <a:chExt cx="7200000" cy="3600000"/>
          </a:xfrm>
        </p:grpSpPr>
        <p:pic>
          <p:nvPicPr>
            <p:cNvPr id="13" name="図 12">
              <a:extLst>
                <a:ext uri="{FF2B5EF4-FFF2-40B4-BE49-F238E27FC236}">
                  <a16:creationId xmlns:a16="http://schemas.microsoft.com/office/drawing/2014/main" id="{390D520E-5DDB-AE43-AA1F-07224E5A5A70}"/>
                </a:ext>
              </a:extLst>
            </p:cNvPr>
            <p:cNvPicPr>
              <a:picLocks noChangeAspect="1"/>
            </p:cNvPicPr>
            <p:nvPr/>
          </p:nvPicPr>
          <p:blipFill>
            <a:blip r:embed="rId4"/>
            <a:stretch>
              <a:fillRect/>
            </a:stretch>
          </p:blipFill>
          <p:spPr>
            <a:xfrm>
              <a:off x="0" y="10291925"/>
              <a:ext cx="3600000" cy="3600000"/>
            </a:xfrm>
            <a:prstGeom prst="rect">
              <a:avLst/>
            </a:prstGeom>
            <a:ln w="12700">
              <a:solidFill>
                <a:schemeClr val="tx1"/>
              </a:solidFill>
            </a:ln>
          </p:spPr>
        </p:pic>
        <p:pic>
          <p:nvPicPr>
            <p:cNvPr id="14" name="図 13">
              <a:extLst>
                <a:ext uri="{FF2B5EF4-FFF2-40B4-BE49-F238E27FC236}">
                  <a16:creationId xmlns:a16="http://schemas.microsoft.com/office/drawing/2014/main" id="{A27DD989-710E-5346-9CFB-5A853E414AED}"/>
                </a:ext>
              </a:extLst>
            </p:cNvPr>
            <p:cNvPicPr>
              <a:picLocks noChangeAspect="1"/>
            </p:cNvPicPr>
            <p:nvPr/>
          </p:nvPicPr>
          <p:blipFill>
            <a:blip r:embed="rId5"/>
            <a:stretch>
              <a:fillRect/>
            </a:stretch>
          </p:blipFill>
          <p:spPr>
            <a:xfrm>
              <a:off x="3600000" y="10291925"/>
              <a:ext cx="3600000" cy="3600000"/>
            </a:xfrm>
            <a:prstGeom prst="rect">
              <a:avLst/>
            </a:prstGeom>
            <a:ln w="12700">
              <a:solidFill>
                <a:schemeClr val="tx1"/>
              </a:solidFill>
            </a:ln>
          </p:spPr>
        </p:pic>
        <p:sp>
          <p:nvSpPr>
            <p:cNvPr id="15" name="正方形/長方形 14">
              <a:extLst>
                <a:ext uri="{FF2B5EF4-FFF2-40B4-BE49-F238E27FC236}">
                  <a16:creationId xmlns:a16="http://schemas.microsoft.com/office/drawing/2014/main" id="{4FCD31BF-B1B5-A946-9339-37E5A5AFF281}"/>
                </a:ext>
              </a:extLst>
            </p:cNvPr>
            <p:cNvSpPr>
              <a:spLocks/>
            </p:cNvSpPr>
            <p:nvPr/>
          </p:nvSpPr>
          <p:spPr>
            <a:xfrm>
              <a:off x="833074" y="12263413"/>
              <a:ext cx="907087" cy="90708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7" name="直線コネクタ 16">
              <a:extLst>
                <a:ext uri="{FF2B5EF4-FFF2-40B4-BE49-F238E27FC236}">
                  <a16:creationId xmlns:a16="http://schemas.microsoft.com/office/drawing/2014/main" id="{B6AEE249-886A-D44D-A73E-C67CA36ECA44}"/>
                </a:ext>
              </a:extLst>
            </p:cNvPr>
            <p:cNvCxnSpPr>
              <a:cxnSpLocks/>
            </p:cNvCxnSpPr>
            <p:nvPr/>
          </p:nvCxnSpPr>
          <p:spPr>
            <a:xfrm flipV="1">
              <a:off x="1740161" y="10291928"/>
              <a:ext cx="1859839" cy="1971485"/>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E9C0DC8E-9143-9F47-A992-4DDD94138306}"/>
                </a:ext>
              </a:extLst>
            </p:cNvPr>
            <p:cNvCxnSpPr>
              <a:cxnSpLocks/>
            </p:cNvCxnSpPr>
            <p:nvPr/>
          </p:nvCxnSpPr>
          <p:spPr>
            <a:xfrm>
              <a:off x="1740161" y="13170500"/>
              <a:ext cx="1845547" cy="721425"/>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grpSp>
      <p:grpSp>
        <p:nvGrpSpPr>
          <p:cNvPr id="30" name="グループ化 29">
            <a:extLst>
              <a:ext uri="{FF2B5EF4-FFF2-40B4-BE49-F238E27FC236}">
                <a16:creationId xmlns:a16="http://schemas.microsoft.com/office/drawing/2014/main" id="{35AC7D42-1406-7E48-93BA-562B39AB0F7A}"/>
              </a:ext>
            </a:extLst>
          </p:cNvPr>
          <p:cNvGrpSpPr>
            <a:grpSpLocks noChangeAspect="1"/>
          </p:cNvGrpSpPr>
          <p:nvPr/>
        </p:nvGrpSpPr>
        <p:grpSpPr>
          <a:xfrm>
            <a:off x="266701" y="3942839"/>
            <a:ext cx="4319999" cy="2160000"/>
            <a:chOff x="0" y="3257999"/>
            <a:chExt cx="7200000" cy="3600001"/>
          </a:xfrm>
        </p:grpSpPr>
        <p:pic>
          <p:nvPicPr>
            <p:cNvPr id="32" name="図 31">
              <a:extLst>
                <a:ext uri="{FF2B5EF4-FFF2-40B4-BE49-F238E27FC236}">
                  <a16:creationId xmlns:a16="http://schemas.microsoft.com/office/drawing/2014/main" id="{06C88990-4630-9445-964A-43A151F39582}"/>
                </a:ext>
              </a:extLst>
            </p:cNvPr>
            <p:cNvPicPr>
              <a:picLocks noChangeAspect="1"/>
            </p:cNvPicPr>
            <p:nvPr/>
          </p:nvPicPr>
          <p:blipFill>
            <a:blip r:embed="rId6"/>
            <a:stretch>
              <a:fillRect/>
            </a:stretch>
          </p:blipFill>
          <p:spPr>
            <a:xfrm>
              <a:off x="0" y="3257999"/>
              <a:ext cx="3600001" cy="3600001"/>
            </a:xfrm>
            <a:prstGeom prst="rect">
              <a:avLst/>
            </a:prstGeom>
            <a:ln w="12700">
              <a:solidFill>
                <a:schemeClr val="tx1"/>
              </a:solidFill>
            </a:ln>
          </p:spPr>
        </p:pic>
        <p:sp>
          <p:nvSpPr>
            <p:cNvPr id="33" name="正方形/長方形 32">
              <a:extLst>
                <a:ext uri="{FF2B5EF4-FFF2-40B4-BE49-F238E27FC236}">
                  <a16:creationId xmlns:a16="http://schemas.microsoft.com/office/drawing/2014/main" id="{93E992D7-0A4E-4D4B-ACBA-3799ADE455F6}"/>
                </a:ext>
              </a:extLst>
            </p:cNvPr>
            <p:cNvSpPr>
              <a:spLocks/>
            </p:cNvSpPr>
            <p:nvPr/>
          </p:nvSpPr>
          <p:spPr>
            <a:xfrm>
              <a:off x="467949" y="4975488"/>
              <a:ext cx="907087" cy="90708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34" name="図 33">
              <a:extLst>
                <a:ext uri="{FF2B5EF4-FFF2-40B4-BE49-F238E27FC236}">
                  <a16:creationId xmlns:a16="http://schemas.microsoft.com/office/drawing/2014/main" id="{8C75C7D9-9408-F647-99ED-9F1BDC089163}"/>
                </a:ext>
              </a:extLst>
            </p:cNvPr>
            <p:cNvPicPr>
              <a:picLocks noChangeAspect="1"/>
            </p:cNvPicPr>
            <p:nvPr/>
          </p:nvPicPr>
          <p:blipFill>
            <a:blip r:embed="rId7"/>
            <a:stretch>
              <a:fillRect/>
            </a:stretch>
          </p:blipFill>
          <p:spPr>
            <a:xfrm>
              <a:off x="3600000" y="3258000"/>
              <a:ext cx="3600000" cy="3600000"/>
            </a:xfrm>
            <a:prstGeom prst="rect">
              <a:avLst/>
            </a:prstGeom>
            <a:ln w="12700">
              <a:solidFill>
                <a:schemeClr val="tx1"/>
              </a:solidFill>
            </a:ln>
          </p:spPr>
        </p:pic>
        <p:cxnSp>
          <p:nvCxnSpPr>
            <p:cNvPr id="35" name="直線コネクタ 34">
              <a:extLst>
                <a:ext uri="{FF2B5EF4-FFF2-40B4-BE49-F238E27FC236}">
                  <a16:creationId xmlns:a16="http://schemas.microsoft.com/office/drawing/2014/main" id="{F64CCDD4-0A72-4A44-8747-1031696E826B}"/>
                </a:ext>
              </a:extLst>
            </p:cNvPr>
            <p:cNvCxnSpPr>
              <a:cxnSpLocks/>
            </p:cNvCxnSpPr>
            <p:nvPr/>
          </p:nvCxnSpPr>
          <p:spPr>
            <a:xfrm flipV="1">
              <a:off x="1375036" y="3258002"/>
              <a:ext cx="2224964" cy="1717486"/>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36" name="直線コネクタ 35">
              <a:extLst>
                <a:ext uri="{FF2B5EF4-FFF2-40B4-BE49-F238E27FC236}">
                  <a16:creationId xmlns:a16="http://schemas.microsoft.com/office/drawing/2014/main" id="{05B65CFA-7377-4446-B71C-2E3E25FA8905}"/>
                </a:ext>
              </a:extLst>
            </p:cNvPr>
            <p:cNvCxnSpPr>
              <a:cxnSpLocks/>
            </p:cNvCxnSpPr>
            <p:nvPr/>
          </p:nvCxnSpPr>
          <p:spPr>
            <a:xfrm>
              <a:off x="1375036" y="5882575"/>
              <a:ext cx="2210672" cy="975425"/>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grpSp>
      <p:grpSp>
        <p:nvGrpSpPr>
          <p:cNvPr id="38" name="グループ化 37">
            <a:extLst>
              <a:ext uri="{FF2B5EF4-FFF2-40B4-BE49-F238E27FC236}">
                <a16:creationId xmlns:a16="http://schemas.microsoft.com/office/drawing/2014/main" id="{3945C299-2BEA-0A4E-937C-C4C373ACBD3B}"/>
              </a:ext>
            </a:extLst>
          </p:cNvPr>
          <p:cNvGrpSpPr>
            <a:grpSpLocks noChangeAspect="1"/>
          </p:cNvGrpSpPr>
          <p:nvPr/>
        </p:nvGrpSpPr>
        <p:grpSpPr>
          <a:xfrm>
            <a:off x="4919250" y="3942839"/>
            <a:ext cx="4320000" cy="2160000"/>
            <a:chOff x="0" y="11080237"/>
            <a:chExt cx="7200000" cy="3600000"/>
          </a:xfrm>
        </p:grpSpPr>
        <p:pic>
          <p:nvPicPr>
            <p:cNvPr id="40" name="図 39">
              <a:extLst>
                <a:ext uri="{FF2B5EF4-FFF2-40B4-BE49-F238E27FC236}">
                  <a16:creationId xmlns:a16="http://schemas.microsoft.com/office/drawing/2014/main" id="{E6C33F67-63AF-D545-BB8A-99EA50EAC073}"/>
                </a:ext>
              </a:extLst>
            </p:cNvPr>
            <p:cNvPicPr>
              <a:picLocks noChangeAspect="1"/>
            </p:cNvPicPr>
            <p:nvPr/>
          </p:nvPicPr>
          <p:blipFill>
            <a:blip r:embed="rId8"/>
            <a:stretch>
              <a:fillRect/>
            </a:stretch>
          </p:blipFill>
          <p:spPr>
            <a:xfrm>
              <a:off x="0" y="11080237"/>
              <a:ext cx="3600000" cy="3600000"/>
            </a:xfrm>
            <a:prstGeom prst="rect">
              <a:avLst/>
            </a:prstGeom>
            <a:ln w="12700">
              <a:solidFill>
                <a:schemeClr val="tx1"/>
              </a:solidFill>
            </a:ln>
          </p:spPr>
        </p:pic>
        <p:pic>
          <p:nvPicPr>
            <p:cNvPr id="41" name="図 40">
              <a:extLst>
                <a:ext uri="{FF2B5EF4-FFF2-40B4-BE49-F238E27FC236}">
                  <a16:creationId xmlns:a16="http://schemas.microsoft.com/office/drawing/2014/main" id="{D322AE83-2AAF-F443-B898-597C95AB0927}"/>
                </a:ext>
              </a:extLst>
            </p:cNvPr>
            <p:cNvPicPr>
              <a:picLocks noChangeAspect="1"/>
            </p:cNvPicPr>
            <p:nvPr/>
          </p:nvPicPr>
          <p:blipFill>
            <a:blip r:embed="rId9"/>
            <a:stretch>
              <a:fillRect/>
            </a:stretch>
          </p:blipFill>
          <p:spPr>
            <a:xfrm>
              <a:off x="3600000" y="11080237"/>
              <a:ext cx="3600000" cy="3600000"/>
            </a:xfrm>
            <a:prstGeom prst="rect">
              <a:avLst/>
            </a:prstGeom>
            <a:ln w="12700">
              <a:solidFill>
                <a:schemeClr val="tx1"/>
              </a:solidFill>
            </a:ln>
          </p:spPr>
        </p:pic>
        <p:sp>
          <p:nvSpPr>
            <p:cNvPr id="42" name="正方形/長方形 41">
              <a:extLst>
                <a:ext uri="{FF2B5EF4-FFF2-40B4-BE49-F238E27FC236}">
                  <a16:creationId xmlns:a16="http://schemas.microsoft.com/office/drawing/2014/main" id="{465DAB49-3117-2344-AA36-0954CC68DCA1}"/>
                </a:ext>
              </a:extLst>
            </p:cNvPr>
            <p:cNvSpPr>
              <a:spLocks/>
            </p:cNvSpPr>
            <p:nvPr/>
          </p:nvSpPr>
          <p:spPr>
            <a:xfrm>
              <a:off x="602515" y="13496713"/>
              <a:ext cx="907087" cy="90708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43" name="直線コネクタ 42">
              <a:extLst>
                <a:ext uri="{FF2B5EF4-FFF2-40B4-BE49-F238E27FC236}">
                  <a16:creationId xmlns:a16="http://schemas.microsoft.com/office/drawing/2014/main" id="{CDBCA0E9-C72A-AF4F-82DF-6EC0146F6246}"/>
                </a:ext>
              </a:extLst>
            </p:cNvPr>
            <p:cNvCxnSpPr>
              <a:cxnSpLocks/>
            </p:cNvCxnSpPr>
            <p:nvPr/>
          </p:nvCxnSpPr>
          <p:spPr>
            <a:xfrm flipV="1">
              <a:off x="1509602" y="11080248"/>
              <a:ext cx="2090398" cy="2416465"/>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44" name="直線コネクタ 43">
              <a:extLst>
                <a:ext uri="{FF2B5EF4-FFF2-40B4-BE49-F238E27FC236}">
                  <a16:creationId xmlns:a16="http://schemas.microsoft.com/office/drawing/2014/main" id="{8AA07039-D5AA-2C48-BA52-EE43886038DD}"/>
                </a:ext>
              </a:extLst>
            </p:cNvPr>
            <p:cNvCxnSpPr>
              <a:cxnSpLocks/>
            </p:cNvCxnSpPr>
            <p:nvPr/>
          </p:nvCxnSpPr>
          <p:spPr>
            <a:xfrm>
              <a:off x="1509602" y="14403800"/>
              <a:ext cx="2076106" cy="276437"/>
            </a:xfrm>
            <a:prstGeom prst="line">
              <a:avLst/>
            </a:prstGeom>
            <a:ln w="12700">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grpSp>
      <p:sp>
        <p:nvSpPr>
          <p:cNvPr id="55" name="TextBox 15">
            <a:extLst>
              <a:ext uri="{FF2B5EF4-FFF2-40B4-BE49-F238E27FC236}">
                <a16:creationId xmlns:a16="http://schemas.microsoft.com/office/drawing/2014/main" id="{9FDFAE91-8F68-294D-B5EB-FE798EC270B0}"/>
              </a:ext>
            </a:extLst>
          </p:cNvPr>
          <p:cNvSpPr txBox="1"/>
          <p:nvPr/>
        </p:nvSpPr>
        <p:spPr>
          <a:xfrm>
            <a:off x="266700" y="419100"/>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A)</a:t>
            </a:r>
          </a:p>
        </p:txBody>
      </p:sp>
      <p:sp>
        <p:nvSpPr>
          <p:cNvPr id="56" name="TextBox 15">
            <a:extLst>
              <a:ext uri="{FF2B5EF4-FFF2-40B4-BE49-F238E27FC236}">
                <a16:creationId xmlns:a16="http://schemas.microsoft.com/office/drawing/2014/main" id="{E90B6202-43C5-844E-8F5B-C9C918112864}"/>
              </a:ext>
            </a:extLst>
          </p:cNvPr>
          <p:cNvSpPr txBox="1"/>
          <p:nvPr/>
        </p:nvSpPr>
        <p:spPr>
          <a:xfrm>
            <a:off x="4919250" y="419100"/>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B)</a:t>
            </a:r>
          </a:p>
        </p:txBody>
      </p:sp>
      <p:sp>
        <p:nvSpPr>
          <p:cNvPr id="57" name="TextBox 15">
            <a:extLst>
              <a:ext uri="{FF2B5EF4-FFF2-40B4-BE49-F238E27FC236}">
                <a16:creationId xmlns:a16="http://schemas.microsoft.com/office/drawing/2014/main" id="{2750518D-BAF7-BF42-9E10-A2D11EF513BF}"/>
              </a:ext>
            </a:extLst>
          </p:cNvPr>
          <p:cNvSpPr txBox="1"/>
          <p:nvPr/>
        </p:nvSpPr>
        <p:spPr>
          <a:xfrm>
            <a:off x="266700" y="3428489"/>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C)</a:t>
            </a:r>
          </a:p>
        </p:txBody>
      </p:sp>
      <p:sp>
        <p:nvSpPr>
          <p:cNvPr id="58" name="TextBox 15">
            <a:extLst>
              <a:ext uri="{FF2B5EF4-FFF2-40B4-BE49-F238E27FC236}">
                <a16:creationId xmlns:a16="http://schemas.microsoft.com/office/drawing/2014/main" id="{28B0B8A1-DF5F-B249-AE9E-18709D1A025F}"/>
              </a:ext>
            </a:extLst>
          </p:cNvPr>
          <p:cNvSpPr txBox="1"/>
          <p:nvPr/>
        </p:nvSpPr>
        <p:spPr>
          <a:xfrm>
            <a:off x="4919250" y="3428489"/>
            <a:ext cx="536325" cy="369332"/>
          </a:xfrm>
          <a:prstGeom prst="rect">
            <a:avLst/>
          </a:prstGeom>
          <a:noFill/>
        </p:spPr>
        <p:txBody>
          <a:bodyPr wrap="square" rtlCol="0">
            <a:spAutoFit/>
          </a:bodyPr>
          <a:lstStyle/>
          <a:p>
            <a:pPr defTabSz="914361">
              <a:defRPr/>
            </a:pPr>
            <a:r>
              <a:rPr lang="en-US" altLang="ja-JP" b="1" dirty="0">
                <a:solidFill>
                  <a:prstClr val="black"/>
                </a:solidFill>
                <a:latin typeface="Helvetica" pitchFamily="2" charset="0"/>
                <a:ea typeface="Meiryo" panose="020B0604030504040204" pitchFamily="34" charset="-128"/>
              </a:rPr>
              <a:t>(D)</a:t>
            </a:r>
          </a:p>
        </p:txBody>
      </p:sp>
      <p:sp>
        <p:nvSpPr>
          <p:cNvPr id="6" name="テキスト ボックス 5">
            <a:extLst>
              <a:ext uri="{FF2B5EF4-FFF2-40B4-BE49-F238E27FC236}">
                <a16:creationId xmlns:a16="http://schemas.microsoft.com/office/drawing/2014/main" id="{79B36522-DB17-E3FE-969F-7642B7904FC1}"/>
              </a:ext>
            </a:extLst>
          </p:cNvPr>
          <p:cNvSpPr txBox="1"/>
          <p:nvPr/>
        </p:nvSpPr>
        <p:spPr>
          <a:xfrm>
            <a:off x="266700" y="6490925"/>
            <a:ext cx="8972550" cy="1015663"/>
          </a:xfrm>
          <a:prstGeom prst="rect">
            <a:avLst/>
          </a:prstGeom>
          <a:noFill/>
        </p:spPr>
        <p:txBody>
          <a:bodyPr wrap="square">
            <a:spAutoFit/>
          </a:bodyPr>
          <a:lstStyle/>
          <a:p>
            <a:r>
              <a:rPr lang="en-US" altLang="ja-JP" sz="1200" b="1" dirty="0">
                <a:solidFill>
                  <a:srgbClr val="000000"/>
                </a:solidFill>
                <a:effectLst/>
                <a:latin typeface="Arial" panose="020B0604020202020204" pitchFamily="34" charset="0"/>
                <a:ea typeface="ＭＳ 明朝" panose="02020609040205080304" pitchFamily="49" charset="-128"/>
                <a:cs typeface="ＭＳ Ｐゴシック" panose="020B0600070205080204" pitchFamily="34" charset="-128"/>
              </a:rPr>
              <a:t>Figure S7: Expression of CD26 on lymphoma cells in patient samples.</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20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Biopsy specimens of patients with T cell malignancies were stained for CD26 by immunohistochemistry. Four typical results of staining assays are demonstrated. (A) ALCL patient with “moderate” staining intensity. (B) AITL patient with “moderate” staining intensity. (C) NK/T patient with “strong” staining intensity. (D) PTCL patient with “strong” staining intensity.</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a:p>
            <a:r>
              <a:rPr lang="en-US" altLang="ja-JP" sz="1200" dirty="0">
                <a:solidFill>
                  <a:srgbClr val="000000"/>
                </a:solidFill>
                <a:effectLst/>
                <a:latin typeface="Century" panose="02040604050505020304" pitchFamily="18" charset="0"/>
                <a:ea typeface="ＭＳ 明朝" panose="02020609040205080304" pitchFamily="49" charset="-128"/>
                <a:cs typeface="Arial" panose="020B0604020202020204" pitchFamily="34" charset="0"/>
              </a:rPr>
              <a:t> </a:t>
            </a:r>
            <a:endParaRPr lang="ja-JP" altLang="ja-JP" sz="12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397352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オブジェクト 4">
            <a:extLst>
              <a:ext uri="{FF2B5EF4-FFF2-40B4-BE49-F238E27FC236}">
                <a16:creationId xmlns:a16="http://schemas.microsoft.com/office/drawing/2014/main" id="{BCFDFCB1-DDD0-8532-718B-112E296B9E5B}"/>
              </a:ext>
            </a:extLst>
          </p:cNvPr>
          <p:cNvGraphicFramePr>
            <a:graphicFrameLocks noChangeAspect="1"/>
          </p:cNvGraphicFramePr>
          <p:nvPr>
            <p:extLst>
              <p:ext uri="{D42A27DB-BD31-4B8C-83A1-F6EECF244321}">
                <p14:modId xmlns:p14="http://schemas.microsoft.com/office/powerpoint/2010/main" val="627975896"/>
              </p:ext>
            </p:extLst>
          </p:nvPr>
        </p:nvGraphicFramePr>
        <p:xfrm>
          <a:off x="2101850" y="2038350"/>
          <a:ext cx="5397500" cy="8153400"/>
        </p:xfrm>
        <a:graphic>
          <a:graphicData uri="http://schemas.openxmlformats.org/presentationml/2006/ole">
            <mc:AlternateContent xmlns:mc="http://schemas.openxmlformats.org/markup-compatibility/2006">
              <mc:Choice xmlns:v="urn:schemas-microsoft-com:vml" Requires="v">
                <p:oleObj name="文書" r:id="rId2" imgW="5397500" imgH="8153400" progId="Word.Document.12">
                  <p:embed/>
                </p:oleObj>
              </mc:Choice>
              <mc:Fallback>
                <p:oleObj name="文書" r:id="rId2" imgW="5397500" imgH="8153400" progId="Word.Document.12">
                  <p:embed/>
                  <p:pic>
                    <p:nvPicPr>
                      <p:cNvPr id="0" name=""/>
                      <p:cNvPicPr/>
                      <p:nvPr/>
                    </p:nvPicPr>
                    <p:blipFill>
                      <a:blip r:embed="rId3"/>
                      <a:stretch>
                        <a:fillRect/>
                      </a:stretch>
                    </p:blipFill>
                    <p:spPr>
                      <a:xfrm>
                        <a:off x="2101850" y="2038350"/>
                        <a:ext cx="5397500" cy="8153400"/>
                      </a:xfrm>
                      <a:prstGeom prst="rect">
                        <a:avLst/>
                      </a:prstGeom>
                    </p:spPr>
                  </p:pic>
                </p:oleObj>
              </mc:Fallback>
            </mc:AlternateContent>
          </a:graphicData>
        </a:graphic>
      </p:graphicFrame>
    </p:spTree>
    <p:extLst>
      <p:ext uri="{BB962C8B-B14F-4D97-AF65-F5344CB8AC3E}">
        <p14:creationId xmlns:p14="http://schemas.microsoft.com/office/powerpoint/2010/main" val="4159036090"/>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52</TotalTime>
  <Words>692</Words>
  <Application>Microsoft Macintosh PowerPoint</Application>
  <PresentationFormat>A3 297x420 mm</PresentationFormat>
  <Paragraphs>175</Paragraphs>
  <Slides>8</Slides>
  <Notes>0</Notes>
  <HiddenSlides>0</HiddenSlides>
  <MMClips>0</MMClips>
  <ScaleCrop>false</ScaleCrop>
  <HeadingPairs>
    <vt:vector size="8" baseType="variant">
      <vt:variant>
        <vt:lpstr>使用されているフォント</vt:lpstr>
      </vt:variant>
      <vt:variant>
        <vt:i4>8</vt:i4>
      </vt:variant>
      <vt:variant>
        <vt:lpstr>テーマ</vt:lpstr>
      </vt:variant>
      <vt:variant>
        <vt:i4>1</vt:i4>
      </vt:variant>
      <vt:variant>
        <vt:lpstr>埋め込まれた OLE サーバー</vt:lpstr>
      </vt:variant>
      <vt:variant>
        <vt:i4>1</vt:i4>
      </vt:variant>
      <vt:variant>
        <vt:lpstr>スライド タイトル</vt:lpstr>
      </vt:variant>
      <vt:variant>
        <vt:i4>8</vt:i4>
      </vt:variant>
    </vt:vector>
  </HeadingPairs>
  <TitlesOfParts>
    <vt:vector size="18" baseType="lpstr">
      <vt:lpstr>ＭＳ Ｐゴシック</vt:lpstr>
      <vt:lpstr>Meiryo</vt:lpstr>
      <vt:lpstr>游ゴシック</vt:lpstr>
      <vt:lpstr>Arial</vt:lpstr>
      <vt:lpstr>Calibri</vt:lpstr>
      <vt:lpstr>Calibri Light</vt:lpstr>
      <vt:lpstr>Century</vt:lpstr>
      <vt:lpstr>Helvetica</vt:lpstr>
      <vt:lpstr>Office テーマ</vt:lpstr>
      <vt:lpstr>文書</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ato Tsutomu</dc:creator>
  <cp:lastModifiedBy>Tsutomu Sato</cp:lastModifiedBy>
  <cp:revision>178</cp:revision>
  <cp:lastPrinted>2022-11-27T06:08:09Z</cp:lastPrinted>
  <dcterms:created xsi:type="dcterms:W3CDTF">2020-07-13T05:54:43Z</dcterms:created>
  <dcterms:modified xsi:type="dcterms:W3CDTF">2023-07-16T03:49:27Z</dcterms:modified>
</cp:coreProperties>
</file>